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slideLayouts/slideLayout10.xml" ContentType="application/vnd.openxmlformats-officedocument.presentationml.slideLayout+xml"/>
  <Default Extension="tiff" ContentType="image/tiff"/>
  <Default Extension="vml" ContentType="application/vnd.openxmlformats-officedocument.vmlDrawing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10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7" r:id="rId2"/>
    <p:sldId id="258" r:id="rId3"/>
    <p:sldId id="259" r:id="rId4"/>
    <p:sldId id="263" r:id="rId5"/>
    <p:sldId id="264" r:id="rId6"/>
    <p:sldId id="265" r:id="rId7"/>
    <p:sldId id="260" r:id="rId8"/>
    <p:sldId id="261" r:id="rId9"/>
    <p:sldId id="262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howGuides="1">
      <p:cViewPr varScale="1">
        <p:scale>
          <a:sx n="64" d="100"/>
          <a:sy n="64" d="100"/>
        </p:scale>
        <p:origin x="-148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GST\GST%20%20submiting%20material\Book1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D:\GST\GST%20%20submiting%20material\Book1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GST\GST%20%20submiting%20material\Book1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GST\GST%20%20submiting%20material\Book1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GST\GST%20%20submiting%20material\Book1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GST\GST%20%20submiting%20material\Book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GST\GST%20%20submiting%20material\Book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AYUM\Downloads\Kayum%20GST%20data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AYUM\Downloads\Kayum%20GST%20data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AYUM\Downloads\Kayum%20GST%20data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AYUM\Downloads\Kayum%20GST%20data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GST\GST%20%20submiting%20material\Book1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GST\GST%20%20submiting%20material\Book1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GST\GST%20%20submiting%20material\Book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0h</c:v>
          </c:tx>
          <c:errBars>
            <c:errBarType val="both"/>
            <c:errValType val="cust"/>
            <c:plus>
              <c:numRef>
                <c:f>Sheet12!$C$13:$S$13</c:f>
                <c:numCache>
                  <c:formatCode>General</c:formatCode>
                  <c:ptCount val="1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</c:numCache>
              </c:numRef>
            </c:plus>
            <c:minus>
              <c:numRef>
                <c:f>Sheet12!$C$13:$S$13</c:f>
                <c:numCache>
                  <c:formatCode>General</c:formatCode>
                  <c:ptCount val="1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</c:numCache>
              </c:numRef>
            </c:minus>
          </c:errBars>
          <c:cat>
            <c:strRef>
              <c:f>Sheet12!$C$4:$S$4</c:f>
              <c:strCache>
                <c:ptCount val="17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4</c:v>
                </c:pt>
                <c:pt idx="13">
                  <c:v>GSTU17</c:v>
                </c:pt>
                <c:pt idx="14">
                  <c:v>GSTF2</c:v>
                </c:pt>
                <c:pt idx="15">
                  <c:v>GSTZ2   </c:v>
                </c:pt>
                <c:pt idx="16">
                  <c:v>GSTL1    </c:v>
                </c:pt>
              </c:strCache>
            </c:strRef>
          </c:cat>
          <c:val>
            <c:numRef>
              <c:f>Sheet12!$C$5:$S$5</c:f>
              <c:numCache>
                <c:formatCode>0.00</c:formatCode>
                <c:ptCount val="1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</c:numCache>
            </c:numRef>
          </c:val>
        </c:ser>
        <c:ser>
          <c:idx val="1"/>
          <c:order val="1"/>
          <c:tx>
            <c:v>6h</c:v>
          </c:tx>
          <c:errBars>
            <c:errBarType val="both"/>
            <c:errValType val="cust"/>
            <c:plus>
              <c:numRef>
                <c:f>Sheet12!$C$14:$S$14</c:f>
                <c:numCache>
                  <c:formatCode>General</c:formatCode>
                  <c:ptCount val="17"/>
                  <c:pt idx="0">
                    <c:v>5.7098408013035562E-2</c:v>
                  </c:pt>
                  <c:pt idx="1">
                    <c:v>1.6658980330515896E-2</c:v>
                  </c:pt>
                  <c:pt idx="2">
                    <c:v>0.34383164755545065</c:v>
                  </c:pt>
                  <c:pt idx="3">
                    <c:v>3.0598279230721271E-2</c:v>
                  </c:pt>
                  <c:pt idx="4">
                    <c:v>2.3973132956427418E-2</c:v>
                  </c:pt>
                  <c:pt idx="5">
                    <c:v>7.7123012370192118E-2</c:v>
                  </c:pt>
                  <c:pt idx="6">
                    <c:v>0.27087140247015601</c:v>
                  </c:pt>
                  <c:pt idx="7">
                    <c:v>0.43421267802104546</c:v>
                  </c:pt>
                  <c:pt idx="8">
                    <c:v>0.28367422065088232</c:v>
                  </c:pt>
                  <c:pt idx="9">
                    <c:v>0.12746002186898953</c:v>
                  </c:pt>
                  <c:pt idx="10">
                    <c:v>0.3175284553579244</c:v>
                  </c:pt>
                  <c:pt idx="11">
                    <c:v>0.66272995705138305</c:v>
                  </c:pt>
                  <c:pt idx="12">
                    <c:v>0.54936369957567999</c:v>
                  </c:pt>
                  <c:pt idx="13">
                    <c:v>4.2616687545912191E-2</c:v>
                  </c:pt>
                  <c:pt idx="14">
                    <c:v>0.50742920549116899</c:v>
                  </c:pt>
                  <c:pt idx="15">
                    <c:v>0.16996448376506718</c:v>
                  </c:pt>
                  <c:pt idx="16">
                    <c:v>5.2491879532297982E-2</c:v>
                  </c:pt>
                </c:numCache>
              </c:numRef>
            </c:plus>
            <c:minus>
              <c:numRef>
                <c:f>Sheet12!$C$14:$S$14</c:f>
                <c:numCache>
                  <c:formatCode>General</c:formatCode>
                  <c:ptCount val="17"/>
                  <c:pt idx="0">
                    <c:v>5.7098408013035562E-2</c:v>
                  </c:pt>
                  <c:pt idx="1">
                    <c:v>1.6658980330515896E-2</c:v>
                  </c:pt>
                  <c:pt idx="2">
                    <c:v>0.34383164755545065</c:v>
                  </c:pt>
                  <c:pt idx="3">
                    <c:v>3.0598279230721271E-2</c:v>
                  </c:pt>
                  <c:pt idx="4">
                    <c:v>2.3973132956427418E-2</c:v>
                  </c:pt>
                  <c:pt idx="5">
                    <c:v>7.7123012370192118E-2</c:v>
                  </c:pt>
                  <c:pt idx="6">
                    <c:v>0.27087140247015601</c:v>
                  </c:pt>
                  <c:pt idx="7">
                    <c:v>0.43421267802104546</c:v>
                  </c:pt>
                  <c:pt idx="8">
                    <c:v>0.28367422065088232</c:v>
                  </c:pt>
                  <c:pt idx="9">
                    <c:v>0.12746002186898953</c:v>
                  </c:pt>
                  <c:pt idx="10">
                    <c:v>0.3175284553579244</c:v>
                  </c:pt>
                  <c:pt idx="11">
                    <c:v>0.66272995705138305</c:v>
                  </c:pt>
                  <c:pt idx="12">
                    <c:v>0.54936369957567999</c:v>
                  </c:pt>
                  <c:pt idx="13">
                    <c:v>4.2616687545912191E-2</c:v>
                  </c:pt>
                  <c:pt idx="14">
                    <c:v>0.50742920549116899</c:v>
                  </c:pt>
                  <c:pt idx="15">
                    <c:v>0.16996448376506718</c:v>
                  </c:pt>
                  <c:pt idx="16">
                    <c:v>5.2491879532297982E-2</c:v>
                  </c:pt>
                </c:numCache>
              </c:numRef>
            </c:minus>
          </c:errBars>
          <c:cat>
            <c:strRef>
              <c:f>Sheet12!$C$4:$S$4</c:f>
              <c:strCache>
                <c:ptCount val="17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4</c:v>
                </c:pt>
                <c:pt idx="13">
                  <c:v>GSTU17</c:v>
                </c:pt>
                <c:pt idx="14">
                  <c:v>GSTF2</c:v>
                </c:pt>
                <c:pt idx="15">
                  <c:v>GSTZ2   </c:v>
                </c:pt>
                <c:pt idx="16">
                  <c:v>GSTL1    </c:v>
                </c:pt>
              </c:strCache>
            </c:strRef>
          </c:cat>
          <c:val>
            <c:numRef>
              <c:f>Sheet12!$C$6:$S$6</c:f>
              <c:numCache>
                <c:formatCode>0.00</c:formatCode>
                <c:ptCount val="17"/>
                <c:pt idx="0">
                  <c:v>1.1654331561897826</c:v>
                </c:pt>
                <c:pt idx="1">
                  <c:v>0.56656441399328361</c:v>
                </c:pt>
                <c:pt idx="2">
                  <c:v>8.3500000000000068</c:v>
                </c:pt>
                <c:pt idx="3">
                  <c:v>0.62454016458206252</c:v>
                </c:pt>
                <c:pt idx="4">
                  <c:v>0.61155512238113763</c:v>
                </c:pt>
                <c:pt idx="5">
                  <c:v>1.2112223889377818</c:v>
                </c:pt>
                <c:pt idx="6">
                  <c:v>3.7621387470774019</c:v>
                </c:pt>
                <c:pt idx="7">
                  <c:v>7.4110832650168303</c:v>
                </c:pt>
                <c:pt idx="8">
                  <c:v>2.1466456117956367</c:v>
                </c:pt>
                <c:pt idx="9">
                  <c:v>1.6270030270817601</c:v>
                </c:pt>
                <c:pt idx="10">
                  <c:v>2.5177352613112411</c:v>
                </c:pt>
                <c:pt idx="11">
                  <c:v>10.914907341310601</c:v>
                </c:pt>
                <c:pt idx="12">
                  <c:v>8.0075603541267046</c:v>
                </c:pt>
                <c:pt idx="13">
                  <c:v>1.0871525893168077</c:v>
                </c:pt>
                <c:pt idx="14">
                  <c:v>3.7896555374036867</c:v>
                </c:pt>
                <c:pt idx="15">
                  <c:v>2.6693042936696658</c:v>
                </c:pt>
                <c:pt idx="16">
                  <c:v>0.5957609330106246</c:v>
                </c:pt>
              </c:numCache>
            </c:numRef>
          </c:val>
        </c:ser>
        <c:ser>
          <c:idx val="2"/>
          <c:order val="2"/>
          <c:tx>
            <c:v>24h</c:v>
          </c:tx>
          <c:errBars>
            <c:errBarType val="both"/>
            <c:errValType val="cust"/>
            <c:plus>
              <c:numRef>
                <c:f>Sheet12!$C$15:$S$15</c:f>
                <c:numCache>
                  <c:formatCode>General</c:formatCode>
                  <c:ptCount val="17"/>
                  <c:pt idx="0">
                    <c:v>3.8264715958134896E-2</c:v>
                  </c:pt>
                  <c:pt idx="1">
                    <c:v>2.8213635110389552E-2</c:v>
                  </c:pt>
                  <c:pt idx="2">
                    <c:v>0.80398797995642357</c:v>
                  </c:pt>
                  <c:pt idx="3">
                    <c:v>3.302993177383709E-2</c:v>
                  </c:pt>
                  <c:pt idx="4">
                    <c:v>3.066540472872822E-2</c:v>
                  </c:pt>
                  <c:pt idx="5">
                    <c:v>0.91269620133330365</c:v>
                  </c:pt>
                  <c:pt idx="6">
                    <c:v>1.0185482083373798</c:v>
                  </c:pt>
                  <c:pt idx="7">
                    <c:v>0.25869452556783001</c:v>
                  </c:pt>
                  <c:pt idx="8">
                    <c:v>0.67715595687985153</c:v>
                  </c:pt>
                  <c:pt idx="9">
                    <c:v>0.22123288042056147</c:v>
                  </c:pt>
                  <c:pt idx="10">
                    <c:v>0.35764877868240252</c:v>
                  </c:pt>
                  <c:pt idx="11">
                    <c:v>0.50170310172660471</c:v>
                  </c:pt>
                  <c:pt idx="12">
                    <c:v>0.61724756333303321</c:v>
                  </c:pt>
                  <c:pt idx="13">
                    <c:v>0.44216557670270412</c:v>
                  </c:pt>
                  <c:pt idx="14">
                    <c:v>0.31408080742673011</c:v>
                  </c:pt>
                  <c:pt idx="15">
                    <c:v>0.37228889258636438</c:v>
                  </c:pt>
                  <c:pt idx="16">
                    <c:v>6.9707943751736265E-2</c:v>
                  </c:pt>
                </c:numCache>
              </c:numRef>
            </c:plus>
            <c:minus>
              <c:numRef>
                <c:f>Sheet12!$C$15:$S$15</c:f>
                <c:numCache>
                  <c:formatCode>General</c:formatCode>
                  <c:ptCount val="17"/>
                  <c:pt idx="0">
                    <c:v>3.8264715958134896E-2</c:v>
                  </c:pt>
                  <c:pt idx="1">
                    <c:v>2.8213635110389552E-2</c:v>
                  </c:pt>
                  <c:pt idx="2">
                    <c:v>0.80398797995642357</c:v>
                  </c:pt>
                  <c:pt idx="3">
                    <c:v>3.302993177383709E-2</c:v>
                  </c:pt>
                  <c:pt idx="4">
                    <c:v>3.066540472872822E-2</c:v>
                  </c:pt>
                  <c:pt idx="5">
                    <c:v>0.91269620133330365</c:v>
                  </c:pt>
                  <c:pt idx="6">
                    <c:v>1.0185482083373798</c:v>
                  </c:pt>
                  <c:pt idx="7">
                    <c:v>0.25869452556783001</c:v>
                  </c:pt>
                  <c:pt idx="8">
                    <c:v>0.67715595687985153</c:v>
                  </c:pt>
                  <c:pt idx="9">
                    <c:v>0.22123288042056147</c:v>
                  </c:pt>
                  <c:pt idx="10">
                    <c:v>0.35764877868240252</c:v>
                  </c:pt>
                  <c:pt idx="11">
                    <c:v>0.50170310172660471</c:v>
                  </c:pt>
                  <c:pt idx="12">
                    <c:v>0.61724756333303321</c:v>
                  </c:pt>
                  <c:pt idx="13">
                    <c:v>0.44216557670270412</c:v>
                  </c:pt>
                  <c:pt idx="14">
                    <c:v>0.31408080742673011</c:v>
                  </c:pt>
                  <c:pt idx="15">
                    <c:v>0.37228889258636438</c:v>
                  </c:pt>
                  <c:pt idx="16">
                    <c:v>6.9707943751736265E-2</c:v>
                  </c:pt>
                </c:numCache>
              </c:numRef>
            </c:minus>
          </c:errBars>
          <c:cat>
            <c:strRef>
              <c:f>Sheet12!$C$4:$S$4</c:f>
              <c:strCache>
                <c:ptCount val="17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4</c:v>
                </c:pt>
                <c:pt idx="13">
                  <c:v>GSTU17</c:v>
                </c:pt>
                <c:pt idx="14">
                  <c:v>GSTF2</c:v>
                </c:pt>
                <c:pt idx="15">
                  <c:v>GSTZ2   </c:v>
                </c:pt>
                <c:pt idx="16">
                  <c:v>GSTL1    </c:v>
                </c:pt>
              </c:strCache>
            </c:strRef>
          </c:cat>
          <c:val>
            <c:numRef>
              <c:f>Sheet12!$C$7:$S$7</c:f>
              <c:numCache>
                <c:formatCode>0.00</c:formatCode>
                <c:ptCount val="17"/>
                <c:pt idx="0">
                  <c:v>0.71007736851137282</c:v>
                </c:pt>
                <c:pt idx="1">
                  <c:v>0.6398039026779696</c:v>
                </c:pt>
                <c:pt idx="2">
                  <c:v>5.1162598220850555</c:v>
                </c:pt>
                <c:pt idx="3">
                  <c:v>0.44967313462338676</c:v>
                </c:pt>
                <c:pt idx="4">
                  <c:v>0.52168371563151461</c:v>
                </c:pt>
                <c:pt idx="5">
                  <c:v>8.4807360538214454</c:v>
                </c:pt>
                <c:pt idx="6">
                  <c:v>12.946148555431</c:v>
                </c:pt>
                <c:pt idx="7">
                  <c:v>6.444824176658579</c:v>
                </c:pt>
                <c:pt idx="8">
                  <c:v>12.932794086350899</c:v>
                </c:pt>
                <c:pt idx="9">
                  <c:v>6.7221206949160397</c:v>
                </c:pt>
                <c:pt idx="10">
                  <c:v>9.7712284758384822</c:v>
                </c:pt>
                <c:pt idx="11">
                  <c:v>6.74748164180766</c:v>
                </c:pt>
                <c:pt idx="12">
                  <c:v>5.39112501061933</c:v>
                </c:pt>
                <c:pt idx="13">
                  <c:v>1.4773918641621928</c:v>
                </c:pt>
                <c:pt idx="14">
                  <c:v>2.4104915732108267</c:v>
                </c:pt>
                <c:pt idx="15">
                  <c:v>1.9841489576890898</c:v>
                </c:pt>
                <c:pt idx="16">
                  <c:v>0.61967281766363802</c:v>
                </c:pt>
              </c:numCache>
            </c:numRef>
          </c:val>
        </c:ser>
        <c:ser>
          <c:idx val="3"/>
          <c:order val="3"/>
          <c:tx>
            <c:v>48h</c:v>
          </c:tx>
          <c:errBars>
            <c:errBarType val="both"/>
            <c:errValType val="cust"/>
            <c:plus>
              <c:numRef>
                <c:f>Sheet12!$C$16:$S$16</c:f>
                <c:numCache>
                  <c:formatCode>General</c:formatCode>
                  <c:ptCount val="17"/>
                  <c:pt idx="0">
                    <c:v>0.10976149245641439</c:v>
                  </c:pt>
                  <c:pt idx="1">
                    <c:v>0.32961312033172702</c:v>
                  </c:pt>
                  <c:pt idx="2">
                    <c:v>3.489869947507222E-3</c:v>
                  </c:pt>
                  <c:pt idx="3">
                    <c:v>6.5464945263651292E-2</c:v>
                  </c:pt>
                  <c:pt idx="4">
                    <c:v>0.17435192869899763</c:v>
                  </c:pt>
                  <c:pt idx="5">
                    <c:v>0.81561956787654499</c:v>
                  </c:pt>
                  <c:pt idx="6">
                    <c:v>0.33610780029437426</c:v>
                  </c:pt>
                  <c:pt idx="7">
                    <c:v>9.3306197411657368E-2</c:v>
                  </c:pt>
                  <c:pt idx="8">
                    <c:v>0.12094675006398904</c:v>
                  </c:pt>
                  <c:pt idx="9">
                    <c:v>0.61057400177958865</c:v>
                  </c:pt>
                  <c:pt idx="10">
                    <c:v>0.74709818377430603</c:v>
                  </c:pt>
                  <c:pt idx="11">
                    <c:v>0.32880368777778479</c:v>
                  </c:pt>
                  <c:pt idx="12">
                    <c:v>0.34404635080529128</c:v>
                  </c:pt>
                  <c:pt idx="13">
                    <c:v>0.11109562231931278</c:v>
                  </c:pt>
                  <c:pt idx="14">
                    <c:v>0.18983086907316671</c:v>
                  </c:pt>
                  <c:pt idx="15">
                    <c:v>0.4062558780782084</c:v>
                  </c:pt>
                  <c:pt idx="16">
                    <c:v>2.2364680072699098E-2</c:v>
                  </c:pt>
                </c:numCache>
              </c:numRef>
            </c:plus>
            <c:minus>
              <c:numRef>
                <c:f>Sheet12!$C$16:$T$16</c:f>
                <c:numCache>
                  <c:formatCode>General</c:formatCode>
                  <c:ptCount val="18"/>
                  <c:pt idx="0">
                    <c:v>0.10976149245641439</c:v>
                  </c:pt>
                  <c:pt idx="1">
                    <c:v>0.32961312033172702</c:v>
                  </c:pt>
                  <c:pt idx="2">
                    <c:v>3.489869947507222E-3</c:v>
                  </c:pt>
                  <c:pt idx="3">
                    <c:v>6.5464945263651292E-2</c:v>
                  </c:pt>
                  <c:pt idx="4">
                    <c:v>0.17435192869899763</c:v>
                  </c:pt>
                  <c:pt idx="5">
                    <c:v>0.81561956787654499</c:v>
                  </c:pt>
                  <c:pt idx="6">
                    <c:v>0.33610780029437426</c:v>
                  </c:pt>
                  <c:pt idx="7">
                    <c:v>9.3306197411657368E-2</c:v>
                  </c:pt>
                  <c:pt idx="8">
                    <c:v>0.12094675006398904</c:v>
                  </c:pt>
                  <c:pt idx="9">
                    <c:v>0.61057400177958865</c:v>
                  </c:pt>
                  <c:pt idx="10">
                    <c:v>0.74709818377430603</c:v>
                  </c:pt>
                  <c:pt idx="11">
                    <c:v>0.32880368777778479</c:v>
                  </c:pt>
                  <c:pt idx="12">
                    <c:v>0.34404635080529128</c:v>
                  </c:pt>
                  <c:pt idx="13">
                    <c:v>0.11109562231931278</c:v>
                  </c:pt>
                  <c:pt idx="14">
                    <c:v>0.18983086907316671</c:v>
                  </c:pt>
                  <c:pt idx="15">
                    <c:v>0.4062558780782084</c:v>
                  </c:pt>
                  <c:pt idx="16">
                    <c:v>2.2364680072699098E-2</c:v>
                  </c:pt>
                </c:numCache>
              </c:numRef>
            </c:minus>
          </c:errBars>
          <c:cat>
            <c:strRef>
              <c:f>Sheet12!$C$4:$S$4</c:f>
              <c:strCache>
                <c:ptCount val="17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4</c:v>
                </c:pt>
                <c:pt idx="13">
                  <c:v>GSTU17</c:v>
                </c:pt>
                <c:pt idx="14">
                  <c:v>GSTF2</c:v>
                </c:pt>
                <c:pt idx="15">
                  <c:v>GSTZ2   </c:v>
                </c:pt>
                <c:pt idx="16">
                  <c:v>GSTL1    </c:v>
                </c:pt>
              </c:strCache>
            </c:strRef>
          </c:cat>
          <c:val>
            <c:numRef>
              <c:f>Sheet12!$C$8:$S$8</c:f>
              <c:numCache>
                <c:formatCode>0.00</c:formatCode>
                <c:ptCount val="17"/>
                <c:pt idx="0">
                  <c:v>3.7329388965466732</c:v>
                </c:pt>
                <c:pt idx="1">
                  <c:v>6.0419266278429253</c:v>
                </c:pt>
                <c:pt idx="2">
                  <c:v>2.3560211012985999</c:v>
                </c:pt>
                <c:pt idx="3">
                  <c:v>0.44682564552074605</c:v>
                </c:pt>
                <c:pt idx="4">
                  <c:v>0.79690221952886064</c:v>
                </c:pt>
                <c:pt idx="5">
                  <c:v>3.9382313323129412</c:v>
                </c:pt>
                <c:pt idx="6">
                  <c:v>7.4568030489335424</c:v>
                </c:pt>
                <c:pt idx="7">
                  <c:v>1.1910359296053266</c:v>
                </c:pt>
                <c:pt idx="8">
                  <c:v>6.1133444673594761</c:v>
                </c:pt>
                <c:pt idx="9">
                  <c:v>5.9297601879244226</c:v>
                </c:pt>
                <c:pt idx="10">
                  <c:v>5.6619817822105851</c:v>
                </c:pt>
                <c:pt idx="11">
                  <c:v>2.2955541807805</c:v>
                </c:pt>
                <c:pt idx="12">
                  <c:v>3.1338972973460608</c:v>
                </c:pt>
                <c:pt idx="13">
                  <c:v>3.2387217153556436</c:v>
                </c:pt>
                <c:pt idx="14">
                  <c:v>1.3400385224909321</c:v>
                </c:pt>
                <c:pt idx="15">
                  <c:v>4.1510116019853776</c:v>
                </c:pt>
                <c:pt idx="16">
                  <c:v>1.5210609643495403</c:v>
                </c:pt>
              </c:numCache>
            </c:numRef>
          </c:val>
        </c:ser>
        <c:ser>
          <c:idx val="4"/>
          <c:order val="4"/>
          <c:tx>
            <c:v>72h</c:v>
          </c:tx>
          <c:errBars>
            <c:errBarType val="both"/>
            <c:errValType val="cust"/>
            <c:plus>
              <c:numRef>
                <c:f>Sheet12!$C$17:$S$17</c:f>
                <c:numCache>
                  <c:formatCode>General</c:formatCode>
                  <c:ptCount val="17"/>
                  <c:pt idx="0">
                    <c:v>3.4392506347625813E-2</c:v>
                  </c:pt>
                  <c:pt idx="1">
                    <c:v>0.1045422848241765</c:v>
                  </c:pt>
                  <c:pt idx="2">
                    <c:v>4.5824461853370135E-3</c:v>
                  </c:pt>
                  <c:pt idx="3">
                    <c:v>7.648379156659663E-3</c:v>
                  </c:pt>
                  <c:pt idx="4">
                    <c:v>1.8832236549948193E-2</c:v>
                  </c:pt>
                  <c:pt idx="5">
                    <c:v>8.9756392396269521E-2</c:v>
                  </c:pt>
                  <c:pt idx="6">
                    <c:v>7.6934205938154074E-2</c:v>
                  </c:pt>
                  <c:pt idx="7">
                    <c:v>2.9170923021564401E-2</c:v>
                  </c:pt>
                  <c:pt idx="8">
                    <c:v>0.12725396069634373</c:v>
                  </c:pt>
                  <c:pt idx="9">
                    <c:v>1.6658246143659728E-2</c:v>
                  </c:pt>
                  <c:pt idx="10">
                    <c:v>0.15493865131725898</c:v>
                  </c:pt>
                  <c:pt idx="11">
                    <c:v>2.9082716238440802E-3</c:v>
                  </c:pt>
                  <c:pt idx="12">
                    <c:v>0.100756894752488</c:v>
                  </c:pt>
                  <c:pt idx="13">
                    <c:v>0.72436357095907067</c:v>
                  </c:pt>
                  <c:pt idx="14">
                    <c:v>4.2048691786822398E-2</c:v>
                  </c:pt>
                  <c:pt idx="15">
                    <c:v>4.6916412635201565E-4</c:v>
                  </c:pt>
                  <c:pt idx="16">
                    <c:v>1.6711069443221168E-16</c:v>
                  </c:pt>
                </c:numCache>
              </c:numRef>
            </c:plus>
            <c:minus>
              <c:numRef>
                <c:f>Sheet12!$C$17:$S$17</c:f>
                <c:numCache>
                  <c:formatCode>General</c:formatCode>
                  <c:ptCount val="17"/>
                  <c:pt idx="0">
                    <c:v>3.4392506347625813E-2</c:v>
                  </c:pt>
                  <c:pt idx="1">
                    <c:v>0.1045422848241765</c:v>
                  </c:pt>
                  <c:pt idx="2">
                    <c:v>4.5824461853370135E-3</c:v>
                  </c:pt>
                  <c:pt idx="3">
                    <c:v>7.648379156659663E-3</c:v>
                  </c:pt>
                  <c:pt idx="4">
                    <c:v>1.8832236549948193E-2</c:v>
                  </c:pt>
                  <c:pt idx="5">
                    <c:v>8.9756392396269521E-2</c:v>
                  </c:pt>
                  <c:pt idx="6">
                    <c:v>7.6934205938154074E-2</c:v>
                  </c:pt>
                  <c:pt idx="7">
                    <c:v>2.9170923021564401E-2</c:v>
                  </c:pt>
                  <c:pt idx="8">
                    <c:v>0.12725396069634373</c:v>
                  </c:pt>
                  <c:pt idx="9">
                    <c:v>1.6658246143659728E-2</c:v>
                  </c:pt>
                  <c:pt idx="10">
                    <c:v>0.15493865131725898</c:v>
                  </c:pt>
                  <c:pt idx="11">
                    <c:v>2.9082716238440802E-3</c:v>
                  </c:pt>
                  <c:pt idx="12">
                    <c:v>0.100756894752488</c:v>
                  </c:pt>
                  <c:pt idx="13">
                    <c:v>0.72436357095907067</c:v>
                  </c:pt>
                  <c:pt idx="14">
                    <c:v>4.2048691786822398E-2</c:v>
                  </c:pt>
                  <c:pt idx="15">
                    <c:v>4.6916412635201565E-4</c:v>
                  </c:pt>
                  <c:pt idx="16">
                    <c:v>1.6711069443221168E-16</c:v>
                  </c:pt>
                </c:numCache>
              </c:numRef>
            </c:minus>
          </c:errBars>
          <c:cat>
            <c:strRef>
              <c:f>Sheet12!$C$4:$S$4</c:f>
              <c:strCache>
                <c:ptCount val="17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4</c:v>
                </c:pt>
                <c:pt idx="13">
                  <c:v>GSTU17</c:v>
                </c:pt>
                <c:pt idx="14">
                  <c:v>GSTF2</c:v>
                </c:pt>
                <c:pt idx="15">
                  <c:v>GSTZ2   </c:v>
                </c:pt>
                <c:pt idx="16">
                  <c:v>GSTL1    </c:v>
                </c:pt>
              </c:strCache>
            </c:strRef>
          </c:cat>
          <c:val>
            <c:numRef>
              <c:f>Sheet12!$C$9:$S$9</c:f>
              <c:numCache>
                <c:formatCode>0.00</c:formatCode>
                <c:ptCount val="17"/>
                <c:pt idx="0">
                  <c:v>0.39034059844681412</c:v>
                </c:pt>
                <c:pt idx="1">
                  <c:v>1.9399885415935265</c:v>
                </c:pt>
                <c:pt idx="2">
                  <c:v>1.0293367762542098</c:v>
                </c:pt>
                <c:pt idx="3">
                  <c:v>5.7964246720116942E-2</c:v>
                </c:pt>
                <c:pt idx="4">
                  <c:v>0.12442173731519859</c:v>
                </c:pt>
                <c:pt idx="5">
                  <c:v>1.6656071088974824</c:v>
                </c:pt>
                <c:pt idx="6">
                  <c:v>0.60535325666237816</c:v>
                </c:pt>
                <c:pt idx="7">
                  <c:v>0.35050393517524397</c:v>
                </c:pt>
                <c:pt idx="8">
                  <c:v>2.7055543452136801</c:v>
                </c:pt>
                <c:pt idx="9">
                  <c:v>3.3987604082609604</c:v>
                </c:pt>
                <c:pt idx="10">
                  <c:v>1.2191276430821696</c:v>
                </c:pt>
                <c:pt idx="11">
                  <c:v>0.11868558252885331</c:v>
                </c:pt>
                <c:pt idx="12">
                  <c:v>1.1544282570802398</c:v>
                </c:pt>
                <c:pt idx="13">
                  <c:v>3.5436355260904442</c:v>
                </c:pt>
                <c:pt idx="14">
                  <c:v>9.3546172959185145E-2</c:v>
                </c:pt>
                <c:pt idx="15">
                  <c:v>9.5722949695268261E-2</c:v>
                </c:pt>
                <c:pt idx="16">
                  <c:v>8.7777804733624704E-2</c:v>
                </c:pt>
              </c:numCache>
            </c:numRef>
          </c:val>
        </c:ser>
        <c:axId val="57189120"/>
        <c:axId val="57190656"/>
      </c:barChart>
      <c:catAx>
        <c:axId val="57189120"/>
        <c:scaling>
          <c:orientation val="minMax"/>
        </c:scaling>
        <c:axPos val="b"/>
        <c:tickLblPos val="nextTo"/>
        <c:crossAx val="57190656"/>
        <c:crosses val="autoZero"/>
        <c:auto val="1"/>
        <c:lblAlgn val="ctr"/>
        <c:lblOffset val="100"/>
      </c:catAx>
      <c:valAx>
        <c:axId val="57190656"/>
        <c:scaling>
          <c:orientation val="minMax"/>
        </c:scaling>
        <c:axPos val="l"/>
        <c:numFmt formatCode="0" sourceLinked="0"/>
        <c:tickLblPos val="nextTo"/>
        <c:crossAx val="57189120"/>
        <c:crosses val="autoZero"/>
        <c:crossBetween val="between"/>
      </c:valAx>
    </c:plotArea>
    <c:plotVisOnly val="1"/>
  </c:chart>
  <c:externalData r:id="rId1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0h</c:v>
          </c:tx>
          <c:errBars>
            <c:errBarType val="both"/>
            <c:errValType val="cust"/>
            <c:plus>
              <c:numRef>
                <c:f>Sheet12!$W$48:$AK$48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</c:numCache>
              </c:numRef>
            </c:plus>
            <c:minus>
              <c:numRef>
                <c:f>Sheet12!$W$48:$AK$48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</c:numCache>
              </c:numRef>
            </c:minus>
          </c:errBars>
          <c:cat>
            <c:strRef>
              <c:f>Sheet12!$W$39:$AK$39</c:f>
              <c:strCache>
                <c:ptCount val="15"/>
                <c:pt idx="0">
                  <c:v>GSTU13</c:v>
                </c:pt>
                <c:pt idx="1">
                  <c:v>GSTU15</c:v>
                </c:pt>
                <c:pt idx="2">
                  <c:v>GSTU16</c:v>
                </c:pt>
                <c:pt idx="3">
                  <c:v>GSTU18</c:v>
                </c:pt>
                <c:pt idx="4">
                  <c:v>GSTF1</c:v>
                </c:pt>
                <c:pt idx="5">
                  <c:v>GSTF3</c:v>
                </c:pt>
                <c:pt idx="6">
                  <c:v>GSTZ1    </c:v>
                </c:pt>
                <c:pt idx="7">
                  <c:v>GSTZ3   </c:v>
                </c:pt>
                <c:pt idx="8">
                  <c:v>EF1G1    </c:v>
                </c:pt>
                <c:pt idx="9">
                  <c:v>EF1G2    </c:v>
                </c:pt>
                <c:pt idx="10">
                  <c:v>EF1G3    </c:v>
                </c:pt>
                <c:pt idx="11">
                  <c:v>GHR1     </c:v>
                </c:pt>
                <c:pt idx="12">
                  <c:v>GHR2    </c:v>
                </c:pt>
                <c:pt idx="13">
                  <c:v>GSTT1    </c:v>
                </c:pt>
                <c:pt idx="14">
                  <c:v>GSTT2    </c:v>
                </c:pt>
              </c:strCache>
            </c:strRef>
          </c:cat>
          <c:val>
            <c:numRef>
              <c:f>Sheet12!$W$40:$AK$40</c:f>
              <c:numCache>
                <c:formatCode>0.00</c:formatCode>
                <c:ptCount val="1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</c:numCache>
            </c:numRef>
          </c:val>
        </c:ser>
        <c:ser>
          <c:idx val="1"/>
          <c:order val="1"/>
          <c:tx>
            <c:v>6h</c:v>
          </c:tx>
          <c:errBars>
            <c:errBarType val="both"/>
            <c:errValType val="cust"/>
            <c:plus>
              <c:numRef>
                <c:f>Sheet12!$W$49:$AK$49</c:f>
                <c:numCache>
                  <c:formatCode>General</c:formatCode>
                  <c:ptCount val="15"/>
                  <c:pt idx="0">
                    <c:v>0.27344984650467286</c:v>
                  </c:pt>
                  <c:pt idx="1">
                    <c:v>2.5513223321944792E-2</c:v>
                  </c:pt>
                  <c:pt idx="2">
                    <c:v>3.4615506583929492E-2</c:v>
                  </c:pt>
                  <c:pt idx="3">
                    <c:v>4.1937298342213533E-2</c:v>
                  </c:pt>
                  <c:pt idx="4">
                    <c:v>1.6430684204716207E-2</c:v>
                  </c:pt>
                  <c:pt idx="5">
                    <c:v>0.1975560116821167</c:v>
                  </c:pt>
                  <c:pt idx="6">
                    <c:v>4.1935283521439314E-3</c:v>
                  </c:pt>
                  <c:pt idx="7">
                    <c:v>5.4257571767078364E-2</c:v>
                  </c:pt>
                  <c:pt idx="8">
                    <c:v>3.2074315156953033E-2</c:v>
                  </c:pt>
                  <c:pt idx="9">
                    <c:v>5.5635845386199673E-2</c:v>
                  </c:pt>
                  <c:pt idx="10">
                    <c:v>0.16901189122429194</c:v>
                  </c:pt>
                  <c:pt idx="11">
                    <c:v>8.3615707882245691E-2</c:v>
                  </c:pt>
                  <c:pt idx="12">
                    <c:v>2.2520238724447191E-2</c:v>
                  </c:pt>
                  <c:pt idx="13">
                    <c:v>0.338408309365688</c:v>
                  </c:pt>
                  <c:pt idx="14">
                    <c:v>3.218302860817561E-2</c:v>
                  </c:pt>
                </c:numCache>
              </c:numRef>
            </c:plus>
            <c:minus>
              <c:numRef>
                <c:f>Sheet12!$W$49:$AK$49</c:f>
                <c:numCache>
                  <c:formatCode>General</c:formatCode>
                  <c:ptCount val="15"/>
                  <c:pt idx="0">
                    <c:v>0.27344984650467286</c:v>
                  </c:pt>
                  <c:pt idx="1">
                    <c:v>2.5513223321944792E-2</c:v>
                  </c:pt>
                  <c:pt idx="2">
                    <c:v>3.4615506583929492E-2</c:v>
                  </c:pt>
                  <c:pt idx="3">
                    <c:v>4.1937298342213533E-2</c:v>
                  </c:pt>
                  <c:pt idx="4">
                    <c:v>1.6430684204716207E-2</c:v>
                  </c:pt>
                  <c:pt idx="5">
                    <c:v>0.1975560116821167</c:v>
                  </c:pt>
                  <c:pt idx="6">
                    <c:v>4.1935283521439314E-3</c:v>
                  </c:pt>
                  <c:pt idx="7">
                    <c:v>5.4257571767078364E-2</c:v>
                  </c:pt>
                  <c:pt idx="8">
                    <c:v>3.2074315156953033E-2</c:v>
                  </c:pt>
                  <c:pt idx="9">
                    <c:v>5.5635845386199673E-2</c:v>
                  </c:pt>
                  <c:pt idx="10">
                    <c:v>0.16901189122429194</c:v>
                  </c:pt>
                  <c:pt idx="11">
                    <c:v>8.3615707882245691E-2</c:v>
                  </c:pt>
                  <c:pt idx="12">
                    <c:v>2.2520238724447191E-2</c:v>
                  </c:pt>
                  <c:pt idx="13">
                    <c:v>0.338408309365688</c:v>
                  </c:pt>
                  <c:pt idx="14">
                    <c:v>3.218302860817561E-2</c:v>
                  </c:pt>
                </c:numCache>
              </c:numRef>
            </c:minus>
          </c:errBars>
          <c:cat>
            <c:strRef>
              <c:f>Sheet12!$W$39:$AK$39</c:f>
              <c:strCache>
                <c:ptCount val="15"/>
                <c:pt idx="0">
                  <c:v>GSTU13</c:v>
                </c:pt>
                <c:pt idx="1">
                  <c:v>GSTU15</c:v>
                </c:pt>
                <c:pt idx="2">
                  <c:v>GSTU16</c:v>
                </c:pt>
                <c:pt idx="3">
                  <c:v>GSTU18</c:v>
                </c:pt>
                <c:pt idx="4">
                  <c:v>GSTF1</c:v>
                </c:pt>
                <c:pt idx="5">
                  <c:v>GSTF3</c:v>
                </c:pt>
                <c:pt idx="6">
                  <c:v>GSTZ1    </c:v>
                </c:pt>
                <c:pt idx="7">
                  <c:v>GSTZ3   </c:v>
                </c:pt>
                <c:pt idx="8">
                  <c:v>EF1G1    </c:v>
                </c:pt>
                <c:pt idx="9">
                  <c:v>EF1G2    </c:v>
                </c:pt>
                <c:pt idx="10">
                  <c:v>EF1G3    </c:v>
                </c:pt>
                <c:pt idx="11">
                  <c:v>GHR1     </c:v>
                </c:pt>
                <c:pt idx="12">
                  <c:v>GHR2    </c:v>
                </c:pt>
                <c:pt idx="13">
                  <c:v>GSTT1    </c:v>
                </c:pt>
                <c:pt idx="14">
                  <c:v>GSTT2    </c:v>
                </c:pt>
              </c:strCache>
            </c:strRef>
          </c:cat>
          <c:val>
            <c:numRef>
              <c:f>Sheet12!$W$41:$AK$41</c:f>
              <c:numCache>
                <c:formatCode>0.00</c:formatCode>
                <c:ptCount val="15"/>
                <c:pt idx="0">
                  <c:v>1.8066417592221238</c:v>
                </c:pt>
                <c:pt idx="1">
                  <c:v>2.6027462344958527</c:v>
                </c:pt>
                <c:pt idx="2">
                  <c:v>0.88304229587745497</c:v>
                </c:pt>
                <c:pt idx="3">
                  <c:v>1.711446978549839</c:v>
                </c:pt>
                <c:pt idx="4">
                  <c:v>0.37260054710131385</c:v>
                </c:pt>
                <c:pt idx="5">
                  <c:v>1.2647516802134018</c:v>
                </c:pt>
                <c:pt idx="6">
                  <c:v>0.85560016410285544</c:v>
                </c:pt>
                <c:pt idx="7">
                  <c:v>0.52807604572068056</c:v>
                </c:pt>
                <c:pt idx="8">
                  <c:v>0.81821644950431716</c:v>
                </c:pt>
                <c:pt idx="9">
                  <c:v>1.0324329789866686</c:v>
                </c:pt>
                <c:pt idx="10">
                  <c:v>0.99006001768198471</c:v>
                </c:pt>
                <c:pt idx="11">
                  <c:v>1.13835347056168</c:v>
                </c:pt>
                <c:pt idx="12">
                  <c:v>1.5316407800263918</c:v>
                </c:pt>
                <c:pt idx="13">
                  <c:v>0.97979677405032861</c:v>
                </c:pt>
                <c:pt idx="14">
                  <c:v>1.0945303003042559</c:v>
                </c:pt>
              </c:numCache>
            </c:numRef>
          </c:val>
        </c:ser>
        <c:ser>
          <c:idx val="2"/>
          <c:order val="2"/>
          <c:tx>
            <c:v>24h</c:v>
          </c:tx>
          <c:errBars>
            <c:errBarType val="both"/>
            <c:errValType val="cust"/>
            <c:plus>
              <c:numRef>
                <c:f>Sheet12!$W$50:$AK$50</c:f>
                <c:numCache>
                  <c:formatCode>General</c:formatCode>
                  <c:ptCount val="15"/>
                  <c:pt idx="0">
                    <c:v>1.6543179232417864E-2</c:v>
                  </c:pt>
                  <c:pt idx="1">
                    <c:v>0.24645049090357071</c:v>
                  </c:pt>
                  <c:pt idx="2">
                    <c:v>0.54003575051391361</c:v>
                  </c:pt>
                  <c:pt idx="3">
                    <c:v>7.2789485342393434E-2</c:v>
                  </c:pt>
                  <c:pt idx="4">
                    <c:v>5.5647594551590893E-2</c:v>
                  </c:pt>
                  <c:pt idx="5">
                    <c:v>0.26739519978838883</c:v>
                  </c:pt>
                  <c:pt idx="6">
                    <c:v>0.16890654075758643</c:v>
                  </c:pt>
                  <c:pt idx="7">
                    <c:v>0.19632930115943908</c:v>
                  </c:pt>
                  <c:pt idx="8">
                    <c:v>7.7605728217077841E-2</c:v>
                  </c:pt>
                  <c:pt idx="9">
                    <c:v>5.4338430975501652E-2</c:v>
                  </c:pt>
                  <c:pt idx="10">
                    <c:v>4.4497678286041967E-2</c:v>
                  </c:pt>
                  <c:pt idx="11">
                    <c:v>8.6137574977200468E-2</c:v>
                  </c:pt>
                  <c:pt idx="12">
                    <c:v>5.8286033069886514E-3</c:v>
                  </c:pt>
                  <c:pt idx="13">
                    <c:v>0.745451571273955</c:v>
                  </c:pt>
                  <c:pt idx="14">
                    <c:v>6.0688302235448174E-2</c:v>
                  </c:pt>
                </c:numCache>
              </c:numRef>
            </c:plus>
            <c:minus>
              <c:numRef>
                <c:f>Sheet12!$W$50:$AK$50</c:f>
                <c:numCache>
                  <c:formatCode>General</c:formatCode>
                  <c:ptCount val="15"/>
                  <c:pt idx="0">
                    <c:v>1.6543179232417864E-2</c:v>
                  </c:pt>
                  <c:pt idx="1">
                    <c:v>0.24645049090357071</c:v>
                  </c:pt>
                  <c:pt idx="2">
                    <c:v>0.54003575051391361</c:v>
                  </c:pt>
                  <c:pt idx="3">
                    <c:v>7.2789485342393434E-2</c:v>
                  </c:pt>
                  <c:pt idx="4">
                    <c:v>5.5647594551590893E-2</c:v>
                  </c:pt>
                  <c:pt idx="5">
                    <c:v>0.26739519978838883</c:v>
                  </c:pt>
                  <c:pt idx="6">
                    <c:v>0.16890654075758643</c:v>
                  </c:pt>
                  <c:pt idx="7">
                    <c:v>0.19632930115943908</c:v>
                  </c:pt>
                  <c:pt idx="8">
                    <c:v>7.7605728217077841E-2</c:v>
                  </c:pt>
                  <c:pt idx="9">
                    <c:v>5.4338430975501652E-2</c:v>
                  </c:pt>
                  <c:pt idx="10">
                    <c:v>4.4497678286041967E-2</c:v>
                  </c:pt>
                  <c:pt idx="11">
                    <c:v>8.6137574977200468E-2</c:v>
                  </c:pt>
                  <c:pt idx="12">
                    <c:v>5.8286033069886514E-3</c:v>
                  </c:pt>
                  <c:pt idx="13">
                    <c:v>0.745451571273955</c:v>
                  </c:pt>
                  <c:pt idx="14">
                    <c:v>6.0688302235448174E-2</c:v>
                  </c:pt>
                </c:numCache>
              </c:numRef>
            </c:minus>
          </c:errBars>
          <c:cat>
            <c:strRef>
              <c:f>Sheet12!$W$39:$AK$39</c:f>
              <c:strCache>
                <c:ptCount val="15"/>
                <c:pt idx="0">
                  <c:v>GSTU13</c:v>
                </c:pt>
                <c:pt idx="1">
                  <c:v>GSTU15</c:v>
                </c:pt>
                <c:pt idx="2">
                  <c:v>GSTU16</c:v>
                </c:pt>
                <c:pt idx="3">
                  <c:v>GSTU18</c:v>
                </c:pt>
                <c:pt idx="4">
                  <c:v>GSTF1</c:v>
                </c:pt>
                <c:pt idx="5">
                  <c:v>GSTF3</c:v>
                </c:pt>
                <c:pt idx="6">
                  <c:v>GSTZ1    </c:v>
                </c:pt>
                <c:pt idx="7">
                  <c:v>GSTZ3   </c:v>
                </c:pt>
                <c:pt idx="8">
                  <c:v>EF1G1    </c:v>
                </c:pt>
                <c:pt idx="9">
                  <c:v>EF1G2    </c:v>
                </c:pt>
                <c:pt idx="10">
                  <c:v>EF1G3    </c:v>
                </c:pt>
                <c:pt idx="11">
                  <c:v>GHR1     </c:v>
                </c:pt>
                <c:pt idx="12">
                  <c:v>GHR2    </c:v>
                </c:pt>
                <c:pt idx="13">
                  <c:v>GSTT1    </c:v>
                </c:pt>
                <c:pt idx="14">
                  <c:v>GSTT2    </c:v>
                </c:pt>
              </c:strCache>
            </c:strRef>
          </c:cat>
          <c:val>
            <c:numRef>
              <c:f>Sheet12!$W$42:$AK$42</c:f>
              <c:numCache>
                <c:formatCode>0.00</c:formatCode>
                <c:ptCount val="15"/>
                <c:pt idx="0">
                  <c:v>3.3752834552324837</c:v>
                </c:pt>
                <c:pt idx="1">
                  <c:v>1.8677574380697226</c:v>
                </c:pt>
                <c:pt idx="2">
                  <c:v>1.3958224210615862</c:v>
                </c:pt>
                <c:pt idx="3">
                  <c:v>2.1219997863674469</c:v>
                </c:pt>
                <c:pt idx="4">
                  <c:v>0.20892433239510969</c:v>
                </c:pt>
                <c:pt idx="5">
                  <c:v>1.1960325090838271</c:v>
                </c:pt>
                <c:pt idx="6">
                  <c:v>0.43151759758185554</c:v>
                </c:pt>
                <c:pt idx="7">
                  <c:v>2.11129118918217</c:v>
                </c:pt>
                <c:pt idx="8">
                  <c:v>3.3136917676415658</c:v>
                </c:pt>
                <c:pt idx="9">
                  <c:v>0.69361977495099769</c:v>
                </c:pt>
                <c:pt idx="10">
                  <c:v>1.2972212040333928</c:v>
                </c:pt>
                <c:pt idx="11">
                  <c:v>0.60805531401171264</c:v>
                </c:pt>
                <c:pt idx="12">
                  <c:v>0.39641349387159397</c:v>
                </c:pt>
                <c:pt idx="13">
                  <c:v>1.9507859438535853</c:v>
                </c:pt>
                <c:pt idx="14">
                  <c:v>1.5481598574604498</c:v>
                </c:pt>
              </c:numCache>
            </c:numRef>
          </c:val>
        </c:ser>
        <c:ser>
          <c:idx val="3"/>
          <c:order val="3"/>
          <c:tx>
            <c:v>48h</c:v>
          </c:tx>
          <c:errBars>
            <c:errBarType val="both"/>
            <c:errValType val="cust"/>
            <c:plus>
              <c:numRef>
                <c:f>Sheet12!$W$51:$AK$51</c:f>
                <c:numCache>
                  <c:formatCode>General</c:formatCode>
                  <c:ptCount val="15"/>
                  <c:pt idx="0">
                    <c:v>6.7360107281996456E-2</c:v>
                  </c:pt>
                  <c:pt idx="1">
                    <c:v>0.10506614381886079</c:v>
                  </c:pt>
                  <c:pt idx="2">
                    <c:v>1.129932440309288E-2</c:v>
                  </c:pt>
                  <c:pt idx="3">
                    <c:v>2.8505140663254207E-2</c:v>
                  </c:pt>
                  <c:pt idx="4">
                    <c:v>2.2448390211859612E-2</c:v>
                  </c:pt>
                  <c:pt idx="5">
                    <c:v>6.7838029099048514E-2</c:v>
                  </c:pt>
                  <c:pt idx="6">
                    <c:v>4.5257742082140187E-3</c:v>
                  </c:pt>
                  <c:pt idx="7">
                    <c:v>9.9445149414204206E-3</c:v>
                  </c:pt>
                  <c:pt idx="8">
                    <c:v>5.5869574069770292E-2</c:v>
                  </c:pt>
                  <c:pt idx="9">
                    <c:v>8.0367488166347548E-2</c:v>
                  </c:pt>
                  <c:pt idx="10">
                    <c:v>3.2587457185171025E-2</c:v>
                  </c:pt>
                  <c:pt idx="11">
                    <c:v>4.4426437607071566E-2</c:v>
                  </c:pt>
                  <c:pt idx="12">
                    <c:v>3.2634378357202412E-2</c:v>
                  </c:pt>
                  <c:pt idx="13">
                    <c:v>5.1817899009952602E-2</c:v>
                  </c:pt>
                  <c:pt idx="14">
                    <c:v>7.2194775418440993E-2</c:v>
                  </c:pt>
                </c:numCache>
              </c:numRef>
            </c:plus>
            <c:minus>
              <c:numRef>
                <c:f>Sheet12!$W$51:$AK$51</c:f>
                <c:numCache>
                  <c:formatCode>General</c:formatCode>
                  <c:ptCount val="15"/>
                  <c:pt idx="0">
                    <c:v>6.7360107281996456E-2</c:v>
                  </c:pt>
                  <c:pt idx="1">
                    <c:v>0.10506614381886079</c:v>
                  </c:pt>
                  <c:pt idx="2">
                    <c:v>1.129932440309288E-2</c:v>
                  </c:pt>
                  <c:pt idx="3">
                    <c:v>2.8505140663254207E-2</c:v>
                  </c:pt>
                  <c:pt idx="4">
                    <c:v>2.2448390211859612E-2</c:v>
                  </c:pt>
                  <c:pt idx="5">
                    <c:v>6.7838029099048514E-2</c:v>
                  </c:pt>
                  <c:pt idx="6">
                    <c:v>4.5257742082140187E-3</c:v>
                  </c:pt>
                  <c:pt idx="7">
                    <c:v>9.9445149414204206E-3</c:v>
                  </c:pt>
                  <c:pt idx="8">
                    <c:v>5.5869574069770292E-2</c:v>
                  </c:pt>
                  <c:pt idx="9">
                    <c:v>8.0367488166347548E-2</c:v>
                  </c:pt>
                  <c:pt idx="10">
                    <c:v>3.2587457185171025E-2</c:v>
                  </c:pt>
                  <c:pt idx="11">
                    <c:v>4.4426437607071566E-2</c:v>
                  </c:pt>
                  <c:pt idx="12">
                    <c:v>3.2634378357202412E-2</c:v>
                  </c:pt>
                  <c:pt idx="13">
                    <c:v>5.1817899009952602E-2</c:v>
                  </c:pt>
                  <c:pt idx="14">
                    <c:v>7.2194775418440993E-2</c:v>
                  </c:pt>
                </c:numCache>
              </c:numRef>
            </c:minus>
          </c:errBars>
          <c:cat>
            <c:strRef>
              <c:f>Sheet12!$W$39:$AK$39</c:f>
              <c:strCache>
                <c:ptCount val="15"/>
                <c:pt idx="0">
                  <c:v>GSTU13</c:v>
                </c:pt>
                <c:pt idx="1">
                  <c:v>GSTU15</c:v>
                </c:pt>
                <c:pt idx="2">
                  <c:v>GSTU16</c:v>
                </c:pt>
                <c:pt idx="3">
                  <c:v>GSTU18</c:v>
                </c:pt>
                <c:pt idx="4">
                  <c:v>GSTF1</c:v>
                </c:pt>
                <c:pt idx="5">
                  <c:v>GSTF3</c:v>
                </c:pt>
                <c:pt idx="6">
                  <c:v>GSTZ1    </c:v>
                </c:pt>
                <c:pt idx="7">
                  <c:v>GSTZ3   </c:v>
                </c:pt>
                <c:pt idx="8">
                  <c:v>EF1G1    </c:v>
                </c:pt>
                <c:pt idx="9">
                  <c:v>EF1G2    </c:v>
                </c:pt>
                <c:pt idx="10">
                  <c:v>EF1G3    </c:v>
                </c:pt>
                <c:pt idx="11">
                  <c:v>GHR1     </c:v>
                </c:pt>
                <c:pt idx="12">
                  <c:v>GHR2    </c:v>
                </c:pt>
                <c:pt idx="13">
                  <c:v>GSTT1    </c:v>
                </c:pt>
                <c:pt idx="14">
                  <c:v>GSTT2    </c:v>
                </c:pt>
              </c:strCache>
            </c:strRef>
          </c:cat>
          <c:val>
            <c:numRef>
              <c:f>Sheet12!$W$43:$AK$43</c:f>
              <c:numCache>
                <c:formatCode>0.00</c:formatCode>
                <c:ptCount val="15"/>
                <c:pt idx="0">
                  <c:v>0.55110856366891181</c:v>
                </c:pt>
                <c:pt idx="1">
                  <c:v>0.79625758052868667</c:v>
                </c:pt>
                <c:pt idx="2">
                  <c:v>2.3053865389023285</c:v>
                </c:pt>
                <c:pt idx="3">
                  <c:v>1.9386844169121935</c:v>
                </c:pt>
                <c:pt idx="4">
                  <c:v>0.38189483293193338</c:v>
                </c:pt>
                <c:pt idx="5">
                  <c:v>0.76993332815951565</c:v>
                </c:pt>
                <c:pt idx="6">
                  <c:v>0.92338785625762387</c:v>
                </c:pt>
                <c:pt idx="7">
                  <c:v>0.12693984886634799</c:v>
                </c:pt>
                <c:pt idx="8">
                  <c:v>2.5191378143493699</c:v>
                </c:pt>
                <c:pt idx="9">
                  <c:v>1.3672217997277198</c:v>
                </c:pt>
                <c:pt idx="10">
                  <c:v>0.33296973694200815</c:v>
                </c:pt>
                <c:pt idx="11">
                  <c:v>1.133319351172533</c:v>
                </c:pt>
                <c:pt idx="12">
                  <c:v>0.74005361424409899</c:v>
                </c:pt>
                <c:pt idx="13">
                  <c:v>1.0576529134839681</c:v>
                </c:pt>
                <c:pt idx="14">
                  <c:v>0.59066353351683254</c:v>
                </c:pt>
              </c:numCache>
            </c:numRef>
          </c:val>
        </c:ser>
        <c:ser>
          <c:idx val="4"/>
          <c:order val="4"/>
          <c:tx>
            <c:v>72h</c:v>
          </c:tx>
          <c:errBars>
            <c:errBarType val="both"/>
            <c:errValType val="cust"/>
            <c:plus>
              <c:numRef>
                <c:f>Sheet12!$W$52:$AK$52</c:f>
                <c:numCache>
                  <c:formatCode>General</c:formatCode>
                  <c:ptCount val="15"/>
                  <c:pt idx="0">
                    <c:v>5.1096552295473996E-2</c:v>
                  </c:pt>
                  <c:pt idx="1">
                    <c:v>4.4686048726117186E-2</c:v>
                  </c:pt>
                  <c:pt idx="2">
                    <c:v>3.6332983459018656E-2</c:v>
                  </c:pt>
                  <c:pt idx="3">
                    <c:v>2.9510843949830341E-2</c:v>
                  </c:pt>
                  <c:pt idx="4">
                    <c:v>3.9811170092158496E-3</c:v>
                  </c:pt>
                  <c:pt idx="5">
                    <c:v>0.25041556017493882</c:v>
                  </c:pt>
                  <c:pt idx="6">
                    <c:v>5.9644642602986221E-2</c:v>
                  </c:pt>
                  <c:pt idx="7">
                    <c:v>0.1091193125508078</c:v>
                  </c:pt>
                  <c:pt idx="8">
                    <c:v>7.0192800843851183E-2</c:v>
                  </c:pt>
                  <c:pt idx="9">
                    <c:v>8.0914180264288663E-2</c:v>
                  </c:pt>
                  <c:pt idx="10">
                    <c:v>2.158193893033147E-2</c:v>
                  </c:pt>
                  <c:pt idx="11">
                    <c:v>2.6968585168094184E-2</c:v>
                  </c:pt>
                  <c:pt idx="12">
                    <c:v>2.2601093224235289E-2</c:v>
                  </c:pt>
                  <c:pt idx="13">
                    <c:v>3.0000000000000002E-2</c:v>
                  </c:pt>
                  <c:pt idx="14">
                    <c:v>5.9982058589578925E-2</c:v>
                  </c:pt>
                </c:numCache>
              </c:numRef>
            </c:plus>
            <c:minus>
              <c:numRef>
                <c:f>Sheet12!$W$52:$AK$52</c:f>
                <c:numCache>
                  <c:formatCode>General</c:formatCode>
                  <c:ptCount val="15"/>
                  <c:pt idx="0">
                    <c:v>5.1096552295473996E-2</c:v>
                  </c:pt>
                  <c:pt idx="1">
                    <c:v>4.4686048726117186E-2</c:v>
                  </c:pt>
                  <c:pt idx="2">
                    <c:v>3.6332983459018656E-2</c:v>
                  </c:pt>
                  <c:pt idx="3">
                    <c:v>2.9510843949830341E-2</c:v>
                  </c:pt>
                  <c:pt idx="4">
                    <c:v>3.9811170092158496E-3</c:v>
                  </c:pt>
                  <c:pt idx="5">
                    <c:v>0.25041556017493882</c:v>
                  </c:pt>
                  <c:pt idx="6">
                    <c:v>5.9644642602986221E-2</c:v>
                  </c:pt>
                  <c:pt idx="7">
                    <c:v>0.1091193125508078</c:v>
                  </c:pt>
                  <c:pt idx="8">
                    <c:v>7.0192800843851183E-2</c:v>
                  </c:pt>
                  <c:pt idx="9">
                    <c:v>8.0914180264288663E-2</c:v>
                  </c:pt>
                  <c:pt idx="10">
                    <c:v>2.158193893033147E-2</c:v>
                  </c:pt>
                  <c:pt idx="11">
                    <c:v>2.6968585168094184E-2</c:v>
                  </c:pt>
                  <c:pt idx="12">
                    <c:v>2.2601093224235289E-2</c:v>
                  </c:pt>
                  <c:pt idx="13">
                    <c:v>3.0000000000000002E-2</c:v>
                  </c:pt>
                  <c:pt idx="14">
                    <c:v>5.9982058589578925E-2</c:v>
                  </c:pt>
                </c:numCache>
              </c:numRef>
            </c:minus>
          </c:errBars>
          <c:cat>
            <c:strRef>
              <c:f>Sheet12!$W$39:$AK$39</c:f>
              <c:strCache>
                <c:ptCount val="15"/>
                <c:pt idx="0">
                  <c:v>GSTU13</c:v>
                </c:pt>
                <c:pt idx="1">
                  <c:v>GSTU15</c:v>
                </c:pt>
                <c:pt idx="2">
                  <c:v>GSTU16</c:v>
                </c:pt>
                <c:pt idx="3">
                  <c:v>GSTU18</c:v>
                </c:pt>
                <c:pt idx="4">
                  <c:v>GSTF1</c:v>
                </c:pt>
                <c:pt idx="5">
                  <c:v>GSTF3</c:v>
                </c:pt>
                <c:pt idx="6">
                  <c:v>GSTZ1    </c:v>
                </c:pt>
                <c:pt idx="7">
                  <c:v>GSTZ3   </c:v>
                </c:pt>
                <c:pt idx="8">
                  <c:v>EF1G1    </c:v>
                </c:pt>
                <c:pt idx="9">
                  <c:v>EF1G2    </c:v>
                </c:pt>
                <c:pt idx="10">
                  <c:v>EF1G3    </c:v>
                </c:pt>
                <c:pt idx="11">
                  <c:v>GHR1     </c:v>
                </c:pt>
                <c:pt idx="12">
                  <c:v>GHR2    </c:v>
                </c:pt>
                <c:pt idx="13">
                  <c:v>GSTT1    </c:v>
                </c:pt>
                <c:pt idx="14">
                  <c:v>GSTT2    </c:v>
                </c:pt>
              </c:strCache>
            </c:strRef>
          </c:cat>
          <c:val>
            <c:numRef>
              <c:f>Sheet12!$W$44:$AK$44</c:f>
              <c:numCache>
                <c:formatCode>0.00</c:formatCode>
                <c:ptCount val="15"/>
                <c:pt idx="0">
                  <c:v>0.38724193755788217</c:v>
                </c:pt>
                <c:pt idx="1">
                  <c:v>0.43491868768973491</c:v>
                </c:pt>
                <c:pt idx="2">
                  <c:v>1.8533541994434131</c:v>
                </c:pt>
                <c:pt idx="3">
                  <c:v>3.0105658151453358</c:v>
                </c:pt>
                <c:pt idx="4">
                  <c:v>0.40613595444497719</c:v>
                </c:pt>
                <c:pt idx="5">
                  <c:v>1.1701630361513651</c:v>
                </c:pt>
                <c:pt idx="6">
                  <c:v>1.3525685351043848</c:v>
                </c:pt>
                <c:pt idx="7">
                  <c:v>0.52158034644637452</c:v>
                </c:pt>
                <c:pt idx="8">
                  <c:v>0.62398298296568178</c:v>
                </c:pt>
                <c:pt idx="9">
                  <c:v>1.8349003278921678</c:v>
                </c:pt>
                <c:pt idx="10">
                  <c:v>0.21005188028391614</c:v>
                </c:pt>
                <c:pt idx="11">
                  <c:v>1.3756739968990395</c:v>
                </c:pt>
                <c:pt idx="12">
                  <c:v>0.51252763399960355</c:v>
                </c:pt>
                <c:pt idx="13">
                  <c:v>1</c:v>
                </c:pt>
                <c:pt idx="14">
                  <c:v>0.72071588410205789</c:v>
                </c:pt>
              </c:numCache>
            </c:numRef>
          </c:val>
        </c:ser>
        <c:axId val="76434048"/>
        <c:axId val="76439936"/>
      </c:barChart>
      <c:catAx>
        <c:axId val="76434048"/>
        <c:scaling>
          <c:orientation val="minMax"/>
        </c:scaling>
        <c:axPos val="b"/>
        <c:tickLblPos val="nextTo"/>
        <c:crossAx val="76439936"/>
        <c:crosses val="autoZero"/>
        <c:auto val="1"/>
        <c:lblAlgn val="ctr"/>
        <c:lblOffset val="100"/>
      </c:catAx>
      <c:valAx>
        <c:axId val="76439936"/>
        <c:scaling>
          <c:orientation val="minMax"/>
        </c:scaling>
        <c:axPos val="l"/>
        <c:numFmt formatCode="0.0" sourceLinked="0"/>
        <c:tickLblPos val="nextTo"/>
        <c:crossAx val="76434048"/>
        <c:crosses val="autoZero"/>
        <c:crossBetween val="between"/>
      </c:valAx>
    </c:plotArea>
    <c:plotVisOnly val="1"/>
  </c:chart>
  <c:externalData r:id="rId1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0h</c:v>
          </c:tx>
          <c:errBars>
            <c:errBarType val="both"/>
            <c:errValType val="cust"/>
            <c:plus>
              <c:numRef>
                <c:f>Sheet12!$Y$88:$AH$88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</c:numCache>
              </c:numRef>
            </c:plus>
            <c:minus>
              <c:numRef>
                <c:f>Sheet12!$Y$88:$AH$88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</c:numCache>
              </c:numRef>
            </c:minus>
          </c:errBars>
          <c:cat>
            <c:strRef>
              <c:f>Sheet12!$Y$78:$AH$78</c:f>
              <c:strCache>
                <c:ptCount val="10"/>
                <c:pt idx="0">
                  <c:v>GSTU13</c:v>
                </c:pt>
                <c:pt idx="1">
                  <c:v>GSTU15</c:v>
                </c:pt>
                <c:pt idx="2">
                  <c:v>GSTU18</c:v>
                </c:pt>
                <c:pt idx="3">
                  <c:v>GSTZ1    </c:v>
                </c:pt>
                <c:pt idx="4">
                  <c:v>GSTZ3   </c:v>
                </c:pt>
                <c:pt idx="5">
                  <c:v>EF1G3    </c:v>
                </c:pt>
                <c:pt idx="6">
                  <c:v>GHR1     </c:v>
                </c:pt>
                <c:pt idx="7">
                  <c:v>GHR2    </c:v>
                </c:pt>
                <c:pt idx="8">
                  <c:v>GSTT1    </c:v>
                </c:pt>
                <c:pt idx="9">
                  <c:v>GSTT2    </c:v>
                </c:pt>
              </c:strCache>
            </c:strRef>
          </c:cat>
          <c:val>
            <c:numRef>
              <c:f>Sheet12!$Y$79:$AH$79</c:f>
              <c:numCache>
                <c:formatCode>0.00</c:formatCode>
                <c:ptCount val="1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</c:ser>
        <c:ser>
          <c:idx val="1"/>
          <c:order val="1"/>
          <c:tx>
            <c:v>6h</c:v>
          </c:tx>
          <c:errBars>
            <c:errBarType val="both"/>
            <c:errValType val="cust"/>
            <c:plus>
              <c:numRef>
                <c:f>Sheet12!$Y$89:$AH$89</c:f>
                <c:numCache>
                  <c:formatCode>General</c:formatCode>
                  <c:ptCount val="10"/>
                  <c:pt idx="0">
                    <c:v>2.2521139677950656E-2</c:v>
                  </c:pt>
                  <c:pt idx="1">
                    <c:v>1.6796546218602294E-3</c:v>
                  </c:pt>
                  <c:pt idx="2">
                    <c:v>3.2406879274640442E-2</c:v>
                  </c:pt>
                  <c:pt idx="3">
                    <c:v>0.18791828974142741</c:v>
                  </c:pt>
                  <c:pt idx="4">
                    <c:v>4.5739814717564706E-2</c:v>
                  </c:pt>
                  <c:pt idx="5">
                    <c:v>0.52413698001633668</c:v>
                  </c:pt>
                  <c:pt idx="6">
                    <c:v>0.15764825399699919</c:v>
                  </c:pt>
                  <c:pt idx="7">
                    <c:v>0.10506614381886079</c:v>
                  </c:pt>
                  <c:pt idx="8">
                    <c:v>0.12293505742041019</c:v>
                  </c:pt>
                  <c:pt idx="9">
                    <c:v>0.27921976580038982</c:v>
                  </c:pt>
                </c:numCache>
              </c:numRef>
            </c:plus>
            <c:minus>
              <c:numRef>
                <c:f>Sheet12!$Y$89:$AH$89</c:f>
                <c:numCache>
                  <c:formatCode>General</c:formatCode>
                  <c:ptCount val="10"/>
                  <c:pt idx="0">
                    <c:v>2.2521139677950656E-2</c:v>
                  </c:pt>
                  <c:pt idx="1">
                    <c:v>1.6796546218602294E-3</c:v>
                  </c:pt>
                  <c:pt idx="2">
                    <c:v>3.2406879274640442E-2</c:v>
                  </c:pt>
                  <c:pt idx="3">
                    <c:v>0.18791828974142741</c:v>
                  </c:pt>
                  <c:pt idx="4">
                    <c:v>4.5739814717564706E-2</c:v>
                  </c:pt>
                  <c:pt idx="5">
                    <c:v>0.52413698001633668</c:v>
                  </c:pt>
                  <c:pt idx="6">
                    <c:v>0.15764825399699919</c:v>
                  </c:pt>
                  <c:pt idx="7">
                    <c:v>0.10506614381886079</c:v>
                  </c:pt>
                  <c:pt idx="8">
                    <c:v>0.12293505742041019</c:v>
                  </c:pt>
                  <c:pt idx="9">
                    <c:v>0.27921976580038982</c:v>
                  </c:pt>
                </c:numCache>
              </c:numRef>
            </c:minus>
          </c:errBars>
          <c:cat>
            <c:strRef>
              <c:f>Sheet12!$Y$78:$AH$78</c:f>
              <c:strCache>
                <c:ptCount val="10"/>
                <c:pt idx="0">
                  <c:v>GSTU13</c:v>
                </c:pt>
                <c:pt idx="1">
                  <c:v>GSTU15</c:v>
                </c:pt>
                <c:pt idx="2">
                  <c:v>GSTU18</c:v>
                </c:pt>
                <c:pt idx="3">
                  <c:v>GSTZ1    </c:v>
                </c:pt>
                <c:pt idx="4">
                  <c:v>GSTZ3   </c:v>
                </c:pt>
                <c:pt idx="5">
                  <c:v>EF1G3    </c:v>
                </c:pt>
                <c:pt idx="6">
                  <c:v>GHR1     </c:v>
                </c:pt>
                <c:pt idx="7">
                  <c:v>GHR2    </c:v>
                </c:pt>
                <c:pt idx="8">
                  <c:v>GSTT1    </c:v>
                </c:pt>
                <c:pt idx="9">
                  <c:v>GSTT2    </c:v>
                </c:pt>
              </c:strCache>
            </c:strRef>
          </c:cat>
          <c:val>
            <c:numRef>
              <c:f>Sheet12!$Y$80:$AH$80</c:f>
              <c:numCache>
                <c:formatCode>0.00</c:formatCode>
                <c:ptCount val="10"/>
                <c:pt idx="0">
                  <c:v>1.1488087358821295</c:v>
                </c:pt>
                <c:pt idx="1">
                  <c:v>0.34269775936176827</c:v>
                </c:pt>
                <c:pt idx="2">
                  <c:v>1.1021433605966215</c:v>
                </c:pt>
                <c:pt idx="3">
                  <c:v>1.1328782969851419</c:v>
                </c:pt>
                <c:pt idx="4">
                  <c:v>0.93359339576783629</c:v>
                </c:pt>
                <c:pt idx="5">
                  <c:v>4.4623479776310555</c:v>
                </c:pt>
                <c:pt idx="6">
                  <c:v>0.78977631316733388</c:v>
                </c:pt>
                <c:pt idx="7">
                  <c:v>0.79625758052868667</c:v>
                </c:pt>
                <c:pt idx="8">
                  <c:v>1.1964976848153781</c:v>
                </c:pt>
                <c:pt idx="9">
                  <c:v>3.5078315936971411</c:v>
                </c:pt>
              </c:numCache>
            </c:numRef>
          </c:val>
        </c:ser>
        <c:ser>
          <c:idx val="2"/>
          <c:order val="2"/>
          <c:tx>
            <c:v>24h</c:v>
          </c:tx>
          <c:errBars>
            <c:errBarType val="both"/>
            <c:errValType val="cust"/>
            <c:plus>
              <c:numRef>
                <c:f>Sheet12!$Y$90:$AH$90</c:f>
                <c:numCache>
                  <c:formatCode>General</c:formatCode>
                  <c:ptCount val="10"/>
                  <c:pt idx="0">
                    <c:v>4.4174871850905933E-2</c:v>
                  </c:pt>
                  <c:pt idx="1">
                    <c:v>7.7985609501445537E-3</c:v>
                  </c:pt>
                  <c:pt idx="2">
                    <c:v>9.4044694471886927E-3</c:v>
                  </c:pt>
                  <c:pt idx="3">
                    <c:v>0.16332102872513832</c:v>
                  </c:pt>
                  <c:pt idx="4">
                    <c:v>2.9043874500384027E-2</c:v>
                  </c:pt>
                  <c:pt idx="5">
                    <c:v>1.7305397986142026E-2</c:v>
                  </c:pt>
                  <c:pt idx="6">
                    <c:v>4.3084274885300734E-2</c:v>
                  </c:pt>
                  <c:pt idx="7">
                    <c:v>4.5841133197286318E-2</c:v>
                  </c:pt>
                  <c:pt idx="8">
                    <c:v>1.6203439637319236E-2</c:v>
                  </c:pt>
                  <c:pt idx="9">
                    <c:v>1.6316143472807725E-2</c:v>
                  </c:pt>
                </c:numCache>
              </c:numRef>
            </c:plus>
            <c:minus>
              <c:numRef>
                <c:f>Sheet12!$Y$90:$AH$90</c:f>
                <c:numCache>
                  <c:formatCode>General</c:formatCode>
                  <c:ptCount val="10"/>
                  <c:pt idx="0">
                    <c:v>4.4174871850905933E-2</c:v>
                  </c:pt>
                  <c:pt idx="1">
                    <c:v>7.7985609501445537E-3</c:v>
                  </c:pt>
                  <c:pt idx="2">
                    <c:v>9.4044694471886927E-3</c:v>
                  </c:pt>
                  <c:pt idx="3">
                    <c:v>0.16332102872513832</c:v>
                  </c:pt>
                  <c:pt idx="4">
                    <c:v>2.9043874500384027E-2</c:v>
                  </c:pt>
                  <c:pt idx="5">
                    <c:v>1.7305397986142026E-2</c:v>
                  </c:pt>
                  <c:pt idx="6">
                    <c:v>4.3084274885300734E-2</c:v>
                  </c:pt>
                  <c:pt idx="7">
                    <c:v>4.5841133197286318E-2</c:v>
                  </c:pt>
                  <c:pt idx="8">
                    <c:v>1.6203439637319236E-2</c:v>
                  </c:pt>
                  <c:pt idx="9">
                    <c:v>1.6316143472807725E-2</c:v>
                  </c:pt>
                </c:numCache>
              </c:numRef>
            </c:minus>
          </c:errBars>
          <c:cat>
            <c:strRef>
              <c:f>Sheet12!$Y$78:$AH$78</c:f>
              <c:strCache>
                <c:ptCount val="10"/>
                <c:pt idx="0">
                  <c:v>GSTU13</c:v>
                </c:pt>
                <c:pt idx="1">
                  <c:v>GSTU15</c:v>
                </c:pt>
                <c:pt idx="2">
                  <c:v>GSTU18</c:v>
                </c:pt>
                <c:pt idx="3">
                  <c:v>GSTZ1    </c:v>
                </c:pt>
                <c:pt idx="4">
                  <c:v>GSTZ3   </c:v>
                </c:pt>
                <c:pt idx="5">
                  <c:v>EF1G3    </c:v>
                </c:pt>
                <c:pt idx="6">
                  <c:v>GHR1     </c:v>
                </c:pt>
                <c:pt idx="7">
                  <c:v>GHR2    </c:v>
                </c:pt>
                <c:pt idx="8">
                  <c:v>GSTT1    </c:v>
                </c:pt>
                <c:pt idx="9">
                  <c:v>GSTT2    </c:v>
                </c:pt>
              </c:strCache>
            </c:strRef>
          </c:cat>
          <c:val>
            <c:numRef>
              <c:f>Sheet12!$Y$81:$AH$81</c:f>
              <c:numCache>
                <c:formatCode>0.00</c:formatCode>
                <c:ptCount val="10"/>
                <c:pt idx="0">
                  <c:v>0.33478507254258438</c:v>
                </c:pt>
                <c:pt idx="1">
                  <c:v>0.39780646427972177</c:v>
                </c:pt>
                <c:pt idx="2">
                  <c:v>0.23990821200377049</c:v>
                </c:pt>
                <c:pt idx="3">
                  <c:v>0.90552671878528557</c:v>
                </c:pt>
                <c:pt idx="4">
                  <c:v>1.1852707070796074</c:v>
                </c:pt>
                <c:pt idx="5">
                  <c:v>1.176970350735588</c:v>
                </c:pt>
                <c:pt idx="6">
                  <c:v>0.67664159825264802</c:v>
                </c:pt>
                <c:pt idx="7">
                  <c:v>0.32359797275819058</c:v>
                </c:pt>
                <c:pt idx="8">
                  <c:v>0.55107168029831</c:v>
                </c:pt>
                <c:pt idx="9">
                  <c:v>0.55490468695546435</c:v>
                </c:pt>
              </c:numCache>
            </c:numRef>
          </c:val>
        </c:ser>
        <c:ser>
          <c:idx val="3"/>
          <c:order val="3"/>
          <c:tx>
            <c:v>48h</c:v>
          </c:tx>
          <c:errBars>
            <c:errBarType val="both"/>
            <c:errValType val="cust"/>
            <c:plus>
              <c:numRef>
                <c:f>Sheet12!$Y$91:$AH$91</c:f>
                <c:numCache>
                  <c:formatCode>General</c:formatCode>
                  <c:ptCount val="10"/>
                  <c:pt idx="0">
                    <c:v>4.7437434685897367E-2</c:v>
                  </c:pt>
                  <c:pt idx="1">
                    <c:v>4.4081154801722984E-3</c:v>
                  </c:pt>
                  <c:pt idx="2">
                    <c:v>3.6452422406080445E-2</c:v>
                  </c:pt>
                  <c:pt idx="3">
                    <c:v>0.13392275136935933</c:v>
                  </c:pt>
                  <c:pt idx="4">
                    <c:v>0.2734498465046713</c:v>
                  </c:pt>
                  <c:pt idx="5">
                    <c:v>0.11705823897324052</c:v>
                  </c:pt>
                  <c:pt idx="6">
                    <c:v>0.16701368733241229</c:v>
                  </c:pt>
                  <c:pt idx="7">
                    <c:v>5.7793276422517477E-2</c:v>
                  </c:pt>
                  <c:pt idx="8">
                    <c:v>2.058250335951534E-2</c:v>
                  </c:pt>
                  <c:pt idx="9">
                    <c:v>6.8583393836386924E-2</c:v>
                  </c:pt>
                </c:numCache>
              </c:numRef>
            </c:plus>
            <c:minus>
              <c:numRef>
                <c:f>Sheet12!$Y$91:$AH$91</c:f>
                <c:numCache>
                  <c:formatCode>General</c:formatCode>
                  <c:ptCount val="10"/>
                  <c:pt idx="0">
                    <c:v>4.7437434685897367E-2</c:v>
                  </c:pt>
                  <c:pt idx="1">
                    <c:v>4.4081154801722984E-3</c:v>
                  </c:pt>
                  <c:pt idx="2">
                    <c:v>3.6452422406080445E-2</c:v>
                  </c:pt>
                  <c:pt idx="3">
                    <c:v>0.13392275136935933</c:v>
                  </c:pt>
                  <c:pt idx="4">
                    <c:v>0.2734498465046713</c:v>
                  </c:pt>
                  <c:pt idx="5">
                    <c:v>0.11705823897324052</c:v>
                  </c:pt>
                  <c:pt idx="6">
                    <c:v>0.16701368733241229</c:v>
                  </c:pt>
                  <c:pt idx="7">
                    <c:v>5.7793276422517477E-2</c:v>
                  </c:pt>
                  <c:pt idx="8">
                    <c:v>2.058250335951534E-2</c:v>
                  </c:pt>
                  <c:pt idx="9">
                    <c:v>6.8583393836386924E-2</c:v>
                  </c:pt>
                </c:numCache>
              </c:numRef>
            </c:minus>
          </c:errBars>
          <c:cat>
            <c:strRef>
              <c:f>Sheet12!$Y$78:$AH$78</c:f>
              <c:strCache>
                <c:ptCount val="10"/>
                <c:pt idx="0">
                  <c:v>GSTU13</c:v>
                </c:pt>
                <c:pt idx="1">
                  <c:v>GSTU15</c:v>
                </c:pt>
                <c:pt idx="2">
                  <c:v>GSTU18</c:v>
                </c:pt>
                <c:pt idx="3">
                  <c:v>GSTZ1    </c:v>
                </c:pt>
                <c:pt idx="4">
                  <c:v>GSTZ3   </c:v>
                </c:pt>
                <c:pt idx="5">
                  <c:v>EF1G3    </c:v>
                </c:pt>
                <c:pt idx="6">
                  <c:v>GHR1     </c:v>
                </c:pt>
                <c:pt idx="7">
                  <c:v>GHR2    </c:v>
                </c:pt>
                <c:pt idx="8">
                  <c:v>GSTT1    </c:v>
                </c:pt>
                <c:pt idx="9">
                  <c:v>GSTT2    </c:v>
                </c:pt>
              </c:strCache>
            </c:strRef>
          </c:cat>
          <c:val>
            <c:numRef>
              <c:f>Sheet12!$Y$82:$AH$82</c:f>
              <c:numCache>
                <c:formatCode>0.00</c:formatCode>
                <c:ptCount val="10"/>
                <c:pt idx="0">
                  <c:v>0.24967763957545874</c:v>
                </c:pt>
                <c:pt idx="1">
                  <c:v>0.17989370364492074</c:v>
                </c:pt>
                <c:pt idx="2">
                  <c:v>0.67644668279498432</c:v>
                </c:pt>
                <c:pt idx="3">
                  <c:v>0.72320437290934969</c:v>
                </c:pt>
                <c:pt idx="4">
                  <c:v>1.8066417592221258</c:v>
                </c:pt>
                <c:pt idx="5">
                  <c:v>1.7072774672842095</c:v>
                </c:pt>
                <c:pt idx="6">
                  <c:v>1.3664270597653307</c:v>
                </c:pt>
                <c:pt idx="7">
                  <c:v>0.25850365848938173</c:v>
                </c:pt>
                <c:pt idx="8">
                  <c:v>0.52506009055290526</c:v>
                </c:pt>
                <c:pt idx="9">
                  <c:v>0.58438251412664233</c:v>
                </c:pt>
              </c:numCache>
            </c:numRef>
          </c:val>
        </c:ser>
        <c:ser>
          <c:idx val="4"/>
          <c:order val="4"/>
          <c:tx>
            <c:v>72h</c:v>
          </c:tx>
          <c:errBars>
            <c:errBarType val="both"/>
            <c:errValType val="cust"/>
            <c:plus>
              <c:numRef>
                <c:f>Sheet12!$Y$92:$AH$92</c:f>
                <c:numCache>
                  <c:formatCode>General</c:formatCode>
                  <c:ptCount val="10"/>
                  <c:pt idx="0">
                    <c:v>6.3626980348170992E-2</c:v>
                  </c:pt>
                  <c:pt idx="1">
                    <c:v>1.8576137056617242E-2</c:v>
                  </c:pt>
                  <c:pt idx="2">
                    <c:v>3.6481407795665687E-2</c:v>
                  </c:pt>
                  <c:pt idx="3">
                    <c:v>0.16612414203531264</c:v>
                  </c:pt>
                  <c:pt idx="4">
                    <c:v>0.10836742887708092</c:v>
                  </c:pt>
                  <c:pt idx="5">
                    <c:v>0.22698594078006082</c:v>
                  </c:pt>
                  <c:pt idx="6">
                    <c:v>2.3590956662406713E-2</c:v>
                  </c:pt>
                  <c:pt idx="7">
                    <c:v>6.1191411051285928E-2</c:v>
                  </c:pt>
                  <c:pt idx="8">
                    <c:v>2.3807538431143412E-2</c:v>
                  </c:pt>
                  <c:pt idx="9">
                    <c:v>8.0047265499846268E-2</c:v>
                  </c:pt>
                </c:numCache>
              </c:numRef>
            </c:plus>
            <c:minus>
              <c:numRef>
                <c:f>Sheet12!$Y$92:$AH$92</c:f>
                <c:numCache>
                  <c:formatCode>General</c:formatCode>
                  <c:ptCount val="10"/>
                  <c:pt idx="0">
                    <c:v>6.3626980348170992E-2</c:v>
                  </c:pt>
                  <c:pt idx="1">
                    <c:v>1.8576137056617242E-2</c:v>
                  </c:pt>
                  <c:pt idx="2">
                    <c:v>3.6481407795665687E-2</c:v>
                  </c:pt>
                  <c:pt idx="3">
                    <c:v>0.16612414203531264</c:v>
                  </c:pt>
                  <c:pt idx="4">
                    <c:v>0.10836742887708092</c:v>
                  </c:pt>
                  <c:pt idx="5">
                    <c:v>0.22698594078006082</c:v>
                  </c:pt>
                  <c:pt idx="6">
                    <c:v>2.3590956662406713E-2</c:v>
                  </c:pt>
                  <c:pt idx="7">
                    <c:v>6.1191411051285928E-2</c:v>
                  </c:pt>
                  <c:pt idx="8">
                    <c:v>2.3807538431143412E-2</c:v>
                  </c:pt>
                  <c:pt idx="9">
                    <c:v>8.0047265499846268E-2</c:v>
                  </c:pt>
                </c:numCache>
              </c:numRef>
            </c:minus>
          </c:errBars>
          <c:cat>
            <c:strRef>
              <c:f>Sheet12!$Y$78:$AH$78</c:f>
              <c:strCache>
                <c:ptCount val="10"/>
                <c:pt idx="0">
                  <c:v>GSTU13</c:v>
                </c:pt>
                <c:pt idx="1">
                  <c:v>GSTU15</c:v>
                </c:pt>
                <c:pt idx="2">
                  <c:v>GSTU18</c:v>
                </c:pt>
                <c:pt idx="3">
                  <c:v>GSTZ1    </c:v>
                </c:pt>
                <c:pt idx="4">
                  <c:v>GSTZ3   </c:v>
                </c:pt>
                <c:pt idx="5">
                  <c:v>EF1G3    </c:v>
                </c:pt>
                <c:pt idx="6">
                  <c:v>GHR1     </c:v>
                </c:pt>
                <c:pt idx="7">
                  <c:v>GHR2    </c:v>
                </c:pt>
                <c:pt idx="8">
                  <c:v>GSTT1    </c:v>
                </c:pt>
                <c:pt idx="9">
                  <c:v>GSTT2    </c:v>
                </c:pt>
              </c:strCache>
            </c:strRef>
          </c:cat>
          <c:val>
            <c:numRef>
              <c:f>Sheet12!$Y$83:$AH$83</c:f>
              <c:numCache>
                <c:formatCode>0.00</c:formatCode>
                <c:ptCount val="10"/>
                <c:pt idx="0">
                  <c:v>0.35277717260684488</c:v>
                </c:pt>
                <c:pt idx="1">
                  <c:v>0.37915673646739234</c:v>
                </c:pt>
                <c:pt idx="2">
                  <c:v>0.57294310146991789</c:v>
                </c:pt>
                <c:pt idx="3">
                  <c:v>1.0635251540775639</c:v>
                </c:pt>
                <c:pt idx="4">
                  <c:v>0.92337265618126407</c:v>
                </c:pt>
                <c:pt idx="5">
                  <c:v>2.727355093085404</c:v>
                </c:pt>
                <c:pt idx="6">
                  <c:v>0.9627389721562627</c:v>
                </c:pt>
                <c:pt idx="7">
                  <c:v>0.33044345045399726</c:v>
                </c:pt>
                <c:pt idx="8">
                  <c:v>0.60733080258278849</c:v>
                </c:pt>
                <c:pt idx="9">
                  <c:v>0.58511098453107258</c:v>
                </c:pt>
              </c:numCache>
            </c:numRef>
          </c:val>
        </c:ser>
        <c:axId val="76531968"/>
        <c:axId val="76546048"/>
      </c:barChart>
      <c:catAx>
        <c:axId val="76531968"/>
        <c:scaling>
          <c:orientation val="minMax"/>
        </c:scaling>
        <c:axPos val="b"/>
        <c:tickLblPos val="nextTo"/>
        <c:crossAx val="76546048"/>
        <c:crosses val="autoZero"/>
        <c:auto val="1"/>
        <c:lblAlgn val="ctr"/>
        <c:lblOffset val="100"/>
      </c:catAx>
      <c:valAx>
        <c:axId val="76546048"/>
        <c:scaling>
          <c:orientation val="minMax"/>
        </c:scaling>
        <c:axPos val="l"/>
        <c:numFmt formatCode="0.0" sourceLinked="0"/>
        <c:tickLblPos val="nextTo"/>
        <c:crossAx val="76531968"/>
        <c:crosses val="autoZero"/>
        <c:crossBetween val="between"/>
      </c:valAx>
    </c:plotArea>
    <c:plotVisOnly val="1"/>
  </c:chart>
  <c:externalData r:id="rId1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0h</c:v>
          </c:tx>
          <c:errBars>
            <c:errBarType val="both"/>
            <c:errValType val="cust"/>
            <c:plus>
              <c:numRef>
                <c:f>Sheet12!$Z$111:$AI$111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</c:numCache>
              </c:numRef>
            </c:plus>
            <c:minus>
              <c:numRef>
                <c:f>Sheet12!$Z$111:$AI$111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</c:numCache>
              </c:numRef>
            </c:minus>
          </c:errBars>
          <c:cat>
            <c:strRef>
              <c:f>Sheet12!$Z$100:$AI$100</c:f>
              <c:strCache>
                <c:ptCount val="10"/>
                <c:pt idx="0">
                  <c:v>GSTU13</c:v>
                </c:pt>
                <c:pt idx="1">
                  <c:v>GSTU15</c:v>
                </c:pt>
                <c:pt idx="2">
                  <c:v>GSTU18</c:v>
                </c:pt>
                <c:pt idx="3">
                  <c:v>GSTZ1    </c:v>
                </c:pt>
                <c:pt idx="4">
                  <c:v>GSTZ3   </c:v>
                </c:pt>
                <c:pt idx="5">
                  <c:v>EF1G3    </c:v>
                </c:pt>
                <c:pt idx="6">
                  <c:v>GHR1     </c:v>
                </c:pt>
                <c:pt idx="7">
                  <c:v>GHR2    </c:v>
                </c:pt>
                <c:pt idx="8">
                  <c:v>GSTT1    </c:v>
                </c:pt>
                <c:pt idx="9">
                  <c:v>GSTT2    </c:v>
                </c:pt>
              </c:strCache>
            </c:strRef>
          </c:cat>
          <c:val>
            <c:numRef>
              <c:f>Sheet12!$Z$101:$AI$101</c:f>
              <c:numCache>
                <c:formatCode>0.00</c:formatCode>
                <c:ptCount val="1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</c:ser>
        <c:ser>
          <c:idx val="1"/>
          <c:order val="1"/>
          <c:tx>
            <c:v>6h</c:v>
          </c:tx>
          <c:errBars>
            <c:errBarType val="both"/>
            <c:errValType val="cust"/>
            <c:plus>
              <c:numRef>
                <c:f>Sheet12!$Z$112:$AI$112</c:f>
                <c:numCache>
                  <c:formatCode>General</c:formatCode>
                  <c:ptCount val="10"/>
                  <c:pt idx="0">
                    <c:v>0.21124600012557257</c:v>
                  </c:pt>
                  <c:pt idx="1">
                    <c:v>0.21805840703200283</c:v>
                  </c:pt>
                  <c:pt idx="2">
                    <c:v>5.6716715577827793E-2</c:v>
                  </c:pt>
                  <c:pt idx="3">
                    <c:v>6.7232303273708882E-2</c:v>
                  </c:pt>
                  <c:pt idx="4">
                    <c:v>0.18631070360794141</c:v>
                  </c:pt>
                  <c:pt idx="5">
                    <c:v>9.6596633357304507E-2</c:v>
                  </c:pt>
                  <c:pt idx="6">
                    <c:v>2.8161614853461331E-2</c:v>
                  </c:pt>
                  <c:pt idx="7">
                    <c:v>0.14143764523740138</c:v>
                  </c:pt>
                  <c:pt idx="8">
                    <c:v>9.3771829165148021E-2</c:v>
                  </c:pt>
                  <c:pt idx="9">
                    <c:v>4.2761133566360361E-2</c:v>
                  </c:pt>
                </c:numCache>
              </c:numRef>
            </c:plus>
            <c:minus>
              <c:numRef>
                <c:f>Sheet12!$Z$112:$AI$112</c:f>
                <c:numCache>
                  <c:formatCode>General</c:formatCode>
                  <c:ptCount val="10"/>
                  <c:pt idx="0">
                    <c:v>0.21124600012557257</c:v>
                  </c:pt>
                  <c:pt idx="1">
                    <c:v>0.21805840703200283</c:v>
                  </c:pt>
                  <c:pt idx="2">
                    <c:v>5.6716715577827793E-2</c:v>
                  </c:pt>
                  <c:pt idx="3">
                    <c:v>6.7232303273708882E-2</c:v>
                  </c:pt>
                  <c:pt idx="4">
                    <c:v>0.18631070360794141</c:v>
                  </c:pt>
                  <c:pt idx="5">
                    <c:v>9.6596633357304507E-2</c:v>
                  </c:pt>
                  <c:pt idx="6">
                    <c:v>2.8161614853461331E-2</c:v>
                  </c:pt>
                  <c:pt idx="7">
                    <c:v>0.14143764523740138</c:v>
                  </c:pt>
                  <c:pt idx="8">
                    <c:v>9.3771829165148021E-2</c:v>
                  </c:pt>
                  <c:pt idx="9">
                    <c:v>4.2761133566360361E-2</c:v>
                  </c:pt>
                </c:numCache>
              </c:numRef>
            </c:minus>
          </c:errBars>
          <c:cat>
            <c:strRef>
              <c:f>Sheet12!$Z$100:$AI$100</c:f>
              <c:strCache>
                <c:ptCount val="10"/>
                <c:pt idx="0">
                  <c:v>GSTU13</c:v>
                </c:pt>
                <c:pt idx="1">
                  <c:v>GSTU15</c:v>
                </c:pt>
                <c:pt idx="2">
                  <c:v>GSTU18</c:v>
                </c:pt>
                <c:pt idx="3">
                  <c:v>GSTZ1    </c:v>
                </c:pt>
                <c:pt idx="4">
                  <c:v>GSTZ3   </c:v>
                </c:pt>
                <c:pt idx="5">
                  <c:v>EF1G3    </c:v>
                </c:pt>
                <c:pt idx="6">
                  <c:v>GHR1     </c:v>
                </c:pt>
                <c:pt idx="7">
                  <c:v>GHR2    </c:v>
                </c:pt>
                <c:pt idx="8">
                  <c:v>GSTT1    </c:v>
                </c:pt>
                <c:pt idx="9">
                  <c:v>GSTT2    </c:v>
                </c:pt>
              </c:strCache>
            </c:strRef>
          </c:cat>
          <c:val>
            <c:numRef>
              <c:f>Sheet12!$Z$102:$AI$102</c:f>
              <c:numCache>
                <c:formatCode>0.00</c:formatCode>
                <c:ptCount val="10"/>
                <c:pt idx="0">
                  <c:v>1.5441171455377329</c:v>
                </c:pt>
                <c:pt idx="1">
                  <c:v>1.5393000464179876</c:v>
                </c:pt>
                <c:pt idx="2">
                  <c:v>0.77214762216452515</c:v>
                </c:pt>
                <c:pt idx="3">
                  <c:v>0.98057340909643476</c:v>
                </c:pt>
                <c:pt idx="4">
                  <c:v>1.032992024539642</c:v>
                </c:pt>
                <c:pt idx="5">
                  <c:v>1.2330377209551937</c:v>
                </c:pt>
                <c:pt idx="6">
                  <c:v>0.82098314642166836</c:v>
                </c:pt>
                <c:pt idx="7">
                  <c:v>1.6052582654734879</c:v>
                </c:pt>
                <c:pt idx="8">
                  <c:v>1.3676485517288801</c:v>
                </c:pt>
                <c:pt idx="9">
                  <c:v>2.8542868831130535</c:v>
                </c:pt>
              </c:numCache>
            </c:numRef>
          </c:val>
        </c:ser>
        <c:ser>
          <c:idx val="2"/>
          <c:order val="2"/>
          <c:tx>
            <c:v>24h</c:v>
          </c:tx>
          <c:errBars>
            <c:errBarType val="both"/>
            <c:errValType val="cust"/>
            <c:plus>
              <c:numRef>
                <c:f>Sheet12!$Z$113:$AI$113</c:f>
                <c:numCache>
                  <c:formatCode>General</c:formatCode>
                  <c:ptCount val="10"/>
                  <c:pt idx="0">
                    <c:v>4.643470915954382E-2</c:v>
                  </c:pt>
                  <c:pt idx="1">
                    <c:v>4.3084274885298132E-2</c:v>
                  </c:pt>
                  <c:pt idx="2">
                    <c:v>4.2226966485100674E-3</c:v>
                  </c:pt>
                  <c:pt idx="3">
                    <c:v>7.7265505687529851E-2</c:v>
                  </c:pt>
                  <c:pt idx="4">
                    <c:v>0.17146289270953521</c:v>
                  </c:pt>
                  <c:pt idx="5">
                    <c:v>2.8116528173883867E-2</c:v>
                  </c:pt>
                  <c:pt idx="6">
                    <c:v>3.6452422406081972E-2</c:v>
                  </c:pt>
                  <c:pt idx="7">
                    <c:v>5.2676569809924224E-2</c:v>
                  </c:pt>
                  <c:pt idx="8">
                    <c:v>5.3411907321592803E-2</c:v>
                  </c:pt>
                  <c:pt idx="9">
                    <c:v>6.4942124209366833E-2</c:v>
                  </c:pt>
                </c:numCache>
              </c:numRef>
            </c:plus>
            <c:minus>
              <c:numRef>
                <c:f>Sheet12!$Z$113:$AI$113</c:f>
                <c:numCache>
                  <c:formatCode>General</c:formatCode>
                  <c:ptCount val="10"/>
                  <c:pt idx="0">
                    <c:v>4.643470915954382E-2</c:v>
                  </c:pt>
                  <c:pt idx="1">
                    <c:v>4.3084274885298132E-2</c:v>
                  </c:pt>
                  <c:pt idx="2">
                    <c:v>4.2226966485100674E-3</c:v>
                  </c:pt>
                  <c:pt idx="3">
                    <c:v>7.7265505687529851E-2</c:v>
                  </c:pt>
                  <c:pt idx="4">
                    <c:v>0.17146289270953521</c:v>
                  </c:pt>
                  <c:pt idx="5">
                    <c:v>2.8116528173883867E-2</c:v>
                  </c:pt>
                  <c:pt idx="6">
                    <c:v>3.6452422406081972E-2</c:v>
                  </c:pt>
                  <c:pt idx="7">
                    <c:v>5.2676569809924224E-2</c:v>
                  </c:pt>
                  <c:pt idx="8">
                    <c:v>5.3411907321592803E-2</c:v>
                  </c:pt>
                  <c:pt idx="9">
                    <c:v>6.4942124209366833E-2</c:v>
                  </c:pt>
                </c:numCache>
              </c:numRef>
            </c:minus>
          </c:errBars>
          <c:cat>
            <c:strRef>
              <c:f>Sheet12!$Z$100:$AI$100</c:f>
              <c:strCache>
                <c:ptCount val="10"/>
                <c:pt idx="0">
                  <c:v>GSTU13</c:v>
                </c:pt>
                <c:pt idx="1">
                  <c:v>GSTU15</c:v>
                </c:pt>
                <c:pt idx="2">
                  <c:v>GSTU18</c:v>
                </c:pt>
                <c:pt idx="3">
                  <c:v>GSTZ1    </c:v>
                </c:pt>
                <c:pt idx="4">
                  <c:v>GSTZ3   </c:v>
                </c:pt>
                <c:pt idx="5">
                  <c:v>EF1G3    </c:v>
                </c:pt>
                <c:pt idx="6">
                  <c:v>GHR1     </c:v>
                </c:pt>
                <c:pt idx="7">
                  <c:v>GHR2    </c:v>
                </c:pt>
                <c:pt idx="8">
                  <c:v>GSTT1    </c:v>
                </c:pt>
                <c:pt idx="9">
                  <c:v>GSTT2    </c:v>
                </c:pt>
              </c:strCache>
            </c:strRef>
          </c:cat>
          <c:val>
            <c:numRef>
              <c:f>Sheet12!$Z$103:$AI$103</c:f>
              <c:numCache>
                <c:formatCode>0.00</c:formatCode>
                <c:ptCount val="10"/>
                <c:pt idx="0">
                  <c:v>0.49935079349754435</c:v>
                </c:pt>
                <c:pt idx="1">
                  <c:v>0.67664159825264936</c:v>
                </c:pt>
                <c:pt idx="2">
                  <c:v>0.86155133387280969</c:v>
                </c:pt>
                <c:pt idx="3">
                  <c:v>0.75200679619866584</c:v>
                </c:pt>
                <c:pt idx="4">
                  <c:v>1.6688075676991687</c:v>
                </c:pt>
                <c:pt idx="5">
                  <c:v>0.71725322091037735</c:v>
                </c:pt>
                <c:pt idx="6">
                  <c:v>0.6764466827949851</c:v>
                </c:pt>
                <c:pt idx="7">
                  <c:v>0.82728927158562215</c:v>
                </c:pt>
                <c:pt idx="8">
                  <c:v>0.83883779945283021</c:v>
                </c:pt>
                <c:pt idx="9">
                  <c:v>1.9471714790239301</c:v>
                </c:pt>
              </c:numCache>
            </c:numRef>
          </c:val>
        </c:ser>
        <c:ser>
          <c:idx val="3"/>
          <c:order val="3"/>
          <c:tx>
            <c:v>48h</c:v>
          </c:tx>
          <c:errBars>
            <c:errBarType val="both"/>
            <c:errValType val="cust"/>
            <c:plus>
              <c:numRef>
                <c:f>Sheet12!$Z$114:$AI$114</c:f>
                <c:numCache>
                  <c:formatCode>General</c:formatCode>
                  <c:ptCount val="10"/>
                  <c:pt idx="0">
                    <c:v>2.1791628133934E-2</c:v>
                  </c:pt>
                  <c:pt idx="1">
                    <c:v>1.5948829219341501E-2</c:v>
                  </c:pt>
                  <c:pt idx="2">
                    <c:v>0</c:v>
                  </c:pt>
                  <c:pt idx="3">
                    <c:v>0.31925619461624588</c:v>
                  </c:pt>
                  <c:pt idx="4">
                    <c:v>6.8972185917886938E-2</c:v>
                  </c:pt>
                  <c:pt idx="5">
                    <c:v>7.0574870424812614E-2</c:v>
                  </c:pt>
                  <c:pt idx="6">
                    <c:v>1.4501845563894073E-2</c:v>
                  </c:pt>
                  <c:pt idx="7">
                    <c:v>0.19668018968377668</c:v>
                  </c:pt>
                  <c:pt idx="8">
                    <c:v>0.2652080844200711</c:v>
                  </c:pt>
                  <c:pt idx="9">
                    <c:v>0.11647697663080969</c:v>
                  </c:pt>
                </c:numCache>
              </c:numRef>
            </c:plus>
            <c:minus>
              <c:numRef>
                <c:f>Sheet12!$Z$114:$AI$114</c:f>
                <c:numCache>
                  <c:formatCode>General</c:formatCode>
                  <c:ptCount val="10"/>
                  <c:pt idx="0">
                    <c:v>2.1791628133934E-2</c:v>
                  </c:pt>
                  <c:pt idx="1">
                    <c:v>1.5948829219341501E-2</c:v>
                  </c:pt>
                  <c:pt idx="2">
                    <c:v>0</c:v>
                  </c:pt>
                  <c:pt idx="3">
                    <c:v>0.31925619461624588</c:v>
                  </c:pt>
                  <c:pt idx="4">
                    <c:v>6.8972185917886938E-2</c:v>
                  </c:pt>
                  <c:pt idx="5">
                    <c:v>7.0574870424812614E-2</c:v>
                  </c:pt>
                  <c:pt idx="6">
                    <c:v>1.4501845563894073E-2</c:v>
                  </c:pt>
                  <c:pt idx="7">
                    <c:v>0.19668018968377668</c:v>
                  </c:pt>
                  <c:pt idx="8">
                    <c:v>0.2652080844200711</c:v>
                  </c:pt>
                  <c:pt idx="9">
                    <c:v>0.11647697663080969</c:v>
                  </c:pt>
                </c:numCache>
              </c:numRef>
            </c:minus>
          </c:errBars>
          <c:cat>
            <c:strRef>
              <c:f>Sheet12!$Z$100:$AI$100</c:f>
              <c:strCache>
                <c:ptCount val="10"/>
                <c:pt idx="0">
                  <c:v>GSTU13</c:v>
                </c:pt>
                <c:pt idx="1">
                  <c:v>GSTU15</c:v>
                </c:pt>
                <c:pt idx="2">
                  <c:v>GSTU18</c:v>
                </c:pt>
                <c:pt idx="3">
                  <c:v>GSTZ1    </c:v>
                </c:pt>
                <c:pt idx="4">
                  <c:v>GSTZ3   </c:v>
                </c:pt>
                <c:pt idx="5">
                  <c:v>EF1G3    </c:v>
                </c:pt>
                <c:pt idx="6">
                  <c:v>GHR1     </c:v>
                </c:pt>
                <c:pt idx="7">
                  <c:v>GHR2    </c:v>
                </c:pt>
                <c:pt idx="8">
                  <c:v>GSTT1    </c:v>
                </c:pt>
                <c:pt idx="9">
                  <c:v>GSTT2    </c:v>
                </c:pt>
              </c:strCache>
            </c:strRef>
          </c:cat>
          <c:val>
            <c:numRef>
              <c:f>Sheet12!$Z$104:$AI$104</c:f>
              <c:numCache>
                <c:formatCode>0.00</c:formatCode>
                <c:ptCount val="10"/>
                <c:pt idx="0">
                  <c:v>0.29667362919880363</c:v>
                </c:pt>
                <c:pt idx="1">
                  <c:v>0.32553086892344152</c:v>
                </c:pt>
                <c:pt idx="2">
                  <c:v>1.05701804056138</c:v>
                </c:pt>
                <c:pt idx="3">
                  <c:v>2.253667179729014</c:v>
                </c:pt>
                <c:pt idx="4">
                  <c:v>1.2799151137207143</c:v>
                </c:pt>
                <c:pt idx="5">
                  <c:v>1.0293242670456706</c:v>
                </c:pt>
                <c:pt idx="6">
                  <c:v>2.9587927879201494</c:v>
                </c:pt>
                <c:pt idx="7">
                  <c:v>1.0096244591465768</c:v>
                </c:pt>
                <c:pt idx="8">
                  <c:v>1.5535706916733236</c:v>
                </c:pt>
                <c:pt idx="9">
                  <c:v>1.4868065357657481</c:v>
                </c:pt>
              </c:numCache>
            </c:numRef>
          </c:val>
        </c:ser>
        <c:ser>
          <c:idx val="4"/>
          <c:order val="4"/>
          <c:tx>
            <c:v>72h</c:v>
          </c:tx>
          <c:errBars>
            <c:errBarType val="both"/>
            <c:errValType val="cust"/>
            <c:plus>
              <c:numRef>
                <c:f>Sheet12!$Z$115:$AI$115</c:f>
                <c:numCache>
                  <c:formatCode>General</c:formatCode>
                  <c:ptCount val="10"/>
                  <c:pt idx="0">
                    <c:v>7.2257643995637033E-3</c:v>
                  </c:pt>
                  <c:pt idx="1">
                    <c:v>3.9371765400515991E-2</c:v>
                  </c:pt>
                  <c:pt idx="2">
                    <c:v>3.5510210784403175E-2</c:v>
                  </c:pt>
                  <c:pt idx="3">
                    <c:v>8.9951951121628224E-2</c:v>
                  </c:pt>
                  <c:pt idx="4">
                    <c:v>0.40263934094399473</c:v>
                  </c:pt>
                  <c:pt idx="5">
                    <c:v>6.5123275943930218E-3</c:v>
                  </c:pt>
                  <c:pt idx="6">
                    <c:v>9.2921644738398229E-2</c:v>
                  </c:pt>
                  <c:pt idx="7">
                    <c:v>2.183121701870536E-2</c:v>
                  </c:pt>
                  <c:pt idx="8">
                    <c:v>0.27850641530098091</c:v>
                  </c:pt>
                  <c:pt idx="9">
                    <c:v>0.12857435724921815</c:v>
                  </c:pt>
                </c:numCache>
              </c:numRef>
            </c:plus>
            <c:minus>
              <c:numRef>
                <c:f>Sheet12!$Z$115:$AI$115</c:f>
                <c:numCache>
                  <c:formatCode>General</c:formatCode>
                  <c:ptCount val="10"/>
                  <c:pt idx="0">
                    <c:v>7.2257643995637033E-3</c:v>
                  </c:pt>
                  <c:pt idx="1">
                    <c:v>3.9371765400515991E-2</c:v>
                  </c:pt>
                  <c:pt idx="2">
                    <c:v>3.5510210784403175E-2</c:v>
                  </c:pt>
                  <c:pt idx="3">
                    <c:v>8.9951951121628224E-2</c:v>
                  </c:pt>
                  <c:pt idx="4">
                    <c:v>0.40263934094399473</c:v>
                  </c:pt>
                  <c:pt idx="5">
                    <c:v>6.5123275943930218E-3</c:v>
                  </c:pt>
                  <c:pt idx="6">
                    <c:v>9.2921644738398229E-2</c:v>
                  </c:pt>
                  <c:pt idx="7">
                    <c:v>2.183121701870536E-2</c:v>
                  </c:pt>
                  <c:pt idx="8">
                    <c:v>0.27850641530098091</c:v>
                  </c:pt>
                  <c:pt idx="9">
                    <c:v>0.12857435724921815</c:v>
                  </c:pt>
                </c:numCache>
              </c:numRef>
            </c:minus>
          </c:errBars>
          <c:cat>
            <c:strRef>
              <c:f>Sheet12!$Z$100:$AI$100</c:f>
              <c:strCache>
                <c:ptCount val="10"/>
                <c:pt idx="0">
                  <c:v>GSTU13</c:v>
                </c:pt>
                <c:pt idx="1">
                  <c:v>GSTU15</c:v>
                </c:pt>
                <c:pt idx="2">
                  <c:v>GSTU18</c:v>
                </c:pt>
                <c:pt idx="3">
                  <c:v>GSTZ1    </c:v>
                </c:pt>
                <c:pt idx="4">
                  <c:v>GSTZ3   </c:v>
                </c:pt>
                <c:pt idx="5">
                  <c:v>EF1G3    </c:v>
                </c:pt>
                <c:pt idx="6">
                  <c:v>GHR1     </c:v>
                </c:pt>
                <c:pt idx="7">
                  <c:v>GHR2    </c:v>
                </c:pt>
                <c:pt idx="8">
                  <c:v>GSTT1    </c:v>
                </c:pt>
                <c:pt idx="9">
                  <c:v>GSTT2    </c:v>
                </c:pt>
              </c:strCache>
            </c:strRef>
          </c:cat>
          <c:val>
            <c:numRef>
              <c:f>Sheet12!$Z$105:$AI$105</c:f>
              <c:numCache>
                <c:formatCode>0.00</c:formatCode>
                <c:ptCount val="10"/>
                <c:pt idx="0">
                  <c:v>0.4914368607123315</c:v>
                </c:pt>
                <c:pt idx="1">
                  <c:v>0.61833637301675548</c:v>
                </c:pt>
                <c:pt idx="2">
                  <c:v>1.4491597064440838</c:v>
                </c:pt>
                <c:pt idx="3">
                  <c:v>1.3119361835206778</c:v>
                </c:pt>
                <c:pt idx="4">
                  <c:v>1.1492462396618461</c:v>
                </c:pt>
                <c:pt idx="5">
                  <c:v>0.66435886638975372</c:v>
                </c:pt>
                <c:pt idx="6">
                  <c:v>1.7243446167424112</c:v>
                </c:pt>
                <c:pt idx="7">
                  <c:v>0.49506906125811501</c:v>
                </c:pt>
                <c:pt idx="8">
                  <c:v>1.54416735172897</c:v>
                </c:pt>
                <c:pt idx="9">
                  <c:v>1.5448883172179317</c:v>
                </c:pt>
              </c:numCache>
            </c:numRef>
          </c:val>
        </c:ser>
        <c:axId val="76581120"/>
        <c:axId val="76587008"/>
      </c:barChart>
      <c:catAx>
        <c:axId val="76581120"/>
        <c:scaling>
          <c:orientation val="minMax"/>
        </c:scaling>
        <c:axPos val="b"/>
        <c:tickLblPos val="nextTo"/>
        <c:crossAx val="76587008"/>
        <c:crosses val="autoZero"/>
        <c:auto val="1"/>
        <c:lblAlgn val="ctr"/>
        <c:lblOffset val="100"/>
      </c:catAx>
      <c:valAx>
        <c:axId val="76587008"/>
        <c:scaling>
          <c:orientation val="minMax"/>
        </c:scaling>
        <c:axPos val="l"/>
        <c:numFmt formatCode="0.0" sourceLinked="0"/>
        <c:tickLblPos val="nextTo"/>
        <c:crossAx val="76581120"/>
        <c:crosses val="autoZero"/>
        <c:crossBetween val="between"/>
      </c:valAx>
    </c:plotArea>
    <c:plotVisOnly val="1"/>
  </c:chart>
  <c:externalData r:id="rId1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0h</c:v>
          </c:tx>
          <c:errBars>
            <c:errBarType val="both"/>
            <c:errValType val="cust"/>
            <c:plus>
              <c:numRef>
                <c:f>Sheet12!$AA$146:$AJ$146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</c:numCache>
              </c:numRef>
            </c:plus>
            <c:minus>
              <c:numRef>
                <c:f>Sheet12!$AA$146:$AJ$146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</c:numCache>
              </c:numRef>
            </c:minus>
          </c:errBars>
          <c:cat>
            <c:strRef>
              <c:f>Sheet12!$AA$136:$AJ$136</c:f>
              <c:strCache>
                <c:ptCount val="10"/>
                <c:pt idx="0">
                  <c:v>GSTU18</c:v>
                </c:pt>
                <c:pt idx="1">
                  <c:v>GSTF1</c:v>
                </c:pt>
                <c:pt idx="2">
                  <c:v>GSTF3</c:v>
                </c:pt>
                <c:pt idx="3">
                  <c:v>GSTZ1    </c:v>
                </c:pt>
                <c:pt idx="4">
                  <c:v>GSTZ3   </c:v>
                </c:pt>
                <c:pt idx="5">
                  <c:v>EF1G1    </c:v>
                </c:pt>
                <c:pt idx="6">
                  <c:v>EF1G3    </c:v>
                </c:pt>
                <c:pt idx="7">
                  <c:v>GHR1     </c:v>
                </c:pt>
                <c:pt idx="8">
                  <c:v>GHR2    </c:v>
                </c:pt>
                <c:pt idx="9">
                  <c:v>GSTT1    </c:v>
                </c:pt>
              </c:strCache>
            </c:strRef>
          </c:cat>
          <c:val>
            <c:numRef>
              <c:f>Sheet12!$AA$137:$AJ$137</c:f>
              <c:numCache>
                <c:formatCode>0.00</c:formatCode>
                <c:ptCount val="1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</c:ser>
        <c:ser>
          <c:idx val="1"/>
          <c:order val="1"/>
          <c:tx>
            <c:v>6h</c:v>
          </c:tx>
          <c:errBars>
            <c:errBarType val="both"/>
            <c:errValType val="cust"/>
            <c:plus>
              <c:numRef>
                <c:f>Sheet12!$AA$147:$AJ$147</c:f>
                <c:numCache>
                  <c:formatCode>General</c:formatCode>
                  <c:ptCount val="10"/>
                  <c:pt idx="0">
                    <c:v>2.0867819165754496E-2</c:v>
                  </c:pt>
                  <c:pt idx="1">
                    <c:v>4.6050791394113492E-2</c:v>
                  </c:pt>
                  <c:pt idx="2">
                    <c:v>4.8953718879403529E-2</c:v>
                  </c:pt>
                  <c:pt idx="3">
                    <c:v>5.5870791395110801E-2</c:v>
                  </c:pt>
                  <c:pt idx="4">
                    <c:v>8.3005557413789247E-3</c:v>
                  </c:pt>
                  <c:pt idx="5">
                    <c:v>3.278812207481361E-3</c:v>
                  </c:pt>
                  <c:pt idx="6">
                    <c:v>5.8235320650176364E-2</c:v>
                  </c:pt>
                  <c:pt idx="7">
                    <c:v>1.7732458338817064E-2</c:v>
                  </c:pt>
                  <c:pt idx="8">
                    <c:v>0.11752531831945859</c:v>
                  </c:pt>
                  <c:pt idx="9">
                    <c:v>0.103753313010816</c:v>
                  </c:pt>
                </c:numCache>
              </c:numRef>
            </c:plus>
            <c:minus>
              <c:numRef>
                <c:f>Sheet12!$AA$147:$AJ$147</c:f>
                <c:numCache>
                  <c:formatCode>General</c:formatCode>
                  <c:ptCount val="10"/>
                  <c:pt idx="0">
                    <c:v>2.0867819165754496E-2</c:v>
                  </c:pt>
                  <c:pt idx="1">
                    <c:v>4.6050791394113492E-2</c:v>
                  </c:pt>
                  <c:pt idx="2">
                    <c:v>4.8953718879403529E-2</c:v>
                  </c:pt>
                  <c:pt idx="3">
                    <c:v>5.5870791395110801E-2</c:v>
                  </c:pt>
                  <c:pt idx="4">
                    <c:v>8.3005557413789247E-3</c:v>
                  </c:pt>
                  <c:pt idx="5">
                    <c:v>3.278812207481361E-3</c:v>
                  </c:pt>
                  <c:pt idx="6">
                    <c:v>5.8235320650176364E-2</c:v>
                  </c:pt>
                  <c:pt idx="7">
                    <c:v>1.7732458338817064E-2</c:v>
                  </c:pt>
                  <c:pt idx="8">
                    <c:v>0.11752531831945859</c:v>
                  </c:pt>
                  <c:pt idx="9">
                    <c:v>0.103753313010816</c:v>
                  </c:pt>
                </c:numCache>
              </c:numRef>
            </c:minus>
          </c:errBars>
          <c:cat>
            <c:strRef>
              <c:f>Sheet12!$AA$136:$AJ$136</c:f>
              <c:strCache>
                <c:ptCount val="10"/>
                <c:pt idx="0">
                  <c:v>GSTU18</c:v>
                </c:pt>
                <c:pt idx="1">
                  <c:v>GSTF1</c:v>
                </c:pt>
                <c:pt idx="2">
                  <c:v>GSTF3</c:v>
                </c:pt>
                <c:pt idx="3">
                  <c:v>GSTZ1    </c:v>
                </c:pt>
                <c:pt idx="4">
                  <c:v>GSTZ3   </c:v>
                </c:pt>
                <c:pt idx="5">
                  <c:v>EF1G1    </c:v>
                </c:pt>
                <c:pt idx="6">
                  <c:v>EF1G3    </c:v>
                </c:pt>
                <c:pt idx="7">
                  <c:v>GHR1     </c:v>
                </c:pt>
                <c:pt idx="8">
                  <c:v>GHR2    </c:v>
                </c:pt>
                <c:pt idx="9">
                  <c:v>GSTT1    </c:v>
                </c:pt>
              </c:strCache>
            </c:strRef>
          </c:cat>
          <c:val>
            <c:numRef>
              <c:f>Sheet12!$AA$138:$AJ$138</c:f>
              <c:numCache>
                <c:formatCode>0.00</c:formatCode>
                <c:ptCount val="10"/>
                <c:pt idx="0">
                  <c:v>1.064472460063751</c:v>
                </c:pt>
                <c:pt idx="1">
                  <c:v>0.34900197536635558</c:v>
                </c:pt>
                <c:pt idx="2">
                  <c:v>1.2488103909789738</c:v>
                </c:pt>
                <c:pt idx="3">
                  <c:v>0.63411017296710193</c:v>
                </c:pt>
                <c:pt idx="4">
                  <c:v>0.42341333896653022</c:v>
                </c:pt>
                <c:pt idx="5">
                  <c:v>0.33448992387027709</c:v>
                </c:pt>
                <c:pt idx="6">
                  <c:v>0.47645387178437615</c:v>
                </c:pt>
                <c:pt idx="7">
                  <c:v>0.40212103136873556</c:v>
                </c:pt>
                <c:pt idx="8">
                  <c:v>3.66952042416073</c:v>
                </c:pt>
                <c:pt idx="9">
                  <c:v>0.76578359756214165</c:v>
                </c:pt>
              </c:numCache>
            </c:numRef>
          </c:val>
        </c:ser>
        <c:ser>
          <c:idx val="2"/>
          <c:order val="2"/>
          <c:tx>
            <c:v>24h</c:v>
          </c:tx>
          <c:errBars>
            <c:errBarType val="both"/>
            <c:errValType val="cust"/>
            <c:plus>
              <c:numRef>
                <c:f>Sheet12!$AA$148:$AJ$148</c:f>
                <c:numCache>
                  <c:formatCode>General</c:formatCode>
                  <c:ptCount val="10"/>
                  <c:pt idx="0">
                    <c:v>5.8694525567830426E-2</c:v>
                  </c:pt>
                  <c:pt idx="1">
                    <c:v>8.865660966938518E-3</c:v>
                  </c:pt>
                  <c:pt idx="2">
                    <c:v>4.9958237786373323E-2</c:v>
                  </c:pt>
                  <c:pt idx="3">
                    <c:v>8.4677161460879516E-2</c:v>
                  </c:pt>
                  <c:pt idx="4">
                    <c:v>3.222464823217603E-3</c:v>
                  </c:pt>
                  <c:pt idx="5">
                    <c:v>7.9800210833906177E-2</c:v>
                  </c:pt>
                  <c:pt idx="6">
                    <c:v>1.92546059551084E-2</c:v>
                  </c:pt>
                  <c:pt idx="7">
                    <c:v>2.981451132535114E-2</c:v>
                  </c:pt>
                  <c:pt idx="8">
                    <c:v>1.4321321367173846E-3</c:v>
                  </c:pt>
                  <c:pt idx="9">
                    <c:v>0.32503124525233001</c:v>
                  </c:pt>
                </c:numCache>
              </c:numRef>
            </c:plus>
            <c:minus>
              <c:numRef>
                <c:f>Sheet12!$AA$148:$AJ$148</c:f>
                <c:numCache>
                  <c:formatCode>General</c:formatCode>
                  <c:ptCount val="10"/>
                  <c:pt idx="0">
                    <c:v>5.8694525567830426E-2</c:v>
                  </c:pt>
                  <c:pt idx="1">
                    <c:v>8.865660966938518E-3</c:v>
                  </c:pt>
                  <c:pt idx="2">
                    <c:v>4.9958237786373323E-2</c:v>
                  </c:pt>
                  <c:pt idx="3">
                    <c:v>8.4677161460879516E-2</c:v>
                  </c:pt>
                  <c:pt idx="4">
                    <c:v>3.222464823217603E-3</c:v>
                  </c:pt>
                  <c:pt idx="5">
                    <c:v>7.9800210833906177E-2</c:v>
                  </c:pt>
                  <c:pt idx="6">
                    <c:v>1.92546059551084E-2</c:v>
                  </c:pt>
                  <c:pt idx="7">
                    <c:v>2.981451132535114E-2</c:v>
                  </c:pt>
                  <c:pt idx="8">
                    <c:v>1.4321321367173846E-3</c:v>
                  </c:pt>
                  <c:pt idx="9">
                    <c:v>0.32503124525233001</c:v>
                  </c:pt>
                </c:numCache>
              </c:numRef>
            </c:minus>
          </c:errBars>
          <c:cat>
            <c:strRef>
              <c:f>Sheet12!$AA$136:$AJ$136</c:f>
              <c:strCache>
                <c:ptCount val="10"/>
                <c:pt idx="0">
                  <c:v>GSTU18</c:v>
                </c:pt>
                <c:pt idx="1">
                  <c:v>GSTF1</c:v>
                </c:pt>
                <c:pt idx="2">
                  <c:v>GSTF3</c:v>
                </c:pt>
                <c:pt idx="3">
                  <c:v>GSTZ1    </c:v>
                </c:pt>
                <c:pt idx="4">
                  <c:v>GSTZ3   </c:v>
                </c:pt>
                <c:pt idx="5">
                  <c:v>EF1G1    </c:v>
                </c:pt>
                <c:pt idx="6">
                  <c:v>EF1G3    </c:v>
                </c:pt>
                <c:pt idx="7">
                  <c:v>GHR1     </c:v>
                </c:pt>
                <c:pt idx="8">
                  <c:v>GHR2    </c:v>
                </c:pt>
                <c:pt idx="9">
                  <c:v>GSTT1    </c:v>
                </c:pt>
              </c:strCache>
            </c:strRef>
          </c:cat>
          <c:val>
            <c:numRef>
              <c:f>Sheet12!$AA$139:$AJ$139</c:f>
              <c:numCache>
                <c:formatCode>0.00</c:formatCode>
                <c:ptCount val="10"/>
                <c:pt idx="0">
                  <c:v>0.44482417665860302</c:v>
                </c:pt>
                <c:pt idx="1">
                  <c:v>0.30151713434680538</c:v>
                </c:pt>
                <c:pt idx="2">
                  <c:v>0.34098587813789238</c:v>
                </c:pt>
                <c:pt idx="3">
                  <c:v>1.0808879207878108</c:v>
                </c:pt>
                <c:pt idx="4">
                  <c:v>0.65747532865781388</c:v>
                </c:pt>
                <c:pt idx="5">
                  <c:v>1.8096387128528382</c:v>
                </c:pt>
                <c:pt idx="6">
                  <c:v>0.20706068663273094</c:v>
                </c:pt>
                <c:pt idx="7">
                  <c:v>0.55326713436259722</c:v>
                </c:pt>
                <c:pt idx="8">
                  <c:v>0.29219606696254197</c:v>
                </c:pt>
                <c:pt idx="9">
                  <c:v>3.7297248610580058</c:v>
                </c:pt>
              </c:numCache>
            </c:numRef>
          </c:val>
        </c:ser>
        <c:ser>
          <c:idx val="3"/>
          <c:order val="3"/>
          <c:tx>
            <c:v>48h</c:v>
          </c:tx>
          <c:errBars>
            <c:errBarType val="both"/>
            <c:errValType val="cust"/>
            <c:plus>
              <c:numRef>
                <c:f>Sheet12!$AA$149:$AJ$149</c:f>
                <c:numCache>
                  <c:formatCode>General</c:formatCode>
                  <c:ptCount val="10"/>
                  <c:pt idx="0">
                    <c:v>1.5381776344657217E-2</c:v>
                  </c:pt>
                  <c:pt idx="1">
                    <c:v>0.12447462349778254</c:v>
                  </c:pt>
                  <c:pt idx="2">
                    <c:v>8.9175209998651528E-2</c:v>
                  </c:pt>
                  <c:pt idx="3">
                    <c:v>0.55435233112043958</c:v>
                  </c:pt>
                  <c:pt idx="4">
                    <c:v>0.2564938127013846</c:v>
                  </c:pt>
                  <c:pt idx="5">
                    <c:v>0.42512773669166032</c:v>
                  </c:pt>
                  <c:pt idx="6">
                    <c:v>5.0247535890998431E-2</c:v>
                  </c:pt>
                  <c:pt idx="7">
                    <c:v>0.16473024792725749</c:v>
                  </c:pt>
                  <c:pt idx="8">
                    <c:v>3.023070639365015E-2</c:v>
                  </c:pt>
                  <c:pt idx="9">
                    <c:v>8.2658398009232206E-2</c:v>
                  </c:pt>
                </c:numCache>
              </c:numRef>
            </c:plus>
            <c:minus>
              <c:numRef>
                <c:f>Sheet12!$AA$149:$AJ$149</c:f>
                <c:numCache>
                  <c:formatCode>General</c:formatCode>
                  <c:ptCount val="10"/>
                  <c:pt idx="0">
                    <c:v>1.5381776344657217E-2</c:v>
                  </c:pt>
                  <c:pt idx="1">
                    <c:v>0.12447462349778254</c:v>
                  </c:pt>
                  <c:pt idx="2">
                    <c:v>8.9175209998651528E-2</c:v>
                  </c:pt>
                  <c:pt idx="3">
                    <c:v>0.55435233112043958</c:v>
                  </c:pt>
                  <c:pt idx="4">
                    <c:v>0.2564938127013846</c:v>
                  </c:pt>
                  <c:pt idx="5">
                    <c:v>0.42512773669166032</c:v>
                  </c:pt>
                  <c:pt idx="6">
                    <c:v>5.0247535890998431E-2</c:v>
                  </c:pt>
                  <c:pt idx="7">
                    <c:v>0.16473024792725749</c:v>
                  </c:pt>
                  <c:pt idx="8">
                    <c:v>3.023070639365015E-2</c:v>
                  </c:pt>
                  <c:pt idx="9">
                    <c:v>8.2658398009232206E-2</c:v>
                  </c:pt>
                </c:numCache>
              </c:numRef>
            </c:minus>
          </c:errBars>
          <c:cat>
            <c:strRef>
              <c:f>Sheet12!$AA$136:$AJ$136</c:f>
              <c:strCache>
                <c:ptCount val="10"/>
                <c:pt idx="0">
                  <c:v>GSTU18</c:v>
                </c:pt>
                <c:pt idx="1">
                  <c:v>GSTF1</c:v>
                </c:pt>
                <c:pt idx="2">
                  <c:v>GSTF3</c:v>
                </c:pt>
                <c:pt idx="3">
                  <c:v>GSTZ1    </c:v>
                </c:pt>
                <c:pt idx="4">
                  <c:v>GSTZ3   </c:v>
                </c:pt>
                <c:pt idx="5">
                  <c:v>EF1G1    </c:v>
                </c:pt>
                <c:pt idx="6">
                  <c:v>EF1G3    </c:v>
                </c:pt>
                <c:pt idx="7">
                  <c:v>GHR1     </c:v>
                </c:pt>
                <c:pt idx="8">
                  <c:v>GHR2    </c:v>
                </c:pt>
                <c:pt idx="9">
                  <c:v>GSTT1    </c:v>
                </c:pt>
              </c:strCache>
            </c:strRef>
          </c:cat>
          <c:val>
            <c:numRef>
              <c:f>Sheet12!$AA$140:$AJ$140</c:f>
              <c:numCache>
                <c:formatCode>0.00</c:formatCode>
                <c:ptCount val="10"/>
                <c:pt idx="0">
                  <c:v>1.0461414822013773</c:v>
                </c:pt>
                <c:pt idx="1">
                  <c:v>0.63896940829923166</c:v>
                </c:pt>
                <c:pt idx="2">
                  <c:v>0.62949833835168212</c:v>
                </c:pt>
                <c:pt idx="3">
                  <c:v>1.2628922491706758</c:v>
                </c:pt>
                <c:pt idx="4">
                  <c:v>1.8748591390185951</c:v>
                </c:pt>
                <c:pt idx="5">
                  <c:v>4.1376671827862133</c:v>
                </c:pt>
                <c:pt idx="6">
                  <c:v>0.29434660432678456</c:v>
                </c:pt>
                <c:pt idx="7">
                  <c:v>0.99308759669193858</c:v>
                </c:pt>
                <c:pt idx="8">
                  <c:v>0.5609904557432206</c:v>
                </c:pt>
                <c:pt idx="9">
                  <c:v>1.2981560136933281</c:v>
                </c:pt>
              </c:numCache>
            </c:numRef>
          </c:val>
        </c:ser>
        <c:ser>
          <c:idx val="4"/>
          <c:order val="4"/>
          <c:tx>
            <c:v>72h</c:v>
          </c:tx>
          <c:errBars>
            <c:errBarType val="both"/>
            <c:errValType val="cust"/>
            <c:plus>
              <c:numRef>
                <c:f>Sheet12!$AA$150:$AJ$150</c:f>
                <c:numCache>
                  <c:formatCode>General</c:formatCode>
                  <c:ptCount val="10"/>
                  <c:pt idx="0">
                    <c:v>4.9148977513650001E-2</c:v>
                  </c:pt>
                  <c:pt idx="1">
                    <c:v>3.214358931230455E-2</c:v>
                  </c:pt>
                  <c:pt idx="2">
                    <c:v>0.10665647760965503</c:v>
                  </c:pt>
                  <c:pt idx="3">
                    <c:v>8.871355602913808E-2</c:v>
                  </c:pt>
                  <c:pt idx="4">
                    <c:v>6.1305422657173522E-2</c:v>
                  </c:pt>
                  <c:pt idx="5">
                    <c:v>8.4636492262608332E-2</c:v>
                  </c:pt>
                  <c:pt idx="6">
                    <c:v>1.3229641701430851E-2</c:v>
                  </c:pt>
                  <c:pt idx="7">
                    <c:v>0.23364597923738681</c:v>
                  </c:pt>
                  <c:pt idx="8">
                    <c:v>1.9140280758653583E-2</c:v>
                  </c:pt>
                  <c:pt idx="9">
                    <c:v>5.7223668621466793E-2</c:v>
                  </c:pt>
                </c:numCache>
              </c:numRef>
            </c:plus>
            <c:minus>
              <c:numRef>
                <c:f>Sheet12!$AA$150:$AJ$150</c:f>
                <c:numCache>
                  <c:formatCode>General</c:formatCode>
                  <c:ptCount val="10"/>
                  <c:pt idx="0">
                    <c:v>4.9148977513650001E-2</c:v>
                  </c:pt>
                  <c:pt idx="1">
                    <c:v>3.214358931230455E-2</c:v>
                  </c:pt>
                  <c:pt idx="2">
                    <c:v>0.10665647760965503</c:v>
                  </c:pt>
                  <c:pt idx="3">
                    <c:v>8.871355602913808E-2</c:v>
                  </c:pt>
                  <c:pt idx="4">
                    <c:v>6.1305422657173522E-2</c:v>
                  </c:pt>
                  <c:pt idx="5">
                    <c:v>8.4636492262608332E-2</c:v>
                  </c:pt>
                  <c:pt idx="6">
                    <c:v>1.3229641701430851E-2</c:v>
                  </c:pt>
                  <c:pt idx="7">
                    <c:v>0.23364597923738681</c:v>
                  </c:pt>
                  <c:pt idx="8">
                    <c:v>1.9140280758653583E-2</c:v>
                  </c:pt>
                  <c:pt idx="9">
                    <c:v>5.7223668621466793E-2</c:v>
                  </c:pt>
                </c:numCache>
              </c:numRef>
            </c:minus>
          </c:errBars>
          <c:cat>
            <c:strRef>
              <c:f>Sheet12!$AA$136:$AJ$136</c:f>
              <c:strCache>
                <c:ptCount val="10"/>
                <c:pt idx="0">
                  <c:v>GSTU18</c:v>
                </c:pt>
                <c:pt idx="1">
                  <c:v>GSTF1</c:v>
                </c:pt>
                <c:pt idx="2">
                  <c:v>GSTF3</c:v>
                </c:pt>
                <c:pt idx="3">
                  <c:v>GSTZ1    </c:v>
                </c:pt>
                <c:pt idx="4">
                  <c:v>GSTZ3   </c:v>
                </c:pt>
                <c:pt idx="5">
                  <c:v>EF1G1    </c:v>
                </c:pt>
                <c:pt idx="6">
                  <c:v>EF1G3    </c:v>
                </c:pt>
                <c:pt idx="7">
                  <c:v>GHR1     </c:v>
                </c:pt>
                <c:pt idx="8">
                  <c:v>GHR2    </c:v>
                </c:pt>
                <c:pt idx="9">
                  <c:v>GSTT1    </c:v>
                </c:pt>
              </c:strCache>
            </c:strRef>
          </c:cat>
          <c:val>
            <c:numRef>
              <c:f>Sheet12!$AA$141:$AJ$141</c:f>
              <c:numCache>
                <c:formatCode>0.00</c:formatCode>
                <c:ptCount val="10"/>
                <c:pt idx="0">
                  <c:v>0.77188818393383762</c:v>
                </c:pt>
                <c:pt idx="1">
                  <c:v>0.3862220793044861</c:v>
                </c:pt>
                <c:pt idx="2">
                  <c:v>0.60760260980193859</c:v>
                </c:pt>
                <c:pt idx="3">
                  <c:v>1.2938743703962934</c:v>
                </c:pt>
                <c:pt idx="4">
                  <c:v>1.137643181345134</c:v>
                </c:pt>
                <c:pt idx="5">
                  <c:v>4.3173277674281945</c:v>
                </c:pt>
                <c:pt idx="6">
                  <c:v>0.18010980145404942</c:v>
                </c:pt>
                <c:pt idx="7">
                  <c:v>1.0918007182060978</c:v>
                </c:pt>
                <c:pt idx="8">
                  <c:v>0.32561685954366093</c:v>
                </c:pt>
                <c:pt idx="9">
                  <c:v>0.97349623566341925</c:v>
                </c:pt>
              </c:numCache>
            </c:numRef>
          </c:val>
        </c:ser>
        <c:axId val="76830592"/>
        <c:axId val="76832128"/>
      </c:barChart>
      <c:catAx>
        <c:axId val="76830592"/>
        <c:scaling>
          <c:orientation val="minMax"/>
        </c:scaling>
        <c:axPos val="b"/>
        <c:tickLblPos val="nextTo"/>
        <c:crossAx val="76832128"/>
        <c:crosses val="autoZero"/>
        <c:auto val="1"/>
        <c:lblAlgn val="ctr"/>
        <c:lblOffset val="100"/>
      </c:catAx>
      <c:valAx>
        <c:axId val="76832128"/>
        <c:scaling>
          <c:orientation val="minMax"/>
        </c:scaling>
        <c:axPos val="l"/>
        <c:numFmt formatCode="0.0" sourceLinked="0"/>
        <c:tickLblPos val="nextTo"/>
        <c:crossAx val="76830592"/>
        <c:crosses val="autoZero"/>
        <c:crossBetween val="between"/>
      </c:valAx>
    </c:plotArea>
    <c:plotVisOnly val="1"/>
  </c:chart>
  <c:externalData r:id="rId1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0h</c:v>
          </c:tx>
          <c:errBars>
            <c:errBarType val="both"/>
            <c:errValType val="cust"/>
            <c:plus>
              <c:numRef>
                <c:f>Sheet12!$AA$171:$AJ$171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</c:numCache>
              </c:numRef>
            </c:plus>
            <c:minus>
              <c:numRef>
                <c:f>Sheet12!$AA$171:$AJ$171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</c:numCache>
              </c:numRef>
            </c:minus>
          </c:errBars>
          <c:cat>
            <c:strRef>
              <c:f>Sheet12!$AA$162:$AJ$162</c:f>
              <c:strCache>
                <c:ptCount val="10"/>
                <c:pt idx="0">
                  <c:v>GSTU18</c:v>
                </c:pt>
                <c:pt idx="1">
                  <c:v>GSTF1</c:v>
                </c:pt>
                <c:pt idx="2">
                  <c:v>GSTF3</c:v>
                </c:pt>
                <c:pt idx="3">
                  <c:v>GSTZ1    </c:v>
                </c:pt>
                <c:pt idx="4">
                  <c:v>GSTZ3   </c:v>
                </c:pt>
                <c:pt idx="5">
                  <c:v>EF1G1    </c:v>
                </c:pt>
                <c:pt idx="6">
                  <c:v>EF1G3    </c:v>
                </c:pt>
                <c:pt idx="7">
                  <c:v>GHR1     </c:v>
                </c:pt>
                <c:pt idx="8">
                  <c:v>GHR2    </c:v>
                </c:pt>
                <c:pt idx="9">
                  <c:v>GSTT1    </c:v>
                </c:pt>
              </c:strCache>
            </c:strRef>
          </c:cat>
          <c:val>
            <c:numRef>
              <c:f>Sheet12!$AA$163:$AJ$163</c:f>
              <c:numCache>
                <c:formatCode>0.00</c:formatCode>
                <c:ptCount val="1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</c:ser>
        <c:ser>
          <c:idx val="1"/>
          <c:order val="1"/>
          <c:tx>
            <c:v>6h</c:v>
          </c:tx>
          <c:errBars>
            <c:errBarType val="both"/>
            <c:errValType val="cust"/>
            <c:plus>
              <c:numRef>
                <c:f>Sheet12!$AA$172:$AJ$172</c:f>
                <c:numCache>
                  <c:formatCode>General</c:formatCode>
                  <c:ptCount val="10"/>
                  <c:pt idx="0">
                    <c:v>6.2529242344405003E-2</c:v>
                  </c:pt>
                  <c:pt idx="1">
                    <c:v>6.6162543182454417E-2</c:v>
                  </c:pt>
                  <c:pt idx="2">
                    <c:v>0.16231479343886646</c:v>
                  </c:pt>
                  <c:pt idx="3">
                    <c:v>0.10498375906459806</c:v>
                  </c:pt>
                  <c:pt idx="4">
                    <c:v>0.13472021456399091</c:v>
                  </c:pt>
                  <c:pt idx="5">
                    <c:v>5.9305446697958423E-3</c:v>
                  </c:pt>
                  <c:pt idx="6">
                    <c:v>0.11562032050369279</c:v>
                  </c:pt>
                  <c:pt idx="7">
                    <c:v>2.7582057200305609E-2</c:v>
                  </c:pt>
                  <c:pt idx="8">
                    <c:v>2.5109510847015015E-2</c:v>
                  </c:pt>
                  <c:pt idx="9">
                    <c:v>7.6020713092298062E-2</c:v>
                  </c:pt>
                </c:numCache>
              </c:numRef>
            </c:plus>
            <c:minus>
              <c:numRef>
                <c:f>Sheet12!$AA$172:$AJ$172</c:f>
                <c:numCache>
                  <c:formatCode>General</c:formatCode>
                  <c:ptCount val="10"/>
                  <c:pt idx="0">
                    <c:v>6.2529242344405003E-2</c:v>
                  </c:pt>
                  <c:pt idx="1">
                    <c:v>6.6162543182454417E-2</c:v>
                  </c:pt>
                  <c:pt idx="2">
                    <c:v>0.16231479343886646</c:v>
                  </c:pt>
                  <c:pt idx="3">
                    <c:v>0.10498375906459806</c:v>
                  </c:pt>
                  <c:pt idx="4">
                    <c:v>0.13472021456399091</c:v>
                  </c:pt>
                  <c:pt idx="5">
                    <c:v>5.9305446697958423E-3</c:v>
                  </c:pt>
                  <c:pt idx="6">
                    <c:v>0.11562032050369279</c:v>
                  </c:pt>
                  <c:pt idx="7">
                    <c:v>2.7582057200305609E-2</c:v>
                  </c:pt>
                  <c:pt idx="8">
                    <c:v>2.5109510847015015E-2</c:v>
                  </c:pt>
                  <c:pt idx="9">
                    <c:v>7.6020713092298062E-2</c:v>
                  </c:pt>
                </c:numCache>
              </c:numRef>
            </c:minus>
          </c:errBars>
          <c:cat>
            <c:strRef>
              <c:f>Sheet12!$AA$162:$AJ$162</c:f>
              <c:strCache>
                <c:ptCount val="10"/>
                <c:pt idx="0">
                  <c:v>GSTU18</c:v>
                </c:pt>
                <c:pt idx="1">
                  <c:v>GSTF1</c:v>
                </c:pt>
                <c:pt idx="2">
                  <c:v>GSTF3</c:v>
                </c:pt>
                <c:pt idx="3">
                  <c:v>GSTZ1    </c:v>
                </c:pt>
                <c:pt idx="4">
                  <c:v>GSTZ3   </c:v>
                </c:pt>
                <c:pt idx="5">
                  <c:v>EF1G1    </c:v>
                </c:pt>
                <c:pt idx="6">
                  <c:v>EF1G3    </c:v>
                </c:pt>
                <c:pt idx="7">
                  <c:v>GHR1     </c:v>
                </c:pt>
                <c:pt idx="8">
                  <c:v>GHR2    </c:v>
                </c:pt>
                <c:pt idx="9">
                  <c:v>GSTT1    </c:v>
                </c:pt>
              </c:strCache>
            </c:strRef>
          </c:cat>
          <c:val>
            <c:numRef>
              <c:f>Sheet12!$AA$164:$AJ$164</c:f>
              <c:numCache>
                <c:formatCode>0.00</c:formatCode>
                <c:ptCount val="10"/>
                <c:pt idx="0">
                  <c:v>0.75132163247073736</c:v>
                </c:pt>
                <c:pt idx="1">
                  <c:v>1.227776644374394</c:v>
                </c:pt>
                <c:pt idx="2">
                  <c:v>1.1078663865645515</c:v>
                </c:pt>
                <c:pt idx="3">
                  <c:v>1.1915218660212521</c:v>
                </c:pt>
                <c:pt idx="4">
                  <c:v>1.102217127337829</c:v>
                </c:pt>
                <c:pt idx="5">
                  <c:v>1.2100013560429028</c:v>
                </c:pt>
                <c:pt idx="6">
                  <c:v>1.0278135593967221</c:v>
                </c:pt>
                <c:pt idx="7">
                  <c:v>0.80408755758216321</c:v>
                </c:pt>
                <c:pt idx="8">
                  <c:v>1.0247106554489216</c:v>
                </c:pt>
                <c:pt idx="9">
                  <c:v>1.7239306005949386</c:v>
                </c:pt>
              </c:numCache>
            </c:numRef>
          </c:val>
        </c:ser>
        <c:ser>
          <c:idx val="2"/>
          <c:order val="2"/>
          <c:tx>
            <c:v>24h</c:v>
          </c:tx>
          <c:errBars>
            <c:errBarType val="both"/>
            <c:errValType val="cust"/>
            <c:plus>
              <c:numRef>
                <c:f>Sheet12!$AA$173:$AJ$173</c:f>
                <c:numCache>
                  <c:formatCode>General</c:formatCode>
                  <c:ptCount val="10"/>
                  <c:pt idx="0">
                    <c:v>9.9744267145071328E-2</c:v>
                  </c:pt>
                  <c:pt idx="1">
                    <c:v>8.2432196147202708E-3</c:v>
                  </c:pt>
                  <c:pt idx="2">
                    <c:v>7.8430699180570912E-2</c:v>
                  </c:pt>
                  <c:pt idx="3">
                    <c:v>0.2086807979020408</c:v>
                  </c:pt>
                  <c:pt idx="4">
                    <c:v>0.17547630734434791</c:v>
                  </c:pt>
                  <c:pt idx="5">
                    <c:v>5.4114480268352722E-2</c:v>
                  </c:pt>
                  <c:pt idx="6">
                    <c:v>4.7307299947270502E-2</c:v>
                  </c:pt>
                  <c:pt idx="7">
                    <c:v>4.5423866738693384E-2</c:v>
                  </c:pt>
                  <c:pt idx="8">
                    <c:v>1.9071501896745412E-2</c:v>
                  </c:pt>
                  <c:pt idx="9">
                    <c:v>8.2715896162061011E-3</c:v>
                  </c:pt>
                </c:numCache>
              </c:numRef>
            </c:plus>
            <c:minus>
              <c:numRef>
                <c:f>Sheet12!$AA$173:$AJ$173</c:f>
                <c:numCache>
                  <c:formatCode>General</c:formatCode>
                  <c:ptCount val="10"/>
                  <c:pt idx="0">
                    <c:v>9.9744267145071328E-2</c:v>
                  </c:pt>
                  <c:pt idx="1">
                    <c:v>8.2432196147202708E-3</c:v>
                  </c:pt>
                  <c:pt idx="2">
                    <c:v>7.8430699180570912E-2</c:v>
                  </c:pt>
                  <c:pt idx="3">
                    <c:v>0.2086807979020408</c:v>
                  </c:pt>
                  <c:pt idx="4">
                    <c:v>0.17547630734434791</c:v>
                  </c:pt>
                  <c:pt idx="5">
                    <c:v>5.4114480268352722E-2</c:v>
                  </c:pt>
                  <c:pt idx="6">
                    <c:v>4.7307299947270502E-2</c:v>
                  </c:pt>
                  <c:pt idx="7">
                    <c:v>4.5423866738693384E-2</c:v>
                  </c:pt>
                  <c:pt idx="8">
                    <c:v>1.9071501896745412E-2</c:v>
                  </c:pt>
                  <c:pt idx="9">
                    <c:v>8.2715896162061011E-3</c:v>
                  </c:pt>
                </c:numCache>
              </c:numRef>
            </c:minus>
          </c:errBars>
          <c:cat>
            <c:strRef>
              <c:f>Sheet12!$AA$162:$AJ$162</c:f>
              <c:strCache>
                <c:ptCount val="10"/>
                <c:pt idx="0">
                  <c:v>GSTU18</c:v>
                </c:pt>
                <c:pt idx="1">
                  <c:v>GSTF1</c:v>
                </c:pt>
                <c:pt idx="2">
                  <c:v>GSTF3</c:v>
                </c:pt>
                <c:pt idx="3">
                  <c:v>GSTZ1    </c:v>
                </c:pt>
                <c:pt idx="4">
                  <c:v>GSTZ3   </c:v>
                </c:pt>
                <c:pt idx="5">
                  <c:v>EF1G1    </c:v>
                </c:pt>
                <c:pt idx="6">
                  <c:v>EF1G3    </c:v>
                </c:pt>
                <c:pt idx="7">
                  <c:v>GHR1     </c:v>
                </c:pt>
                <c:pt idx="8">
                  <c:v>GHR2    </c:v>
                </c:pt>
                <c:pt idx="9">
                  <c:v>GSTT1    </c:v>
                </c:pt>
              </c:strCache>
            </c:strRef>
          </c:cat>
          <c:val>
            <c:numRef>
              <c:f>Sheet12!$AA$165:$AJ$165</c:f>
              <c:numCache>
                <c:formatCode>0.00</c:formatCode>
                <c:ptCount val="10"/>
                <c:pt idx="0">
                  <c:v>4.0705298476827609</c:v>
                </c:pt>
                <c:pt idx="1">
                  <c:v>0.42048860939560151</c:v>
                </c:pt>
                <c:pt idx="2">
                  <c:v>2.0007687740683542</c:v>
                </c:pt>
                <c:pt idx="3">
                  <c:v>1.5815148553157798</c:v>
                </c:pt>
                <c:pt idx="4">
                  <c:v>1.1593454107021426</c:v>
                </c:pt>
                <c:pt idx="5">
                  <c:v>1.0042010448829828</c:v>
                </c:pt>
                <c:pt idx="6">
                  <c:v>0.43957751077045903</c:v>
                </c:pt>
                <c:pt idx="7">
                  <c:v>0.92714459512661851</c:v>
                </c:pt>
                <c:pt idx="8">
                  <c:v>0.48651441168139931</c:v>
                </c:pt>
                <c:pt idx="9">
                  <c:v>1.6876417276162461</c:v>
                </c:pt>
              </c:numCache>
            </c:numRef>
          </c:val>
        </c:ser>
        <c:ser>
          <c:idx val="3"/>
          <c:order val="3"/>
          <c:tx>
            <c:v>48h</c:v>
          </c:tx>
          <c:errBars>
            <c:errBarType val="both"/>
            <c:errValType val="cust"/>
            <c:plus>
              <c:numRef>
                <c:f>Sheet12!$AA$174:$AJ$174</c:f>
                <c:numCache>
                  <c:formatCode>General</c:formatCode>
                  <c:ptCount val="10"/>
                  <c:pt idx="0">
                    <c:v>0.55263207269360182</c:v>
                  </c:pt>
                  <c:pt idx="1">
                    <c:v>0.49937885214181915</c:v>
                  </c:pt>
                  <c:pt idx="2">
                    <c:v>0.45293186038457173</c:v>
                  </c:pt>
                  <c:pt idx="3">
                    <c:v>0.66877569946524196</c:v>
                  </c:pt>
                  <c:pt idx="4">
                    <c:v>0.97411891503725856</c:v>
                  </c:pt>
                  <c:pt idx="5">
                    <c:v>0.310390971897815</c:v>
                  </c:pt>
                  <c:pt idx="6">
                    <c:v>0.56670696809384768</c:v>
                  </c:pt>
                  <c:pt idx="7">
                    <c:v>0.16014200139422471</c:v>
                  </c:pt>
                  <c:pt idx="8">
                    <c:v>0.34109323951481657</c:v>
                  </c:pt>
                  <c:pt idx="9">
                    <c:v>0.41110028346490363</c:v>
                  </c:pt>
                </c:numCache>
              </c:numRef>
            </c:plus>
            <c:minus>
              <c:numRef>
                <c:f>Sheet12!$AA$174:$AJ$174</c:f>
                <c:numCache>
                  <c:formatCode>General</c:formatCode>
                  <c:ptCount val="10"/>
                  <c:pt idx="0">
                    <c:v>0.55263207269360182</c:v>
                  </c:pt>
                  <c:pt idx="1">
                    <c:v>0.49937885214181915</c:v>
                  </c:pt>
                  <c:pt idx="2">
                    <c:v>0.45293186038457173</c:v>
                  </c:pt>
                  <c:pt idx="3">
                    <c:v>0.66877569946524196</c:v>
                  </c:pt>
                  <c:pt idx="4">
                    <c:v>0.97411891503725856</c:v>
                  </c:pt>
                  <c:pt idx="5">
                    <c:v>0.310390971897815</c:v>
                  </c:pt>
                  <c:pt idx="6">
                    <c:v>0.56670696809384768</c:v>
                  </c:pt>
                  <c:pt idx="7">
                    <c:v>0.16014200139422471</c:v>
                  </c:pt>
                  <c:pt idx="8">
                    <c:v>0.34109323951481657</c:v>
                  </c:pt>
                  <c:pt idx="9">
                    <c:v>0.41110028346490363</c:v>
                  </c:pt>
                </c:numCache>
              </c:numRef>
            </c:minus>
          </c:errBars>
          <c:cat>
            <c:strRef>
              <c:f>Sheet12!$AA$162:$AJ$162</c:f>
              <c:strCache>
                <c:ptCount val="10"/>
                <c:pt idx="0">
                  <c:v>GSTU18</c:v>
                </c:pt>
                <c:pt idx="1">
                  <c:v>GSTF1</c:v>
                </c:pt>
                <c:pt idx="2">
                  <c:v>GSTF3</c:v>
                </c:pt>
                <c:pt idx="3">
                  <c:v>GSTZ1    </c:v>
                </c:pt>
                <c:pt idx="4">
                  <c:v>GSTZ3   </c:v>
                </c:pt>
                <c:pt idx="5">
                  <c:v>EF1G1    </c:v>
                </c:pt>
                <c:pt idx="6">
                  <c:v>EF1G3    </c:v>
                </c:pt>
                <c:pt idx="7">
                  <c:v>GHR1     </c:v>
                </c:pt>
                <c:pt idx="8">
                  <c:v>GHR2    </c:v>
                </c:pt>
                <c:pt idx="9">
                  <c:v>GSTT1    </c:v>
                </c:pt>
              </c:strCache>
            </c:strRef>
          </c:cat>
          <c:val>
            <c:numRef>
              <c:f>Sheet12!$AA$166:$AJ$166</c:f>
              <c:numCache>
                <c:formatCode>0.00</c:formatCode>
                <c:ptCount val="10"/>
                <c:pt idx="0">
                  <c:v>2.9772880077050599</c:v>
                </c:pt>
                <c:pt idx="1">
                  <c:v>4.6402080228758074</c:v>
                </c:pt>
                <c:pt idx="2">
                  <c:v>6.8046871272994869</c:v>
                </c:pt>
                <c:pt idx="3">
                  <c:v>3.6503521084657997</c:v>
                </c:pt>
                <c:pt idx="4">
                  <c:v>5.1270839787762785</c:v>
                </c:pt>
                <c:pt idx="5">
                  <c:v>5.7599174334917214</c:v>
                </c:pt>
                <c:pt idx="6">
                  <c:v>0.80928136080179958</c:v>
                </c:pt>
                <c:pt idx="7">
                  <c:v>2.1688818955923859</c:v>
                </c:pt>
                <c:pt idx="8">
                  <c:v>3.8712659639464464</c:v>
                </c:pt>
                <c:pt idx="9">
                  <c:v>1.4871768167397998</c:v>
                </c:pt>
              </c:numCache>
            </c:numRef>
          </c:val>
        </c:ser>
        <c:ser>
          <c:idx val="4"/>
          <c:order val="4"/>
          <c:tx>
            <c:v>72h</c:v>
          </c:tx>
          <c:errBars>
            <c:errBarType val="both"/>
            <c:errValType val="cust"/>
            <c:plus>
              <c:numRef>
                <c:f>Sheet12!$AA$175:$AJ$175</c:f>
                <c:numCache>
                  <c:formatCode>General</c:formatCode>
                  <c:ptCount val="10"/>
                  <c:pt idx="0">
                    <c:v>7.8430699180582333E-2</c:v>
                  </c:pt>
                  <c:pt idx="1">
                    <c:v>2.077042931730276E-2</c:v>
                  </c:pt>
                  <c:pt idx="2">
                    <c:v>0.29631358163531607</c:v>
                  </c:pt>
                  <c:pt idx="3">
                    <c:v>8.7432194484497894E-3</c:v>
                  </c:pt>
                  <c:pt idx="4">
                    <c:v>2.413755985290052E-2</c:v>
                  </c:pt>
                  <c:pt idx="5">
                    <c:v>0.10243541703196736</c:v>
                  </c:pt>
                  <c:pt idx="6">
                    <c:v>6.4672402942282997E-3</c:v>
                  </c:pt>
                  <c:pt idx="7">
                    <c:v>5.0600602911850014E-2</c:v>
                  </c:pt>
                  <c:pt idx="8">
                    <c:v>2.2601093224236212E-2</c:v>
                  </c:pt>
                  <c:pt idx="9">
                    <c:v>8.9173311416156559E-2</c:v>
                  </c:pt>
                </c:numCache>
              </c:numRef>
            </c:plus>
            <c:minus>
              <c:numRef>
                <c:f>Sheet12!$AA$175:$AJ$175</c:f>
                <c:numCache>
                  <c:formatCode>General</c:formatCode>
                  <c:ptCount val="10"/>
                  <c:pt idx="0">
                    <c:v>7.8430699180582333E-2</c:v>
                  </c:pt>
                  <c:pt idx="1">
                    <c:v>2.077042931730276E-2</c:v>
                  </c:pt>
                  <c:pt idx="2">
                    <c:v>0.29631358163531607</c:v>
                  </c:pt>
                  <c:pt idx="3">
                    <c:v>8.7432194484497894E-3</c:v>
                  </c:pt>
                  <c:pt idx="4">
                    <c:v>2.413755985290052E-2</c:v>
                  </c:pt>
                  <c:pt idx="5">
                    <c:v>0.10243541703196736</c:v>
                  </c:pt>
                  <c:pt idx="6">
                    <c:v>6.4672402942282997E-3</c:v>
                  </c:pt>
                  <c:pt idx="7">
                    <c:v>5.0600602911850014E-2</c:v>
                  </c:pt>
                  <c:pt idx="8">
                    <c:v>2.2601093224236212E-2</c:v>
                  </c:pt>
                  <c:pt idx="9">
                    <c:v>8.9173311416156559E-2</c:v>
                  </c:pt>
                </c:numCache>
              </c:numRef>
            </c:minus>
          </c:errBars>
          <c:cat>
            <c:strRef>
              <c:f>Sheet12!$AA$162:$AJ$162</c:f>
              <c:strCache>
                <c:ptCount val="10"/>
                <c:pt idx="0">
                  <c:v>GSTU18</c:v>
                </c:pt>
                <c:pt idx="1">
                  <c:v>GSTF1</c:v>
                </c:pt>
                <c:pt idx="2">
                  <c:v>GSTF3</c:v>
                </c:pt>
                <c:pt idx="3">
                  <c:v>GSTZ1    </c:v>
                </c:pt>
                <c:pt idx="4">
                  <c:v>GSTZ3   </c:v>
                </c:pt>
                <c:pt idx="5">
                  <c:v>EF1G1    </c:v>
                </c:pt>
                <c:pt idx="6">
                  <c:v>EF1G3    </c:v>
                </c:pt>
                <c:pt idx="7">
                  <c:v>GHR1     </c:v>
                </c:pt>
                <c:pt idx="8">
                  <c:v>GHR2    </c:v>
                </c:pt>
                <c:pt idx="9">
                  <c:v>GSTT1    </c:v>
                </c:pt>
              </c:strCache>
            </c:strRef>
          </c:cat>
          <c:val>
            <c:numRef>
              <c:f>Sheet12!$AA$167:$AJ$167</c:f>
              <c:numCache>
                <c:formatCode>0.00</c:formatCode>
                <c:ptCount val="10"/>
                <c:pt idx="0">
                  <c:v>2.0007687740683542</c:v>
                </c:pt>
                <c:pt idx="1">
                  <c:v>0.24956759872192447</c:v>
                </c:pt>
                <c:pt idx="2">
                  <c:v>1.7357845518925672</c:v>
                </c:pt>
                <c:pt idx="3">
                  <c:v>1.7838677520945407</c:v>
                </c:pt>
                <c:pt idx="4">
                  <c:v>1.2312627166483299</c:v>
                </c:pt>
                <c:pt idx="5">
                  <c:v>0.72310370573794103</c:v>
                </c:pt>
                <c:pt idx="6">
                  <c:v>0.43984831111567557</c:v>
                </c:pt>
                <c:pt idx="7">
                  <c:v>0.73800246732009755</c:v>
                </c:pt>
                <c:pt idx="8">
                  <c:v>0.51252763399960422</c:v>
                </c:pt>
                <c:pt idx="9">
                  <c:v>1.5170275705235361</c:v>
                </c:pt>
              </c:numCache>
            </c:numRef>
          </c:val>
        </c:ser>
        <c:axId val="76752768"/>
        <c:axId val="76754304"/>
      </c:barChart>
      <c:catAx>
        <c:axId val="76752768"/>
        <c:scaling>
          <c:orientation val="minMax"/>
        </c:scaling>
        <c:axPos val="b"/>
        <c:tickLblPos val="nextTo"/>
        <c:crossAx val="76754304"/>
        <c:crosses val="autoZero"/>
        <c:auto val="1"/>
        <c:lblAlgn val="ctr"/>
        <c:lblOffset val="100"/>
      </c:catAx>
      <c:valAx>
        <c:axId val="76754304"/>
        <c:scaling>
          <c:orientation val="minMax"/>
        </c:scaling>
        <c:axPos val="l"/>
        <c:numFmt formatCode="0.0" sourceLinked="0"/>
        <c:tickLblPos val="nextTo"/>
        <c:crossAx val="76752768"/>
        <c:crosses val="autoZero"/>
        <c:crossBetween val="between"/>
      </c:valAx>
    </c:plotArea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0h</c:v>
          </c:tx>
          <c:errBars>
            <c:errBarType val="both"/>
            <c:errValType val="cust"/>
            <c:plus>
              <c:numRef>
                <c:f>Sheet12!$C$48:$S$48</c:f>
                <c:numCache>
                  <c:formatCode>General</c:formatCode>
                  <c:ptCount val="1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</c:numCache>
              </c:numRef>
            </c:plus>
            <c:minus>
              <c:numRef>
                <c:f>Sheet12!$C$48:$S$48</c:f>
                <c:numCache>
                  <c:formatCode>General</c:formatCode>
                  <c:ptCount val="1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</c:numCache>
              </c:numRef>
            </c:minus>
          </c:errBars>
          <c:cat>
            <c:strRef>
              <c:f>Sheet12!$C$39:$S$39</c:f>
              <c:strCache>
                <c:ptCount val="17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4</c:v>
                </c:pt>
                <c:pt idx="13">
                  <c:v>GSTU17</c:v>
                </c:pt>
                <c:pt idx="14">
                  <c:v>GSTF2</c:v>
                </c:pt>
                <c:pt idx="15">
                  <c:v>GSTZ2   </c:v>
                </c:pt>
                <c:pt idx="16">
                  <c:v>GSTL1    </c:v>
                </c:pt>
              </c:strCache>
            </c:strRef>
          </c:cat>
          <c:val>
            <c:numRef>
              <c:f>Sheet12!$C$40:$S$40</c:f>
              <c:numCache>
                <c:formatCode>0.00</c:formatCode>
                <c:ptCount val="1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</c:numCache>
            </c:numRef>
          </c:val>
        </c:ser>
        <c:ser>
          <c:idx val="1"/>
          <c:order val="1"/>
          <c:tx>
            <c:v>6h</c:v>
          </c:tx>
          <c:errBars>
            <c:errBarType val="both"/>
            <c:errValType val="cust"/>
            <c:plus>
              <c:numRef>
                <c:f>Sheet12!$C$49:$S$49</c:f>
                <c:numCache>
                  <c:formatCode>General</c:formatCode>
                  <c:ptCount val="17"/>
                  <c:pt idx="0">
                    <c:v>0</c:v>
                  </c:pt>
                  <c:pt idx="1">
                    <c:v>7.9685475404310036E-2</c:v>
                  </c:pt>
                  <c:pt idx="2">
                    <c:v>0.13756424000849538</c:v>
                  </c:pt>
                  <c:pt idx="3">
                    <c:v>2.623112778845672E-2</c:v>
                  </c:pt>
                  <c:pt idx="4">
                    <c:v>0.10516123147188222</c:v>
                  </c:pt>
                  <c:pt idx="5">
                    <c:v>2.609421612677337E-2</c:v>
                  </c:pt>
                  <c:pt idx="6">
                    <c:v>3.491217077655525E-2</c:v>
                  </c:pt>
                  <c:pt idx="7">
                    <c:v>0.37681048326243333</c:v>
                  </c:pt>
                  <c:pt idx="8">
                    <c:v>0</c:v>
                  </c:pt>
                  <c:pt idx="9">
                    <c:v>7.8558859747005869E-2</c:v>
                  </c:pt>
                  <c:pt idx="10">
                    <c:v>4.9982340574332172E-2</c:v>
                  </c:pt>
                  <c:pt idx="11">
                    <c:v>1.4154120637027395E-2</c:v>
                  </c:pt>
                  <c:pt idx="12">
                    <c:v>1.485781657470101E-2</c:v>
                  </c:pt>
                  <c:pt idx="13">
                    <c:v>0.26132617794664792</c:v>
                  </c:pt>
                  <c:pt idx="14">
                    <c:v>0.61842008650366365</c:v>
                  </c:pt>
                  <c:pt idx="15">
                    <c:v>0.45203294969652003</c:v>
                  </c:pt>
                  <c:pt idx="16">
                    <c:v>0.54511884272676858</c:v>
                  </c:pt>
                </c:numCache>
              </c:numRef>
            </c:plus>
            <c:minus>
              <c:numRef>
                <c:f>Sheet12!$C$49:$S$49</c:f>
                <c:numCache>
                  <c:formatCode>General</c:formatCode>
                  <c:ptCount val="17"/>
                  <c:pt idx="0">
                    <c:v>0</c:v>
                  </c:pt>
                  <c:pt idx="1">
                    <c:v>7.9685475404310036E-2</c:v>
                  </c:pt>
                  <c:pt idx="2">
                    <c:v>0.13756424000849538</c:v>
                  </c:pt>
                  <c:pt idx="3">
                    <c:v>2.623112778845672E-2</c:v>
                  </c:pt>
                  <c:pt idx="4">
                    <c:v>0.10516123147188222</c:v>
                  </c:pt>
                  <c:pt idx="5">
                    <c:v>2.609421612677337E-2</c:v>
                  </c:pt>
                  <c:pt idx="6">
                    <c:v>3.491217077655525E-2</c:v>
                  </c:pt>
                  <c:pt idx="7">
                    <c:v>0.37681048326243333</c:v>
                  </c:pt>
                  <c:pt idx="8">
                    <c:v>0</c:v>
                  </c:pt>
                  <c:pt idx="9">
                    <c:v>7.8558859747005869E-2</c:v>
                  </c:pt>
                  <c:pt idx="10">
                    <c:v>4.9982340574332172E-2</c:v>
                  </c:pt>
                  <c:pt idx="11">
                    <c:v>1.4154120637027395E-2</c:v>
                  </c:pt>
                  <c:pt idx="12">
                    <c:v>1.485781657470101E-2</c:v>
                  </c:pt>
                  <c:pt idx="13">
                    <c:v>0.26132617794664792</c:v>
                  </c:pt>
                  <c:pt idx="14">
                    <c:v>0.61842008650366365</c:v>
                  </c:pt>
                  <c:pt idx="15">
                    <c:v>0.45203294969652003</c:v>
                  </c:pt>
                  <c:pt idx="16">
                    <c:v>0.54511884272676858</c:v>
                  </c:pt>
                </c:numCache>
              </c:numRef>
            </c:minus>
          </c:errBars>
          <c:cat>
            <c:strRef>
              <c:f>Sheet12!$C$39:$S$39</c:f>
              <c:strCache>
                <c:ptCount val="17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4</c:v>
                </c:pt>
                <c:pt idx="13">
                  <c:v>GSTU17</c:v>
                </c:pt>
                <c:pt idx="14">
                  <c:v>GSTF2</c:v>
                </c:pt>
                <c:pt idx="15">
                  <c:v>GSTZ2   </c:v>
                </c:pt>
                <c:pt idx="16">
                  <c:v>GSTL1    </c:v>
                </c:pt>
              </c:strCache>
            </c:strRef>
          </c:cat>
          <c:val>
            <c:numRef>
              <c:f>Sheet12!$C$41:$S$41</c:f>
              <c:numCache>
                <c:formatCode>0.00</c:formatCode>
                <c:ptCount val="17"/>
                <c:pt idx="0">
                  <c:v>1.3379275547861103</c:v>
                </c:pt>
                <c:pt idx="1">
                  <c:v>3.8142044232756467</c:v>
                </c:pt>
                <c:pt idx="2">
                  <c:v>0.82931545493159164</c:v>
                </c:pt>
                <c:pt idx="3">
                  <c:v>1.3380561191102864</c:v>
                </c:pt>
                <c:pt idx="4">
                  <c:v>3.2635673348944212</c:v>
                </c:pt>
                <c:pt idx="5">
                  <c:v>0.76071318248751163</c:v>
                </c:pt>
                <c:pt idx="6">
                  <c:v>1.0177791281390776</c:v>
                </c:pt>
                <c:pt idx="7">
                  <c:v>1.37368187967043</c:v>
                </c:pt>
                <c:pt idx="8">
                  <c:v>1.8150383106343198</c:v>
                </c:pt>
                <c:pt idx="9">
                  <c:v>1.0695089822394137</c:v>
                </c:pt>
                <c:pt idx="10">
                  <c:v>1.2750505518986761</c:v>
                </c:pt>
                <c:pt idx="11">
                  <c:v>0.96264647272811599</c:v>
                </c:pt>
                <c:pt idx="12">
                  <c:v>1.0105060628535969</c:v>
                </c:pt>
                <c:pt idx="13">
                  <c:v>1.3414736964329184</c:v>
                </c:pt>
                <c:pt idx="14">
                  <c:v>3.9396130299671399</c:v>
                </c:pt>
                <c:pt idx="15">
                  <c:v>5.7204935176361955</c:v>
                </c:pt>
                <c:pt idx="16">
                  <c:v>1.3153297372142898</c:v>
                </c:pt>
              </c:numCache>
            </c:numRef>
          </c:val>
        </c:ser>
        <c:ser>
          <c:idx val="2"/>
          <c:order val="2"/>
          <c:tx>
            <c:v>24h</c:v>
          </c:tx>
          <c:errBars>
            <c:errBarType val="both"/>
            <c:errValType val="cust"/>
            <c:plus>
              <c:numRef>
                <c:f>Sheet12!$C$50:$S$50</c:f>
                <c:numCache>
                  <c:formatCode>General</c:formatCode>
                  <c:ptCount val="17"/>
                  <c:pt idx="0">
                    <c:v>1.4613801815049099</c:v>
                  </c:pt>
                  <c:pt idx="1">
                    <c:v>1.0376394341705446</c:v>
                  </c:pt>
                  <c:pt idx="2">
                    <c:v>5.6361257019166132E-2</c:v>
                  </c:pt>
                  <c:pt idx="3">
                    <c:v>1.674006597235248</c:v>
                  </c:pt>
                  <c:pt idx="4">
                    <c:v>0.55647073942124159</c:v>
                  </c:pt>
                  <c:pt idx="5">
                    <c:v>9.1339898053267726E-2</c:v>
                  </c:pt>
                  <c:pt idx="6">
                    <c:v>0.37009519064971846</c:v>
                  </c:pt>
                  <c:pt idx="7">
                    <c:v>0.39789690673734257</c:v>
                  </c:pt>
                  <c:pt idx="8">
                    <c:v>2.3898437090739365E-14</c:v>
                  </c:pt>
                  <c:pt idx="9">
                    <c:v>1.0747318398649699</c:v>
                  </c:pt>
                  <c:pt idx="10">
                    <c:v>0.36369435155995111</c:v>
                  </c:pt>
                  <c:pt idx="11">
                    <c:v>3.3548226817138198E-2</c:v>
                  </c:pt>
                  <c:pt idx="12">
                    <c:v>0.79331640790137159</c:v>
                  </c:pt>
                  <c:pt idx="13">
                    <c:v>1.4999698700640534</c:v>
                  </c:pt>
                  <c:pt idx="14">
                    <c:v>0.10906841006499775</c:v>
                  </c:pt>
                  <c:pt idx="15">
                    <c:v>0.10205289328782932</c:v>
                  </c:pt>
                  <c:pt idx="16">
                    <c:v>0.25830946411303402</c:v>
                  </c:pt>
                </c:numCache>
              </c:numRef>
            </c:plus>
            <c:minus>
              <c:numRef>
                <c:f>Sheet12!$C$50:$S$50</c:f>
                <c:numCache>
                  <c:formatCode>General</c:formatCode>
                  <c:ptCount val="17"/>
                  <c:pt idx="0">
                    <c:v>1.4613801815049099</c:v>
                  </c:pt>
                  <c:pt idx="1">
                    <c:v>1.0376394341705446</c:v>
                  </c:pt>
                  <c:pt idx="2">
                    <c:v>5.6361257019166132E-2</c:v>
                  </c:pt>
                  <c:pt idx="3">
                    <c:v>1.674006597235248</c:v>
                  </c:pt>
                  <c:pt idx="4">
                    <c:v>0.55647073942124159</c:v>
                  </c:pt>
                  <c:pt idx="5">
                    <c:v>9.1339898053267726E-2</c:v>
                  </c:pt>
                  <c:pt idx="6">
                    <c:v>0.37009519064971846</c:v>
                  </c:pt>
                  <c:pt idx="7">
                    <c:v>0.39789690673734257</c:v>
                  </c:pt>
                  <c:pt idx="8">
                    <c:v>2.3898437090739365E-14</c:v>
                  </c:pt>
                  <c:pt idx="9">
                    <c:v>1.0747318398649699</c:v>
                  </c:pt>
                  <c:pt idx="10">
                    <c:v>0.36369435155995111</c:v>
                  </c:pt>
                  <c:pt idx="11">
                    <c:v>3.3548226817138198E-2</c:v>
                  </c:pt>
                  <c:pt idx="12">
                    <c:v>0.79331640790137159</c:v>
                  </c:pt>
                  <c:pt idx="13">
                    <c:v>1.4999698700640534</c:v>
                  </c:pt>
                  <c:pt idx="14">
                    <c:v>0.10906841006499775</c:v>
                  </c:pt>
                  <c:pt idx="15">
                    <c:v>0.10205289328782932</c:v>
                  </c:pt>
                  <c:pt idx="16">
                    <c:v>0.25830946411303402</c:v>
                  </c:pt>
                </c:numCache>
              </c:numRef>
            </c:minus>
          </c:errBars>
          <c:cat>
            <c:strRef>
              <c:f>Sheet12!$C$39:$S$39</c:f>
              <c:strCache>
                <c:ptCount val="17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4</c:v>
                </c:pt>
                <c:pt idx="13">
                  <c:v>GSTU17</c:v>
                </c:pt>
                <c:pt idx="14">
                  <c:v>GSTF2</c:v>
                </c:pt>
                <c:pt idx="15">
                  <c:v>GSTZ2   </c:v>
                </c:pt>
                <c:pt idx="16">
                  <c:v>GSTL1    </c:v>
                </c:pt>
              </c:strCache>
            </c:strRef>
          </c:cat>
          <c:val>
            <c:numRef>
              <c:f>Sheet12!$C$42:$S$42</c:f>
              <c:numCache>
                <c:formatCode>0.00</c:formatCode>
                <c:ptCount val="17"/>
                <c:pt idx="0">
                  <c:v>17.2230809994407</c:v>
                </c:pt>
                <c:pt idx="1">
                  <c:v>16.296201038925062</c:v>
                </c:pt>
                <c:pt idx="2">
                  <c:v>1.6062875508286065</c:v>
                </c:pt>
                <c:pt idx="3">
                  <c:v>16.290392549352013</c:v>
                </c:pt>
                <c:pt idx="4">
                  <c:v>15.709382894983239</c:v>
                </c:pt>
                <c:pt idx="5">
                  <c:v>6.3180925325486603</c:v>
                </c:pt>
                <c:pt idx="6">
                  <c:v>2.6020484967064199</c:v>
                </c:pt>
                <c:pt idx="7">
                  <c:v>1.8717640590869955</c:v>
                </c:pt>
                <c:pt idx="8">
                  <c:v>2.1369223476095001</c:v>
                </c:pt>
                <c:pt idx="9">
                  <c:v>11.416770141639498</c:v>
                </c:pt>
                <c:pt idx="10">
                  <c:v>3.4655380429692002</c:v>
                </c:pt>
                <c:pt idx="11">
                  <c:v>2.8448013128228302</c:v>
                </c:pt>
                <c:pt idx="12">
                  <c:v>2.7211599790774001</c:v>
                </c:pt>
                <c:pt idx="13">
                  <c:v>12.9429991069357</c:v>
                </c:pt>
                <c:pt idx="14">
                  <c:v>1.7129271294857593</c:v>
                </c:pt>
                <c:pt idx="15">
                  <c:v>10.410984937983475</c:v>
                </c:pt>
                <c:pt idx="16">
                  <c:v>3.6998701091105599</c:v>
                </c:pt>
              </c:numCache>
            </c:numRef>
          </c:val>
        </c:ser>
        <c:ser>
          <c:idx val="3"/>
          <c:order val="3"/>
          <c:tx>
            <c:v>48h</c:v>
          </c:tx>
          <c:errBars>
            <c:errBarType val="both"/>
            <c:errValType val="cust"/>
            <c:plus>
              <c:numRef>
                <c:f>Sheet12!$C$51:$S$51</c:f>
                <c:numCache>
                  <c:formatCode>General</c:formatCode>
                  <c:ptCount val="17"/>
                  <c:pt idx="0">
                    <c:v>0.17162908107140537</c:v>
                  </c:pt>
                  <c:pt idx="1">
                    <c:v>0.31118251876661435</c:v>
                  </c:pt>
                  <c:pt idx="2">
                    <c:v>7.0062248381960526E-2</c:v>
                  </c:pt>
                  <c:pt idx="3">
                    <c:v>0.14457778517272943</c:v>
                  </c:pt>
                  <c:pt idx="4">
                    <c:v>0.10827608379522077</c:v>
                  </c:pt>
                  <c:pt idx="5">
                    <c:v>1.9689074389073642</c:v>
                  </c:pt>
                  <c:pt idx="6">
                    <c:v>0.23203975537068439</c:v>
                  </c:pt>
                  <c:pt idx="7">
                    <c:v>0.29568412513941233</c:v>
                  </c:pt>
                  <c:pt idx="8">
                    <c:v>0.2698932110479238</c:v>
                  </c:pt>
                  <c:pt idx="9">
                    <c:v>0.92837946591256149</c:v>
                  </c:pt>
                  <c:pt idx="10">
                    <c:v>0.11329190757957978</c:v>
                  </c:pt>
                  <c:pt idx="11">
                    <c:v>0.24245391672185029</c:v>
                  </c:pt>
                  <c:pt idx="12">
                    <c:v>0.24106045076515978</c:v>
                  </c:pt>
                  <c:pt idx="13">
                    <c:v>1.015542693233175</c:v>
                  </c:pt>
                  <c:pt idx="14">
                    <c:v>2.160372121937059E-2</c:v>
                  </c:pt>
                  <c:pt idx="15">
                    <c:v>0.65889328022202065</c:v>
                  </c:pt>
                  <c:pt idx="16">
                    <c:v>0.77000000000000235</c:v>
                  </c:pt>
                </c:numCache>
              </c:numRef>
            </c:plus>
            <c:minus>
              <c:numRef>
                <c:f>Sheet12!$C$51:$S$51</c:f>
                <c:numCache>
                  <c:formatCode>General</c:formatCode>
                  <c:ptCount val="17"/>
                  <c:pt idx="0">
                    <c:v>0.17162908107140537</c:v>
                  </c:pt>
                  <c:pt idx="1">
                    <c:v>0.31118251876661435</c:v>
                  </c:pt>
                  <c:pt idx="2">
                    <c:v>7.0062248381960526E-2</c:v>
                  </c:pt>
                  <c:pt idx="3">
                    <c:v>0.14457778517272943</c:v>
                  </c:pt>
                  <c:pt idx="4">
                    <c:v>0.10827608379522077</c:v>
                  </c:pt>
                  <c:pt idx="5">
                    <c:v>1.9689074389073642</c:v>
                  </c:pt>
                  <c:pt idx="6">
                    <c:v>0.23203975537068439</c:v>
                  </c:pt>
                  <c:pt idx="7">
                    <c:v>0.29568412513941233</c:v>
                  </c:pt>
                  <c:pt idx="8">
                    <c:v>0.2698932110479238</c:v>
                  </c:pt>
                  <c:pt idx="9">
                    <c:v>0.92837946591256149</c:v>
                  </c:pt>
                  <c:pt idx="10">
                    <c:v>0.11329190757957978</c:v>
                  </c:pt>
                  <c:pt idx="11">
                    <c:v>0.24245391672185029</c:v>
                  </c:pt>
                  <c:pt idx="12">
                    <c:v>0.24106045076515978</c:v>
                  </c:pt>
                  <c:pt idx="13">
                    <c:v>1.015542693233175</c:v>
                  </c:pt>
                  <c:pt idx="14">
                    <c:v>2.160372121937059E-2</c:v>
                  </c:pt>
                  <c:pt idx="15">
                    <c:v>0.65889328022202065</c:v>
                  </c:pt>
                  <c:pt idx="16">
                    <c:v>0.77000000000000235</c:v>
                  </c:pt>
                </c:numCache>
              </c:numRef>
            </c:minus>
          </c:errBars>
          <c:cat>
            <c:strRef>
              <c:f>Sheet12!$C$39:$S$39</c:f>
              <c:strCache>
                <c:ptCount val="17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4</c:v>
                </c:pt>
                <c:pt idx="13">
                  <c:v>GSTU17</c:v>
                </c:pt>
                <c:pt idx="14">
                  <c:v>GSTF2</c:v>
                </c:pt>
                <c:pt idx="15">
                  <c:v>GSTZ2   </c:v>
                </c:pt>
                <c:pt idx="16">
                  <c:v>GSTL1    </c:v>
                </c:pt>
              </c:strCache>
            </c:strRef>
          </c:cat>
          <c:val>
            <c:numRef>
              <c:f>Sheet12!$C$43:$S$43</c:f>
              <c:numCache>
                <c:formatCode>0.00</c:formatCode>
                <c:ptCount val="17"/>
                <c:pt idx="0">
                  <c:v>11.672793651254402</c:v>
                </c:pt>
                <c:pt idx="1">
                  <c:v>5.14079112014642</c:v>
                </c:pt>
                <c:pt idx="2">
                  <c:v>0.35099344785875058</c:v>
                </c:pt>
                <c:pt idx="3">
                  <c:v>5.9682979153781934</c:v>
                </c:pt>
                <c:pt idx="4">
                  <c:v>4.7643336621617856</c:v>
                </c:pt>
                <c:pt idx="5">
                  <c:v>8.0609496130640448</c:v>
                </c:pt>
                <c:pt idx="6">
                  <c:v>3.8915675159262597</c:v>
                </c:pt>
                <c:pt idx="7">
                  <c:v>1.722828790383955</c:v>
                </c:pt>
                <c:pt idx="8">
                  <c:v>3.7576951148540068</c:v>
                </c:pt>
                <c:pt idx="9">
                  <c:v>6.5535402850255284</c:v>
                </c:pt>
                <c:pt idx="10">
                  <c:v>1.4461497328574739</c:v>
                </c:pt>
                <c:pt idx="11">
                  <c:v>1.3442757578711375</c:v>
                </c:pt>
                <c:pt idx="12">
                  <c:v>2.1429208883986481</c:v>
                </c:pt>
                <c:pt idx="13">
                  <c:v>5.1711555912365865</c:v>
                </c:pt>
                <c:pt idx="14">
                  <c:v>1.1020110002991395</c:v>
                </c:pt>
                <c:pt idx="15">
                  <c:v>8.4106478700195364</c:v>
                </c:pt>
                <c:pt idx="16">
                  <c:v>5.0849315216822308</c:v>
                </c:pt>
              </c:numCache>
            </c:numRef>
          </c:val>
        </c:ser>
        <c:ser>
          <c:idx val="4"/>
          <c:order val="4"/>
          <c:tx>
            <c:v>72h</c:v>
          </c:tx>
          <c:errBars>
            <c:errBarType val="both"/>
            <c:errValType val="cust"/>
            <c:plus>
              <c:numRef>
                <c:f>Sheet12!$C$52:$S$52</c:f>
                <c:numCache>
                  <c:formatCode>General</c:formatCode>
                  <c:ptCount val="17"/>
                  <c:pt idx="0">
                    <c:v>1.8097400258304466</c:v>
                  </c:pt>
                  <c:pt idx="1">
                    <c:v>0.20631229491223876</c:v>
                  </c:pt>
                  <c:pt idx="2">
                    <c:v>5.0043173261206629E-3</c:v>
                  </c:pt>
                  <c:pt idx="3">
                    <c:v>5.2462255576940585E-2</c:v>
                  </c:pt>
                  <c:pt idx="4">
                    <c:v>2.4137559852898324E-2</c:v>
                  </c:pt>
                  <c:pt idx="5">
                    <c:v>1.27139558617274</c:v>
                  </c:pt>
                  <c:pt idx="6">
                    <c:v>0.16926891822075568</c:v>
                  </c:pt>
                  <c:pt idx="7">
                    <c:v>0.15472522630619368</c:v>
                  </c:pt>
                  <c:pt idx="8">
                    <c:v>0.35617911916433781</c:v>
                  </c:pt>
                  <c:pt idx="9">
                    <c:v>0.98450257303866473</c:v>
                  </c:pt>
                  <c:pt idx="10">
                    <c:v>0.23411647794649687</c:v>
                  </c:pt>
                  <c:pt idx="11">
                    <c:v>0.3706265777630568</c:v>
                  </c:pt>
                  <c:pt idx="12">
                    <c:v>0.19209260346071075</c:v>
                  </c:pt>
                  <c:pt idx="13">
                    <c:v>0.1422988521738715</c:v>
                  </c:pt>
                  <c:pt idx="14">
                    <c:v>7.0230332028776113E-2</c:v>
                  </c:pt>
                  <c:pt idx="15">
                    <c:v>4.1973956858600024E-2</c:v>
                  </c:pt>
                  <c:pt idx="16">
                    <c:v>2.0437874683423368E-2</c:v>
                  </c:pt>
                </c:numCache>
              </c:numRef>
            </c:plus>
            <c:minus>
              <c:numRef>
                <c:f>Sheet12!$C$52:$S$52</c:f>
                <c:numCache>
                  <c:formatCode>General</c:formatCode>
                  <c:ptCount val="17"/>
                  <c:pt idx="0">
                    <c:v>1.8097400258304466</c:v>
                  </c:pt>
                  <c:pt idx="1">
                    <c:v>0.20631229491223876</c:v>
                  </c:pt>
                  <c:pt idx="2">
                    <c:v>5.0043173261206629E-3</c:v>
                  </c:pt>
                  <c:pt idx="3">
                    <c:v>5.2462255576940585E-2</c:v>
                  </c:pt>
                  <c:pt idx="4">
                    <c:v>2.4137559852898324E-2</c:v>
                  </c:pt>
                  <c:pt idx="5">
                    <c:v>1.27139558617274</c:v>
                  </c:pt>
                  <c:pt idx="6">
                    <c:v>0.16926891822075568</c:v>
                  </c:pt>
                  <c:pt idx="7">
                    <c:v>0.15472522630619368</c:v>
                  </c:pt>
                  <c:pt idx="8">
                    <c:v>0.35617911916433781</c:v>
                  </c:pt>
                  <c:pt idx="9">
                    <c:v>0.98450257303866473</c:v>
                  </c:pt>
                  <c:pt idx="10">
                    <c:v>0.23411647794649687</c:v>
                  </c:pt>
                  <c:pt idx="11">
                    <c:v>0.3706265777630568</c:v>
                  </c:pt>
                  <c:pt idx="12">
                    <c:v>0.19209260346071075</c:v>
                  </c:pt>
                  <c:pt idx="13">
                    <c:v>0.1422988521738715</c:v>
                  </c:pt>
                  <c:pt idx="14">
                    <c:v>7.0230332028776113E-2</c:v>
                  </c:pt>
                  <c:pt idx="15">
                    <c:v>4.1973956858600024E-2</c:v>
                  </c:pt>
                  <c:pt idx="16">
                    <c:v>2.0437874683423368E-2</c:v>
                  </c:pt>
                </c:numCache>
              </c:numRef>
            </c:minus>
          </c:errBars>
          <c:cat>
            <c:strRef>
              <c:f>Sheet12!$C$39:$S$39</c:f>
              <c:strCache>
                <c:ptCount val="17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4</c:v>
                </c:pt>
                <c:pt idx="13">
                  <c:v>GSTU17</c:v>
                </c:pt>
                <c:pt idx="14">
                  <c:v>GSTF2</c:v>
                </c:pt>
                <c:pt idx="15">
                  <c:v>GSTZ2   </c:v>
                </c:pt>
                <c:pt idx="16">
                  <c:v>GSTL1    </c:v>
                </c:pt>
              </c:strCache>
            </c:strRef>
          </c:cat>
          <c:val>
            <c:numRef>
              <c:f>Sheet12!$C$44:$S$44</c:f>
              <c:numCache>
                <c:formatCode>0.00</c:formatCode>
                <c:ptCount val="17"/>
                <c:pt idx="0">
                  <c:v>10.034029054535335</c:v>
                </c:pt>
                <c:pt idx="1">
                  <c:v>1.2878893641001958</c:v>
                </c:pt>
                <c:pt idx="2">
                  <c:v>0.51051832661152352</c:v>
                </c:pt>
                <c:pt idx="3">
                  <c:v>2.6761122382205658</c:v>
                </c:pt>
                <c:pt idx="4">
                  <c:v>1.2312627166483279</c:v>
                </c:pt>
                <c:pt idx="5">
                  <c:v>5.4478763300377855</c:v>
                </c:pt>
                <c:pt idx="6">
                  <c:v>1.2680666004987999</c:v>
                </c:pt>
                <c:pt idx="7">
                  <c:v>1.0774108269351141</c:v>
                </c:pt>
                <c:pt idx="8">
                  <c:v>2.2796788707050397</c:v>
                </c:pt>
                <c:pt idx="9">
                  <c:v>8.7517928459450047</c:v>
                </c:pt>
                <c:pt idx="10">
                  <c:v>3.4145549345684127</c:v>
                </c:pt>
                <c:pt idx="11">
                  <c:v>2.0322915026460699</c:v>
                </c:pt>
                <c:pt idx="12">
                  <c:v>1.5999910095404355</c:v>
                </c:pt>
                <c:pt idx="13">
                  <c:v>1.0401432325412183</c:v>
                </c:pt>
                <c:pt idx="14">
                  <c:v>0.7970849683399982</c:v>
                </c:pt>
                <c:pt idx="15">
                  <c:v>1.5149614754872298</c:v>
                </c:pt>
                <c:pt idx="16">
                  <c:v>2.0849816074644578</c:v>
                </c:pt>
              </c:numCache>
            </c:numRef>
          </c:val>
        </c:ser>
        <c:axId val="57734656"/>
        <c:axId val="57736192"/>
      </c:barChart>
      <c:catAx>
        <c:axId val="57734656"/>
        <c:scaling>
          <c:orientation val="minMax"/>
        </c:scaling>
        <c:axPos val="b"/>
        <c:tickLblPos val="nextTo"/>
        <c:crossAx val="57736192"/>
        <c:crosses val="autoZero"/>
        <c:auto val="1"/>
        <c:lblAlgn val="ctr"/>
        <c:lblOffset val="100"/>
      </c:catAx>
      <c:valAx>
        <c:axId val="57736192"/>
        <c:scaling>
          <c:orientation val="minMax"/>
        </c:scaling>
        <c:axPos val="l"/>
        <c:numFmt formatCode="0" sourceLinked="0"/>
        <c:tickLblPos val="nextTo"/>
        <c:crossAx val="57734656"/>
        <c:crosses val="autoZero"/>
        <c:crossBetween val="between"/>
      </c:valAx>
    </c:plotArea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0h</c:v>
          </c:tx>
          <c:errBars>
            <c:errBarType val="both"/>
            <c:errValType val="cust"/>
            <c:plus>
              <c:numRef>
                <c:f>Sheet1!$AE$71:$AU$71</c:f>
                <c:numCache>
                  <c:formatCode>General</c:formatCode>
                  <c:ptCount val="1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</c:numCache>
              </c:numRef>
            </c:plus>
            <c:minus>
              <c:numRef>
                <c:f>Sheet1!$AE$71:$AU$71</c:f>
                <c:numCache>
                  <c:formatCode>General</c:formatCode>
                  <c:ptCount val="1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</c:numCache>
              </c:numRef>
            </c:minus>
          </c:errBars>
          <c:cat>
            <c:strRef>
              <c:f>Sheet1!$AE$56:$AU$56</c:f>
              <c:strCache>
                <c:ptCount val="17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10</c:v>
                </c:pt>
                <c:pt idx="6">
                  <c:v>GSTU12</c:v>
                </c:pt>
                <c:pt idx="7">
                  <c:v>GSTU14</c:v>
                </c:pt>
                <c:pt idx="8">
                  <c:v>GSTU16</c:v>
                </c:pt>
                <c:pt idx="9">
                  <c:v>GSTU17</c:v>
                </c:pt>
                <c:pt idx="10">
                  <c:v>GSTF1</c:v>
                </c:pt>
                <c:pt idx="11">
                  <c:v>GSTF2</c:v>
                </c:pt>
                <c:pt idx="12">
                  <c:v>GSTF3</c:v>
                </c:pt>
                <c:pt idx="13">
                  <c:v>GSTZ2   </c:v>
                </c:pt>
                <c:pt idx="14">
                  <c:v>EF1G1    </c:v>
                </c:pt>
                <c:pt idx="15">
                  <c:v>EF1G2    </c:v>
                </c:pt>
                <c:pt idx="16">
                  <c:v>GSTL1    </c:v>
                </c:pt>
              </c:strCache>
            </c:strRef>
          </c:cat>
          <c:val>
            <c:numRef>
              <c:f>Sheet1!$AE$57:$AU$57</c:f>
              <c:numCache>
                <c:formatCode>General</c:formatCode>
                <c:ptCount val="1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</c:numCache>
            </c:numRef>
          </c:val>
        </c:ser>
        <c:ser>
          <c:idx val="1"/>
          <c:order val="1"/>
          <c:tx>
            <c:v>6h</c:v>
          </c:tx>
          <c:errBars>
            <c:errBarType val="both"/>
            <c:errValType val="cust"/>
            <c:plus>
              <c:numRef>
                <c:f>Sheet1!$AE$72:$AU$72</c:f>
                <c:numCache>
                  <c:formatCode>General</c:formatCode>
                  <c:ptCount val="17"/>
                  <c:pt idx="0">
                    <c:v>3.5148193018067674E-2</c:v>
                  </c:pt>
                  <c:pt idx="1">
                    <c:v>0.32192155785500748</c:v>
                  </c:pt>
                  <c:pt idx="2">
                    <c:v>1.0732815755535401</c:v>
                  </c:pt>
                  <c:pt idx="3">
                    <c:v>0.10943958972293856</c:v>
                  </c:pt>
                  <c:pt idx="4">
                    <c:v>9.54358319574755E-2</c:v>
                  </c:pt>
                  <c:pt idx="5">
                    <c:v>0.61619123791257457</c:v>
                  </c:pt>
                  <c:pt idx="6">
                    <c:v>0.74948956827781199</c:v>
                  </c:pt>
                  <c:pt idx="7">
                    <c:v>1.0204383656573099</c:v>
                  </c:pt>
                  <c:pt idx="8">
                    <c:v>7.0190697322550177E-2</c:v>
                  </c:pt>
                  <c:pt idx="9">
                    <c:v>1.0803552651949</c:v>
                  </c:pt>
                  <c:pt idx="10">
                    <c:v>1.5870994782427001E-2</c:v>
                  </c:pt>
                  <c:pt idx="11">
                    <c:v>1.3206472599668329E-2</c:v>
                  </c:pt>
                  <c:pt idx="12">
                    <c:v>1.4253140525545818E-2</c:v>
                  </c:pt>
                  <c:pt idx="13">
                    <c:v>0.17900083796321564</c:v>
                  </c:pt>
                  <c:pt idx="14">
                    <c:v>0.21957512319740369</c:v>
                  </c:pt>
                  <c:pt idx="15">
                    <c:v>2.7668298459483338E-2</c:v>
                  </c:pt>
                  <c:pt idx="16">
                    <c:v>6.3293740141983953E-2</c:v>
                  </c:pt>
                </c:numCache>
              </c:numRef>
            </c:plus>
            <c:minus>
              <c:numRef>
                <c:f>Sheet1!$AE$72:$AU$72</c:f>
                <c:numCache>
                  <c:formatCode>General</c:formatCode>
                  <c:ptCount val="17"/>
                  <c:pt idx="0">
                    <c:v>3.5148193018067674E-2</c:v>
                  </c:pt>
                  <c:pt idx="1">
                    <c:v>0.32192155785500748</c:v>
                  </c:pt>
                  <c:pt idx="2">
                    <c:v>1.0732815755535401</c:v>
                  </c:pt>
                  <c:pt idx="3">
                    <c:v>0.10943958972293856</c:v>
                  </c:pt>
                  <c:pt idx="4">
                    <c:v>9.54358319574755E-2</c:v>
                  </c:pt>
                  <c:pt idx="5">
                    <c:v>0.61619123791257457</c:v>
                  </c:pt>
                  <c:pt idx="6">
                    <c:v>0.74948956827781199</c:v>
                  </c:pt>
                  <c:pt idx="7">
                    <c:v>1.0204383656573099</c:v>
                  </c:pt>
                  <c:pt idx="8">
                    <c:v>7.0190697322550177E-2</c:v>
                  </c:pt>
                  <c:pt idx="9">
                    <c:v>1.0803552651949</c:v>
                  </c:pt>
                  <c:pt idx="10">
                    <c:v>1.5870994782427001E-2</c:v>
                  </c:pt>
                  <c:pt idx="11">
                    <c:v>1.3206472599668329E-2</c:v>
                  </c:pt>
                  <c:pt idx="12">
                    <c:v>1.4253140525545818E-2</c:v>
                  </c:pt>
                  <c:pt idx="13">
                    <c:v>0.17900083796321564</c:v>
                  </c:pt>
                  <c:pt idx="14">
                    <c:v>0.21957512319740369</c:v>
                  </c:pt>
                  <c:pt idx="15">
                    <c:v>2.7668298459483338E-2</c:v>
                  </c:pt>
                  <c:pt idx="16">
                    <c:v>6.3293740141983953E-2</c:v>
                  </c:pt>
                </c:numCache>
              </c:numRef>
            </c:minus>
          </c:errBars>
          <c:cat>
            <c:strRef>
              <c:f>Sheet1!$AE$56:$AU$56</c:f>
              <c:strCache>
                <c:ptCount val="17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10</c:v>
                </c:pt>
                <c:pt idx="6">
                  <c:v>GSTU12</c:v>
                </c:pt>
                <c:pt idx="7">
                  <c:v>GSTU14</c:v>
                </c:pt>
                <c:pt idx="8">
                  <c:v>GSTU16</c:v>
                </c:pt>
                <c:pt idx="9">
                  <c:v>GSTU17</c:v>
                </c:pt>
                <c:pt idx="10">
                  <c:v>GSTF1</c:v>
                </c:pt>
                <c:pt idx="11">
                  <c:v>GSTF2</c:v>
                </c:pt>
                <c:pt idx="12">
                  <c:v>GSTF3</c:v>
                </c:pt>
                <c:pt idx="13">
                  <c:v>GSTZ2   </c:v>
                </c:pt>
                <c:pt idx="14">
                  <c:v>EF1G1    </c:v>
                </c:pt>
                <c:pt idx="15">
                  <c:v>EF1G2    </c:v>
                </c:pt>
                <c:pt idx="16">
                  <c:v>GSTL1    </c:v>
                </c:pt>
              </c:strCache>
            </c:strRef>
          </c:cat>
          <c:val>
            <c:numRef>
              <c:f>Sheet1!$AE$58:$AU$58</c:f>
              <c:numCache>
                <c:formatCode>0.000</c:formatCode>
                <c:ptCount val="17"/>
                <c:pt idx="0">
                  <c:v>0.74226178531452469</c:v>
                </c:pt>
                <c:pt idx="1">
                  <c:v>1.8403753012497541</c:v>
                </c:pt>
                <c:pt idx="2">
                  <c:v>15.221482898665249</c:v>
                </c:pt>
                <c:pt idx="3">
                  <c:v>1.0942937012607421</c:v>
                </c:pt>
                <c:pt idx="4">
                  <c:v>1.2141948843950479</c:v>
                </c:pt>
                <c:pt idx="5">
                  <c:v>2.6758551095722161</c:v>
                </c:pt>
                <c:pt idx="6">
                  <c:v>15.420007401773301</c:v>
                </c:pt>
                <c:pt idx="7">
                  <c:v>14.737046983004101</c:v>
                </c:pt>
                <c:pt idx="8">
                  <c:v>3.6300766212686435</c:v>
                </c:pt>
                <c:pt idx="9">
                  <c:v>5.1475007251520495</c:v>
                </c:pt>
                <c:pt idx="10">
                  <c:v>0.37113089265726334</c:v>
                </c:pt>
                <c:pt idx="11">
                  <c:v>7.3517102191444446</c:v>
                </c:pt>
                <c:pt idx="12">
                  <c:v>0.73713460864555391</c:v>
                </c:pt>
                <c:pt idx="13">
                  <c:v>1.337927554786114</c:v>
                </c:pt>
                <c:pt idx="14">
                  <c:v>1.394743666350406</c:v>
                </c:pt>
                <c:pt idx="15">
                  <c:v>1.1095694720678431</c:v>
                </c:pt>
                <c:pt idx="16">
                  <c:v>0.54336743126302933</c:v>
                </c:pt>
              </c:numCache>
            </c:numRef>
          </c:val>
        </c:ser>
        <c:ser>
          <c:idx val="2"/>
          <c:order val="2"/>
          <c:tx>
            <c:v>24h</c:v>
          </c:tx>
          <c:errBars>
            <c:errBarType val="both"/>
            <c:errValType val="cust"/>
            <c:plus>
              <c:numRef>
                <c:f>Sheet1!$AE$73:$AU$73</c:f>
                <c:numCache>
                  <c:formatCode>General</c:formatCode>
                  <c:ptCount val="17"/>
                  <c:pt idx="0">
                    <c:v>0.2300338056907664</c:v>
                  </c:pt>
                  <c:pt idx="1">
                    <c:v>0.38994631123167239</c:v>
                  </c:pt>
                  <c:pt idx="2">
                    <c:v>0.81456296409183127</c:v>
                  </c:pt>
                  <c:pt idx="3">
                    <c:v>5.1387535433108533E-2</c:v>
                  </c:pt>
                  <c:pt idx="4">
                    <c:v>0.12242056186676922</c:v>
                  </c:pt>
                  <c:pt idx="5">
                    <c:v>0.46743058795749154</c:v>
                  </c:pt>
                  <c:pt idx="6">
                    <c:v>1</c:v>
                  </c:pt>
                  <c:pt idx="7">
                    <c:v>0.85705804614460046</c:v>
                  </c:pt>
                  <c:pt idx="8">
                    <c:v>0.36360919609185288</c:v>
                  </c:pt>
                  <c:pt idx="9">
                    <c:v>0.9300681045226975</c:v>
                  </c:pt>
                  <c:pt idx="10">
                    <c:v>3.184842703199299E-2</c:v>
                  </c:pt>
                  <c:pt idx="11">
                    <c:v>1.0732980079214598</c:v>
                  </c:pt>
                  <c:pt idx="12">
                    <c:v>3.1647559615123409E-2</c:v>
                  </c:pt>
                  <c:pt idx="13">
                    <c:v>0.17463854352087904</c:v>
                  </c:pt>
                  <c:pt idx="14">
                    <c:v>6.9412890097726318E-2</c:v>
                  </c:pt>
                  <c:pt idx="15">
                    <c:v>4.2029971014948452E-2</c:v>
                  </c:pt>
                  <c:pt idx="16">
                    <c:v>1.0755398603728268</c:v>
                  </c:pt>
                </c:numCache>
              </c:numRef>
            </c:plus>
            <c:minus>
              <c:numRef>
                <c:f>Sheet1!$AE$73:$AU$73</c:f>
                <c:numCache>
                  <c:formatCode>General</c:formatCode>
                  <c:ptCount val="17"/>
                  <c:pt idx="0">
                    <c:v>0.2300338056907664</c:v>
                  </c:pt>
                  <c:pt idx="1">
                    <c:v>0.38994631123167239</c:v>
                  </c:pt>
                  <c:pt idx="2">
                    <c:v>0.81456296409183127</c:v>
                  </c:pt>
                  <c:pt idx="3">
                    <c:v>5.1387535433108533E-2</c:v>
                  </c:pt>
                  <c:pt idx="4">
                    <c:v>0.12242056186676922</c:v>
                  </c:pt>
                  <c:pt idx="5">
                    <c:v>0.46743058795749154</c:v>
                  </c:pt>
                  <c:pt idx="6">
                    <c:v>1</c:v>
                  </c:pt>
                  <c:pt idx="7">
                    <c:v>0.85705804614460046</c:v>
                  </c:pt>
                  <c:pt idx="8">
                    <c:v>0.36360919609185288</c:v>
                  </c:pt>
                  <c:pt idx="9">
                    <c:v>0.9300681045226975</c:v>
                  </c:pt>
                  <c:pt idx="10">
                    <c:v>3.184842703199299E-2</c:v>
                  </c:pt>
                  <c:pt idx="11">
                    <c:v>1.0732980079214598</c:v>
                  </c:pt>
                  <c:pt idx="12">
                    <c:v>3.1647559615123409E-2</c:v>
                  </c:pt>
                  <c:pt idx="13">
                    <c:v>0.17463854352087904</c:v>
                  </c:pt>
                  <c:pt idx="14">
                    <c:v>6.9412890097726318E-2</c:v>
                  </c:pt>
                  <c:pt idx="15">
                    <c:v>4.2029971014948452E-2</c:v>
                  </c:pt>
                  <c:pt idx="16">
                    <c:v>1.0755398603728268</c:v>
                  </c:pt>
                </c:numCache>
              </c:numRef>
            </c:minus>
          </c:errBars>
          <c:cat>
            <c:strRef>
              <c:f>Sheet1!$AE$56:$AU$56</c:f>
              <c:strCache>
                <c:ptCount val="17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10</c:v>
                </c:pt>
                <c:pt idx="6">
                  <c:v>GSTU12</c:v>
                </c:pt>
                <c:pt idx="7">
                  <c:v>GSTU14</c:v>
                </c:pt>
                <c:pt idx="8">
                  <c:v>GSTU16</c:v>
                </c:pt>
                <c:pt idx="9">
                  <c:v>GSTU17</c:v>
                </c:pt>
                <c:pt idx="10">
                  <c:v>GSTF1</c:v>
                </c:pt>
                <c:pt idx="11">
                  <c:v>GSTF2</c:v>
                </c:pt>
                <c:pt idx="12">
                  <c:v>GSTF3</c:v>
                </c:pt>
                <c:pt idx="13">
                  <c:v>GSTZ2   </c:v>
                </c:pt>
                <c:pt idx="14">
                  <c:v>EF1G1    </c:v>
                </c:pt>
                <c:pt idx="15">
                  <c:v>EF1G2    </c:v>
                </c:pt>
                <c:pt idx="16">
                  <c:v>GSTL1    </c:v>
                </c:pt>
              </c:strCache>
            </c:strRef>
          </c:cat>
          <c:val>
            <c:numRef>
              <c:f>Sheet1!$AE$59:$AU$59</c:f>
              <c:numCache>
                <c:formatCode>0.000</c:formatCode>
                <c:ptCount val="17"/>
                <c:pt idx="0">
                  <c:v>3.2943640690702898</c:v>
                </c:pt>
                <c:pt idx="1">
                  <c:v>7.7812395792982887</c:v>
                </c:pt>
                <c:pt idx="2">
                  <c:v>11.210073671684498</c:v>
                </c:pt>
                <c:pt idx="3">
                  <c:v>1.34723357686569</c:v>
                </c:pt>
                <c:pt idx="4">
                  <c:v>1.7532114426320651</c:v>
                </c:pt>
                <c:pt idx="5">
                  <c:v>8.2522194538947993</c:v>
                </c:pt>
                <c:pt idx="6">
                  <c:v>10.483147230866928</c:v>
                </c:pt>
                <c:pt idx="7">
                  <c:v>8.4561443244910528</c:v>
                </c:pt>
                <c:pt idx="8">
                  <c:v>3.9723699817481317</c:v>
                </c:pt>
                <c:pt idx="9">
                  <c:v>8.64646262152608</c:v>
                </c:pt>
                <c:pt idx="10">
                  <c:v>2.1885874025214891</c:v>
                </c:pt>
                <c:pt idx="11">
                  <c:v>7.3517102191444446</c:v>
                </c:pt>
                <c:pt idx="12">
                  <c:v>0.33680839421642428</c:v>
                </c:pt>
                <c:pt idx="13">
                  <c:v>5.8158900692812345</c:v>
                </c:pt>
                <c:pt idx="14">
                  <c:v>0.69737183317520324</c:v>
                </c:pt>
                <c:pt idx="15">
                  <c:v>1.1019051158766111</c:v>
                </c:pt>
                <c:pt idx="16">
                  <c:v>4.5947934199881404</c:v>
                </c:pt>
              </c:numCache>
            </c:numRef>
          </c:val>
        </c:ser>
        <c:ser>
          <c:idx val="3"/>
          <c:order val="3"/>
          <c:tx>
            <c:v>48h</c:v>
          </c:tx>
          <c:errBars>
            <c:errBarType val="both"/>
            <c:errValType val="cust"/>
            <c:plus>
              <c:numRef>
                <c:f>Sheet1!$AE$74:$AU$74</c:f>
                <c:numCache>
                  <c:formatCode>General</c:formatCode>
                  <c:ptCount val="17"/>
                  <c:pt idx="0">
                    <c:v>0.11822395804614722</c:v>
                  </c:pt>
                  <c:pt idx="1">
                    <c:v>0.16811988405979328</c:v>
                  </c:pt>
                  <c:pt idx="2">
                    <c:v>0.14044885016718681</c:v>
                  </c:pt>
                  <c:pt idx="3">
                    <c:v>3.437639981424899E-2</c:v>
                  </c:pt>
                  <c:pt idx="4">
                    <c:v>0.14617641531874717</c:v>
                  </c:pt>
                  <c:pt idx="5">
                    <c:v>1.2071107037744098</c:v>
                  </c:pt>
                  <c:pt idx="6">
                    <c:v>1.180161909795574</c:v>
                  </c:pt>
                  <c:pt idx="7">
                    <c:v>0.95155943717148272</c:v>
                  </c:pt>
                  <c:pt idx="8">
                    <c:v>6.2609976429093925E-2</c:v>
                  </c:pt>
                  <c:pt idx="9">
                    <c:v>0.24432381488055502</c:v>
                  </c:pt>
                  <c:pt idx="10">
                    <c:v>0.23697167298856919</c:v>
                  </c:pt>
                  <c:pt idx="11">
                    <c:v>1.0346121806253601</c:v>
                  </c:pt>
                  <c:pt idx="12">
                    <c:v>3.3776379428461664E-2</c:v>
                  </c:pt>
                  <c:pt idx="13">
                    <c:v>0.49064647565965286</c:v>
                  </c:pt>
                  <c:pt idx="14">
                    <c:v>3.6640787776774299E-2</c:v>
                  </c:pt>
                  <c:pt idx="15">
                    <c:v>4.0790520713642114E-2</c:v>
                  </c:pt>
                  <c:pt idx="16">
                    <c:v>1.0713053614062711</c:v>
                  </c:pt>
                </c:numCache>
              </c:numRef>
            </c:plus>
            <c:minus>
              <c:numRef>
                <c:f>Sheet1!$AE$74:$AU$74</c:f>
                <c:numCache>
                  <c:formatCode>General</c:formatCode>
                  <c:ptCount val="17"/>
                  <c:pt idx="0">
                    <c:v>0.11822395804614722</c:v>
                  </c:pt>
                  <c:pt idx="1">
                    <c:v>0.16811988405979328</c:v>
                  </c:pt>
                  <c:pt idx="2">
                    <c:v>0.14044885016718681</c:v>
                  </c:pt>
                  <c:pt idx="3">
                    <c:v>3.437639981424899E-2</c:v>
                  </c:pt>
                  <c:pt idx="4">
                    <c:v>0.14617641531874717</c:v>
                  </c:pt>
                  <c:pt idx="5">
                    <c:v>1.2071107037744098</c:v>
                  </c:pt>
                  <c:pt idx="6">
                    <c:v>1.180161909795574</c:v>
                  </c:pt>
                  <c:pt idx="7">
                    <c:v>0.95155943717148272</c:v>
                  </c:pt>
                  <c:pt idx="8">
                    <c:v>6.2609976429093925E-2</c:v>
                  </c:pt>
                  <c:pt idx="9">
                    <c:v>0.24432381488055502</c:v>
                  </c:pt>
                  <c:pt idx="10">
                    <c:v>0.23697167298856919</c:v>
                  </c:pt>
                  <c:pt idx="11">
                    <c:v>1.0346121806253601</c:v>
                  </c:pt>
                  <c:pt idx="12">
                    <c:v>3.3776379428461664E-2</c:v>
                  </c:pt>
                  <c:pt idx="13">
                    <c:v>0.49064647565965286</c:v>
                  </c:pt>
                  <c:pt idx="14">
                    <c:v>3.6640787776774299E-2</c:v>
                  </c:pt>
                  <c:pt idx="15">
                    <c:v>4.0790520713642114E-2</c:v>
                  </c:pt>
                  <c:pt idx="16">
                    <c:v>1.0713053614062711</c:v>
                  </c:pt>
                </c:numCache>
              </c:numRef>
            </c:minus>
          </c:errBars>
          <c:cat>
            <c:strRef>
              <c:f>Sheet1!$AE$56:$AU$56</c:f>
              <c:strCache>
                <c:ptCount val="17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10</c:v>
                </c:pt>
                <c:pt idx="6">
                  <c:v>GSTU12</c:v>
                </c:pt>
                <c:pt idx="7">
                  <c:v>GSTU14</c:v>
                </c:pt>
                <c:pt idx="8">
                  <c:v>GSTU16</c:v>
                </c:pt>
                <c:pt idx="9">
                  <c:v>GSTU17</c:v>
                </c:pt>
                <c:pt idx="10">
                  <c:v>GSTF1</c:v>
                </c:pt>
                <c:pt idx="11">
                  <c:v>GSTF2</c:v>
                </c:pt>
                <c:pt idx="12">
                  <c:v>GSTF3</c:v>
                </c:pt>
                <c:pt idx="13">
                  <c:v>GSTZ2   </c:v>
                </c:pt>
                <c:pt idx="14">
                  <c:v>EF1G1    </c:v>
                </c:pt>
                <c:pt idx="15">
                  <c:v>EF1G2    </c:v>
                </c:pt>
                <c:pt idx="16">
                  <c:v>GSTL1    </c:v>
                </c:pt>
              </c:strCache>
            </c:strRef>
          </c:cat>
          <c:val>
            <c:numRef>
              <c:f>Sheet1!$AE$60:$AU$60</c:f>
              <c:numCache>
                <c:formatCode>0.000</c:formatCode>
                <c:ptCount val="17"/>
                <c:pt idx="0">
                  <c:v>2.4966610978032167</c:v>
                </c:pt>
                <c:pt idx="1">
                  <c:v>4.4076204635064551</c:v>
                </c:pt>
                <c:pt idx="2">
                  <c:v>2.0849315216822575</c:v>
                </c:pt>
                <c:pt idx="3">
                  <c:v>0.90125046261083164</c:v>
                </c:pt>
                <c:pt idx="4">
                  <c:v>0.91383145022940349</c:v>
                </c:pt>
                <c:pt idx="5">
                  <c:v>10.794153738328799</c:v>
                </c:pt>
                <c:pt idx="6">
                  <c:v>11.056106996174636</c:v>
                </c:pt>
                <c:pt idx="7">
                  <c:v>10.483147230866985</c:v>
                </c:pt>
                <c:pt idx="8">
                  <c:v>1.4640856959456297</c:v>
                </c:pt>
                <c:pt idx="9">
                  <c:v>1.8403753012497541</c:v>
                </c:pt>
                <c:pt idx="10">
                  <c:v>1.8403753012497501</c:v>
                </c:pt>
                <c:pt idx="11">
                  <c:v>9.8491553067593607</c:v>
                </c:pt>
                <c:pt idx="12">
                  <c:v>0.60290391384538355</c:v>
                </c:pt>
                <c:pt idx="13">
                  <c:v>8.6938789002084889</c:v>
                </c:pt>
                <c:pt idx="14">
                  <c:v>0.7737824967711987</c:v>
                </c:pt>
                <c:pt idx="15">
                  <c:v>1.6934906247250563</c:v>
                </c:pt>
                <c:pt idx="16">
                  <c:v>7.8765557765427685</c:v>
                </c:pt>
              </c:numCache>
            </c:numRef>
          </c:val>
        </c:ser>
        <c:ser>
          <c:idx val="4"/>
          <c:order val="4"/>
          <c:tx>
            <c:v>72h</c:v>
          </c:tx>
          <c:errBars>
            <c:errBarType val="both"/>
            <c:errValType val="cust"/>
            <c:plus>
              <c:numRef>
                <c:f>Sheet1!$AE$75:$AU$75</c:f>
                <c:numCache>
                  <c:formatCode>General</c:formatCode>
                  <c:ptCount val="17"/>
                  <c:pt idx="0">
                    <c:v>0.98016879436590387</c:v>
                  </c:pt>
                  <c:pt idx="1">
                    <c:v>0.10152267365819725</c:v>
                  </c:pt>
                  <c:pt idx="2">
                    <c:v>1.7186135556695323E-2</c:v>
                  </c:pt>
                  <c:pt idx="3">
                    <c:v>2.2164240460052852E-2</c:v>
                  </c:pt>
                  <c:pt idx="4">
                    <c:v>5.5923339767872456E-2</c:v>
                  </c:pt>
                  <c:pt idx="5">
                    <c:v>0.95574346947881272</c:v>
                  </c:pt>
                  <c:pt idx="6">
                    <c:v>0.31697564700377412</c:v>
                  </c:pt>
                  <c:pt idx="7">
                    <c:v>0.1041997446142167</c:v>
                  </c:pt>
                  <c:pt idx="8">
                    <c:v>7.3426462605933829E-2</c:v>
                  </c:pt>
                  <c:pt idx="9">
                    <c:v>0.15018171708282291</c:v>
                  </c:pt>
                  <c:pt idx="10">
                    <c:v>0.19184834790073046</c:v>
                  </c:pt>
                  <c:pt idx="11">
                    <c:v>0.14891245887925542</c:v>
                  </c:pt>
                  <c:pt idx="12">
                    <c:v>1.8841109504205615E-15</c:v>
                  </c:pt>
                  <c:pt idx="13">
                    <c:v>0.14038139464520141</c:v>
                  </c:pt>
                  <c:pt idx="14">
                    <c:v>3.1088748865612598E-2</c:v>
                  </c:pt>
                  <c:pt idx="15">
                    <c:v>5.8715038509468992E-2</c:v>
                  </c:pt>
                  <c:pt idx="16">
                    <c:v>1.8327563288561501</c:v>
                  </c:pt>
                </c:numCache>
              </c:numRef>
            </c:plus>
            <c:minus>
              <c:numRef>
                <c:f>Sheet1!$AE$75:$AU$75</c:f>
                <c:numCache>
                  <c:formatCode>General</c:formatCode>
                  <c:ptCount val="17"/>
                  <c:pt idx="0">
                    <c:v>0.98016879436590387</c:v>
                  </c:pt>
                  <c:pt idx="1">
                    <c:v>0.10152267365819725</c:v>
                  </c:pt>
                  <c:pt idx="2">
                    <c:v>1.7186135556695323E-2</c:v>
                  </c:pt>
                  <c:pt idx="3">
                    <c:v>2.2164240460052852E-2</c:v>
                  </c:pt>
                  <c:pt idx="4">
                    <c:v>5.5923339767872456E-2</c:v>
                  </c:pt>
                  <c:pt idx="5">
                    <c:v>0.95574346947881272</c:v>
                  </c:pt>
                  <c:pt idx="6">
                    <c:v>0.31697564700377412</c:v>
                  </c:pt>
                  <c:pt idx="7">
                    <c:v>0.1041997446142167</c:v>
                  </c:pt>
                  <c:pt idx="8">
                    <c:v>7.3426462605933829E-2</c:v>
                  </c:pt>
                  <c:pt idx="9">
                    <c:v>0.15018171708282291</c:v>
                  </c:pt>
                  <c:pt idx="10">
                    <c:v>0.19184834790073046</c:v>
                  </c:pt>
                  <c:pt idx="11">
                    <c:v>0.14891245887925542</c:v>
                  </c:pt>
                  <c:pt idx="12">
                    <c:v>1.8841109504205615E-15</c:v>
                  </c:pt>
                  <c:pt idx="13">
                    <c:v>0.14038139464520141</c:v>
                  </c:pt>
                  <c:pt idx="14">
                    <c:v>3.1088748865612598E-2</c:v>
                  </c:pt>
                  <c:pt idx="15">
                    <c:v>5.8715038509468992E-2</c:v>
                  </c:pt>
                  <c:pt idx="16">
                    <c:v>1.8327563288561501</c:v>
                  </c:pt>
                </c:numCache>
              </c:numRef>
            </c:minus>
          </c:errBars>
          <c:cat>
            <c:strRef>
              <c:f>Sheet1!$AE$56:$AU$56</c:f>
              <c:strCache>
                <c:ptCount val="17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10</c:v>
                </c:pt>
                <c:pt idx="6">
                  <c:v>GSTU12</c:v>
                </c:pt>
                <c:pt idx="7">
                  <c:v>GSTU14</c:v>
                </c:pt>
                <c:pt idx="8">
                  <c:v>GSTU16</c:v>
                </c:pt>
                <c:pt idx="9">
                  <c:v>GSTU17</c:v>
                </c:pt>
                <c:pt idx="10">
                  <c:v>GSTF1</c:v>
                </c:pt>
                <c:pt idx="11">
                  <c:v>GSTF2</c:v>
                </c:pt>
                <c:pt idx="12">
                  <c:v>GSTF3</c:v>
                </c:pt>
                <c:pt idx="13">
                  <c:v>GSTZ2   </c:v>
                </c:pt>
                <c:pt idx="14">
                  <c:v>EF1G1    </c:v>
                </c:pt>
                <c:pt idx="15">
                  <c:v>EF1G2    </c:v>
                </c:pt>
                <c:pt idx="16">
                  <c:v>GSTL1    </c:v>
                </c:pt>
              </c:strCache>
            </c:strRef>
          </c:cat>
          <c:val>
            <c:numRef>
              <c:f>Sheet1!$AE$61:$AU$61</c:f>
              <c:numCache>
                <c:formatCode>0.000</c:formatCode>
                <c:ptCount val="17"/>
                <c:pt idx="0">
                  <c:v>3.9176811903477136</c:v>
                </c:pt>
                <c:pt idx="1">
                  <c:v>3.0314331330207946</c:v>
                </c:pt>
                <c:pt idx="2">
                  <c:v>1.7654059925813144</c:v>
                </c:pt>
                <c:pt idx="3">
                  <c:v>0.92018765062487906</c:v>
                </c:pt>
                <c:pt idx="4">
                  <c:v>1.1809926614295321</c:v>
                </c:pt>
                <c:pt idx="5">
                  <c:v>10.392401564776632</c:v>
                </c:pt>
                <c:pt idx="6">
                  <c:v>8</c:v>
                </c:pt>
                <c:pt idx="7">
                  <c:v>5.3889343074627645</c:v>
                </c:pt>
                <c:pt idx="8">
                  <c:v>2.5491212546385369</c:v>
                </c:pt>
                <c:pt idx="9">
                  <c:v>0.85856543643775463</c:v>
                </c:pt>
                <c:pt idx="10">
                  <c:v>1.7052697835359083</c:v>
                </c:pt>
                <c:pt idx="11">
                  <c:v>3.4822022531845063</c:v>
                </c:pt>
                <c:pt idx="12">
                  <c:v>1.0424657608411261</c:v>
                </c:pt>
                <c:pt idx="13">
                  <c:v>7.2601532425372852</c:v>
                </c:pt>
                <c:pt idx="14">
                  <c:v>0.72698625866015665</c:v>
                </c:pt>
                <c:pt idx="15">
                  <c:v>1.7532114426320693</c:v>
                </c:pt>
                <c:pt idx="16">
                  <c:v>8.0004678775104008</c:v>
                </c:pt>
              </c:numCache>
            </c:numRef>
          </c:val>
        </c:ser>
        <c:axId val="67097728"/>
        <c:axId val="67099264"/>
      </c:barChart>
      <c:catAx>
        <c:axId val="67097728"/>
        <c:scaling>
          <c:orientation val="minMax"/>
        </c:scaling>
        <c:axPos val="b"/>
        <c:tickLblPos val="nextTo"/>
        <c:crossAx val="67099264"/>
        <c:crosses val="autoZero"/>
        <c:auto val="1"/>
        <c:lblAlgn val="ctr"/>
        <c:lblOffset val="100"/>
      </c:catAx>
      <c:valAx>
        <c:axId val="67099264"/>
        <c:scaling>
          <c:orientation val="minMax"/>
        </c:scaling>
        <c:axPos val="l"/>
        <c:numFmt formatCode="General" sourceLinked="1"/>
        <c:tickLblPos val="nextTo"/>
        <c:crossAx val="67097728"/>
        <c:crosses val="autoZero"/>
        <c:crossBetween val="between"/>
      </c:valAx>
    </c:plotArea>
    <c:plotVisOnly val="1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0h</c:v>
          </c:tx>
          <c:errBars>
            <c:errBarType val="both"/>
            <c:errValType val="cust"/>
            <c:plus>
              <c:numRef>
                <c:f>Sheet1!$BD$70:$BH$7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plus>
            <c:minus>
              <c:numRef>
                <c:f>Sheet1!$BD$70:$BH$7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minus>
          </c:errBars>
          <c:cat>
            <c:strRef>
              <c:f>Sheet1!$BD$56:$BH$56</c:f>
              <c:strCache>
                <c:ptCount val="5"/>
                <c:pt idx="0">
                  <c:v>GSTU6</c:v>
                </c:pt>
                <c:pt idx="1">
                  <c:v>GSTU7</c:v>
                </c:pt>
                <c:pt idx="2">
                  <c:v>GSTU8</c:v>
                </c:pt>
                <c:pt idx="3">
                  <c:v>GSTU9</c:v>
                </c:pt>
                <c:pt idx="4">
                  <c:v>GSTU11</c:v>
                </c:pt>
              </c:strCache>
            </c:strRef>
          </c:cat>
          <c:val>
            <c:numRef>
              <c:f>Sheet1!$BD$57:$BH$57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</c:ser>
        <c:ser>
          <c:idx val="1"/>
          <c:order val="1"/>
          <c:tx>
            <c:v>6h</c:v>
          </c:tx>
          <c:errBars>
            <c:errBarType val="both"/>
            <c:errValType val="cust"/>
            <c:plus>
              <c:numRef>
                <c:f>Sheet1!$BD$71:$BH$71</c:f>
                <c:numCache>
                  <c:formatCode>General</c:formatCode>
                  <c:ptCount val="5"/>
                  <c:pt idx="0">
                    <c:v>1.3800000000000001</c:v>
                  </c:pt>
                  <c:pt idx="1">
                    <c:v>1.1171894648495648</c:v>
                  </c:pt>
                  <c:pt idx="2">
                    <c:v>2.5489760179829419</c:v>
                  </c:pt>
                  <c:pt idx="3">
                    <c:v>2.428037067737709</c:v>
                  </c:pt>
                  <c:pt idx="4">
                    <c:v>1.53801806516211</c:v>
                  </c:pt>
                </c:numCache>
              </c:numRef>
            </c:plus>
            <c:minus>
              <c:numRef>
                <c:f>Sheet1!$BD$71:$BH$71</c:f>
                <c:numCache>
                  <c:formatCode>General</c:formatCode>
                  <c:ptCount val="5"/>
                  <c:pt idx="0">
                    <c:v>1.3800000000000001</c:v>
                  </c:pt>
                  <c:pt idx="1">
                    <c:v>1.1171894648495648</c:v>
                  </c:pt>
                  <c:pt idx="2">
                    <c:v>2.5489760179829419</c:v>
                  </c:pt>
                  <c:pt idx="3">
                    <c:v>2.428037067737709</c:v>
                  </c:pt>
                  <c:pt idx="4">
                    <c:v>1.53801806516211</c:v>
                  </c:pt>
                </c:numCache>
              </c:numRef>
            </c:minus>
          </c:errBars>
          <c:cat>
            <c:strRef>
              <c:f>Sheet1!$BD$56:$BH$56</c:f>
              <c:strCache>
                <c:ptCount val="5"/>
                <c:pt idx="0">
                  <c:v>GSTU6</c:v>
                </c:pt>
                <c:pt idx="1">
                  <c:v>GSTU7</c:v>
                </c:pt>
                <c:pt idx="2">
                  <c:v>GSTU8</c:v>
                </c:pt>
                <c:pt idx="3">
                  <c:v>GSTU9</c:v>
                </c:pt>
                <c:pt idx="4">
                  <c:v>GSTU11</c:v>
                </c:pt>
              </c:strCache>
            </c:strRef>
          </c:cat>
          <c:val>
            <c:numRef>
              <c:f>Sheet1!$BD$58:$BH$58</c:f>
              <c:numCache>
                <c:formatCode>0.000</c:formatCode>
                <c:ptCount val="5"/>
                <c:pt idx="0">
                  <c:v>9.3178686917476377</c:v>
                </c:pt>
                <c:pt idx="1">
                  <c:v>38.319318547805878</c:v>
                </c:pt>
                <c:pt idx="2">
                  <c:v>38.124488886146295</c:v>
                </c:pt>
                <c:pt idx="3">
                  <c:v>51.625072590216007</c:v>
                </c:pt>
                <c:pt idx="4">
                  <c:v>38.054627680086959</c:v>
                </c:pt>
              </c:numCache>
            </c:numRef>
          </c:val>
        </c:ser>
        <c:ser>
          <c:idx val="2"/>
          <c:order val="2"/>
          <c:tx>
            <c:v>24h</c:v>
          </c:tx>
          <c:errBars>
            <c:errBarType val="both"/>
            <c:errValType val="cust"/>
            <c:plus>
              <c:numRef>
                <c:f>Sheet1!$BD$72:$BH$72</c:f>
                <c:numCache>
                  <c:formatCode>General</c:formatCode>
                  <c:ptCount val="5"/>
                  <c:pt idx="0">
                    <c:v>6.7982984036892171</c:v>
                  </c:pt>
                  <c:pt idx="1">
                    <c:v>2.2276820370228498</c:v>
                  </c:pt>
                  <c:pt idx="2">
                    <c:v>1.326283314050495</c:v>
                  </c:pt>
                  <c:pt idx="3">
                    <c:v>6.3826049440729875</c:v>
                  </c:pt>
                  <c:pt idx="4">
                    <c:v>3.8456668243950967</c:v>
                  </c:pt>
                </c:numCache>
              </c:numRef>
            </c:plus>
            <c:minus>
              <c:numRef>
                <c:f>Sheet1!$BD$72:$BH$72</c:f>
                <c:numCache>
                  <c:formatCode>General</c:formatCode>
                  <c:ptCount val="5"/>
                  <c:pt idx="0">
                    <c:v>6.7982984036892171</c:v>
                  </c:pt>
                  <c:pt idx="1">
                    <c:v>2.2276820370228498</c:v>
                  </c:pt>
                  <c:pt idx="2">
                    <c:v>1.326283314050495</c:v>
                  </c:pt>
                  <c:pt idx="3">
                    <c:v>6.3826049440729875</c:v>
                  </c:pt>
                  <c:pt idx="4">
                    <c:v>3.8456668243950967</c:v>
                  </c:pt>
                </c:numCache>
              </c:numRef>
            </c:minus>
          </c:errBars>
          <c:cat>
            <c:strRef>
              <c:f>Sheet1!$BD$56:$BH$56</c:f>
              <c:strCache>
                <c:ptCount val="5"/>
                <c:pt idx="0">
                  <c:v>GSTU6</c:v>
                </c:pt>
                <c:pt idx="1">
                  <c:v>GSTU7</c:v>
                </c:pt>
                <c:pt idx="2">
                  <c:v>GSTU8</c:v>
                </c:pt>
                <c:pt idx="3">
                  <c:v>GSTU9</c:v>
                </c:pt>
                <c:pt idx="4">
                  <c:v>GSTU11</c:v>
                </c:pt>
              </c:strCache>
            </c:strRef>
          </c:cat>
          <c:val>
            <c:numRef>
              <c:f>Sheet1!$BD$59:$BH$59</c:f>
              <c:numCache>
                <c:formatCode>0.000</c:formatCode>
                <c:ptCount val="5"/>
                <c:pt idx="0">
                  <c:v>70.521927416102955</c:v>
                </c:pt>
                <c:pt idx="1">
                  <c:v>64.948187932016282</c:v>
                </c:pt>
                <c:pt idx="2">
                  <c:v>77.181867751876283</c:v>
                </c:pt>
                <c:pt idx="3">
                  <c:v>83.222948919403507</c:v>
                </c:pt>
                <c:pt idx="4">
                  <c:v>98.914334960315159</c:v>
                </c:pt>
              </c:numCache>
            </c:numRef>
          </c:val>
        </c:ser>
        <c:ser>
          <c:idx val="3"/>
          <c:order val="3"/>
          <c:tx>
            <c:v>48h</c:v>
          </c:tx>
          <c:errBars>
            <c:errBarType val="both"/>
            <c:errValType val="cust"/>
            <c:plus>
              <c:numRef>
                <c:f>Sheet1!$BD$73:$BH$73</c:f>
                <c:numCache>
                  <c:formatCode>General</c:formatCode>
                  <c:ptCount val="5"/>
                  <c:pt idx="0">
                    <c:v>0.84801312589109357</c:v>
                  </c:pt>
                  <c:pt idx="1">
                    <c:v>5.5156699566901999</c:v>
                  </c:pt>
                  <c:pt idx="2">
                    <c:v>0.60180413764560636</c:v>
                  </c:pt>
                  <c:pt idx="3">
                    <c:v>5.3755764112626414</c:v>
                  </c:pt>
                  <c:pt idx="4">
                    <c:v>6.2132498176734998</c:v>
                  </c:pt>
                </c:numCache>
              </c:numRef>
            </c:plus>
            <c:minus>
              <c:numRef>
                <c:f>Sheet1!$BD$73:$BH$73</c:f>
                <c:numCache>
                  <c:formatCode>General</c:formatCode>
                  <c:ptCount val="5"/>
                  <c:pt idx="0">
                    <c:v>0.84801312589109357</c:v>
                  </c:pt>
                  <c:pt idx="1">
                    <c:v>5.5156699566901999</c:v>
                  </c:pt>
                  <c:pt idx="2">
                    <c:v>0.60180413764560636</c:v>
                  </c:pt>
                  <c:pt idx="3">
                    <c:v>5.3755764112626414</c:v>
                  </c:pt>
                  <c:pt idx="4">
                    <c:v>6.2132498176734998</c:v>
                  </c:pt>
                </c:numCache>
              </c:numRef>
            </c:minus>
          </c:errBars>
          <c:cat>
            <c:strRef>
              <c:f>Sheet1!$BD$56:$BH$56</c:f>
              <c:strCache>
                <c:ptCount val="5"/>
                <c:pt idx="0">
                  <c:v>GSTU6</c:v>
                </c:pt>
                <c:pt idx="1">
                  <c:v>GSTU7</c:v>
                </c:pt>
                <c:pt idx="2">
                  <c:v>GSTU8</c:v>
                </c:pt>
                <c:pt idx="3">
                  <c:v>GSTU9</c:v>
                </c:pt>
                <c:pt idx="4">
                  <c:v>GSTU11</c:v>
                </c:pt>
              </c:strCache>
            </c:strRef>
          </c:cat>
          <c:val>
            <c:numRef>
              <c:f>Sheet1!$BD$60:$BH$60</c:f>
              <c:numCache>
                <c:formatCode>0.000</c:formatCode>
                <c:ptCount val="5"/>
                <c:pt idx="0">
                  <c:v>15.136922347609548</c:v>
                </c:pt>
                <c:pt idx="1">
                  <c:v>50.835175956318103</c:v>
                </c:pt>
                <c:pt idx="2">
                  <c:v>46.001871510041894</c:v>
                </c:pt>
                <c:pt idx="3">
                  <c:v>72.344776045260204</c:v>
                </c:pt>
                <c:pt idx="4">
                  <c:v>35.506223106171213</c:v>
                </c:pt>
              </c:numCache>
            </c:numRef>
          </c:val>
        </c:ser>
        <c:ser>
          <c:idx val="4"/>
          <c:order val="4"/>
          <c:tx>
            <c:v>72h</c:v>
          </c:tx>
          <c:errBars>
            <c:errBarType val="both"/>
            <c:errValType val="cust"/>
            <c:plus>
              <c:numRef>
                <c:f>Sheet1!$BD$74:$BH$74</c:f>
                <c:numCache>
                  <c:formatCode>General</c:formatCode>
                  <c:ptCount val="5"/>
                  <c:pt idx="0">
                    <c:v>2.5610619319329699</c:v>
                  </c:pt>
                  <c:pt idx="1">
                    <c:v>3.7770510805958999</c:v>
                  </c:pt>
                  <c:pt idx="2">
                    <c:v>4.1883358163761768</c:v>
                  </c:pt>
                  <c:pt idx="3">
                    <c:v>2.7679326971953127</c:v>
                  </c:pt>
                  <c:pt idx="4">
                    <c:v>3.1544159525705999</c:v>
                  </c:pt>
                </c:numCache>
              </c:numRef>
            </c:plus>
            <c:minus>
              <c:numRef>
                <c:f>Sheet1!$BD$74:$BH$74</c:f>
                <c:numCache>
                  <c:formatCode>General</c:formatCode>
                  <c:ptCount val="5"/>
                  <c:pt idx="0">
                    <c:v>2.5610619319329699</c:v>
                  </c:pt>
                  <c:pt idx="1">
                    <c:v>3.7770510805958999</c:v>
                  </c:pt>
                  <c:pt idx="2">
                    <c:v>4.1883358163761768</c:v>
                  </c:pt>
                  <c:pt idx="3">
                    <c:v>2.7679326971953127</c:v>
                  </c:pt>
                  <c:pt idx="4">
                    <c:v>3.1544159525705999</c:v>
                  </c:pt>
                </c:numCache>
              </c:numRef>
            </c:minus>
          </c:errBars>
          <c:cat>
            <c:strRef>
              <c:f>Sheet1!$BD$56:$BH$56</c:f>
              <c:strCache>
                <c:ptCount val="5"/>
                <c:pt idx="0">
                  <c:v>GSTU6</c:v>
                </c:pt>
                <c:pt idx="1">
                  <c:v>GSTU7</c:v>
                </c:pt>
                <c:pt idx="2">
                  <c:v>GSTU8</c:v>
                </c:pt>
                <c:pt idx="3">
                  <c:v>GSTU9</c:v>
                </c:pt>
                <c:pt idx="4">
                  <c:v>GSTU11</c:v>
                </c:pt>
              </c:strCache>
            </c:strRef>
          </c:cat>
          <c:val>
            <c:numRef>
              <c:f>Sheet1!$BD$61:$BH$61</c:f>
              <c:numCache>
                <c:formatCode>0.000</c:formatCode>
                <c:ptCount val="5"/>
                <c:pt idx="0">
                  <c:v>37.284316536574728</c:v>
                </c:pt>
                <c:pt idx="1">
                  <c:v>40.224427984698544</c:v>
                </c:pt>
                <c:pt idx="2">
                  <c:v>30.538225466062201</c:v>
                </c:pt>
                <c:pt idx="3">
                  <c:v>65.064727974848395</c:v>
                </c:pt>
                <c:pt idx="4">
                  <c:v>84.885931594660306</c:v>
                </c:pt>
              </c:numCache>
            </c:numRef>
          </c:val>
        </c:ser>
        <c:axId val="73976448"/>
        <c:axId val="73982336"/>
      </c:barChart>
      <c:catAx>
        <c:axId val="73976448"/>
        <c:scaling>
          <c:orientation val="minMax"/>
        </c:scaling>
        <c:axPos val="b"/>
        <c:tickLblPos val="nextTo"/>
        <c:crossAx val="73982336"/>
        <c:crosses val="autoZero"/>
        <c:auto val="1"/>
        <c:lblAlgn val="ctr"/>
        <c:lblOffset val="100"/>
      </c:catAx>
      <c:valAx>
        <c:axId val="73982336"/>
        <c:scaling>
          <c:orientation val="minMax"/>
        </c:scaling>
        <c:axPos val="l"/>
        <c:numFmt formatCode="General" sourceLinked="1"/>
        <c:tickLblPos val="nextTo"/>
        <c:crossAx val="73976448"/>
        <c:crosses val="autoZero"/>
        <c:crossBetween val="between"/>
      </c:valAx>
    </c:plotArea>
    <c:plotVisOnly val="1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0h</c:v>
          </c:tx>
          <c:errBars>
            <c:errBarType val="both"/>
            <c:errValType val="cust"/>
            <c:plus>
              <c:numRef>
                <c:f>Sheet1!$AY$22:$BN$22</c:f>
                <c:numCache>
                  <c:formatCode>General</c:formatCode>
                  <c:ptCount val="1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</c:numCache>
              </c:numRef>
            </c:plus>
            <c:minus>
              <c:numRef>
                <c:f>Sheet1!$AY$22:$BN$22</c:f>
                <c:numCache>
                  <c:formatCode>General</c:formatCode>
                  <c:ptCount val="1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</c:numCache>
              </c:numRef>
            </c:minus>
          </c:errBars>
          <c:cat>
            <c:strRef>
              <c:f>Sheet1!$AY$13:$BN$13</c:f>
              <c:strCache>
                <c:ptCount val="16"/>
                <c:pt idx="0">
                  <c:v>GSTU2</c:v>
                </c:pt>
                <c:pt idx="1">
                  <c:v>GSTU3</c:v>
                </c:pt>
                <c:pt idx="2">
                  <c:v>GSTU7</c:v>
                </c:pt>
                <c:pt idx="3">
                  <c:v>GSTU8</c:v>
                </c:pt>
                <c:pt idx="4">
                  <c:v>GSTU9</c:v>
                </c:pt>
                <c:pt idx="5">
                  <c:v>GSTU11</c:v>
                </c:pt>
                <c:pt idx="6">
                  <c:v>GSTU12</c:v>
                </c:pt>
                <c:pt idx="7">
                  <c:v>GSTU14</c:v>
                </c:pt>
                <c:pt idx="8">
                  <c:v>GSTU16</c:v>
                </c:pt>
                <c:pt idx="9">
                  <c:v>GSTU17</c:v>
                </c:pt>
                <c:pt idx="10">
                  <c:v>GSTF1</c:v>
                </c:pt>
                <c:pt idx="11">
                  <c:v>GSTF2</c:v>
                </c:pt>
                <c:pt idx="12">
                  <c:v>GSTF3</c:v>
                </c:pt>
                <c:pt idx="13">
                  <c:v>GSTZ2   </c:v>
                </c:pt>
                <c:pt idx="14">
                  <c:v>EF1G1    </c:v>
                </c:pt>
                <c:pt idx="15">
                  <c:v>EF1G2    </c:v>
                </c:pt>
              </c:strCache>
            </c:strRef>
          </c:cat>
          <c:val>
            <c:numRef>
              <c:f>Sheet1!$AY$14:$BN$14</c:f>
              <c:numCache>
                <c:formatCode>General</c:formatCode>
                <c:ptCount val="16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</c:numCache>
            </c:numRef>
          </c:val>
        </c:ser>
        <c:ser>
          <c:idx val="1"/>
          <c:order val="1"/>
          <c:tx>
            <c:v>6h</c:v>
          </c:tx>
          <c:errBars>
            <c:errBarType val="both"/>
            <c:errValType val="cust"/>
            <c:plus>
              <c:numRef>
                <c:f>Sheet1!$AY$23:$BN$23</c:f>
                <c:numCache>
                  <c:formatCode>General</c:formatCode>
                  <c:ptCount val="16"/>
                  <c:pt idx="0">
                    <c:v>3.853849140843451E-2</c:v>
                  </c:pt>
                  <c:pt idx="1">
                    <c:v>4.5540855818265155E-2</c:v>
                  </c:pt>
                  <c:pt idx="2">
                    <c:v>0.17742711205827141</c:v>
                  </c:pt>
                  <c:pt idx="3">
                    <c:v>4.6313040081520714E-2</c:v>
                  </c:pt>
                  <c:pt idx="4">
                    <c:v>0.58684178051026636</c:v>
                  </c:pt>
                  <c:pt idx="5">
                    <c:v>4.3650999563058547E-2</c:v>
                  </c:pt>
                  <c:pt idx="6">
                    <c:v>9.4687453460374008E-3</c:v>
                  </c:pt>
                  <c:pt idx="7">
                    <c:v>0.10172567808738735</c:v>
                  </c:pt>
                  <c:pt idx="8">
                    <c:v>0.18152078168629499</c:v>
                  </c:pt>
                  <c:pt idx="9">
                    <c:v>0.39619851946331902</c:v>
                  </c:pt>
                  <c:pt idx="10">
                    <c:v>0.10299704462279795</c:v>
                  </c:pt>
                  <c:pt idx="11">
                    <c:v>6.6261212813256923E-3</c:v>
                  </c:pt>
                  <c:pt idx="12">
                    <c:v>5.9640820207653107E-2</c:v>
                  </c:pt>
                  <c:pt idx="13">
                    <c:v>0.13472021456399291</c:v>
                  </c:pt>
                  <c:pt idx="14">
                    <c:v>2.5780854787617546E-2</c:v>
                  </c:pt>
                  <c:pt idx="15">
                    <c:v>3.4254656031588795E-2</c:v>
                  </c:pt>
                </c:numCache>
              </c:numRef>
            </c:plus>
            <c:minus>
              <c:numRef>
                <c:f>Sheet1!$AY$23:$BN$23</c:f>
                <c:numCache>
                  <c:formatCode>General</c:formatCode>
                  <c:ptCount val="16"/>
                  <c:pt idx="0">
                    <c:v>3.853849140843451E-2</c:v>
                  </c:pt>
                  <c:pt idx="1">
                    <c:v>4.5540855818265155E-2</c:v>
                  </c:pt>
                  <c:pt idx="2">
                    <c:v>0.17742711205827141</c:v>
                  </c:pt>
                  <c:pt idx="3">
                    <c:v>4.6313040081520714E-2</c:v>
                  </c:pt>
                  <c:pt idx="4">
                    <c:v>0.58684178051026636</c:v>
                  </c:pt>
                  <c:pt idx="5">
                    <c:v>4.3650999563058547E-2</c:v>
                  </c:pt>
                  <c:pt idx="6">
                    <c:v>9.4687453460374008E-3</c:v>
                  </c:pt>
                  <c:pt idx="7">
                    <c:v>0.10172567808738735</c:v>
                  </c:pt>
                  <c:pt idx="8">
                    <c:v>0.18152078168629499</c:v>
                  </c:pt>
                  <c:pt idx="9">
                    <c:v>0.39619851946331902</c:v>
                  </c:pt>
                  <c:pt idx="10">
                    <c:v>0.10299704462279795</c:v>
                  </c:pt>
                  <c:pt idx="11">
                    <c:v>6.6261212813256923E-3</c:v>
                  </c:pt>
                  <c:pt idx="12">
                    <c:v>5.9640820207653107E-2</c:v>
                  </c:pt>
                  <c:pt idx="13">
                    <c:v>0.13472021456399291</c:v>
                  </c:pt>
                  <c:pt idx="14">
                    <c:v>2.5780854787617546E-2</c:v>
                  </c:pt>
                  <c:pt idx="15">
                    <c:v>3.4254656031588795E-2</c:v>
                  </c:pt>
                </c:numCache>
              </c:numRef>
            </c:minus>
          </c:errBars>
          <c:cat>
            <c:strRef>
              <c:f>Sheet1!$AY$13:$BN$13</c:f>
              <c:strCache>
                <c:ptCount val="16"/>
                <c:pt idx="0">
                  <c:v>GSTU2</c:v>
                </c:pt>
                <c:pt idx="1">
                  <c:v>GSTU3</c:v>
                </c:pt>
                <c:pt idx="2">
                  <c:v>GSTU7</c:v>
                </c:pt>
                <c:pt idx="3">
                  <c:v>GSTU8</c:v>
                </c:pt>
                <c:pt idx="4">
                  <c:v>GSTU9</c:v>
                </c:pt>
                <c:pt idx="5">
                  <c:v>GSTU11</c:v>
                </c:pt>
                <c:pt idx="6">
                  <c:v>GSTU12</c:v>
                </c:pt>
                <c:pt idx="7">
                  <c:v>GSTU14</c:v>
                </c:pt>
                <c:pt idx="8">
                  <c:v>GSTU16</c:v>
                </c:pt>
                <c:pt idx="9">
                  <c:v>GSTU17</c:v>
                </c:pt>
                <c:pt idx="10">
                  <c:v>GSTF1</c:v>
                </c:pt>
                <c:pt idx="11">
                  <c:v>GSTF2</c:v>
                </c:pt>
                <c:pt idx="12">
                  <c:v>GSTF3</c:v>
                </c:pt>
                <c:pt idx="13">
                  <c:v>GSTZ2   </c:v>
                </c:pt>
                <c:pt idx="14">
                  <c:v>EF1G1    </c:v>
                </c:pt>
                <c:pt idx="15">
                  <c:v>EF1G2    </c:v>
                </c:pt>
              </c:strCache>
            </c:strRef>
          </c:cat>
          <c:val>
            <c:numRef>
              <c:f>Sheet1!$AY$15:$BN$15</c:f>
              <c:numCache>
                <c:formatCode>0.00</c:formatCode>
                <c:ptCount val="16"/>
                <c:pt idx="0">
                  <c:v>1.3106767261745069</c:v>
                </c:pt>
                <c:pt idx="1">
                  <c:v>0.71522237634733288</c:v>
                </c:pt>
                <c:pt idx="2">
                  <c:v>2.5877487407925979</c:v>
                </c:pt>
                <c:pt idx="3">
                  <c:v>1.18144661969604</c:v>
                </c:pt>
                <c:pt idx="4">
                  <c:v>3.3431311943736413</c:v>
                </c:pt>
                <c:pt idx="5">
                  <c:v>0.81003049745710665</c:v>
                </c:pt>
                <c:pt idx="6">
                  <c:v>1.6591087458660267</c:v>
                </c:pt>
                <c:pt idx="7">
                  <c:v>1.9124532891237394</c:v>
                </c:pt>
                <c:pt idx="8">
                  <c:v>1.6866837349776627</c:v>
                </c:pt>
                <c:pt idx="9">
                  <c:v>9.7473406483484499</c:v>
                </c:pt>
                <c:pt idx="10">
                  <c:v>1.2375634951634038</c:v>
                </c:pt>
                <c:pt idx="11">
                  <c:v>1.3519189521566799</c:v>
                </c:pt>
                <c:pt idx="12">
                  <c:v>2.02835741927841</c:v>
                </c:pt>
                <c:pt idx="13">
                  <c:v>1.102217127337827</c:v>
                </c:pt>
                <c:pt idx="14">
                  <c:v>5.6061194483050469</c:v>
                </c:pt>
                <c:pt idx="15">
                  <c:v>1.1649854154355721</c:v>
                </c:pt>
              </c:numCache>
            </c:numRef>
          </c:val>
        </c:ser>
        <c:ser>
          <c:idx val="2"/>
          <c:order val="2"/>
          <c:tx>
            <c:v>24h</c:v>
          </c:tx>
          <c:errBars>
            <c:errBarType val="both"/>
            <c:errValType val="cust"/>
            <c:plus>
              <c:numRef>
                <c:f>Sheet1!$AY$24:$BN$24</c:f>
                <c:numCache>
                  <c:formatCode>General</c:formatCode>
                  <c:ptCount val="16"/>
                  <c:pt idx="0">
                    <c:v>0.41128393683739517</c:v>
                  </c:pt>
                  <c:pt idx="1">
                    <c:v>0.29402344593805735</c:v>
                  </c:pt>
                  <c:pt idx="2">
                    <c:v>0.51496145962685813</c:v>
                  </c:pt>
                  <c:pt idx="3">
                    <c:v>0.53978642209583461</c:v>
                  </c:pt>
                  <c:pt idx="4">
                    <c:v>0.66102533896733995</c:v>
                  </c:pt>
                  <c:pt idx="5">
                    <c:v>0.84931859055905701</c:v>
                  </c:pt>
                  <c:pt idx="6">
                    <c:v>0.81646722672556427</c:v>
                  </c:pt>
                  <c:pt idx="7">
                    <c:v>0.20772630164600744</c:v>
                  </c:pt>
                  <c:pt idx="8">
                    <c:v>0.15736193419850203</c:v>
                  </c:pt>
                  <c:pt idx="9">
                    <c:v>0.60264488556267226</c:v>
                  </c:pt>
                  <c:pt idx="10">
                    <c:v>0.15281667431250234</c:v>
                  </c:pt>
                  <c:pt idx="11">
                    <c:v>0.7062140328218367</c:v>
                  </c:pt>
                  <c:pt idx="12">
                    <c:v>1.5705231179613928E-2</c:v>
                  </c:pt>
                  <c:pt idx="13">
                    <c:v>7.1461262559238597E-2</c:v>
                  </c:pt>
                  <c:pt idx="14">
                    <c:v>0.77909646510620212</c:v>
                  </c:pt>
                  <c:pt idx="15">
                    <c:v>9.1642364996326067E-2</c:v>
                  </c:pt>
                </c:numCache>
              </c:numRef>
            </c:plus>
            <c:minus>
              <c:numRef>
                <c:f>Sheet1!$AY$24:$BN$24</c:f>
                <c:numCache>
                  <c:formatCode>General</c:formatCode>
                  <c:ptCount val="16"/>
                  <c:pt idx="0">
                    <c:v>0.41128393683739517</c:v>
                  </c:pt>
                  <c:pt idx="1">
                    <c:v>0.29402344593805735</c:v>
                  </c:pt>
                  <c:pt idx="2">
                    <c:v>0.51496145962685813</c:v>
                  </c:pt>
                  <c:pt idx="3">
                    <c:v>0.53978642209583461</c:v>
                  </c:pt>
                  <c:pt idx="4">
                    <c:v>0.66102533896733995</c:v>
                  </c:pt>
                  <c:pt idx="5">
                    <c:v>0.84931859055905701</c:v>
                  </c:pt>
                  <c:pt idx="6">
                    <c:v>0.81646722672556427</c:v>
                  </c:pt>
                  <c:pt idx="7">
                    <c:v>0.20772630164600744</c:v>
                  </c:pt>
                  <c:pt idx="8">
                    <c:v>0.15736193419850203</c:v>
                  </c:pt>
                  <c:pt idx="9">
                    <c:v>0.60264488556267226</c:v>
                  </c:pt>
                  <c:pt idx="10">
                    <c:v>0.15281667431250234</c:v>
                  </c:pt>
                  <c:pt idx="11">
                    <c:v>0.7062140328218367</c:v>
                  </c:pt>
                  <c:pt idx="12">
                    <c:v>1.5705231179613928E-2</c:v>
                  </c:pt>
                  <c:pt idx="13">
                    <c:v>7.1461262559238597E-2</c:v>
                  </c:pt>
                  <c:pt idx="14">
                    <c:v>0.77909646510620212</c:v>
                  </c:pt>
                  <c:pt idx="15">
                    <c:v>9.1642364996326067E-2</c:v>
                  </c:pt>
                </c:numCache>
              </c:numRef>
            </c:minus>
          </c:errBars>
          <c:cat>
            <c:strRef>
              <c:f>Sheet1!$AY$13:$BN$13</c:f>
              <c:strCache>
                <c:ptCount val="16"/>
                <c:pt idx="0">
                  <c:v>GSTU2</c:v>
                </c:pt>
                <c:pt idx="1">
                  <c:v>GSTU3</c:v>
                </c:pt>
                <c:pt idx="2">
                  <c:v>GSTU7</c:v>
                </c:pt>
                <c:pt idx="3">
                  <c:v>GSTU8</c:v>
                </c:pt>
                <c:pt idx="4">
                  <c:v>GSTU9</c:v>
                </c:pt>
                <c:pt idx="5">
                  <c:v>GSTU11</c:v>
                </c:pt>
                <c:pt idx="6">
                  <c:v>GSTU12</c:v>
                </c:pt>
                <c:pt idx="7">
                  <c:v>GSTU14</c:v>
                </c:pt>
                <c:pt idx="8">
                  <c:v>GSTU16</c:v>
                </c:pt>
                <c:pt idx="9">
                  <c:v>GSTU17</c:v>
                </c:pt>
                <c:pt idx="10">
                  <c:v>GSTF1</c:v>
                </c:pt>
                <c:pt idx="11">
                  <c:v>GSTF2</c:v>
                </c:pt>
                <c:pt idx="12">
                  <c:v>GSTF3</c:v>
                </c:pt>
                <c:pt idx="13">
                  <c:v>GSTZ2   </c:v>
                </c:pt>
                <c:pt idx="14">
                  <c:v>EF1G1    </c:v>
                </c:pt>
                <c:pt idx="15">
                  <c:v>EF1G2    </c:v>
                </c:pt>
              </c:strCache>
            </c:strRef>
          </c:cat>
          <c:val>
            <c:numRef>
              <c:f>Sheet1!$AY$16:$BN$16</c:f>
              <c:numCache>
                <c:formatCode>0.00</c:formatCode>
                <c:ptCount val="16"/>
                <c:pt idx="0">
                  <c:v>9.0709100958223647</c:v>
                </c:pt>
                <c:pt idx="1">
                  <c:v>2.5053026824447104</c:v>
                </c:pt>
                <c:pt idx="2">
                  <c:v>5.8389206195683387</c:v>
                </c:pt>
                <c:pt idx="3">
                  <c:v>5.5153902297080206</c:v>
                </c:pt>
                <c:pt idx="4">
                  <c:v>5.0215701162462363</c:v>
                </c:pt>
                <c:pt idx="5">
                  <c:v>8.6651011933198809</c:v>
                </c:pt>
                <c:pt idx="6">
                  <c:v>3.0240118192492513</c:v>
                </c:pt>
                <c:pt idx="7">
                  <c:v>3.1000134498863252</c:v>
                </c:pt>
                <c:pt idx="8">
                  <c:v>2.9201614422484012</c:v>
                </c:pt>
                <c:pt idx="9">
                  <c:v>10.829904372639945</c:v>
                </c:pt>
                <c:pt idx="10">
                  <c:v>6.5742627435931738</c:v>
                </c:pt>
                <c:pt idx="11">
                  <c:v>15.843829592922082</c:v>
                </c:pt>
                <c:pt idx="12">
                  <c:v>1.6021782429770466</c:v>
                </c:pt>
                <c:pt idx="13">
                  <c:v>8.9784336470726966</c:v>
                </c:pt>
                <c:pt idx="14">
                  <c:v>2.8390819854312364</c:v>
                </c:pt>
                <c:pt idx="15">
                  <c:v>1.7006050548484364</c:v>
                </c:pt>
              </c:numCache>
            </c:numRef>
          </c:val>
        </c:ser>
        <c:ser>
          <c:idx val="3"/>
          <c:order val="3"/>
          <c:tx>
            <c:v>48h</c:v>
          </c:tx>
          <c:errBars>
            <c:errBarType val="both"/>
            <c:errValType val="cust"/>
            <c:plus>
              <c:numRef>
                <c:f>Sheet1!$AY$25:$BN$25</c:f>
                <c:numCache>
                  <c:formatCode>General</c:formatCode>
                  <c:ptCount val="16"/>
                  <c:pt idx="0">
                    <c:v>0.25931108815506881</c:v>
                  </c:pt>
                  <c:pt idx="1">
                    <c:v>0.12136494225359423</c:v>
                  </c:pt>
                  <c:pt idx="2">
                    <c:v>0.56639242430278069</c:v>
                  </c:pt>
                  <c:pt idx="3">
                    <c:v>4.8976655391409947E-2</c:v>
                  </c:pt>
                  <c:pt idx="4">
                    <c:v>0.89318508326823998</c:v>
                  </c:pt>
                  <c:pt idx="5">
                    <c:v>0.28437344577663998</c:v>
                  </c:pt>
                  <c:pt idx="6">
                    <c:v>0.59479341998814272</c:v>
                  </c:pt>
                  <c:pt idx="7">
                    <c:v>0.92871330816616249</c:v>
                  </c:pt>
                  <c:pt idx="8">
                    <c:v>3.2857814292768746E-2</c:v>
                  </c:pt>
                  <c:pt idx="9">
                    <c:v>5.2351610658961149E-2</c:v>
                  </c:pt>
                  <c:pt idx="10">
                    <c:v>1.3214835815631041</c:v>
                  </c:pt>
                  <c:pt idx="11">
                    <c:v>3.4731302480859622E-2</c:v>
                  </c:pt>
                  <c:pt idx="12">
                    <c:v>7.4705896602350191E-2</c:v>
                  </c:pt>
                  <c:pt idx="13">
                    <c:v>0.25181927009952132</c:v>
                  </c:pt>
                  <c:pt idx="14">
                    <c:v>0.17063434771520047</c:v>
                  </c:pt>
                  <c:pt idx="15">
                    <c:v>0.43991551399319184</c:v>
                  </c:pt>
                </c:numCache>
              </c:numRef>
            </c:plus>
            <c:minus>
              <c:numRef>
                <c:f>Sheet1!$AY$25:$BN$25</c:f>
                <c:numCache>
                  <c:formatCode>General</c:formatCode>
                  <c:ptCount val="16"/>
                  <c:pt idx="0">
                    <c:v>0.25931108815506881</c:v>
                  </c:pt>
                  <c:pt idx="1">
                    <c:v>0.12136494225359423</c:v>
                  </c:pt>
                  <c:pt idx="2">
                    <c:v>0.56639242430278069</c:v>
                  </c:pt>
                  <c:pt idx="3">
                    <c:v>4.8976655391409947E-2</c:v>
                  </c:pt>
                  <c:pt idx="4">
                    <c:v>0.89318508326823998</c:v>
                  </c:pt>
                  <c:pt idx="5">
                    <c:v>0.28437344577663998</c:v>
                  </c:pt>
                  <c:pt idx="6">
                    <c:v>0.59479341998814272</c:v>
                  </c:pt>
                  <c:pt idx="7">
                    <c:v>0.92871330816616249</c:v>
                  </c:pt>
                  <c:pt idx="8">
                    <c:v>3.2857814292768746E-2</c:v>
                  </c:pt>
                  <c:pt idx="9">
                    <c:v>5.2351610658961149E-2</c:v>
                  </c:pt>
                  <c:pt idx="10">
                    <c:v>1.3214835815631041</c:v>
                  </c:pt>
                  <c:pt idx="11">
                    <c:v>3.4731302480859622E-2</c:v>
                  </c:pt>
                  <c:pt idx="12">
                    <c:v>7.4705896602350191E-2</c:v>
                  </c:pt>
                  <c:pt idx="13">
                    <c:v>0.25181927009952132</c:v>
                  </c:pt>
                  <c:pt idx="14">
                    <c:v>0.17063434771520047</c:v>
                  </c:pt>
                  <c:pt idx="15">
                    <c:v>0.43991551399319184</c:v>
                  </c:pt>
                </c:numCache>
              </c:numRef>
            </c:minus>
          </c:errBars>
          <c:cat>
            <c:strRef>
              <c:f>Sheet1!$AY$13:$BN$13</c:f>
              <c:strCache>
                <c:ptCount val="16"/>
                <c:pt idx="0">
                  <c:v>GSTU2</c:v>
                </c:pt>
                <c:pt idx="1">
                  <c:v>GSTU3</c:v>
                </c:pt>
                <c:pt idx="2">
                  <c:v>GSTU7</c:v>
                </c:pt>
                <c:pt idx="3">
                  <c:v>GSTU8</c:v>
                </c:pt>
                <c:pt idx="4">
                  <c:v>GSTU9</c:v>
                </c:pt>
                <c:pt idx="5">
                  <c:v>GSTU11</c:v>
                </c:pt>
                <c:pt idx="6">
                  <c:v>GSTU12</c:v>
                </c:pt>
                <c:pt idx="7">
                  <c:v>GSTU14</c:v>
                </c:pt>
                <c:pt idx="8">
                  <c:v>GSTU16</c:v>
                </c:pt>
                <c:pt idx="9">
                  <c:v>GSTU17</c:v>
                </c:pt>
                <c:pt idx="10">
                  <c:v>GSTF1</c:v>
                </c:pt>
                <c:pt idx="11">
                  <c:v>GSTF2</c:v>
                </c:pt>
                <c:pt idx="12">
                  <c:v>GSTF3</c:v>
                </c:pt>
                <c:pt idx="13">
                  <c:v>GSTZ2   </c:v>
                </c:pt>
                <c:pt idx="14">
                  <c:v>EF1G1    </c:v>
                </c:pt>
                <c:pt idx="15">
                  <c:v>EF1G2    </c:v>
                </c:pt>
              </c:strCache>
            </c:strRef>
          </c:cat>
          <c:val>
            <c:numRef>
              <c:f>Sheet1!$AY$17:$BN$17</c:f>
              <c:numCache>
                <c:formatCode>0.00</c:formatCode>
                <c:ptCount val="16"/>
                <c:pt idx="0">
                  <c:v>4.4114327911168489</c:v>
                </c:pt>
                <c:pt idx="1">
                  <c:v>2.1144931603458037</c:v>
                </c:pt>
                <c:pt idx="2">
                  <c:v>3.7256768516187915</c:v>
                </c:pt>
                <c:pt idx="3">
                  <c:v>0.55586460556766248</c:v>
                </c:pt>
                <c:pt idx="4">
                  <c:v>3.5663725210013792</c:v>
                </c:pt>
                <c:pt idx="5">
                  <c:v>6.5129115868732654</c:v>
                </c:pt>
                <c:pt idx="6">
                  <c:v>2.8393918131668503</c:v>
                </c:pt>
                <c:pt idx="7">
                  <c:v>4.5700721283903833</c:v>
                </c:pt>
                <c:pt idx="8">
                  <c:v>6.7039373387283305</c:v>
                </c:pt>
                <c:pt idx="9">
                  <c:v>2.0711161314144038</c:v>
                </c:pt>
                <c:pt idx="10">
                  <c:v>8.6680152867811486</c:v>
                </c:pt>
                <c:pt idx="11">
                  <c:v>7.086182709828897</c:v>
                </c:pt>
                <c:pt idx="12">
                  <c:v>5.0808785441694608</c:v>
                </c:pt>
                <c:pt idx="13">
                  <c:v>10.29208209103467</c:v>
                </c:pt>
                <c:pt idx="14">
                  <c:v>1.7317335087871764</c:v>
                </c:pt>
                <c:pt idx="15">
                  <c:v>6.4161040789359562</c:v>
                </c:pt>
              </c:numCache>
            </c:numRef>
          </c:val>
        </c:ser>
        <c:ser>
          <c:idx val="4"/>
          <c:order val="4"/>
          <c:tx>
            <c:v>72h</c:v>
          </c:tx>
          <c:errBars>
            <c:errBarType val="both"/>
            <c:errValType val="cust"/>
            <c:plus>
              <c:numRef>
                <c:f>Sheet1!$AY$26:$BN$26</c:f>
                <c:numCache>
                  <c:formatCode>General</c:formatCode>
                  <c:ptCount val="16"/>
                  <c:pt idx="0">
                    <c:v>8.2715896162059675E-3</c:v>
                  </c:pt>
                  <c:pt idx="1">
                    <c:v>0.11624965865339949</c:v>
                  </c:pt>
                  <c:pt idx="2">
                    <c:v>0.33339361621218111</c:v>
                  </c:pt>
                  <c:pt idx="3">
                    <c:v>0.18421634490888444</c:v>
                  </c:pt>
                  <c:pt idx="4">
                    <c:v>0.91426029177780688</c:v>
                  </c:pt>
                  <c:pt idx="5">
                    <c:v>0.67861952605154474</c:v>
                  </c:pt>
                  <c:pt idx="6">
                    <c:v>6.5722736818857E-2</c:v>
                  </c:pt>
                  <c:pt idx="7">
                    <c:v>0.36304947357600031</c:v>
                  </c:pt>
                  <c:pt idx="8">
                    <c:v>0.26617751145618779</c:v>
                  </c:pt>
                  <c:pt idx="9">
                    <c:v>2.2834609541790611E-2</c:v>
                  </c:pt>
                  <c:pt idx="10">
                    <c:v>0.21574005036381391</c:v>
                  </c:pt>
                  <c:pt idx="11">
                    <c:v>0.22538456008183788</c:v>
                  </c:pt>
                  <c:pt idx="12">
                    <c:v>1.1714001010807433E-2</c:v>
                  </c:pt>
                  <c:pt idx="13">
                    <c:v>9.2133771043844681E-2</c:v>
                  </c:pt>
                  <c:pt idx="14">
                    <c:v>0.27881672109893751</c:v>
                  </c:pt>
                  <c:pt idx="15">
                    <c:v>0.23934653289589977</c:v>
                  </c:pt>
                </c:numCache>
              </c:numRef>
            </c:plus>
            <c:minus>
              <c:numRef>
                <c:f>Sheet1!$AY$26:$BN$26</c:f>
                <c:numCache>
                  <c:formatCode>General</c:formatCode>
                  <c:ptCount val="16"/>
                  <c:pt idx="0">
                    <c:v>8.2715896162059675E-3</c:v>
                  </c:pt>
                  <c:pt idx="1">
                    <c:v>0.11624965865339949</c:v>
                  </c:pt>
                  <c:pt idx="2">
                    <c:v>0.33339361621218111</c:v>
                  </c:pt>
                  <c:pt idx="3">
                    <c:v>0.18421634490888444</c:v>
                  </c:pt>
                  <c:pt idx="4">
                    <c:v>0.91426029177780688</c:v>
                  </c:pt>
                  <c:pt idx="5">
                    <c:v>0.67861952605154474</c:v>
                  </c:pt>
                  <c:pt idx="6">
                    <c:v>6.5722736818857E-2</c:v>
                  </c:pt>
                  <c:pt idx="7">
                    <c:v>0.36304947357600031</c:v>
                  </c:pt>
                  <c:pt idx="8">
                    <c:v>0.26617751145618779</c:v>
                  </c:pt>
                  <c:pt idx="9">
                    <c:v>2.2834609541790611E-2</c:v>
                  </c:pt>
                  <c:pt idx="10">
                    <c:v>0.21574005036381391</c:v>
                  </c:pt>
                  <c:pt idx="11">
                    <c:v>0.22538456008183788</c:v>
                  </c:pt>
                  <c:pt idx="12">
                    <c:v>1.1714001010807433E-2</c:v>
                  </c:pt>
                  <c:pt idx="13">
                    <c:v>9.2133771043844681E-2</c:v>
                  </c:pt>
                  <c:pt idx="14">
                    <c:v>0.27881672109893751</c:v>
                  </c:pt>
                  <c:pt idx="15">
                    <c:v>0.23934653289589977</c:v>
                  </c:pt>
                </c:numCache>
              </c:numRef>
            </c:minus>
          </c:errBars>
          <c:cat>
            <c:strRef>
              <c:f>Sheet1!$AY$13:$BN$13</c:f>
              <c:strCache>
                <c:ptCount val="16"/>
                <c:pt idx="0">
                  <c:v>GSTU2</c:v>
                </c:pt>
                <c:pt idx="1">
                  <c:v>GSTU3</c:v>
                </c:pt>
                <c:pt idx="2">
                  <c:v>GSTU7</c:v>
                </c:pt>
                <c:pt idx="3">
                  <c:v>GSTU8</c:v>
                </c:pt>
                <c:pt idx="4">
                  <c:v>GSTU9</c:v>
                </c:pt>
                <c:pt idx="5">
                  <c:v>GSTU11</c:v>
                </c:pt>
                <c:pt idx="6">
                  <c:v>GSTU12</c:v>
                </c:pt>
                <c:pt idx="7">
                  <c:v>GSTU14</c:v>
                </c:pt>
                <c:pt idx="8">
                  <c:v>GSTU16</c:v>
                </c:pt>
                <c:pt idx="9">
                  <c:v>GSTU17</c:v>
                </c:pt>
                <c:pt idx="10">
                  <c:v>GSTF1</c:v>
                </c:pt>
                <c:pt idx="11">
                  <c:v>GSTF2</c:v>
                </c:pt>
                <c:pt idx="12">
                  <c:v>GSTF3</c:v>
                </c:pt>
                <c:pt idx="13">
                  <c:v>GSTZ2   </c:v>
                </c:pt>
                <c:pt idx="14">
                  <c:v>EF1G1    </c:v>
                </c:pt>
                <c:pt idx="15">
                  <c:v>EF1G2    </c:v>
                </c:pt>
              </c:strCache>
            </c:strRef>
          </c:cat>
          <c:val>
            <c:numRef>
              <c:f>Sheet1!$AY$18:$BN$18</c:f>
              <c:numCache>
                <c:formatCode>0.00</c:formatCode>
                <c:ptCount val="16"/>
                <c:pt idx="0">
                  <c:v>1.6876417276162403</c:v>
                </c:pt>
                <c:pt idx="1">
                  <c:v>1.6954844403886962</c:v>
                </c:pt>
                <c:pt idx="2">
                  <c:v>4.8624976224491006</c:v>
                </c:pt>
                <c:pt idx="3">
                  <c:v>0.99479785799833664</c:v>
                </c:pt>
                <c:pt idx="4">
                  <c:v>1.7472900216399099</c:v>
                </c:pt>
                <c:pt idx="5">
                  <c:v>8.1539694233187685</c:v>
                </c:pt>
                <c:pt idx="6">
                  <c:v>1.3504712850221556</c:v>
                </c:pt>
                <c:pt idx="7">
                  <c:v>1.8994581018817382</c:v>
                </c:pt>
                <c:pt idx="8">
                  <c:v>2.7197291112905893</c:v>
                </c:pt>
                <c:pt idx="9">
                  <c:v>1.8037025144853827</c:v>
                </c:pt>
                <c:pt idx="10">
                  <c:v>12.773464568684066</c:v>
                </c:pt>
                <c:pt idx="11">
                  <c:v>2.3029178758812083</c:v>
                </c:pt>
                <c:pt idx="12">
                  <c:v>0.47804442415657389</c:v>
                </c:pt>
                <c:pt idx="13">
                  <c:v>2.6859352219981014</c:v>
                </c:pt>
                <c:pt idx="14">
                  <c:v>0.88886403360931365</c:v>
                </c:pt>
                <c:pt idx="15">
                  <c:v>8.0278222002268684</c:v>
                </c:pt>
              </c:numCache>
            </c:numRef>
          </c:val>
        </c:ser>
        <c:axId val="74180480"/>
        <c:axId val="74182016"/>
      </c:barChart>
      <c:catAx>
        <c:axId val="74180480"/>
        <c:scaling>
          <c:orientation val="minMax"/>
        </c:scaling>
        <c:axPos val="b"/>
        <c:tickLblPos val="nextTo"/>
        <c:crossAx val="74182016"/>
        <c:crosses val="autoZero"/>
        <c:auto val="1"/>
        <c:lblAlgn val="ctr"/>
        <c:lblOffset val="100"/>
      </c:catAx>
      <c:valAx>
        <c:axId val="74182016"/>
        <c:scaling>
          <c:orientation val="minMax"/>
        </c:scaling>
        <c:axPos val="l"/>
        <c:numFmt formatCode="General" sourceLinked="1"/>
        <c:tickLblPos val="nextTo"/>
        <c:crossAx val="74180480"/>
        <c:crosses val="autoZero"/>
        <c:crossBetween val="between"/>
      </c:valAx>
    </c:plotArea>
    <c:plotVisOnly val="1"/>
  </c:chart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0h</c:v>
          </c:tx>
          <c:errBars>
            <c:errBarType val="both"/>
            <c:errValType val="cust"/>
            <c:plus>
              <c:numRef>
                <c:f>Sheet1!$BR$21:$BW$21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</c:numCache>
              </c:numRef>
            </c:plus>
            <c:minus>
              <c:numRef>
                <c:f>Sheet1!$BR$21:$BW$21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</c:numCache>
              </c:numRef>
            </c:minus>
          </c:errBars>
          <c:cat>
            <c:strRef>
              <c:f>Sheet1!$BR$13:$BW$13</c:f>
              <c:strCache>
                <c:ptCount val="6"/>
                <c:pt idx="0">
                  <c:v>GSTU1</c:v>
                </c:pt>
                <c:pt idx="1">
                  <c:v>GSTU4</c:v>
                </c:pt>
                <c:pt idx="2">
                  <c:v>GSTU5</c:v>
                </c:pt>
                <c:pt idx="3">
                  <c:v>GSTU6</c:v>
                </c:pt>
                <c:pt idx="4">
                  <c:v>GSTU10</c:v>
                </c:pt>
                <c:pt idx="5">
                  <c:v>GSTL1</c:v>
                </c:pt>
              </c:strCache>
            </c:strRef>
          </c:cat>
          <c:val>
            <c:numRef>
              <c:f>Sheet1!$BR$14:$BW$14</c:f>
              <c:numCache>
                <c:formatCode>General</c:formatCode>
                <c:ptCount val="6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</c:numCache>
            </c:numRef>
          </c:val>
        </c:ser>
        <c:ser>
          <c:idx val="1"/>
          <c:order val="1"/>
          <c:tx>
            <c:v>6h</c:v>
          </c:tx>
          <c:errBars>
            <c:errBarType val="both"/>
            <c:errValType val="cust"/>
            <c:plus>
              <c:numRef>
                <c:f>Sheet1!$BR$22:$BW$22</c:f>
                <c:numCache>
                  <c:formatCode>General</c:formatCode>
                  <c:ptCount val="6"/>
                  <c:pt idx="0">
                    <c:v>0.39391828559696823</c:v>
                  </c:pt>
                  <c:pt idx="1">
                    <c:v>9.2397850991784256E-2</c:v>
                  </c:pt>
                  <c:pt idx="2">
                    <c:v>5.7340549543680001E-2</c:v>
                  </c:pt>
                  <c:pt idx="3">
                    <c:v>9.2397850991784256E-2</c:v>
                  </c:pt>
                  <c:pt idx="4">
                    <c:v>5.7340549543680001E-2</c:v>
                  </c:pt>
                  <c:pt idx="5">
                    <c:v>8.0191566546715096E-2</c:v>
                  </c:pt>
                </c:numCache>
              </c:numRef>
            </c:plus>
            <c:minus>
              <c:numRef>
                <c:f>Sheet1!$BR$22:$BW$22</c:f>
                <c:numCache>
                  <c:formatCode>General</c:formatCode>
                  <c:ptCount val="6"/>
                  <c:pt idx="0">
                    <c:v>0.39391828559696823</c:v>
                  </c:pt>
                  <c:pt idx="1">
                    <c:v>9.2397850991784256E-2</c:v>
                  </c:pt>
                  <c:pt idx="2">
                    <c:v>5.7340549543680001E-2</c:v>
                  </c:pt>
                  <c:pt idx="3">
                    <c:v>9.2397850991784256E-2</c:v>
                  </c:pt>
                  <c:pt idx="4">
                    <c:v>5.7340549543680001E-2</c:v>
                  </c:pt>
                  <c:pt idx="5">
                    <c:v>8.0191566546715096E-2</c:v>
                  </c:pt>
                </c:numCache>
              </c:numRef>
            </c:minus>
          </c:errBars>
          <c:cat>
            <c:strRef>
              <c:f>Sheet1!$BR$13:$BW$13</c:f>
              <c:strCache>
                <c:ptCount val="6"/>
                <c:pt idx="0">
                  <c:v>GSTU1</c:v>
                </c:pt>
                <c:pt idx="1">
                  <c:v>GSTU4</c:v>
                </c:pt>
                <c:pt idx="2">
                  <c:v>GSTU5</c:v>
                </c:pt>
                <c:pt idx="3">
                  <c:v>GSTU6</c:v>
                </c:pt>
                <c:pt idx="4">
                  <c:v>GSTU10</c:v>
                </c:pt>
                <c:pt idx="5">
                  <c:v>GSTL1</c:v>
                </c:pt>
              </c:strCache>
            </c:strRef>
          </c:cat>
          <c:val>
            <c:numRef>
              <c:f>Sheet1!$BR$15:$BW$15</c:f>
              <c:numCache>
                <c:formatCode>0.00</c:formatCode>
                <c:ptCount val="6"/>
                <c:pt idx="0">
                  <c:v>3.8339130156452677</c:v>
                </c:pt>
                <c:pt idx="1">
                  <c:v>0.9659595333687786</c:v>
                </c:pt>
                <c:pt idx="2">
                  <c:v>1.7305700084252686</c:v>
                </c:pt>
                <c:pt idx="3">
                  <c:v>0.78729974476460152</c:v>
                </c:pt>
                <c:pt idx="4">
                  <c:v>1.2934706384023378</c:v>
                </c:pt>
                <c:pt idx="5">
                  <c:v>1.6367866242259046</c:v>
                </c:pt>
              </c:numCache>
            </c:numRef>
          </c:val>
        </c:ser>
        <c:ser>
          <c:idx val="2"/>
          <c:order val="2"/>
          <c:tx>
            <c:v>24h</c:v>
          </c:tx>
          <c:errBars>
            <c:errBarType val="both"/>
            <c:errValType val="cust"/>
            <c:plus>
              <c:numRef>
                <c:f>Sheet1!$BR$23:$BW$23</c:f>
                <c:numCache>
                  <c:formatCode>General</c:formatCode>
                  <c:ptCount val="6"/>
                  <c:pt idx="0">
                    <c:v>7.3414285104851897</c:v>
                  </c:pt>
                  <c:pt idx="1">
                    <c:v>2.9002632124862</c:v>
                  </c:pt>
                  <c:pt idx="2">
                    <c:v>1.19316493073649</c:v>
                  </c:pt>
                  <c:pt idx="3">
                    <c:v>2.9002632124862</c:v>
                  </c:pt>
                  <c:pt idx="4">
                    <c:v>1.19316493073649</c:v>
                  </c:pt>
                  <c:pt idx="5">
                    <c:v>1.0642771352300353</c:v>
                  </c:pt>
                </c:numCache>
              </c:numRef>
            </c:plus>
            <c:minus>
              <c:numRef>
                <c:f>Sheet1!$BR$23:$BW$23</c:f>
                <c:numCache>
                  <c:formatCode>General</c:formatCode>
                  <c:ptCount val="6"/>
                  <c:pt idx="0">
                    <c:v>7.3414285104851897</c:v>
                  </c:pt>
                  <c:pt idx="1">
                    <c:v>2.9002632124862</c:v>
                  </c:pt>
                  <c:pt idx="2">
                    <c:v>1.19316493073649</c:v>
                  </c:pt>
                  <c:pt idx="3">
                    <c:v>2.9002632124862</c:v>
                  </c:pt>
                  <c:pt idx="4">
                    <c:v>1.19316493073649</c:v>
                  </c:pt>
                  <c:pt idx="5">
                    <c:v>1.0642771352300353</c:v>
                  </c:pt>
                </c:numCache>
              </c:numRef>
            </c:minus>
          </c:errBars>
          <c:cat>
            <c:strRef>
              <c:f>Sheet1!$BR$13:$BW$13</c:f>
              <c:strCache>
                <c:ptCount val="6"/>
                <c:pt idx="0">
                  <c:v>GSTU1</c:v>
                </c:pt>
                <c:pt idx="1">
                  <c:v>GSTU4</c:v>
                </c:pt>
                <c:pt idx="2">
                  <c:v>GSTU5</c:v>
                </c:pt>
                <c:pt idx="3">
                  <c:v>GSTU6</c:v>
                </c:pt>
                <c:pt idx="4">
                  <c:v>GSTU10</c:v>
                </c:pt>
                <c:pt idx="5">
                  <c:v>GSTL1</c:v>
                </c:pt>
              </c:strCache>
            </c:strRef>
          </c:cat>
          <c:val>
            <c:numRef>
              <c:f>Sheet1!$BR$16:$BW$16</c:f>
              <c:numCache>
                <c:formatCode>0.00</c:formatCode>
                <c:ptCount val="6"/>
                <c:pt idx="0">
                  <c:v>66.866357060267745</c:v>
                </c:pt>
                <c:pt idx="1">
                  <c:v>26.604717671422186</c:v>
                </c:pt>
                <c:pt idx="2">
                  <c:v>46.69566109831802</c:v>
                </c:pt>
                <c:pt idx="3">
                  <c:v>34.18621908387685</c:v>
                </c:pt>
                <c:pt idx="4">
                  <c:v>15.44013811460732</c:v>
                </c:pt>
                <c:pt idx="5">
                  <c:v>31.026402274602038</c:v>
                </c:pt>
              </c:numCache>
            </c:numRef>
          </c:val>
        </c:ser>
        <c:ser>
          <c:idx val="3"/>
          <c:order val="3"/>
          <c:tx>
            <c:v>48h</c:v>
          </c:tx>
          <c:errBars>
            <c:errBarType val="both"/>
            <c:errValType val="cust"/>
            <c:plus>
              <c:numRef>
                <c:f>Sheet1!$BR$24:$BW$24</c:f>
                <c:numCache>
                  <c:formatCode>General</c:formatCode>
                  <c:ptCount val="6"/>
                  <c:pt idx="0">
                    <c:v>1.5</c:v>
                  </c:pt>
                  <c:pt idx="1">
                    <c:v>5.7029167421995846</c:v>
                  </c:pt>
                  <c:pt idx="2">
                    <c:v>2.9434201666361002</c:v>
                  </c:pt>
                  <c:pt idx="3">
                    <c:v>5.7029167421995846</c:v>
                  </c:pt>
                  <c:pt idx="4">
                    <c:v>2.9434201666361002</c:v>
                  </c:pt>
                  <c:pt idx="5">
                    <c:v>4.5123677586047197</c:v>
                  </c:pt>
                </c:numCache>
              </c:numRef>
            </c:plus>
            <c:minus>
              <c:numRef>
                <c:f>Sheet1!$BR$24:$BW$24</c:f>
                <c:numCache>
                  <c:formatCode>General</c:formatCode>
                  <c:ptCount val="6"/>
                  <c:pt idx="0">
                    <c:v>1.5</c:v>
                  </c:pt>
                  <c:pt idx="1">
                    <c:v>5.7029167421995846</c:v>
                  </c:pt>
                  <c:pt idx="2">
                    <c:v>2.9434201666361002</c:v>
                  </c:pt>
                  <c:pt idx="3">
                    <c:v>5.7029167421995846</c:v>
                  </c:pt>
                  <c:pt idx="4">
                    <c:v>2.9434201666361002</c:v>
                  </c:pt>
                  <c:pt idx="5">
                    <c:v>4.5123677586047197</c:v>
                  </c:pt>
                </c:numCache>
              </c:numRef>
            </c:minus>
          </c:errBars>
          <c:cat>
            <c:strRef>
              <c:f>Sheet1!$BR$13:$BW$13</c:f>
              <c:strCache>
                <c:ptCount val="6"/>
                <c:pt idx="0">
                  <c:v>GSTU1</c:v>
                </c:pt>
                <c:pt idx="1">
                  <c:v>GSTU4</c:v>
                </c:pt>
                <c:pt idx="2">
                  <c:v>GSTU5</c:v>
                </c:pt>
                <c:pt idx="3">
                  <c:v>GSTU6</c:v>
                </c:pt>
                <c:pt idx="4">
                  <c:v>GSTU10</c:v>
                </c:pt>
                <c:pt idx="5">
                  <c:v>GSTL1</c:v>
                </c:pt>
              </c:strCache>
            </c:strRef>
          </c:cat>
          <c:val>
            <c:numRef>
              <c:f>Sheet1!$BR$17:$BW$17</c:f>
              <c:numCache>
                <c:formatCode>0.00</c:formatCode>
                <c:ptCount val="6"/>
                <c:pt idx="0">
                  <c:v>66.183105243011184</c:v>
                </c:pt>
                <c:pt idx="1">
                  <c:v>29.920885696137493</c:v>
                </c:pt>
                <c:pt idx="2">
                  <c:v>38.463669801228484</c:v>
                </c:pt>
                <c:pt idx="3">
                  <c:v>21.980092748068166</c:v>
                </c:pt>
                <c:pt idx="4">
                  <c:v>63.38404652265379</c:v>
                </c:pt>
                <c:pt idx="5">
                  <c:v>68.608332316280951</c:v>
                </c:pt>
              </c:numCache>
            </c:numRef>
          </c:val>
        </c:ser>
        <c:ser>
          <c:idx val="4"/>
          <c:order val="4"/>
          <c:tx>
            <c:v>72h</c:v>
          </c:tx>
          <c:errBars>
            <c:errBarType val="both"/>
            <c:errValType val="cust"/>
            <c:plus>
              <c:numRef>
                <c:f>Sheet1!$BR$25:$BW$25</c:f>
                <c:numCache>
                  <c:formatCode>General</c:formatCode>
                  <c:ptCount val="6"/>
                  <c:pt idx="0">
                    <c:v>3.3163455366369567</c:v>
                  </c:pt>
                  <c:pt idx="1">
                    <c:v>1.6971740943672999</c:v>
                  </c:pt>
                  <c:pt idx="2">
                    <c:v>2.2377985837920011</c:v>
                  </c:pt>
                  <c:pt idx="3">
                    <c:v>1.6971740943672999</c:v>
                  </c:pt>
                  <c:pt idx="4">
                    <c:v>2.2377985837920011</c:v>
                  </c:pt>
                  <c:pt idx="5">
                    <c:v>1.0570888880376099</c:v>
                  </c:pt>
                </c:numCache>
              </c:numRef>
            </c:plus>
            <c:minus>
              <c:numRef>
                <c:f>Sheet1!$BR$25:$BW$25</c:f>
                <c:numCache>
                  <c:formatCode>General</c:formatCode>
                  <c:ptCount val="6"/>
                  <c:pt idx="0">
                    <c:v>3.3163455366369567</c:v>
                  </c:pt>
                  <c:pt idx="1">
                    <c:v>1.6971740943672999</c:v>
                  </c:pt>
                  <c:pt idx="2">
                    <c:v>2.2377985837920011</c:v>
                  </c:pt>
                  <c:pt idx="3">
                    <c:v>1.6971740943672999</c:v>
                  </c:pt>
                  <c:pt idx="4">
                    <c:v>2.2377985837920011</c:v>
                  </c:pt>
                  <c:pt idx="5">
                    <c:v>1.0570888880376099</c:v>
                  </c:pt>
                </c:numCache>
              </c:numRef>
            </c:minus>
          </c:errBars>
          <c:cat>
            <c:strRef>
              <c:f>Sheet1!$BR$13:$BW$13</c:f>
              <c:strCache>
                <c:ptCount val="6"/>
                <c:pt idx="0">
                  <c:v>GSTU1</c:v>
                </c:pt>
                <c:pt idx="1">
                  <c:v>GSTU4</c:v>
                </c:pt>
                <c:pt idx="2">
                  <c:v>GSTU5</c:v>
                </c:pt>
                <c:pt idx="3">
                  <c:v>GSTU6</c:v>
                </c:pt>
                <c:pt idx="4">
                  <c:v>GSTU10</c:v>
                </c:pt>
                <c:pt idx="5">
                  <c:v>GSTL1</c:v>
                </c:pt>
              </c:strCache>
            </c:strRef>
          </c:cat>
          <c:val>
            <c:numRef>
              <c:f>Sheet1!$BR$18:$BW$18</c:f>
              <c:numCache>
                <c:formatCode>0.00</c:formatCode>
                <c:ptCount val="6"/>
                <c:pt idx="0">
                  <c:v>46.316777126529317</c:v>
                </c:pt>
                <c:pt idx="1">
                  <c:v>11.923217507242027</c:v>
                </c:pt>
                <c:pt idx="2">
                  <c:v>34.365343328242105</c:v>
                </c:pt>
                <c:pt idx="3">
                  <c:v>12.988856210988176</c:v>
                </c:pt>
                <c:pt idx="4">
                  <c:v>30.748504962764265</c:v>
                </c:pt>
                <c:pt idx="5">
                  <c:v>37.428053905341642</c:v>
                </c:pt>
              </c:numCache>
            </c:numRef>
          </c:val>
        </c:ser>
        <c:axId val="74202496"/>
        <c:axId val="74224768"/>
      </c:barChart>
      <c:catAx>
        <c:axId val="74202496"/>
        <c:scaling>
          <c:orientation val="minMax"/>
        </c:scaling>
        <c:axPos val="b"/>
        <c:tickLblPos val="nextTo"/>
        <c:crossAx val="74224768"/>
        <c:crosses val="autoZero"/>
        <c:auto val="1"/>
        <c:lblAlgn val="ctr"/>
        <c:lblOffset val="100"/>
      </c:catAx>
      <c:valAx>
        <c:axId val="74224768"/>
        <c:scaling>
          <c:orientation val="minMax"/>
        </c:scaling>
        <c:axPos val="l"/>
        <c:numFmt formatCode="General" sourceLinked="1"/>
        <c:tickLblPos val="nextTo"/>
        <c:crossAx val="74202496"/>
        <c:crosses val="autoZero"/>
        <c:crossBetween val="between"/>
      </c:valAx>
    </c:plotArea>
    <c:plotVisOnly val="1"/>
  </c:chart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0h</c:v>
          </c:tx>
          <c:errBars>
            <c:errBarType val="both"/>
            <c:errValType val="cust"/>
            <c:plus>
              <c:numRef>
                <c:f>Sheet12!$B$146:$W$146</c:f>
                <c:numCache>
                  <c:formatCode>General</c:formatCode>
                  <c:ptCount val="22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  <c:pt idx="21">
                    <c:v>0</c:v>
                  </c:pt>
                </c:numCache>
              </c:numRef>
            </c:plus>
            <c:minus>
              <c:numRef>
                <c:f>Sheet12!$B$146:$W$146</c:f>
                <c:numCache>
                  <c:formatCode>General</c:formatCode>
                  <c:ptCount val="22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  <c:pt idx="21">
                    <c:v>0</c:v>
                  </c:pt>
                </c:numCache>
              </c:numRef>
            </c:minus>
          </c:errBars>
          <c:cat>
            <c:strRef>
              <c:f>Sheet12!$B$136:$W$136</c:f>
              <c:strCache>
                <c:ptCount val="22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3</c:v>
                </c:pt>
                <c:pt idx="13">
                  <c:v>GSTU14</c:v>
                </c:pt>
                <c:pt idx="14">
                  <c:v>GSTU15</c:v>
                </c:pt>
                <c:pt idx="15">
                  <c:v>GSTU16</c:v>
                </c:pt>
                <c:pt idx="16">
                  <c:v>GSTU17</c:v>
                </c:pt>
                <c:pt idx="17">
                  <c:v>GSTF2</c:v>
                </c:pt>
                <c:pt idx="18">
                  <c:v>GSTZ2   </c:v>
                </c:pt>
                <c:pt idx="19">
                  <c:v>EF1G2    </c:v>
                </c:pt>
                <c:pt idx="20">
                  <c:v>GSTL1    </c:v>
                </c:pt>
                <c:pt idx="21">
                  <c:v>GSTT2    </c:v>
                </c:pt>
              </c:strCache>
            </c:strRef>
          </c:cat>
          <c:val>
            <c:numRef>
              <c:f>Sheet12!$B$137:$W$137</c:f>
              <c:numCache>
                <c:formatCode>0.00</c:formatCode>
                <c:ptCount val="22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</c:numCache>
            </c:numRef>
          </c:val>
        </c:ser>
        <c:ser>
          <c:idx val="1"/>
          <c:order val="1"/>
          <c:tx>
            <c:v>6h</c:v>
          </c:tx>
          <c:errBars>
            <c:errBarType val="both"/>
            <c:errValType val="cust"/>
            <c:plus>
              <c:numRef>
                <c:f>Sheet12!$B$147:$W$147</c:f>
                <c:numCache>
                  <c:formatCode>General</c:formatCode>
                  <c:ptCount val="22"/>
                  <c:pt idx="0">
                    <c:v>0.32509219364891262</c:v>
                  </c:pt>
                  <c:pt idx="1">
                    <c:v>6.1354170077569055E-2</c:v>
                  </c:pt>
                  <c:pt idx="2">
                    <c:v>2.5420892637006445E-2</c:v>
                  </c:pt>
                  <c:pt idx="3">
                    <c:v>0.14704506884730495</c:v>
                  </c:pt>
                  <c:pt idx="4">
                    <c:v>8.3582699066329702E-2</c:v>
                  </c:pt>
                  <c:pt idx="5">
                    <c:v>0.44910992742356093</c:v>
                  </c:pt>
                  <c:pt idx="6">
                    <c:v>0.45526583313882668</c:v>
                  </c:pt>
                  <c:pt idx="7">
                    <c:v>7.9105145049368039E-2</c:v>
                  </c:pt>
                  <c:pt idx="8">
                    <c:v>0.11642452343053154</c:v>
                  </c:pt>
                  <c:pt idx="9">
                    <c:v>8.8821052179085147E-2</c:v>
                  </c:pt>
                  <c:pt idx="10">
                    <c:v>0.95309216619271098</c:v>
                  </c:pt>
                  <c:pt idx="11">
                    <c:v>0.6433494800844004</c:v>
                  </c:pt>
                  <c:pt idx="12">
                    <c:v>0.11070414124756429</c:v>
                  </c:pt>
                  <c:pt idx="13">
                    <c:v>0.36427763206458702</c:v>
                  </c:pt>
                  <c:pt idx="14">
                    <c:v>3.2392462762261412E-3</c:v>
                  </c:pt>
                  <c:pt idx="15">
                    <c:v>0.11976166309636256</c:v>
                  </c:pt>
                  <c:pt idx="16">
                    <c:v>0.2164935750700499</c:v>
                  </c:pt>
                  <c:pt idx="17">
                    <c:v>4.8783475966927933E-2</c:v>
                  </c:pt>
                  <c:pt idx="18">
                    <c:v>0.43588673126814886</c:v>
                  </c:pt>
                  <c:pt idx="19">
                    <c:v>0.11576533225257032</c:v>
                  </c:pt>
                  <c:pt idx="20">
                    <c:v>8.7461136067386105E-2</c:v>
                  </c:pt>
                  <c:pt idx="21">
                    <c:v>4.6480061966082772E-2</c:v>
                  </c:pt>
                </c:numCache>
              </c:numRef>
            </c:plus>
            <c:minus>
              <c:numRef>
                <c:f>Sheet12!$B$147:$W$147</c:f>
                <c:numCache>
                  <c:formatCode>General</c:formatCode>
                  <c:ptCount val="22"/>
                  <c:pt idx="0">
                    <c:v>0.32509219364891262</c:v>
                  </c:pt>
                  <c:pt idx="1">
                    <c:v>6.1354170077569055E-2</c:v>
                  </c:pt>
                  <c:pt idx="2">
                    <c:v>2.5420892637006445E-2</c:v>
                  </c:pt>
                  <c:pt idx="3">
                    <c:v>0.14704506884730495</c:v>
                  </c:pt>
                  <c:pt idx="4">
                    <c:v>8.3582699066329702E-2</c:v>
                  </c:pt>
                  <c:pt idx="5">
                    <c:v>0.44910992742356093</c:v>
                  </c:pt>
                  <c:pt idx="6">
                    <c:v>0.45526583313882668</c:v>
                  </c:pt>
                  <c:pt idx="7">
                    <c:v>7.9105145049368039E-2</c:v>
                  </c:pt>
                  <c:pt idx="8">
                    <c:v>0.11642452343053154</c:v>
                  </c:pt>
                  <c:pt idx="9">
                    <c:v>8.8821052179085147E-2</c:v>
                  </c:pt>
                  <c:pt idx="10">
                    <c:v>0.95309216619271098</c:v>
                  </c:pt>
                  <c:pt idx="11">
                    <c:v>0.6433494800844004</c:v>
                  </c:pt>
                  <c:pt idx="12">
                    <c:v>0.11070414124756429</c:v>
                  </c:pt>
                  <c:pt idx="13">
                    <c:v>0.36427763206458702</c:v>
                  </c:pt>
                  <c:pt idx="14">
                    <c:v>3.2392462762261412E-3</c:v>
                  </c:pt>
                  <c:pt idx="15">
                    <c:v>0.11976166309636256</c:v>
                  </c:pt>
                  <c:pt idx="16">
                    <c:v>0.2164935750700499</c:v>
                  </c:pt>
                  <c:pt idx="17">
                    <c:v>4.8783475966927933E-2</c:v>
                  </c:pt>
                  <c:pt idx="18">
                    <c:v>0.43588673126814886</c:v>
                  </c:pt>
                  <c:pt idx="19">
                    <c:v>0.11576533225257032</c:v>
                  </c:pt>
                  <c:pt idx="20">
                    <c:v>8.7461136067386105E-2</c:v>
                  </c:pt>
                  <c:pt idx="21">
                    <c:v>4.6480061966082772E-2</c:v>
                  </c:pt>
                </c:numCache>
              </c:numRef>
            </c:minus>
          </c:errBars>
          <c:cat>
            <c:strRef>
              <c:f>Sheet12!$B$136:$W$136</c:f>
              <c:strCache>
                <c:ptCount val="22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3</c:v>
                </c:pt>
                <c:pt idx="13">
                  <c:v>GSTU14</c:v>
                </c:pt>
                <c:pt idx="14">
                  <c:v>GSTU15</c:v>
                </c:pt>
                <c:pt idx="15">
                  <c:v>GSTU16</c:v>
                </c:pt>
                <c:pt idx="16">
                  <c:v>GSTU17</c:v>
                </c:pt>
                <c:pt idx="17">
                  <c:v>GSTF2</c:v>
                </c:pt>
                <c:pt idx="18">
                  <c:v>GSTZ2   </c:v>
                </c:pt>
                <c:pt idx="19">
                  <c:v>EF1G2    </c:v>
                </c:pt>
                <c:pt idx="20">
                  <c:v>GSTL1    </c:v>
                </c:pt>
                <c:pt idx="21">
                  <c:v>GSTT2    </c:v>
                </c:pt>
              </c:strCache>
            </c:strRef>
          </c:cat>
          <c:val>
            <c:numRef>
              <c:f>Sheet12!$B$138:$W$138</c:f>
              <c:numCache>
                <c:formatCode>0.00</c:formatCode>
                <c:ptCount val="22"/>
                <c:pt idx="0">
                  <c:v>0.66515017628802076</c:v>
                </c:pt>
                <c:pt idx="1">
                  <c:v>0.96357160034079758</c:v>
                </c:pt>
                <c:pt idx="2">
                  <c:v>0.47173486322602182</c:v>
                </c:pt>
                <c:pt idx="3">
                  <c:v>0.46246537732592946</c:v>
                </c:pt>
                <c:pt idx="4">
                  <c:v>0.55221824554635657</c:v>
                </c:pt>
                <c:pt idx="5">
                  <c:v>5.9113316840208396</c:v>
                </c:pt>
                <c:pt idx="6">
                  <c:v>2.2807621530288587</c:v>
                </c:pt>
                <c:pt idx="7">
                  <c:v>9.4912110661391669</c:v>
                </c:pt>
                <c:pt idx="8">
                  <c:v>1.0349625680580781</c:v>
                </c:pt>
                <c:pt idx="9">
                  <c:v>0.39728785700448443</c:v>
                </c:pt>
                <c:pt idx="10">
                  <c:v>14.5071545949121</c:v>
                </c:pt>
                <c:pt idx="11">
                  <c:v>12.804435208099756</c:v>
                </c:pt>
                <c:pt idx="12">
                  <c:v>0.55459864800355374</c:v>
                </c:pt>
                <c:pt idx="13">
                  <c:v>6.6567712883575085</c:v>
                </c:pt>
                <c:pt idx="14">
                  <c:v>9.4432319088546518E-2</c:v>
                </c:pt>
                <c:pt idx="15">
                  <c:v>1.3592449114208769</c:v>
                </c:pt>
                <c:pt idx="16">
                  <c:v>1.0116495114531046</c:v>
                </c:pt>
                <c:pt idx="17">
                  <c:v>1.106268589202358</c:v>
                </c:pt>
                <c:pt idx="18">
                  <c:v>4.7324825322208701</c:v>
                </c:pt>
                <c:pt idx="19">
                  <c:v>0.79111739107810053</c:v>
                </c:pt>
                <c:pt idx="20">
                  <c:v>0.42786578638993705</c:v>
                </c:pt>
                <c:pt idx="21">
                  <c:v>0.79072465026138805</c:v>
                </c:pt>
              </c:numCache>
            </c:numRef>
          </c:val>
        </c:ser>
        <c:ser>
          <c:idx val="2"/>
          <c:order val="2"/>
          <c:tx>
            <c:v>24h</c:v>
          </c:tx>
          <c:errBars>
            <c:errBarType val="both"/>
            <c:errValType val="cust"/>
            <c:plus>
              <c:numRef>
                <c:f>Sheet12!$B$148:$W$148</c:f>
                <c:numCache>
                  <c:formatCode>General</c:formatCode>
                  <c:ptCount val="22"/>
                  <c:pt idx="0">
                    <c:v>0.63980809746084366</c:v>
                  </c:pt>
                  <c:pt idx="1">
                    <c:v>0.39805730978284626</c:v>
                  </c:pt>
                  <c:pt idx="2">
                    <c:v>6.9735556335242005E-2</c:v>
                  </c:pt>
                  <c:pt idx="3">
                    <c:v>0.1250679944630777</c:v>
                  </c:pt>
                  <c:pt idx="4">
                    <c:v>0.1040094052975568</c:v>
                  </c:pt>
                  <c:pt idx="5">
                    <c:v>0.14656315110708507</c:v>
                  </c:pt>
                  <c:pt idx="6">
                    <c:v>0.36470095901807031</c:v>
                  </c:pt>
                  <c:pt idx="7">
                    <c:v>7.8769347634667711E-2</c:v>
                  </c:pt>
                  <c:pt idx="8">
                    <c:v>0.6122369598505335</c:v>
                  </c:pt>
                  <c:pt idx="9">
                    <c:v>0.32534159082779307</c:v>
                  </c:pt>
                  <c:pt idx="10">
                    <c:v>0.54604837402984463</c:v>
                  </c:pt>
                  <c:pt idx="11">
                    <c:v>0.65870366275825565</c:v>
                  </c:pt>
                  <c:pt idx="12">
                    <c:v>2.8355432892838577E-2</c:v>
                  </c:pt>
                  <c:pt idx="13">
                    <c:v>0.88754759281282758</c:v>
                  </c:pt>
                  <c:pt idx="14">
                    <c:v>1.248470748002518E-3</c:v>
                  </c:pt>
                  <c:pt idx="15">
                    <c:v>5.9629022650694807E-2</c:v>
                  </c:pt>
                  <c:pt idx="16">
                    <c:v>3.900810703241863E-2</c:v>
                  </c:pt>
                  <c:pt idx="17">
                    <c:v>0.15157636488499895</c:v>
                  </c:pt>
                  <c:pt idx="18">
                    <c:v>0.62344103445653498</c:v>
                  </c:pt>
                  <c:pt idx="19">
                    <c:v>5.4343001666295312E-2</c:v>
                  </c:pt>
                  <c:pt idx="20">
                    <c:v>0.3392295267815158</c:v>
                  </c:pt>
                  <c:pt idx="21">
                    <c:v>3.2852762556762692E-2</c:v>
                  </c:pt>
                </c:numCache>
              </c:numRef>
            </c:plus>
            <c:minus>
              <c:numRef>
                <c:f>Sheet12!$B$148:$W$148</c:f>
                <c:numCache>
                  <c:formatCode>General</c:formatCode>
                  <c:ptCount val="22"/>
                  <c:pt idx="0">
                    <c:v>0.63980809746084366</c:v>
                  </c:pt>
                  <c:pt idx="1">
                    <c:v>0.39805730978284626</c:v>
                  </c:pt>
                  <c:pt idx="2">
                    <c:v>6.9735556335242005E-2</c:v>
                  </c:pt>
                  <c:pt idx="3">
                    <c:v>0.1250679944630777</c:v>
                  </c:pt>
                  <c:pt idx="4">
                    <c:v>0.1040094052975568</c:v>
                  </c:pt>
                  <c:pt idx="5">
                    <c:v>0.14656315110708507</c:v>
                  </c:pt>
                  <c:pt idx="6">
                    <c:v>0.36470095901807031</c:v>
                  </c:pt>
                  <c:pt idx="7">
                    <c:v>7.8769347634667711E-2</c:v>
                  </c:pt>
                  <c:pt idx="8">
                    <c:v>0.6122369598505335</c:v>
                  </c:pt>
                  <c:pt idx="9">
                    <c:v>0.32534159082779307</c:v>
                  </c:pt>
                  <c:pt idx="10">
                    <c:v>0.54604837402984463</c:v>
                  </c:pt>
                  <c:pt idx="11">
                    <c:v>0.65870366275825565</c:v>
                  </c:pt>
                  <c:pt idx="12">
                    <c:v>2.8355432892838577E-2</c:v>
                  </c:pt>
                  <c:pt idx="13">
                    <c:v>0.88754759281282758</c:v>
                  </c:pt>
                  <c:pt idx="14">
                    <c:v>1.248470748002518E-3</c:v>
                  </c:pt>
                  <c:pt idx="15">
                    <c:v>5.9629022650694807E-2</c:v>
                  </c:pt>
                  <c:pt idx="16">
                    <c:v>3.900810703241863E-2</c:v>
                  </c:pt>
                  <c:pt idx="17">
                    <c:v>0.15157636488499895</c:v>
                  </c:pt>
                  <c:pt idx="18">
                    <c:v>0.62344103445653498</c:v>
                  </c:pt>
                  <c:pt idx="19">
                    <c:v>5.4343001666295312E-2</c:v>
                  </c:pt>
                  <c:pt idx="20">
                    <c:v>0.3392295267815158</c:v>
                  </c:pt>
                  <c:pt idx="21">
                    <c:v>3.2852762556762692E-2</c:v>
                  </c:pt>
                </c:numCache>
              </c:numRef>
            </c:minus>
          </c:errBars>
          <c:cat>
            <c:strRef>
              <c:f>Sheet12!$B$136:$W$136</c:f>
              <c:strCache>
                <c:ptCount val="22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3</c:v>
                </c:pt>
                <c:pt idx="13">
                  <c:v>GSTU14</c:v>
                </c:pt>
                <c:pt idx="14">
                  <c:v>GSTU15</c:v>
                </c:pt>
                <c:pt idx="15">
                  <c:v>GSTU16</c:v>
                </c:pt>
                <c:pt idx="16">
                  <c:v>GSTU17</c:v>
                </c:pt>
                <c:pt idx="17">
                  <c:v>GSTF2</c:v>
                </c:pt>
                <c:pt idx="18">
                  <c:v>GSTZ2   </c:v>
                </c:pt>
                <c:pt idx="19">
                  <c:v>EF1G2    </c:v>
                </c:pt>
                <c:pt idx="20">
                  <c:v>GSTL1    </c:v>
                </c:pt>
                <c:pt idx="21">
                  <c:v>GSTT2    </c:v>
                </c:pt>
              </c:strCache>
            </c:strRef>
          </c:cat>
          <c:val>
            <c:numRef>
              <c:f>Sheet12!$B$139:$W$139</c:f>
              <c:numCache>
                <c:formatCode>0.00</c:formatCode>
                <c:ptCount val="22"/>
                <c:pt idx="0">
                  <c:v>1.1167555514208822</c:v>
                </c:pt>
                <c:pt idx="1">
                  <c:v>4.7715594265613523</c:v>
                </c:pt>
                <c:pt idx="2">
                  <c:v>0.57054336519502458</c:v>
                </c:pt>
                <c:pt idx="3">
                  <c:v>0.37165739831819339</c:v>
                </c:pt>
                <c:pt idx="4">
                  <c:v>0.50882103744114626</c:v>
                </c:pt>
                <c:pt idx="5">
                  <c:v>12.991494189064802</c:v>
                </c:pt>
                <c:pt idx="6">
                  <c:v>1.7841417301874678</c:v>
                </c:pt>
                <c:pt idx="7">
                  <c:v>4.2905790271656095</c:v>
                </c:pt>
                <c:pt idx="8">
                  <c:v>6.2483605372303996</c:v>
                </c:pt>
                <c:pt idx="9">
                  <c:v>0.39845544218456291</c:v>
                </c:pt>
                <c:pt idx="10">
                  <c:v>7.3131830367386446</c:v>
                </c:pt>
                <c:pt idx="11">
                  <c:v>10.198197941922098</c:v>
                </c:pt>
                <c:pt idx="12">
                  <c:v>0.22311341797106471</c:v>
                </c:pt>
                <c:pt idx="13">
                  <c:v>14.863828969739902</c:v>
                </c:pt>
                <c:pt idx="14">
                  <c:v>5.0949669481376865E-2</c:v>
                </c:pt>
                <c:pt idx="15">
                  <c:v>1.1065342687251938</c:v>
                </c:pt>
                <c:pt idx="16">
                  <c:v>0.53106067203223351</c:v>
                </c:pt>
                <c:pt idx="17">
                  <c:v>1.9348435759365945</c:v>
                </c:pt>
                <c:pt idx="18">
                  <c:v>3.2644304004017402</c:v>
                </c:pt>
                <c:pt idx="19">
                  <c:v>0.61677039694091162</c:v>
                </c:pt>
                <c:pt idx="20">
                  <c:v>2.1717441566156022</c:v>
                </c:pt>
                <c:pt idx="21">
                  <c:v>0.60964788580053864</c:v>
                </c:pt>
              </c:numCache>
            </c:numRef>
          </c:val>
        </c:ser>
        <c:ser>
          <c:idx val="3"/>
          <c:order val="3"/>
          <c:tx>
            <c:v>48h</c:v>
          </c:tx>
          <c:errBars>
            <c:errBarType val="both"/>
            <c:errValType val="cust"/>
            <c:plus>
              <c:numRef>
                <c:f>Sheet12!$B$149:$W$149</c:f>
                <c:numCache>
                  <c:formatCode>General</c:formatCode>
                  <c:ptCount val="22"/>
                  <c:pt idx="0">
                    <c:v>1.0835090146731059</c:v>
                  </c:pt>
                  <c:pt idx="1">
                    <c:v>0.69111415345920668</c:v>
                  </c:pt>
                  <c:pt idx="2">
                    <c:v>0.21314657818428343</c:v>
                  </c:pt>
                  <c:pt idx="3">
                    <c:v>0.20742718193355511</c:v>
                  </c:pt>
                  <c:pt idx="4">
                    <c:v>7.3097622483809951E-2</c:v>
                  </c:pt>
                  <c:pt idx="5">
                    <c:v>0</c:v>
                  </c:pt>
                  <c:pt idx="6">
                    <c:v>1.3509769947184269</c:v>
                  </c:pt>
                  <c:pt idx="7">
                    <c:v>0.10231173206456101</c:v>
                  </c:pt>
                  <c:pt idx="8">
                    <c:v>0.37620588751854733</c:v>
                  </c:pt>
                  <c:pt idx="9">
                    <c:v>1.06437018245336</c:v>
                  </c:pt>
                  <c:pt idx="10">
                    <c:v>6.9603245328332897E-2</c:v>
                  </c:pt>
                  <c:pt idx="11">
                    <c:v>0.38109908939329334</c:v>
                  </c:pt>
                  <c:pt idx="12">
                    <c:v>1.6400389334507805E-2</c:v>
                  </c:pt>
                  <c:pt idx="13">
                    <c:v>0.30383235368097838</c:v>
                  </c:pt>
                  <c:pt idx="14">
                    <c:v>3.5142722222594194E-2</c:v>
                  </c:pt>
                  <c:pt idx="15">
                    <c:v>6.6504433546673583E-2</c:v>
                  </c:pt>
                  <c:pt idx="16">
                    <c:v>6.0975679240207942E-2</c:v>
                  </c:pt>
                  <c:pt idx="17">
                    <c:v>0.33867081525414633</c:v>
                  </c:pt>
                  <c:pt idx="18">
                    <c:v>4.8111859437453601E-2</c:v>
                  </c:pt>
                  <c:pt idx="19">
                    <c:v>9.9029564688377564E-2</c:v>
                  </c:pt>
                  <c:pt idx="20">
                    <c:v>0.51220239306965409</c:v>
                  </c:pt>
                  <c:pt idx="21">
                    <c:v>4.3662434037412302E-2</c:v>
                  </c:pt>
                </c:numCache>
              </c:numRef>
            </c:plus>
            <c:minus>
              <c:numRef>
                <c:f>Sheet12!$B$149:$W$149</c:f>
                <c:numCache>
                  <c:formatCode>General</c:formatCode>
                  <c:ptCount val="22"/>
                  <c:pt idx="0">
                    <c:v>1.0835090146731059</c:v>
                  </c:pt>
                  <c:pt idx="1">
                    <c:v>0.69111415345920668</c:v>
                  </c:pt>
                  <c:pt idx="2">
                    <c:v>0.21314657818428343</c:v>
                  </c:pt>
                  <c:pt idx="3">
                    <c:v>0.20742718193355511</c:v>
                  </c:pt>
                  <c:pt idx="4">
                    <c:v>7.3097622483809951E-2</c:v>
                  </c:pt>
                  <c:pt idx="5">
                    <c:v>0</c:v>
                  </c:pt>
                  <c:pt idx="6">
                    <c:v>1.3509769947184269</c:v>
                  </c:pt>
                  <c:pt idx="7">
                    <c:v>0.10231173206456101</c:v>
                  </c:pt>
                  <c:pt idx="8">
                    <c:v>0.37620588751854733</c:v>
                  </c:pt>
                  <c:pt idx="9">
                    <c:v>1.06437018245336</c:v>
                  </c:pt>
                  <c:pt idx="10">
                    <c:v>6.9603245328332897E-2</c:v>
                  </c:pt>
                  <c:pt idx="11">
                    <c:v>0.38109908939329334</c:v>
                  </c:pt>
                  <c:pt idx="12">
                    <c:v>1.6400389334507805E-2</c:v>
                  </c:pt>
                  <c:pt idx="13">
                    <c:v>0.30383235368097838</c:v>
                  </c:pt>
                  <c:pt idx="14">
                    <c:v>3.5142722222594194E-2</c:v>
                  </c:pt>
                  <c:pt idx="15">
                    <c:v>6.6504433546673583E-2</c:v>
                  </c:pt>
                  <c:pt idx="16">
                    <c:v>6.0975679240207942E-2</c:v>
                  </c:pt>
                  <c:pt idx="17">
                    <c:v>0.33867081525414633</c:v>
                  </c:pt>
                  <c:pt idx="18">
                    <c:v>4.8111859437453601E-2</c:v>
                  </c:pt>
                  <c:pt idx="19">
                    <c:v>9.9029564688377564E-2</c:v>
                  </c:pt>
                  <c:pt idx="20">
                    <c:v>0.51220239306965409</c:v>
                  </c:pt>
                  <c:pt idx="21">
                    <c:v>4.3662434037412302E-2</c:v>
                  </c:pt>
                </c:numCache>
              </c:numRef>
            </c:minus>
          </c:errBars>
          <c:cat>
            <c:strRef>
              <c:f>Sheet12!$B$136:$W$136</c:f>
              <c:strCache>
                <c:ptCount val="22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3</c:v>
                </c:pt>
                <c:pt idx="13">
                  <c:v>GSTU14</c:v>
                </c:pt>
                <c:pt idx="14">
                  <c:v>GSTU15</c:v>
                </c:pt>
                <c:pt idx="15">
                  <c:v>GSTU16</c:v>
                </c:pt>
                <c:pt idx="16">
                  <c:v>GSTU17</c:v>
                </c:pt>
                <c:pt idx="17">
                  <c:v>GSTF2</c:v>
                </c:pt>
                <c:pt idx="18">
                  <c:v>GSTZ2   </c:v>
                </c:pt>
                <c:pt idx="19">
                  <c:v>EF1G2    </c:v>
                </c:pt>
                <c:pt idx="20">
                  <c:v>GSTL1    </c:v>
                </c:pt>
                <c:pt idx="21">
                  <c:v>GSTT2    </c:v>
                </c:pt>
              </c:strCache>
            </c:strRef>
          </c:cat>
          <c:val>
            <c:numRef>
              <c:f>Sheet12!$B$140:$W$140</c:f>
              <c:numCache>
                <c:formatCode>0.00</c:formatCode>
                <c:ptCount val="22"/>
                <c:pt idx="0">
                  <c:v>1.891215056440916</c:v>
                </c:pt>
                <c:pt idx="1">
                  <c:v>5.0517463679586836</c:v>
                </c:pt>
                <c:pt idx="2">
                  <c:v>2.9018010271002987</c:v>
                </c:pt>
                <c:pt idx="3">
                  <c:v>0.79284958226638214</c:v>
                </c:pt>
                <c:pt idx="4">
                  <c:v>0.71144177993336288</c:v>
                </c:pt>
                <c:pt idx="5">
                  <c:v>2.5140267490436536</c:v>
                </c:pt>
                <c:pt idx="6">
                  <c:v>11.511348280375518</c:v>
                </c:pt>
                <c:pt idx="7">
                  <c:v>2.5828513823913801</c:v>
                </c:pt>
                <c:pt idx="8">
                  <c:v>11.678722229309599</c:v>
                </c:pt>
                <c:pt idx="9">
                  <c:v>2.2578701211166008</c:v>
                </c:pt>
                <c:pt idx="10">
                  <c:v>1.0151532556890968</c:v>
                </c:pt>
                <c:pt idx="11">
                  <c:v>4.3253156695741257</c:v>
                </c:pt>
                <c:pt idx="12">
                  <c:v>0.47811332228093317</c:v>
                </c:pt>
                <c:pt idx="13">
                  <c:v>3.2673603355528082</c:v>
                </c:pt>
                <c:pt idx="14">
                  <c:v>0.26633373942416222</c:v>
                </c:pt>
                <c:pt idx="15">
                  <c:v>1.3574191397981781</c:v>
                </c:pt>
                <c:pt idx="16">
                  <c:v>2.4883968716623657</c:v>
                </c:pt>
                <c:pt idx="17">
                  <c:v>6.9450255860479055</c:v>
                </c:pt>
                <c:pt idx="18">
                  <c:v>1.0910382626250934</c:v>
                </c:pt>
                <c:pt idx="19">
                  <c:v>0.84380697350029865</c:v>
                </c:pt>
                <c:pt idx="20">
                  <c:v>2.5057287105521215</c:v>
                </c:pt>
                <c:pt idx="21">
                  <c:v>0.99013812251622846</c:v>
                </c:pt>
              </c:numCache>
            </c:numRef>
          </c:val>
        </c:ser>
        <c:ser>
          <c:idx val="4"/>
          <c:order val="4"/>
          <c:tx>
            <c:v>72h</c:v>
          </c:tx>
          <c:errBars>
            <c:errBarType val="both"/>
            <c:errValType val="cust"/>
            <c:plus>
              <c:numRef>
                <c:f>Sheet12!$B$150:$W$150</c:f>
                <c:numCache>
                  <c:formatCode>General</c:formatCode>
                  <c:ptCount val="22"/>
                  <c:pt idx="0">
                    <c:v>0.87463935510182589</c:v>
                  </c:pt>
                  <c:pt idx="1">
                    <c:v>0.83741214381200135</c:v>
                  </c:pt>
                  <c:pt idx="2">
                    <c:v>7.0940622608787321E-2</c:v>
                  </c:pt>
                  <c:pt idx="3">
                    <c:v>0.12875127449145971</c:v>
                  </c:pt>
                  <c:pt idx="4">
                    <c:v>2.8718350918452477E-2</c:v>
                  </c:pt>
                  <c:pt idx="5">
                    <c:v>0.25344928372511005</c:v>
                  </c:pt>
                  <c:pt idx="6">
                    <c:v>0.73226376286744743</c:v>
                  </c:pt>
                  <c:pt idx="7">
                    <c:v>1.7128425710609681E-2</c:v>
                  </c:pt>
                  <c:pt idx="8">
                    <c:v>3.0978025241927821E-2</c:v>
                  </c:pt>
                  <c:pt idx="9">
                    <c:v>1.0929328213597229</c:v>
                  </c:pt>
                  <c:pt idx="10">
                    <c:v>0.13896137141300174</c:v>
                  </c:pt>
                  <c:pt idx="11">
                    <c:v>0.18404324683856962</c:v>
                  </c:pt>
                  <c:pt idx="12">
                    <c:v>3.4672011367905882E-2</c:v>
                  </c:pt>
                  <c:pt idx="13">
                    <c:v>0.19185878334323192</c:v>
                  </c:pt>
                  <c:pt idx="14">
                    <c:v>1.8022816478560445E-2</c:v>
                  </c:pt>
                  <c:pt idx="15">
                    <c:v>3.3668943736039576E-2</c:v>
                  </c:pt>
                  <c:pt idx="16">
                    <c:v>0.56108580056701063</c:v>
                  </c:pt>
                  <c:pt idx="17">
                    <c:v>8.7324868074824563E-2</c:v>
                  </c:pt>
                  <c:pt idx="18">
                    <c:v>6.7139481861961434E-2</c:v>
                  </c:pt>
                  <c:pt idx="19">
                    <c:v>0.12677425080603441</c:v>
                  </c:pt>
                  <c:pt idx="20">
                    <c:v>0.41542461823152482</c:v>
                  </c:pt>
                  <c:pt idx="21">
                    <c:v>5.1931575411503887E-2</c:v>
                  </c:pt>
                </c:numCache>
              </c:numRef>
            </c:plus>
            <c:minus>
              <c:numRef>
                <c:f>Sheet12!$B$150:$W$150</c:f>
                <c:numCache>
                  <c:formatCode>General</c:formatCode>
                  <c:ptCount val="22"/>
                  <c:pt idx="0">
                    <c:v>0.87463935510182589</c:v>
                  </c:pt>
                  <c:pt idx="1">
                    <c:v>0.83741214381200135</c:v>
                  </c:pt>
                  <c:pt idx="2">
                    <c:v>7.0940622608787321E-2</c:v>
                  </c:pt>
                  <c:pt idx="3">
                    <c:v>0.12875127449145971</c:v>
                  </c:pt>
                  <c:pt idx="4">
                    <c:v>2.8718350918452477E-2</c:v>
                  </c:pt>
                  <c:pt idx="5">
                    <c:v>0.25344928372511005</c:v>
                  </c:pt>
                  <c:pt idx="6">
                    <c:v>0.73226376286744743</c:v>
                  </c:pt>
                  <c:pt idx="7">
                    <c:v>1.7128425710609681E-2</c:v>
                  </c:pt>
                  <c:pt idx="8">
                    <c:v>3.0978025241927821E-2</c:v>
                  </c:pt>
                  <c:pt idx="9">
                    <c:v>1.0929328213597229</c:v>
                  </c:pt>
                  <c:pt idx="10">
                    <c:v>0.13896137141300174</c:v>
                  </c:pt>
                  <c:pt idx="11">
                    <c:v>0.18404324683856962</c:v>
                  </c:pt>
                  <c:pt idx="12">
                    <c:v>3.4672011367905882E-2</c:v>
                  </c:pt>
                  <c:pt idx="13">
                    <c:v>0.19185878334323192</c:v>
                  </c:pt>
                  <c:pt idx="14">
                    <c:v>1.8022816478560445E-2</c:v>
                  </c:pt>
                  <c:pt idx="15">
                    <c:v>3.3668943736039576E-2</c:v>
                  </c:pt>
                  <c:pt idx="16">
                    <c:v>0.56108580056701063</c:v>
                  </c:pt>
                  <c:pt idx="17">
                    <c:v>8.7324868074824563E-2</c:v>
                  </c:pt>
                  <c:pt idx="18">
                    <c:v>6.7139481861961434E-2</c:v>
                  </c:pt>
                  <c:pt idx="19">
                    <c:v>0.12677425080603441</c:v>
                  </c:pt>
                  <c:pt idx="20">
                    <c:v>0.41542461823152482</c:v>
                  </c:pt>
                  <c:pt idx="21">
                    <c:v>5.1931575411503887E-2</c:v>
                  </c:pt>
                </c:numCache>
              </c:numRef>
            </c:minus>
          </c:errBars>
          <c:cat>
            <c:strRef>
              <c:f>Sheet12!$B$136:$W$136</c:f>
              <c:strCache>
                <c:ptCount val="22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3</c:v>
                </c:pt>
                <c:pt idx="13">
                  <c:v>GSTU14</c:v>
                </c:pt>
                <c:pt idx="14">
                  <c:v>GSTU15</c:v>
                </c:pt>
                <c:pt idx="15">
                  <c:v>GSTU16</c:v>
                </c:pt>
                <c:pt idx="16">
                  <c:v>GSTU17</c:v>
                </c:pt>
                <c:pt idx="17">
                  <c:v>GSTF2</c:v>
                </c:pt>
                <c:pt idx="18">
                  <c:v>GSTZ2   </c:v>
                </c:pt>
                <c:pt idx="19">
                  <c:v>EF1G2    </c:v>
                </c:pt>
                <c:pt idx="20">
                  <c:v>GSTL1    </c:v>
                </c:pt>
                <c:pt idx="21">
                  <c:v>GSTT2    </c:v>
                </c:pt>
              </c:strCache>
            </c:strRef>
          </c:cat>
          <c:val>
            <c:numRef>
              <c:f>Sheet12!$B$141:$W$141</c:f>
              <c:numCache>
                <c:formatCode>0.00</c:formatCode>
                <c:ptCount val="22"/>
                <c:pt idx="0">
                  <c:v>1.7435219037739358</c:v>
                </c:pt>
                <c:pt idx="1">
                  <c:v>1.9393733824031198</c:v>
                </c:pt>
                <c:pt idx="2">
                  <c:v>1.2068507792135581</c:v>
                </c:pt>
                <c:pt idx="3">
                  <c:v>0.43019198114123991</c:v>
                </c:pt>
                <c:pt idx="4">
                  <c:v>0.36658430770666628</c:v>
                </c:pt>
                <c:pt idx="5">
                  <c:v>1.9942540178432244</c:v>
                </c:pt>
                <c:pt idx="6">
                  <c:v>5.7879503170009681</c:v>
                </c:pt>
                <c:pt idx="7">
                  <c:v>0.38842331282379</c:v>
                </c:pt>
                <c:pt idx="8">
                  <c:v>3.1602411633033354</c:v>
                </c:pt>
                <c:pt idx="9">
                  <c:v>2.431459300993672</c:v>
                </c:pt>
                <c:pt idx="10">
                  <c:v>2.3640282986407142</c:v>
                </c:pt>
                <c:pt idx="11">
                  <c:v>2.3492771720068326</c:v>
                </c:pt>
                <c:pt idx="12">
                  <c:v>0.21529921547569419</c:v>
                </c:pt>
                <c:pt idx="13">
                  <c:v>2.4490410145427797</c:v>
                </c:pt>
                <c:pt idx="14">
                  <c:v>0.17541178767831309</c:v>
                </c:pt>
                <c:pt idx="15">
                  <c:v>0.85889545785951682</c:v>
                </c:pt>
                <c:pt idx="16">
                  <c:v>2.2134238276628082</c:v>
                </c:pt>
                <c:pt idx="17">
                  <c:v>3.9802762450324698</c:v>
                </c:pt>
                <c:pt idx="18">
                  <c:v>1.0544303329666629</c:v>
                </c:pt>
                <c:pt idx="19">
                  <c:v>0.81160753018603993</c:v>
                </c:pt>
                <c:pt idx="20">
                  <c:v>1.3880432658840851</c:v>
                </c:pt>
                <c:pt idx="21">
                  <c:v>0.88346648149369789</c:v>
                </c:pt>
              </c:numCache>
            </c:numRef>
          </c:val>
        </c:ser>
        <c:axId val="74577024"/>
        <c:axId val="74578560"/>
      </c:barChart>
      <c:catAx>
        <c:axId val="74577024"/>
        <c:scaling>
          <c:orientation val="minMax"/>
        </c:scaling>
        <c:axPos val="b"/>
        <c:tickLblPos val="nextTo"/>
        <c:crossAx val="74578560"/>
        <c:crosses val="autoZero"/>
        <c:auto val="1"/>
        <c:lblAlgn val="ctr"/>
        <c:lblOffset val="100"/>
      </c:catAx>
      <c:valAx>
        <c:axId val="74578560"/>
        <c:scaling>
          <c:orientation val="minMax"/>
        </c:scaling>
        <c:axPos val="l"/>
        <c:numFmt formatCode="0" sourceLinked="0"/>
        <c:tickLblPos val="nextTo"/>
        <c:crossAx val="74577024"/>
        <c:crosses val="autoZero"/>
        <c:crossBetween val="between"/>
      </c:valAx>
    </c:plotArea>
    <c:plotVisOnly val="1"/>
  </c:chart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0h</c:v>
          </c:tx>
          <c:errBars>
            <c:errBarType val="both"/>
            <c:errValType val="cust"/>
            <c:plus>
              <c:numRef>
                <c:f>Sheet12!$B$171:$W$171</c:f>
                <c:numCache>
                  <c:formatCode>General</c:formatCode>
                  <c:ptCount val="22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  <c:pt idx="21">
                    <c:v>0</c:v>
                  </c:pt>
                </c:numCache>
              </c:numRef>
            </c:plus>
            <c:minus>
              <c:numRef>
                <c:f>Sheet12!$B$171:$W$171</c:f>
                <c:numCache>
                  <c:formatCode>General</c:formatCode>
                  <c:ptCount val="22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  <c:pt idx="21">
                    <c:v>0</c:v>
                  </c:pt>
                </c:numCache>
              </c:numRef>
            </c:minus>
          </c:errBars>
          <c:cat>
            <c:strRef>
              <c:f>Sheet12!$B$162:$W$162</c:f>
              <c:strCache>
                <c:ptCount val="22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3</c:v>
                </c:pt>
                <c:pt idx="13">
                  <c:v>GSTU14</c:v>
                </c:pt>
                <c:pt idx="14">
                  <c:v>GSTU15</c:v>
                </c:pt>
                <c:pt idx="15">
                  <c:v>GSTU16</c:v>
                </c:pt>
                <c:pt idx="16">
                  <c:v>GSTU17</c:v>
                </c:pt>
                <c:pt idx="17">
                  <c:v>GSTF2</c:v>
                </c:pt>
                <c:pt idx="18">
                  <c:v>GSTZ2   </c:v>
                </c:pt>
                <c:pt idx="19">
                  <c:v>EF1G2    </c:v>
                </c:pt>
                <c:pt idx="20">
                  <c:v>GSTL1    </c:v>
                </c:pt>
                <c:pt idx="21">
                  <c:v>GSTT2    </c:v>
                </c:pt>
              </c:strCache>
            </c:strRef>
          </c:cat>
          <c:val>
            <c:numRef>
              <c:f>Sheet12!$B$163:$W$163</c:f>
              <c:numCache>
                <c:formatCode>0.00</c:formatCode>
                <c:ptCount val="22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</c:numCache>
            </c:numRef>
          </c:val>
        </c:ser>
        <c:ser>
          <c:idx val="1"/>
          <c:order val="1"/>
          <c:tx>
            <c:v>6h</c:v>
          </c:tx>
          <c:errBars>
            <c:errBarType val="both"/>
            <c:errValType val="cust"/>
            <c:plus>
              <c:numRef>
                <c:f>Sheet12!$B$172:$W$172</c:f>
                <c:numCache>
                  <c:formatCode>General</c:formatCode>
                  <c:ptCount val="22"/>
                  <c:pt idx="0">
                    <c:v>0.49393603031709582</c:v>
                  </c:pt>
                  <c:pt idx="1">
                    <c:v>7.8636744623522811E-2</c:v>
                  </c:pt>
                  <c:pt idx="2">
                    <c:v>0.26697584014819076</c:v>
                  </c:pt>
                  <c:pt idx="3">
                    <c:v>0.17164109103141933</c:v>
                  </c:pt>
                  <c:pt idx="4">
                    <c:v>6.6189941334160896E-2</c:v>
                  </c:pt>
                  <c:pt idx="5">
                    <c:v>0</c:v>
                  </c:pt>
                  <c:pt idx="6">
                    <c:v>1.3528620067088243E-2</c:v>
                  </c:pt>
                  <c:pt idx="7">
                    <c:v>0.11385823244480001</c:v>
                  </c:pt>
                  <c:pt idx="8">
                    <c:v>0.16411585396527945</c:v>
                  </c:pt>
                  <c:pt idx="9">
                    <c:v>4.2465760841130462E-2</c:v>
                  </c:pt>
                  <c:pt idx="10">
                    <c:v>0</c:v>
                  </c:pt>
                  <c:pt idx="11">
                    <c:v>4.4328480920118735E-2</c:v>
                  </c:pt>
                  <c:pt idx="12">
                    <c:v>1.9605790832712428E-2</c:v>
                  </c:pt>
                  <c:pt idx="13">
                    <c:v>9.5676499711790913E-3</c:v>
                  </c:pt>
                  <c:pt idx="14">
                    <c:v>1.727101704552177E-15</c:v>
                  </c:pt>
                  <c:pt idx="15">
                    <c:v>0.33227751898137431</c:v>
                  </c:pt>
                  <c:pt idx="16">
                    <c:v>0.13539988184911594</c:v>
                  </c:pt>
                  <c:pt idx="17">
                    <c:v>5.1216618066684406E-2</c:v>
                  </c:pt>
                  <c:pt idx="18">
                    <c:v>5.7414632396642809E-2</c:v>
                  </c:pt>
                  <c:pt idx="19">
                    <c:v>0.15362307967455277</c:v>
                  </c:pt>
                  <c:pt idx="20">
                    <c:v>0.23970769993898897</c:v>
                  </c:pt>
                  <c:pt idx="21">
                    <c:v>2.0722845563360452E-2</c:v>
                  </c:pt>
                </c:numCache>
              </c:numRef>
            </c:plus>
            <c:minus>
              <c:numRef>
                <c:f>Sheet12!$B$172:$W$172</c:f>
                <c:numCache>
                  <c:formatCode>General</c:formatCode>
                  <c:ptCount val="22"/>
                  <c:pt idx="0">
                    <c:v>0.49393603031709582</c:v>
                  </c:pt>
                  <c:pt idx="1">
                    <c:v>7.8636744623522811E-2</c:v>
                  </c:pt>
                  <c:pt idx="2">
                    <c:v>0.26697584014819076</c:v>
                  </c:pt>
                  <c:pt idx="3">
                    <c:v>0.17164109103141933</c:v>
                  </c:pt>
                  <c:pt idx="4">
                    <c:v>6.6189941334160896E-2</c:v>
                  </c:pt>
                  <c:pt idx="5">
                    <c:v>0</c:v>
                  </c:pt>
                  <c:pt idx="6">
                    <c:v>1.3528620067088243E-2</c:v>
                  </c:pt>
                  <c:pt idx="7">
                    <c:v>0.11385823244480001</c:v>
                  </c:pt>
                  <c:pt idx="8">
                    <c:v>0.16411585396527945</c:v>
                  </c:pt>
                  <c:pt idx="9">
                    <c:v>4.2465760841130462E-2</c:v>
                  </c:pt>
                  <c:pt idx="10">
                    <c:v>0</c:v>
                  </c:pt>
                  <c:pt idx="11">
                    <c:v>4.4328480920118735E-2</c:v>
                  </c:pt>
                  <c:pt idx="12">
                    <c:v>1.9605790832712428E-2</c:v>
                  </c:pt>
                  <c:pt idx="13">
                    <c:v>9.5676499711790913E-3</c:v>
                  </c:pt>
                  <c:pt idx="14">
                    <c:v>1.727101704552177E-15</c:v>
                  </c:pt>
                  <c:pt idx="15">
                    <c:v>0.33227751898137431</c:v>
                  </c:pt>
                  <c:pt idx="16">
                    <c:v>0.13539988184911594</c:v>
                  </c:pt>
                  <c:pt idx="17">
                    <c:v>5.1216618066684406E-2</c:v>
                  </c:pt>
                  <c:pt idx="18">
                    <c:v>5.7414632396642809E-2</c:v>
                  </c:pt>
                  <c:pt idx="19">
                    <c:v>0.15362307967455277</c:v>
                  </c:pt>
                  <c:pt idx="20">
                    <c:v>0.23970769993898897</c:v>
                  </c:pt>
                  <c:pt idx="21">
                    <c:v>2.0722845563360452E-2</c:v>
                  </c:pt>
                </c:numCache>
              </c:numRef>
            </c:minus>
          </c:errBars>
          <c:cat>
            <c:strRef>
              <c:f>Sheet12!$B$162:$W$162</c:f>
              <c:strCache>
                <c:ptCount val="22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3</c:v>
                </c:pt>
                <c:pt idx="13">
                  <c:v>GSTU14</c:v>
                </c:pt>
                <c:pt idx="14">
                  <c:v>GSTU15</c:v>
                </c:pt>
                <c:pt idx="15">
                  <c:v>GSTU16</c:v>
                </c:pt>
                <c:pt idx="16">
                  <c:v>GSTU17</c:v>
                </c:pt>
                <c:pt idx="17">
                  <c:v>GSTF2</c:v>
                </c:pt>
                <c:pt idx="18">
                  <c:v>GSTZ2   </c:v>
                </c:pt>
                <c:pt idx="19">
                  <c:v>EF1G2    </c:v>
                </c:pt>
                <c:pt idx="20">
                  <c:v>GSTL1    </c:v>
                </c:pt>
                <c:pt idx="21">
                  <c:v>GSTT2    </c:v>
                </c:pt>
              </c:strCache>
            </c:strRef>
          </c:cat>
          <c:val>
            <c:numRef>
              <c:f>Sheet12!$B$164:$W$164</c:f>
              <c:numCache>
                <c:formatCode>0.00</c:formatCode>
                <c:ptCount val="22"/>
                <c:pt idx="0">
                  <c:v>2.3081061116834403</c:v>
                </c:pt>
                <c:pt idx="1">
                  <c:v>0.84564588723710921</c:v>
                </c:pt>
                <c:pt idx="2">
                  <c:v>1.3374787819788001</c:v>
                </c:pt>
                <c:pt idx="3">
                  <c:v>1.5258134551365738</c:v>
                </c:pt>
                <c:pt idx="4">
                  <c:v>1.1260315928681544</c:v>
                </c:pt>
                <c:pt idx="5">
                  <c:v>0.80664175922212922</c:v>
                </c:pt>
                <c:pt idx="6">
                  <c:v>0.25105026122074797</c:v>
                </c:pt>
                <c:pt idx="7">
                  <c:v>0.90587391528287864</c:v>
                </c:pt>
                <c:pt idx="8">
                  <c:v>1.158513194080194</c:v>
                </c:pt>
                <c:pt idx="9">
                  <c:v>1.4442413898320998</c:v>
                </c:pt>
                <c:pt idx="10">
                  <c:v>0.90125046261083164</c:v>
                </c:pt>
                <c:pt idx="11">
                  <c:v>1.809030331791448</c:v>
                </c:pt>
                <c:pt idx="12">
                  <c:v>1.0000960921416906</c:v>
                </c:pt>
                <c:pt idx="13">
                  <c:v>1.9520752449992178</c:v>
                </c:pt>
                <c:pt idx="14">
                  <c:v>0.95926411932526556</c:v>
                </c:pt>
                <c:pt idx="15">
                  <c:v>3.3951209343610778</c:v>
                </c:pt>
                <c:pt idx="16">
                  <c:v>1.9747876730553944</c:v>
                </c:pt>
                <c:pt idx="17">
                  <c:v>0.87130353737276667</c:v>
                </c:pt>
                <c:pt idx="18">
                  <c:v>1.464648471504072</c:v>
                </c:pt>
                <c:pt idx="19">
                  <c:v>1.3656412959064608</c:v>
                </c:pt>
                <c:pt idx="20">
                  <c:v>1.583712502502586</c:v>
                </c:pt>
                <c:pt idx="21">
                  <c:v>1.4093969309737395</c:v>
                </c:pt>
              </c:numCache>
            </c:numRef>
          </c:val>
        </c:ser>
        <c:ser>
          <c:idx val="2"/>
          <c:order val="2"/>
          <c:tx>
            <c:v>24h</c:v>
          </c:tx>
          <c:errBars>
            <c:errBarType val="both"/>
            <c:errValType val="cust"/>
            <c:plus>
              <c:numRef>
                <c:f>Sheet12!$B$173:$W$173</c:f>
                <c:numCache>
                  <c:formatCode>General</c:formatCode>
                  <c:ptCount val="22"/>
                  <c:pt idx="0">
                    <c:v>2.1577193510591401</c:v>
                  </c:pt>
                  <c:pt idx="1">
                    <c:v>0.53657282469566459</c:v>
                  </c:pt>
                  <c:pt idx="2">
                    <c:v>0.34566989846375185</c:v>
                  </c:pt>
                  <c:pt idx="3">
                    <c:v>1.2233265190219955</c:v>
                  </c:pt>
                  <c:pt idx="4">
                    <c:v>0.62641252304107298</c:v>
                  </c:pt>
                  <c:pt idx="5">
                    <c:v>0.16578276450688256</c:v>
                  </c:pt>
                  <c:pt idx="6">
                    <c:v>1.9470363743073201E-2</c:v>
                  </c:pt>
                  <c:pt idx="7">
                    <c:v>0.17225426155486093</c:v>
                  </c:pt>
                  <c:pt idx="8">
                    <c:v>0.34629518391189656</c:v>
                  </c:pt>
                  <c:pt idx="9">
                    <c:v>1.1827609363186717</c:v>
                  </c:pt>
                  <c:pt idx="10">
                    <c:v>0.19111810619544156</c:v>
                  </c:pt>
                  <c:pt idx="11">
                    <c:v>0.44056403951672374</c:v>
                  </c:pt>
                  <c:pt idx="12">
                    <c:v>3.4530214532637708E-2</c:v>
                  </c:pt>
                  <c:pt idx="13">
                    <c:v>0.50255936520917011</c:v>
                  </c:pt>
                  <c:pt idx="14">
                    <c:v>5.144925603268475E-3</c:v>
                  </c:pt>
                  <c:pt idx="15">
                    <c:v>0.25670915131332905</c:v>
                  </c:pt>
                  <c:pt idx="16">
                    <c:v>3.2246768095030444E-2</c:v>
                  </c:pt>
                  <c:pt idx="17">
                    <c:v>3.4905406714419419E-2</c:v>
                  </c:pt>
                  <c:pt idx="18">
                    <c:v>0.90751915531715799</c:v>
                  </c:pt>
                  <c:pt idx="19">
                    <c:v>0.51042432580978359</c:v>
                  </c:pt>
                  <c:pt idx="20">
                    <c:v>1.03844196259703</c:v>
                  </c:pt>
                  <c:pt idx="21">
                    <c:v>4.5891721423749587E-2</c:v>
                  </c:pt>
                </c:numCache>
              </c:numRef>
            </c:plus>
            <c:minus>
              <c:numRef>
                <c:f>Sheet12!$B$173:$W$173</c:f>
                <c:numCache>
                  <c:formatCode>General</c:formatCode>
                  <c:ptCount val="22"/>
                  <c:pt idx="0">
                    <c:v>2.1577193510591401</c:v>
                  </c:pt>
                  <c:pt idx="1">
                    <c:v>0.53657282469566459</c:v>
                  </c:pt>
                  <c:pt idx="2">
                    <c:v>0.34566989846375185</c:v>
                  </c:pt>
                  <c:pt idx="3">
                    <c:v>1.2233265190219955</c:v>
                  </c:pt>
                  <c:pt idx="4">
                    <c:v>0.62641252304107298</c:v>
                  </c:pt>
                  <c:pt idx="5">
                    <c:v>0.16578276450688256</c:v>
                  </c:pt>
                  <c:pt idx="6">
                    <c:v>1.9470363743073201E-2</c:v>
                  </c:pt>
                  <c:pt idx="7">
                    <c:v>0.17225426155486093</c:v>
                  </c:pt>
                  <c:pt idx="8">
                    <c:v>0.34629518391189656</c:v>
                  </c:pt>
                  <c:pt idx="9">
                    <c:v>1.1827609363186717</c:v>
                  </c:pt>
                  <c:pt idx="10">
                    <c:v>0.19111810619544156</c:v>
                  </c:pt>
                  <c:pt idx="11">
                    <c:v>0.44056403951672374</c:v>
                  </c:pt>
                  <c:pt idx="12">
                    <c:v>3.4530214532637708E-2</c:v>
                  </c:pt>
                  <c:pt idx="13">
                    <c:v>0.50255936520917011</c:v>
                  </c:pt>
                  <c:pt idx="14">
                    <c:v>5.144925603268475E-3</c:v>
                  </c:pt>
                  <c:pt idx="15">
                    <c:v>0.25670915131332905</c:v>
                  </c:pt>
                  <c:pt idx="16">
                    <c:v>3.2246768095030444E-2</c:v>
                  </c:pt>
                  <c:pt idx="17">
                    <c:v>3.4905406714419419E-2</c:v>
                  </c:pt>
                  <c:pt idx="18">
                    <c:v>0.90751915531715799</c:v>
                  </c:pt>
                  <c:pt idx="19">
                    <c:v>0.51042432580978359</c:v>
                  </c:pt>
                  <c:pt idx="20">
                    <c:v>1.03844196259703</c:v>
                  </c:pt>
                  <c:pt idx="21">
                    <c:v>4.5891721423749587E-2</c:v>
                  </c:pt>
                </c:numCache>
              </c:numRef>
            </c:minus>
          </c:errBars>
          <c:cat>
            <c:strRef>
              <c:f>Sheet12!$B$162:$W$162</c:f>
              <c:strCache>
                <c:ptCount val="22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3</c:v>
                </c:pt>
                <c:pt idx="13">
                  <c:v>GSTU14</c:v>
                </c:pt>
                <c:pt idx="14">
                  <c:v>GSTU15</c:v>
                </c:pt>
                <c:pt idx="15">
                  <c:v>GSTU16</c:v>
                </c:pt>
                <c:pt idx="16">
                  <c:v>GSTU17</c:v>
                </c:pt>
                <c:pt idx="17">
                  <c:v>GSTF2</c:v>
                </c:pt>
                <c:pt idx="18">
                  <c:v>GSTZ2   </c:v>
                </c:pt>
                <c:pt idx="19">
                  <c:v>EF1G2    </c:v>
                </c:pt>
                <c:pt idx="20">
                  <c:v>GSTL1    </c:v>
                </c:pt>
                <c:pt idx="21">
                  <c:v>GSTT2    </c:v>
                </c:pt>
              </c:strCache>
            </c:strRef>
          </c:cat>
          <c:val>
            <c:numRef>
              <c:f>Sheet12!$B$165:$W$165</c:f>
              <c:numCache>
                <c:formatCode>0.00</c:formatCode>
                <c:ptCount val="22"/>
                <c:pt idx="0">
                  <c:v>26.7743124531465</c:v>
                </c:pt>
                <c:pt idx="1">
                  <c:v>6.7304961623497324</c:v>
                </c:pt>
                <c:pt idx="2">
                  <c:v>3.0728526540019767</c:v>
                </c:pt>
                <c:pt idx="3">
                  <c:v>24.325718494586599</c:v>
                </c:pt>
                <c:pt idx="4">
                  <c:v>20.796361836483687</c:v>
                </c:pt>
                <c:pt idx="5">
                  <c:v>11.275175447789916</c:v>
                </c:pt>
                <c:pt idx="6">
                  <c:v>0.99318792382182175</c:v>
                </c:pt>
                <c:pt idx="7">
                  <c:v>0.48529528576380132</c:v>
                </c:pt>
                <c:pt idx="8">
                  <c:v>1.5827952276224535</c:v>
                </c:pt>
                <c:pt idx="9">
                  <c:v>21.948464850959667</c:v>
                </c:pt>
                <c:pt idx="10">
                  <c:v>4.3340076433905743</c:v>
                </c:pt>
                <c:pt idx="11">
                  <c:v>2.4732773096639997</c:v>
                </c:pt>
                <c:pt idx="12">
                  <c:v>12.294223607977841</c:v>
                </c:pt>
                <c:pt idx="13">
                  <c:v>3.1799404330528871</c:v>
                </c:pt>
                <c:pt idx="14">
                  <c:v>0.34991537881050438</c:v>
                </c:pt>
                <c:pt idx="15">
                  <c:v>2.3853310134395191</c:v>
                </c:pt>
                <c:pt idx="16">
                  <c:v>5.4703144438553304</c:v>
                </c:pt>
                <c:pt idx="17">
                  <c:v>12.712452758857706</c:v>
                </c:pt>
                <c:pt idx="18">
                  <c:v>1.6417129487814501</c:v>
                </c:pt>
                <c:pt idx="19">
                  <c:v>4.0162503029802803</c:v>
                </c:pt>
                <c:pt idx="20">
                  <c:v>18.12084830826555</c:v>
                </c:pt>
                <c:pt idx="21">
                  <c:v>1.8728256486688117</c:v>
                </c:pt>
              </c:numCache>
            </c:numRef>
          </c:val>
        </c:ser>
        <c:ser>
          <c:idx val="3"/>
          <c:order val="3"/>
          <c:tx>
            <c:v>48h</c:v>
          </c:tx>
          <c:errBars>
            <c:errBarType val="both"/>
            <c:errValType val="cust"/>
            <c:plus>
              <c:numRef>
                <c:f>Sheet12!$B$174:$W$174</c:f>
                <c:numCache>
                  <c:formatCode>General</c:formatCode>
                  <c:ptCount val="22"/>
                  <c:pt idx="0">
                    <c:v>2.4794951096250957</c:v>
                  </c:pt>
                  <c:pt idx="1">
                    <c:v>0.76578276450688365</c:v>
                  </c:pt>
                  <c:pt idx="2">
                    <c:v>2.4500080989414936</c:v>
                  </c:pt>
                  <c:pt idx="3">
                    <c:v>1.61539913968589</c:v>
                  </c:pt>
                  <c:pt idx="4">
                    <c:v>2.8443617179812017</c:v>
                  </c:pt>
                  <c:pt idx="5">
                    <c:v>0.6080999286648342</c:v>
                  </c:pt>
                  <c:pt idx="6">
                    <c:v>0.49398405105543042</c:v>
                  </c:pt>
                  <c:pt idx="7">
                    <c:v>0.52943899683735307</c:v>
                  </c:pt>
                  <c:pt idx="8">
                    <c:v>1.5465931109615401</c:v>
                  </c:pt>
                  <c:pt idx="9">
                    <c:v>3.6647417437058198</c:v>
                  </c:pt>
                  <c:pt idx="10">
                    <c:v>0.51561914393904851</c:v>
                  </c:pt>
                  <c:pt idx="11">
                    <c:v>0.22104014601634506</c:v>
                  </c:pt>
                  <c:pt idx="12">
                    <c:v>0.90209258111821822</c:v>
                  </c:pt>
                  <c:pt idx="13">
                    <c:v>2.6682421044734967</c:v>
                  </c:pt>
                  <c:pt idx="14">
                    <c:v>1.7585035537258577E-14</c:v>
                  </c:pt>
                  <c:pt idx="15">
                    <c:v>2.6993214956629998</c:v>
                  </c:pt>
                  <c:pt idx="16">
                    <c:v>0.20768139850878498</c:v>
                  </c:pt>
                  <c:pt idx="17">
                    <c:v>0.73589012073318116</c:v>
                  </c:pt>
                  <c:pt idx="18">
                    <c:v>0.1795871216948762</c:v>
                  </c:pt>
                  <c:pt idx="19">
                    <c:v>2.1463392819053335</c:v>
                  </c:pt>
                  <c:pt idx="20">
                    <c:v>1.5285444440188041</c:v>
                  </c:pt>
                  <c:pt idx="21">
                    <c:v>0.15255735561089157</c:v>
                  </c:pt>
                </c:numCache>
              </c:numRef>
            </c:plus>
            <c:minus>
              <c:numRef>
                <c:f>Sheet12!$B$174:$W$174</c:f>
                <c:numCache>
                  <c:formatCode>General</c:formatCode>
                  <c:ptCount val="22"/>
                  <c:pt idx="0">
                    <c:v>2.4794951096250957</c:v>
                  </c:pt>
                  <c:pt idx="1">
                    <c:v>0.76578276450688365</c:v>
                  </c:pt>
                  <c:pt idx="2">
                    <c:v>2.4500080989414936</c:v>
                  </c:pt>
                  <c:pt idx="3">
                    <c:v>1.61539913968589</c:v>
                  </c:pt>
                  <c:pt idx="4">
                    <c:v>2.8443617179812017</c:v>
                  </c:pt>
                  <c:pt idx="5">
                    <c:v>0.6080999286648342</c:v>
                  </c:pt>
                  <c:pt idx="6">
                    <c:v>0.49398405105543042</c:v>
                  </c:pt>
                  <c:pt idx="7">
                    <c:v>0.52943899683735307</c:v>
                  </c:pt>
                  <c:pt idx="8">
                    <c:v>1.5465931109615401</c:v>
                  </c:pt>
                  <c:pt idx="9">
                    <c:v>3.6647417437058198</c:v>
                  </c:pt>
                  <c:pt idx="10">
                    <c:v>0.51561914393904851</c:v>
                  </c:pt>
                  <c:pt idx="11">
                    <c:v>0.22104014601634506</c:v>
                  </c:pt>
                  <c:pt idx="12">
                    <c:v>0.90209258111821822</c:v>
                  </c:pt>
                  <c:pt idx="13">
                    <c:v>2.6682421044734967</c:v>
                  </c:pt>
                  <c:pt idx="14">
                    <c:v>1.7585035537258577E-14</c:v>
                  </c:pt>
                  <c:pt idx="15">
                    <c:v>2.6993214956629998</c:v>
                  </c:pt>
                  <c:pt idx="16">
                    <c:v>0.20768139850878498</c:v>
                  </c:pt>
                  <c:pt idx="17">
                    <c:v>0.73589012073318116</c:v>
                  </c:pt>
                  <c:pt idx="18">
                    <c:v>0.1795871216948762</c:v>
                  </c:pt>
                  <c:pt idx="19">
                    <c:v>2.1463392819053335</c:v>
                  </c:pt>
                  <c:pt idx="20">
                    <c:v>1.5285444440188041</c:v>
                  </c:pt>
                  <c:pt idx="21">
                    <c:v>0.15255735561089157</c:v>
                  </c:pt>
                </c:numCache>
              </c:numRef>
            </c:minus>
          </c:errBars>
          <c:cat>
            <c:strRef>
              <c:f>Sheet12!$B$162:$W$162</c:f>
              <c:strCache>
                <c:ptCount val="22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3</c:v>
                </c:pt>
                <c:pt idx="13">
                  <c:v>GSTU14</c:v>
                </c:pt>
                <c:pt idx="14">
                  <c:v>GSTU15</c:v>
                </c:pt>
                <c:pt idx="15">
                  <c:v>GSTU16</c:v>
                </c:pt>
                <c:pt idx="16">
                  <c:v>GSTU17</c:v>
                </c:pt>
                <c:pt idx="17">
                  <c:v>GSTF2</c:v>
                </c:pt>
                <c:pt idx="18">
                  <c:v>GSTZ2   </c:v>
                </c:pt>
                <c:pt idx="19">
                  <c:v>EF1G2    </c:v>
                </c:pt>
                <c:pt idx="20">
                  <c:v>GSTL1    </c:v>
                </c:pt>
                <c:pt idx="21">
                  <c:v>GSTT2    </c:v>
                </c:pt>
              </c:strCache>
            </c:strRef>
          </c:cat>
          <c:val>
            <c:numRef>
              <c:f>Sheet12!$B$166:$W$166</c:f>
              <c:numCache>
                <c:formatCode>0.00</c:formatCode>
                <c:ptCount val="22"/>
                <c:pt idx="0">
                  <c:v>30.531212061195799</c:v>
                </c:pt>
                <c:pt idx="1">
                  <c:v>14.2751754477899</c:v>
                </c:pt>
                <c:pt idx="2">
                  <c:v>3.2948964993200978</c:v>
                </c:pt>
                <c:pt idx="3">
                  <c:v>20.560885436891535</c:v>
                </c:pt>
                <c:pt idx="4">
                  <c:v>42.141256892727498</c:v>
                </c:pt>
                <c:pt idx="5">
                  <c:v>6.0698416855759998</c:v>
                </c:pt>
                <c:pt idx="6">
                  <c:v>1.2021340918807</c:v>
                </c:pt>
                <c:pt idx="7">
                  <c:v>3.0061500434507997</c:v>
                </c:pt>
                <c:pt idx="8">
                  <c:v>3.2422406601004998</c:v>
                </c:pt>
                <c:pt idx="9">
                  <c:v>34.280017304258699</c:v>
                </c:pt>
                <c:pt idx="10">
                  <c:v>2.0422430833887821</c:v>
                </c:pt>
                <c:pt idx="11">
                  <c:v>5.0985350097773789</c:v>
                </c:pt>
                <c:pt idx="12">
                  <c:v>9.7009468637331491</c:v>
                </c:pt>
                <c:pt idx="13">
                  <c:v>3.5258508827799999</c:v>
                </c:pt>
                <c:pt idx="14">
                  <c:v>9.7811222215365419</c:v>
                </c:pt>
                <c:pt idx="15">
                  <c:v>12.162506794062139</c:v>
                </c:pt>
                <c:pt idx="16">
                  <c:v>17.0631507756747</c:v>
                </c:pt>
                <c:pt idx="17">
                  <c:v>30.772572348473489</c:v>
                </c:pt>
                <c:pt idx="18">
                  <c:v>13.0551586634554</c:v>
                </c:pt>
                <c:pt idx="19">
                  <c:v>24.928886488835087</c:v>
                </c:pt>
                <c:pt idx="20">
                  <c:v>28.365160678285289</c:v>
                </c:pt>
                <c:pt idx="21">
                  <c:v>12.7819872952744</c:v>
                </c:pt>
              </c:numCache>
            </c:numRef>
          </c:val>
        </c:ser>
        <c:ser>
          <c:idx val="4"/>
          <c:order val="4"/>
          <c:tx>
            <c:v>72h</c:v>
          </c:tx>
          <c:errBars>
            <c:errBarType val="both"/>
            <c:errValType val="cust"/>
            <c:plus>
              <c:numRef>
                <c:f>Sheet12!$B$175:$W$175</c:f>
                <c:numCache>
                  <c:formatCode>General</c:formatCode>
                  <c:ptCount val="22"/>
                  <c:pt idx="0">
                    <c:v>2.5513836219643652E-2</c:v>
                  </c:pt>
                  <c:pt idx="1">
                    <c:v>7.7477316710203692E-2</c:v>
                  </c:pt>
                  <c:pt idx="2">
                    <c:v>0.10022729855769467</c:v>
                  </c:pt>
                  <c:pt idx="3">
                    <c:v>0.11276157263978152</c:v>
                  </c:pt>
                  <c:pt idx="4">
                    <c:v>7.6378854035539564E-3</c:v>
                  </c:pt>
                  <c:pt idx="5">
                    <c:v>0.11343343115565968</c:v>
                  </c:pt>
                  <c:pt idx="6">
                    <c:v>1.3485588318600829E-2</c:v>
                  </c:pt>
                  <c:pt idx="7">
                    <c:v>0.30341470147692573</c:v>
                  </c:pt>
                  <c:pt idx="8">
                    <c:v>3.9673195643063659E-3</c:v>
                  </c:pt>
                  <c:pt idx="9">
                    <c:v>0</c:v>
                  </c:pt>
                  <c:pt idx="10">
                    <c:v>3.5462643867747834E-2</c:v>
                  </c:pt>
                  <c:pt idx="11">
                    <c:v>0.14533193383607057</c:v>
                  </c:pt>
                  <c:pt idx="12">
                    <c:v>3.4664297458268246E-2</c:v>
                  </c:pt>
                  <c:pt idx="13">
                    <c:v>0.40049992403718443</c:v>
                  </c:pt>
                  <c:pt idx="14">
                    <c:v>9.0754734536670767E-2</c:v>
                  </c:pt>
                  <c:pt idx="15">
                    <c:v>5.3199712956557232E-2</c:v>
                  </c:pt>
                  <c:pt idx="16">
                    <c:v>1.3206789855416651E-2</c:v>
                  </c:pt>
                  <c:pt idx="17">
                    <c:v>3.3311370031726219E-2</c:v>
                  </c:pt>
                  <c:pt idx="18">
                    <c:v>2.0249360667862688</c:v>
                  </c:pt>
                  <c:pt idx="19">
                    <c:v>0.12918963864625918</c:v>
                  </c:pt>
                  <c:pt idx="20">
                    <c:v>0.27816312934631476</c:v>
                  </c:pt>
                  <c:pt idx="21">
                    <c:v>7.0477434240312442E-2</c:v>
                  </c:pt>
                </c:numCache>
              </c:numRef>
            </c:plus>
            <c:minus>
              <c:numRef>
                <c:f>Sheet12!$B$175:$W$175</c:f>
                <c:numCache>
                  <c:formatCode>General</c:formatCode>
                  <c:ptCount val="22"/>
                  <c:pt idx="0">
                    <c:v>2.5513836219643652E-2</c:v>
                  </c:pt>
                  <c:pt idx="1">
                    <c:v>7.7477316710203692E-2</c:v>
                  </c:pt>
                  <c:pt idx="2">
                    <c:v>0.10022729855769467</c:v>
                  </c:pt>
                  <c:pt idx="3">
                    <c:v>0.11276157263978152</c:v>
                  </c:pt>
                  <c:pt idx="4">
                    <c:v>7.6378854035539564E-3</c:v>
                  </c:pt>
                  <c:pt idx="5">
                    <c:v>0.11343343115565968</c:v>
                  </c:pt>
                  <c:pt idx="6">
                    <c:v>1.3485588318600829E-2</c:v>
                  </c:pt>
                  <c:pt idx="7">
                    <c:v>0.30341470147692573</c:v>
                  </c:pt>
                  <c:pt idx="8">
                    <c:v>3.9673195643063659E-3</c:v>
                  </c:pt>
                  <c:pt idx="9">
                    <c:v>0</c:v>
                  </c:pt>
                  <c:pt idx="10">
                    <c:v>3.5462643867747834E-2</c:v>
                  </c:pt>
                  <c:pt idx="11">
                    <c:v>0.14533193383607057</c:v>
                  </c:pt>
                  <c:pt idx="12">
                    <c:v>3.4664297458268246E-2</c:v>
                  </c:pt>
                  <c:pt idx="13">
                    <c:v>0.40049992403718443</c:v>
                  </c:pt>
                  <c:pt idx="14">
                    <c:v>9.0754734536670767E-2</c:v>
                  </c:pt>
                  <c:pt idx="15">
                    <c:v>5.3199712956557232E-2</c:v>
                  </c:pt>
                  <c:pt idx="16">
                    <c:v>1.3206789855416651E-2</c:v>
                  </c:pt>
                  <c:pt idx="17">
                    <c:v>3.3311370031726219E-2</c:v>
                  </c:pt>
                  <c:pt idx="18">
                    <c:v>2.0249360667862688</c:v>
                  </c:pt>
                  <c:pt idx="19">
                    <c:v>0.12918963864625918</c:v>
                  </c:pt>
                  <c:pt idx="20">
                    <c:v>0.27816312934631476</c:v>
                  </c:pt>
                  <c:pt idx="21">
                    <c:v>7.0477434240312442E-2</c:v>
                  </c:pt>
                </c:numCache>
              </c:numRef>
            </c:minus>
          </c:errBars>
          <c:cat>
            <c:strRef>
              <c:f>Sheet12!$B$162:$W$162</c:f>
              <c:strCache>
                <c:ptCount val="22"/>
                <c:pt idx="0">
                  <c:v>GSTU1</c:v>
                </c:pt>
                <c:pt idx="1">
                  <c:v>GSTU2</c:v>
                </c:pt>
                <c:pt idx="2">
                  <c:v>GSTU3</c:v>
                </c:pt>
                <c:pt idx="3">
                  <c:v>GSTU4</c:v>
                </c:pt>
                <c:pt idx="4">
                  <c:v>GSTU5</c:v>
                </c:pt>
                <c:pt idx="5">
                  <c:v>GSTU6</c:v>
                </c:pt>
                <c:pt idx="6">
                  <c:v>GSTU7</c:v>
                </c:pt>
                <c:pt idx="7">
                  <c:v>GSTU8</c:v>
                </c:pt>
                <c:pt idx="8">
                  <c:v>GSTU9</c:v>
                </c:pt>
                <c:pt idx="9">
                  <c:v>GSTU10</c:v>
                </c:pt>
                <c:pt idx="10">
                  <c:v>GSTU11</c:v>
                </c:pt>
                <c:pt idx="11">
                  <c:v>GSTU12</c:v>
                </c:pt>
                <c:pt idx="12">
                  <c:v>GSTU13</c:v>
                </c:pt>
                <c:pt idx="13">
                  <c:v>GSTU14</c:v>
                </c:pt>
                <c:pt idx="14">
                  <c:v>GSTU15</c:v>
                </c:pt>
                <c:pt idx="15">
                  <c:v>GSTU16</c:v>
                </c:pt>
                <c:pt idx="16">
                  <c:v>GSTU17</c:v>
                </c:pt>
                <c:pt idx="17">
                  <c:v>GSTF2</c:v>
                </c:pt>
                <c:pt idx="18">
                  <c:v>GSTZ2   </c:v>
                </c:pt>
                <c:pt idx="19">
                  <c:v>EF1G2    </c:v>
                </c:pt>
                <c:pt idx="20">
                  <c:v>GSTL1    </c:v>
                </c:pt>
                <c:pt idx="21">
                  <c:v>GSTT2    </c:v>
                </c:pt>
              </c:strCache>
            </c:strRef>
          </c:cat>
          <c:val>
            <c:numRef>
              <c:f>Sheet12!$B$167:$W$167</c:f>
              <c:numCache>
                <c:formatCode>0.00</c:formatCode>
                <c:ptCount val="22"/>
                <c:pt idx="0">
                  <c:v>1.3014669041678999</c:v>
                </c:pt>
                <c:pt idx="1">
                  <c:v>1.0547847360339233</c:v>
                </c:pt>
                <c:pt idx="2">
                  <c:v>1.0778269525268758</c:v>
                </c:pt>
                <c:pt idx="3">
                  <c:v>1.2126183579666456</c:v>
                </c:pt>
                <c:pt idx="4">
                  <c:v>5.7791832973339714</c:v>
                </c:pt>
                <c:pt idx="5">
                  <c:v>1.5442952443290479</c:v>
                </c:pt>
                <c:pt idx="6">
                  <c:v>0.3440176396449024</c:v>
                </c:pt>
                <c:pt idx="7">
                  <c:v>0.6620591283900138</c:v>
                </c:pt>
                <c:pt idx="8">
                  <c:v>0.80944707778918445</c:v>
                </c:pt>
                <c:pt idx="9">
                  <c:v>3.8105519921757467</c:v>
                </c:pt>
                <c:pt idx="10">
                  <c:v>1.2060685373872246</c:v>
                </c:pt>
                <c:pt idx="11">
                  <c:v>2.41341679777365</c:v>
                </c:pt>
                <c:pt idx="12">
                  <c:v>0.70753148817500522</c:v>
                </c:pt>
                <c:pt idx="13">
                  <c:v>1.6755977769279999</c:v>
                </c:pt>
                <c:pt idx="14">
                  <c:v>1.1584669894764061</c:v>
                </c:pt>
                <c:pt idx="15">
                  <c:v>1.357125788561651</c:v>
                </c:pt>
                <c:pt idx="16">
                  <c:v>0.67368151771272888</c:v>
                </c:pt>
                <c:pt idx="17">
                  <c:v>0.61815825314140982</c:v>
                </c:pt>
                <c:pt idx="18">
                  <c:v>17.017632461920599</c:v>
                </c:pt>
                <c:pt idx="19">
                  <c:v>3.2956303799043001</c:v>
                </c:pt>
                <c:pt idx="20">
                  <c:v>2.3701607600889658</c:v>
                </c:pt>
                <c:pt idx="21">
                  <c:v>8.1068531122333187</c:v>
                </c:pt>
              </c:numCache>
            </c:numRef>
          </c:val>
        </c:ser>
        <c:axId val="74781824"/>
        <c:axId val="74783360"/>
      </c:barChart>
      <c:catAx>
        <c:axId val="74781824"/>
        <c:scaling>
          <c:orientation val="minMax"/>
        </c:scaling>
        <c:axPos val="b"/>
        <c:tickLblPos val="nextTo"/>
        <c:crossAx val="74783360"/>
        <c:crosses val="autoZero"/>
        <c:auto val="1"/>
        <c:lblAlgn val="ctr"/>
        <c:lblOffset val="100"/>
      </c:catAx>
      <c:valAx>
        <c:axId val="74783360"/>
        <c:scaling>
          <c:orientation val="minMax"/>
        </c:scaling>
        <c:axPos val="l"/>
        <c:numFmt formatCode="0" sourceLinked="0"/>
        <c:tickLblPos val="nextTo"/>
        <c:crossAx val="74781824"/>
        <c:crosses val="autoZero"/>
        <c:crossBetween val="between"/>
      </c:valAx>
    </c:plotArea>
    <c:plotVisOnly val="1"/>
  </c:chart>
  <c:externalData r:id="rId1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0h</c:v>
          </c:tx>
          <c:errBars>
            <c:errBarType val="both"/>
            <c:errValType val="cust"/>
            <c:plus>
              <c:numRef>
                <c:f>Sheet12!$X$13:$AL$13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</c:numCache>
              </c:numRef>
            </c:plus>
            <c:minus>
              <c:numRef>
                <c:f>Sheet12!$X$13:$AL$13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</c:numCache>
              </c:numRef>
            </c:minus>
          </c:errBars>
          <c:cat>
            <c:strRef>
              <c:f>Sheet12!$X$4:$AL$4</c:f>
              <c:strCache>
                <c:ptCount val="15"/>
                <c:pt idx="0">
                  <c:v>GSTU13</c:v>
                </c:pt>
                <c:pt idx="1">
                  <c:v>GSTU15</c:v>
                </c:pt>
                <c:pt idx="2">
                  <c:v>GSTU16</c:v>
                </c:pt>
                <c:pt idx="3">
                  <c:v>GSTU18</c:v>
                </c:pt>
                <c:pt idx="4">
                  <c:v>GSTF1</c:v>
                </c:pt>
                <c:pt idx="5">
                  <c:v>GSTF3</c:v>
                </c:pt>
                <c:pt idx="6">
                  <c:v>GSTZ1    </c:v>
                </c:pt>
                <c:pt idx="7">
                  <c:v>GSTZ3   </c:v>
                </c:pt>
                <c:pt idx="8">
                  <c:v>EF1G1    </c:v>
                </c:pt>
                <c:pt idx="9">
                  <c:v>EF1G2    </c:v>
                </c:pt>
                <c:pt idx="10">
                  <c:v>EF1G3    </c:v>
                </c:pt>
                <c:pt idx="11">
                  <c:v>GHR1     </c:v>
                </c:pt>
                <c:pt idx="12">
                  <c:v>GHR2    </c:v>
                </c:pt>
                <c:pt idx="13">
                  <c:v>GSTT1    </c:v>
                </c:pt>
                <c:pt idx="14">
                  <c:v>GSTT2    </c:v>
                </c:pt>
              </c:strCache>
            </c:strRef>
          </c:cat>
          <c:val>
            <c:numRef>
              <c:f>Sheet12!$X$5:$AL$5</c:f>
              <c:numCache>
                <c:formatCode>0.00</c:formatCode>
                <c:ptCount val="1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</c:numCache>
            </c:numRef>
          </c:val>
        </c:ser>
        <c:ser>
          <c:idx val="1"/>
          <c:order val="1"/>
          <c:tx>
            <c:v>6h</c:v>
          </c:tx>
          <c:errBars>
            <c:errBarType val="both"/>
            <c:errValType val="cust"/>
            <c:plus>
              <c:numRef>
                <c:f>Sheet12!$X$14:$AL$14</c:f>
                <c:numCache>
                  <c:formatCode>General</c:formatCode>
                  <c:ptCount val="15"/>
                  <c:pt idx="0">
                    <c:v>1.1378418883980999E-2</c:v>
                  </c:pt>
                  <c:pt idx="1">
                    <c:v>6.3099751667517384E-2</c:v>
                  </c:pt>
                  <c:pt idx="2">
                    <c:v>0.27075520792741181</c:v>
                  </c:pt>
                  <c:pt idx="3">
                    <c:v>0.18621743171114735</c:v>
                  </c:pt>
                  <c:pt idx="4">
                    <c:v>4.0647037730456954E-3</c:v>
                  </c:pt>
                  <c:pt idx="5">
                    <c:v>4.9713069408511376E-2</c:v>
                  </c:pt>
                  <c:pt idx="6">
                    <c:v>8.7734861697940734E-3</c:v>
                  </c:pt>
                  <c:pt idx="7">
                    <c:v>4.3669075602008965E-2</c:v>
                  </c:pt>
                  <c:pt idx="8">
                    <c:v>6.425345310502778E-2</c:v>
                  </c:pt>
                  <c:pt idx="9">
                    <c:v>1.482707402120498E-2</c:v>
                  </c:pt>
                  <c:pt idx="10">
                    <c:v>1.1221768828808041E-2</c:v>
                  </c:pt>
                  <c:pt idx="11">
                    <c:v>2.3396619560211541E-2</c:v>
                  </c:pt>
                  <c:pt idx="12">
                    <c:v>3.8632752843766417E-2</c:v>
                  </c:pt>
                  <c:pt idx="13">
                    <c:v>5.2605133725243482E-2</c:v>
                  </c:pt>
                  <c:pt idx="14">
                    <c:v>6.4246825969766413E-2</c:v>
                  </c:pt>
                </c:numCache>
              </c:numRef>
            </c:plus>
            <c:minus>
              <c:numRef>
                <c:f>Sheet12!$X$14:$AL$14</c:f>
                <c:numCache>
                  <c:formatCode>General</c:formatCode>
                  <c:ptCount val="15"/>
                  <c:pt idx="0">
                    <c:v>1.1378418883980999E-2</c:v>
                  </c:pt>
                  <c:pt idx="1">
                    <c:v>6.3099751667517384E-2</c:v>
                  </c:pt>
                  <c:pt idx="2">
                    <c:v>0.27075520792741181</c:v>
                  </c:pt>
                  <c:pt idx="3">
                    <c:v>0.18621743171114735</c:v>
                  </c:pt>
                  <c:pt idx="4">
                    <c:v>4.0647037730456954E-3</c:v>
                  </c:pt>
                  <c:pt idx="5">
                    <c:v>4.9713069408511376E-2</c:v>
                  </c:pt>
                  <c:pt idx="6">
                    <c:v>8.7734861697940734E-3</c:v>
                  </c:pt>
                  <c:pt idx="7">
                    <c:v>4.3669075602008965E-2</c:v>
                  </c:pt>
                  <c:pt idx="8">
                    <c:v>6.425345310502778E-2</c:v>
                  </c:pt>
                  <c:pt idx="9">
                    <c:v>1.482707402120498E-2</c:v>
                  </c:pt>
                  <c:pt idx="10">
                    <c:v>1.1221768828808041E-2</c:v>
                  </c:pt>
                  <c:pt idx="11">
                    <c:v>2.3396619560211541E-2</c:v>
                  </c:pt>
                  <c:pt idx="12">
                    <c:v>3.8632752843766417E-2</c:v>
                  </c:pt>
                  <c:pt idx="13">
                    <c:v>5.2605133725243482E-2</c:v>
                  </c:pt>
                  <c:pt idx="14">
                    <c:v>6.4246825969766413E-2</c:v>
                  </c:pt>
                </c:numCache>
              </c:numRef>
            </c:minus>
          </c:errBars>
          <c:cat>
            <c:strRef>
              <c:f>Sheet12!$X$4:$AL$4</c:f>
              <c:strCache>
                <c:ptCount val="15"/>
                <c:pt idx="0">
                  <c:v>GSTU13</c:v>
                </c:pt>
                <c:pt idx="1">
                  <c:v>GSTU15</c:v>
                </c:pt>
                <c:pt idx="2">
                  <c:v>GSTU16</c:v>
                </c:pt>
                <c:pt idx="3">
                  <c:v>GSTU18</c:v>
                </c:pt>
                <c:pt idx="4">
                  <c:v>GSTF1</c:v>
                </c:pt>
                <c:pt idx="5">
                  <c:v>GSTF3</c:v>
                </c:pt>
                <c:pt idx="6">
                  <c:v>GSTZ1    </c:v>
                </c:pt>
                <c:pt idx="7">
                  <c:v>GSTZ3   </c:v>
                </c:pt>
                <c:pt idx="8">
                  <c:v>EF1G1    </c:v>
                </c:pt>
                <c:pt idx="9">
                  <c:v>EF1G2    </c:v>
                </c:pt>
                <c:pt idx="10">
                  <c:v>EF1G3    </c:v>
                </c:pt>
                <c:pt idx="11">
                  <c:v>GHR1     </c:v>
                </c:pt>
                <c:pt idx="12">
                  <c:v>GHR2    </c:v>
                </c:pt>
                <c:pt idx="13">
                  <c:v>GSTT1    </c:v>
                </c:pt>
                <c:pt idx="14">
                  <c:v>GSTT2    </c:v>
                </c:pt>
              </c:strCache>
            </c:strRef>
          </c:cat>
          <c:val>
            <c:numRef>
              <c:f>Sheet12!$X$6:$AL$6</c:f>
              <c:numCache>
                <c:formatCode>0.00</c:formatCode>
                <c:ptCount val="15"/>
                <c:pt idx="0">
                  <c:v>0.38697489877964664</c:v>
                </c:pt>
                <c:pt idx="1">
                  <c:v>0.2327741057216722</c:v>
                </c:pt>
                <c:pt idx="2">
                  <c:v>0.96523534033824121</c:v>
                </c:pt>
                <c:pt idx="3">
                  <c:v>0.65290848915865562</c:v>
                </c:pt>
                <c:pt idx="4">
                  <c:v>0.27644760491661985</c:v>
                </c:pt>
                <c:pt idx="5">
                  <c:v>0.39116499739162436</c:v>
                </c:pt>
                <c:pt idx="6">
                  <c:v>0.59670012228007319</c:v>
                </c:pt>
                <c:pt idx="7">
                  <c:v>0.742903797284866</c:v>
                </c:pt>
                <c:pt idx="8">
                  <c:v>0.87475359821965815</c:v>
                </c:pt>
                <c:pt idx="9">
                  <c:v>0.605087882086908</c:v>
                </c:pt>
                <c:pt idx="10">
                  <c:v>0.38164730099449296</c:v>
                </c:pt>
                <c:pt idx="11">
                  <c:v>0.79570848800836769</c:v>
                </c:pt>
                <c:pt idx="12">
                  <c:v>0.37600339809933181</c:v>
                </c:pt>
                <c:pt idx="13">
                  <c:v>0.56570646706303462</c:v>
                </c:pt>
                <c:pt idx="14">
                  <c:v>0.50552319162537052</c:v>
                </c:pt>
              </c:numCache>
            </c:numRef>
          </c:val>
        </c:ser>
        <c:ser>
          <c:idx val="2"/>
          <c:order val="2"/>
          <c:tx>
            <c:v>24h</c:v>
          </c:tx>
          <c:errBars>
            <c:errBarType val="both"/>
            <c:errValType val="cust"/>
            <c:plus>
              <c:numRef>
                <c:f>Sheet12!$X$15:$AL$15</c:f>
                <c:numCache>
                  <c:formatCode>General</c:formatCode>
                  <c:ptCount val="15"/>
                  <c:pt idx="0">
                    <c:v>8.018578789239143E-3</c:v>
                  </c:pt>
                  <c:pt idx="1">
                    <c:v>9.3045913220024708E-3</c:v>
                  </c:pt>
                  <c:pt idx="2">
                    <c:v>0.33316997781864527</c:v>
                  </c:pt>
                  <c:pt idx="3">
                    <c:v>5.9235735030372827E-2</c:v>
                  </c:pt>
                  <c:pt idx="4">
                    <c:v>7.3114726558281377E-3</c:v>
                  </c:pt>
                  <c:pt idx="5">
                    <c:v>7.9208659333562734E-3</c:v>
                  </c:pt>
                  <c:pt idx="6">
                    <c:v>2.1087565623009782E-2</c:v>
                  </c:pt>
                  <c:pt idx="7">
                    <c:v>2.2555050585964981E-2</c:v>
                  </c:pt>
                  <c:pt idx="8">
                    <c:v>1.8356615651482083E-2</c:v>
                  </c:pt>
                  <c:pt idx="9">
                    <c:v>7.1637877255392973E-2</c:v>
                  </c:pt>
                  <c:pt idx="10">
                    <c:v>8.1305139777922524E-3</c:v>
                  </c:pt>
                  <c:pt idx="11">
                    <c:v>1.9674133517236923E-2</c:v>
                  </c:pt>
                  <c:pt idx="12">
                    <c:v>1.1620015491520416E-2</c:v>
                  </c:pt>
                  <c:pt idx="13">
                    <c:v>7.0856474390725441E-2</c:v>
                  </c:pt>
                  <c:pt idx="14">
                    <c:v>8.8775526961008041E-3</c:v>
                  </c:pt>
                </c:numCache>
              </c:numRef>
            </c:plus>
            <c:minus>
              <c:numRef>
                <c:f>Sheet12!$X$15:$AL$15</c:f>
                <c:numCache>
                  <c:formatCode>General</c:formatCode>
                  <c:ptCount val="15"/>
                  <c:pt idx="0">
                    <c:v>8.018578789239143E-3</c:v>
                  </c:pt>
                  <c:pt idx="1">
                    <c:v>9.3045913220024708E-3</c:v>
                  </c:pt>
                  <c:pt idx="2">
                    <c:v>0.33316997781864527</c:v>
                  </c:pt>
                  <c:pt idx="3">
                    <c:v>5.9235735030372827E-2</c:v>
                  </c:pt>
                  <c:pt idx="4">
                    <c:v>7.3114726558281377E-3</c:v>
                  </c:pt>
                  <c:pt idx="5">
                    <c:v>7.9208659333562734E-3</c:v>
                  </c:pt>
                  <c:pt idx="6">
                    <c:v>2.1087565623009782E-2</c:v>
                  </c:pt>
                  <c:pt idx="7">
                    <c:v>2.2555050585964981E-2</c:v>
                  </c:pt>
                  <c:pt idx="8">
                    <c:v>1.8356615651482083E-2</c:v>
                  </c:pt>
                  <c:pt idx="9">
                    <c:v>7.1637877255392973E-2</c:v>
                  </c:pt>
                  <c:pt idx="10">
                    <c:v>8.1305139777922524E-3</c:v>
                  </c:pt>
                  <c:pt idx="11">
                    <c:v>1.9674133517236923E-2</c:v>
                  </c:pt>
                  <c:pt idx="12">
                    <c:v>1.1620015491520416E-2</c:v>
                  </c:pt>
                  <c:pt idx="13">
                    <c:v>7.0856474390725441E-2</c:v>
                  </c:pt>
                  <c:pt idx="14">
                    <c:v>8.8775526961008041E-3</c:v>
                  </c:pt>
                </c:numCache>
              </c:numRef>
            </c:minus>
          </c:errBars>
          <c:cat>
            <c:strRef>
              <c:f>Sheet12!$X$4:$AL$4</c:f>
              <c:strCache>
                <c:ptCount val="15"/>
                <c:pt idx="0">
                  <c:v>GSTU13</c:v>
                </c:pt>
                <c:pt idx="1">
                  <c:v>GSTU15</c:v>
                </c:pt>
                <c:pt idx="2">
                  <c:v>GSTU16</c:v>
                </c:pt>
                <c:pt idx="3">
                  <c:v>GSTU18</c:v>
                </c:pt>
                <c:pt idx="4">
                  <c:v>GSTF1</c:v>
                </c:pt>
                <c:pt idx="5">
                  <c:v>GSTF3</c:v>
                </c:pt>
                <c:pt idx="6">
                  <c:v>GSTZ1    </c:v>
                </c:pt>
                <c:pt idx="7">
                  <c:v>GSTZ3   </c:v>
                </c:pt>
                <c:pt idx="8">
                  <c:v>EF1G1    </c:v>
                </c:pt>
                <c:pt idx="9">
                  <c:v>EF1G2    </c:v>
                </c:pt>
                <c:pt idx="10">
                  <c:v>EF1G3    </c:v>
                </c:pt>
                <c:pt idx="11">
                  <c:v>GHR1     </c:v>
                </c:pt>
                <c:pt idx="12">
                  <c:v>GHR2    </c:v>
                </c:pt>
                <c:pt idx="13">
                  <c:v>GSTT1    </c:v>
                </c:pt>
                <c:pt idx="14">
                  <c:v>GSTT2    </c:v>
                </c:pt>
              </c:strCache>
            </c:strRef>
          </c:cat>
          <c:val>
            <c:numRef>
              <c:f>Sheet12!$X$7:$AL$7</c:f>
              <c:numCache>
                <c:formatCode>0.00</c:formatCode>
                <c:ptCount val="15"/>
                <c:pt idx="0">
                  <c:v>0.20455411237607904</c:v>
                </c:pt>
                <c:pt idx="1">
                  <c:v>0.17266506638202136</c:v>
                </c:pt>
                <c:pt idx="2">
                  <c:v>1.0478391469595694</c:v>
                </c:pt>
                <c:pt idx="3">
                  <c:v>0.16688598992854567</c:v>
                </c:pt>
                <c:pt idx="4">
                  <c:v>0.2983787292033665</c:v>
                </c:pt>
                <c:pt idx="5">
                  <c:v>0.23091351366705298</c:v>
                </c:pt>
                <c:pt idx="6">
                  <c:v>0.47820519159593211</c:v>
                </c:pt>
                <c:pt idx="7">
                  <c:v>0.46037016980262757</c:v>
                </c:pt>
                <c:pt idx="8">
                  <c:v>0.62430022625283343</c:v>
                </c:pt>
                <c:pt idx="9">
                  <c:v>0.488958489455116</c:v>
                </c:pt>
                <c:pt idx="10">
                  <c:v>0.20740958137376056</c:v>
                </c:pt>
                <c:pt idx="11">
                  <c:v>0.66910841515319353</c:v>
                </c:pt>
                <c:pt idx="12">
                  <c:v>0.19768116256534649</c:v>
                </c:pt>
                <c:pt idx="13">
                  <c:v>0.40365648412592647</c:v>
                </c:pt>
                <c:pt idx="14">
                  <c:v>0.36228992661102122</c:v>
                </c:pt>
              </c:numCache>
            </c:numRef>
          </c:val>
        </c:ser>
        <c:ser>
          <c:idx val="3"/>
          <c:order val="3"/>
          <c:tx>
            <c:v>48h</c:v>
          </c:tx>
          <c:errBars>
            <c:errBarType val="both"/>
            <c:errValType val="cust"/>
            <c:plus>
              <c:numRef>
                <c:f>Sheet12!$X$16:$AL$16</c:f>
                <c:numCache>
                  <c:formatCode>General</c:formatCode>
                  <c:ptCount val="15"/>
                  <c:pt idx="0">
                    <c:v>2.2624082678691468E-2</c:v>
                  </c:pt>
                  <c:pt idx="1">
                    <c:v>4.8256476806924534E-2</c:v>
                  </c:pt>
                  <c:pt idx="2">
                    <c:v>5.5274420395829985E-2</c:v>
                  </c:pt>
                  <c:pt idx="3">
                    <c:v>0.20522836899184371</c:v>
                  </c:pt>
                  <c:pt idx="4">
                    <c:v>9.5348347256823708E-3</c:v>
                  </c:pt>
                  <c:pt idx="5">
                    <c:v>2.7158776006387976E-2</c:v>
                  </c:pt>
                  <c:pt idx="6">
                    <c:v>1.2110849783574804E-2</c:v>
                  </c:pt>
                  <c:pt idx="7">
                    <c:v>5.3449061271914492E-3</c:v>
                  </c:pt>
                  <c:pt idx="8">
                    <c:v>7.2203202195581434E-2</c:v>
                  </c:pt>
                  <c:pt idx="9">
                    <c:v>0.14893828116472499</c:v>
                  </c:pt>
                  <c:pt idx="10">
                    <c:v>2.9449194898399354E-3</c:v>
                  </c:pt>
                  <c:pt idx="11">
                    <c:v>0.30859319160429582</c:v>
                  </c:pt>
                  <c:pt idx="12">
                    <c:v>1.3071208737907373E-2</c:v>
                  </c:pt>
                  <c:pt idx="13">
                    <c:v>3.6101601097788386E-2</c:v>
                  </c:pt>
                  <c:pt idx="14">
                    <c:v>3.1496763694805412E-2</c:v>
                  </c:pt>
                </c:numCache>
              </c:numRef>
            </c:plus>
            <c:minus>
              <c:numRef>
                <c:f>Sheet12!$X$16:$AL$16</c:f>
                <c:numCache>
                  <c:formatCode>General</c:formatCode>
                  <c:ptCount val="15"/>
                  <c:pt idx="0">
                    <c:v>2.2624082678691468E-2</c:v>
                  </c:pt>
                  <c:pt idx="1">
                    <c:v>4.8256476806924534E-2</c:v>
                  </c:pt>
                  <c:pt idx="2">
                    <c:v>5.5274420395829985E-2</c:v>
                  </c:pt>
                  <c:pt idx="3">
                    <c:v>0.20522836899184371</c:v>
                  </c:pt>
                  <c:pt idx="4">
                    <c:v>9.5348347256823708E-3</c:v>
                  </c:pt>
                  <c:pt idx="5">
                    <c:v>2.7158776006387976E-2</c:v>
                  </c:pt>
                  <c:pt idx="6">
                    <c:v>1.2110849783574804E-2</c:v>
                  </c:pt>
                  <c:pt idx="7">
                    <c:v>5.3449061271914492E-3</c:v>
                  </c:pt>
                  <c:pt idx="8">
                    <c:v>7.2203202195581434E-2</c:v>
                  </c:pt>
                  <c:pt idx="9">
                    <c:v>0.14893828116472499</c:v>
                  </c:pt>
                  <c:pt idx="10">
                    <c:v>2.9449194898399354E-3</c:v>
                  </c:pt>
                  <c:pt idx="11">
                    <c:v>0.30859319160429582</c:v>
                  </c:pt>
                  <c:pt idx="12">
                    <c:v>1.3071208737907373E-2</c:v>
                  </c:pt>
                  <c:pt idx="13">
                    <c:v>3.6101601097788386E-2</c:v>
                  </c:pt>
                  <c:pt idx="14">
                    <c:v>3.1496763694805412E-2</c:v>
                  </c:pt>
                </c:numCache>
              </c:numRef>
            </c:minus>
          </c:errBars>
          <c:cat>
            <c:strRef>
              <c:f>Sheet12!$X$4:$AL$4</c:f>
              <c:strCache>
                <c:ptCount val="15"/>
                <c:pt idx="0">
                  <c:v>GSTU13</c:v>
                </c:pt>
                <c:pt idx="1">
                  <c:v>GSTU15</c:v>
                </c:pt>
                <c:pt idx="2">
                  <c:v>GSTU16</c:v>
                </c:pt>
                <c:pt idx="3">
                  <c:v>GSTU18</c:v>
                </c:pt>
                <c:pt idx="4">
                  <c:v>GSTF1</c:v>
                </c:pt>
                <c:pt idx="5">
                  <c:v>GSTF3</c:v>
                </c:pt>
                <c:pt idx="6">
                  <c:v>GSTZ1    </c:v>
                </c:pt>
                <c:pt idx="7">
                  <c:v>GSTZ3   </c:v>
                </c:pt>
                <c:pt idx="8">
                  <c:v>EF1G1    </c:v>
                </c:pt>
                <c:pt idx="9">
                  <c:v>EF1G2    </c:v>
                </c:pt>
                <c:pt idx="10">
                  <c:v>EF1G3    </c:v>
                </c:pt>
                <c:pt idx="11">
                  <c:v>GHR1     </c:v>
                </c:pt>
                <c:pt idx="12">
                  <c:v>GHR2    </c:v>
                </c:pt>
                <c:pt idx="13">
                  <c:v>GSTT1    </c:v>
                </c:pt>
                <c:pt idx="14">
                  <c:v>GSTT2    </c:v>
                </c:pt>
              </c:strCache>
            </c:strRef>
          </c:cat>
          <c:val>
            <c:numRef>
              <c:f>Sheet12!$X$8:$AL$8</c:f>
              <c:numCache>
                <c:formatCode>0.00</c:formatCode>
                <c:ptCount val="15"/>
                <c:pt idx="0">
                  <c:v>0.19277433757686541</c:v>
                </c:pt>
                <c:pt idx="1">
                  <c:v>0.32937064734373173</c:v>
                </c:pt>
                <c:pt idx="2">
                  <c:v>0.94033538009887863</c:v>
                </c:pt>
                <c:pt idx="3">
                  <c:v>0.47045383526647144</c:v>
                </c:pt>
                <c:pt idx="4">
                  <c:v>0.48637420595465786</c:v>
                </c:pt>
                <c:pt idx="5">
                  <c:v>0.69282094311569242</c:v>
                </c:pt>
                <c:pt idx="6">
                  <c:v>0.41188454361896115</c:v>
                </c:pt>
                <c:pt idx="7">
                  <c:v>1.0905142818933988</c:v>
                </c:pt>
                <c:pt idx="8">
                  <c:v>0.67090922386537333</c:v>
                </c:pt>
                <c:pt idx="9">
                  <c:v>1.0513729153154414</c:v>
                </c:pt>
                <c:pt idx="10">
                  <c:v>0.10015538477840823</c:v>
                </c:pt>
                <c:pt idx="11">
                  <c:v>1.1383959890362767</c:v>
                </c:pt>
                <c:pt idx="12">
                  <c:v>0.29641732908613783</c:v>
                </c:pt>
                <c:pt idx="13">
                  <c:v>0.335454611932687</c:v>
                </c:pt>
                <c:pt idx="14">
                  <c:v>0.33871072368659688</c:v>
                </c:pt>
              </c:numCache>
            </c:numRef>
          </c:val>
        </c:ser>
        <c:ser>
          <c:idx val="4"/>
          <c:order val="4"/>
          <c:tx>
            <c:v>72h</c:v>
          </c:tx>
          <c:errBars>
            <c:errBarType val="both"/>
            <c:errValType val="cust"/>
            <c:plus>
              <c:numRef>
                <c:f>Sheet12!$X$17:$AL$17</c:f>
                <c:numCache>
                  <c:formatCode>General</c:formatCode>
                  <c:ptCount val="15"/>
                  <c:pt idx="0">
                    <c:v>3.2260915780823406E-3</c:v>
                  </c:pt>
                  <c:pt idx="1">
                    <c:v>1.1925273472257996E-3</c:v>
                  </c:pt>
                  <c:pt idx="2">
                    <c:v>3.314787125648027E-2</c:v>
                  </c:pt>
                  <c:pt idx="3">
                    <c:v>5.4647529953410297E-4</c:v>
                  </c:pt>
                  <c:pt idx="4">
                    <c:v>1.7693579593071423E-2</c:v>
                  </c:pt>
                  <c:pt idx="5">
                    <c:v>7.5365330213105217E-3</c:v>
                  </c:pt>
                  <c:pt idx="6">
                    <c:v>2.5422368085699556E-2</c:v>
                  </c:pt>
                  <c:pt idx="7">
                    <c:v>9.9394999627103412E-3</c:v>
                  </c:pt>
                  <c:pt idx="8">
                    <c:v>4.9648584200578079E-3</c:v>
                  </c:pt>
                  <c:pt idx="9">
                    <c:v>2.1033886572262114E-2</c:v>
                  </c:pt>
                  <c:pt idx="10">
                    <c:v>1.1633040285425667E-3</c:v>
                  </c:pt>
                  <c:pt idx="11">
                    <c:v>1.8661858969093857E-4</c:v>
                  </c:pt>
                  <c:pt idx="12">
                    <c:v>1.5968221065527404E-2</c:v>
                  </c:pt>
                  <c:pt idx="13">
                    <c:v>2.4509593493926662E-3</c:v>
                  </c:pt>
                  <c:pt idx="14">
                    <c:v>4.8699298916418188E-3</c:v>
                  </c:pt>
                </c:numCache>
              </c:numRef>
            </c:plus>
            <c:minus>
              <c:numRef>
                <c:f>Sheet12!$X$17:$AL$17</c:f>
                <c:numCache>
                  <c:formatCode>General</c:formatCode>
                  <c:ptCount val="15"/>
                  <c:pt idx="0">
                    <c:v>3.2260915780823406E-3</c:v>
                  </c:pt>
                  <c:pt idx="1">
                    <c:v>1.1925273472257996E-3</c:v>
                  </c:pt>
                  <c:pt idx="2">
                    <c:v>3.314787125648027E-2</c:v>
                  </c:pt>
                  <c:pt idx="3">
                    <c:v>5.4647529953410297E-4</c:v>
                  </c:pt>
                  <c:pt idx="4">
                    <c:v>1.7693579593071423E-2</c:v>
                  </c:pt>
                  <c:pt idx="5">
                    <c:v>7.5365330213105217E-3</c:v>
                  </c:pt>
                  <c:pt idx="6">
                    <c:v>2.5422368085699556E-2</c:v>
                  </c:pt>
                  <c:pt idx="7">
                    <c:v>9.9394999627103412E-3</c:v>
                  </c:pt>
                  <c:pt idx="8">
                    <c:v>4.9648584200578079E-3</c:v>
                  </c:pt>
                  <c:pt idx="9">
                    <c:v>2.1033886572262114E-2</c:v>
                  </c:pt>
                  <c:pt idx="10">
                    <c:v>1.1633040285425667E-3</c:v>
                  </c:pt>
                  <c:pt idx="11">
                    <c:v>1.8661858969093857E-4</c:v>
                  </c:pt>
                  <c:pt idx="12">
                    <c:v>1.5968221065527404E-2</c:v>
                  </c:pt>
                  <c:pt idx="13">
                    <c:v>2.4509593493926662E-3</c:v>
                  </c:pt>
                  <c:pt idx="14">
                    <c:v>4.8699298916418188E-3</c:v>
                  </c:pt>
                </c:numCache>
              </c:numRef>
            </c:minus>
          </c:errBars>
          <c:cat>
            <c:strRef>
              <c:f>Sheet12!$X$4:$AL$4</c:f>
              <c:strCache>
                <c:ptCount val="15"/>
                <c:pt idx="0">
                  <c:v>GSTU13</c:v>
                </c:pt>
                <c:pt idx="1">
                  <c:v>GSTU15</c:v>
                </c:pt>
                <c:pt idx="2">
                  <c:v>GSTU16</c:v>
                </c:pt>
                <c:pt idx="3">
                  <c:v>GSTU18</c:v>
                </c:pt>
                <c:pt idx="4">
                  <c:v>GSTF1</c:v>
                </c:pt>
                <c:pt idx="5">
                  <c:v>GSTF3</c:v>
                </c:pt>
                <c:pt idx="6">
                  <c:v>GSTZ1    </c:v>
                </c:pt>
                <c:pt idx="7">
                  <c:v>GSTZ3   </c:v>
                </c:pt>
                <c:pt idx="8">
                  <c:v>EF1G1    </c:v>
                </c:pt>
                <c:pt idx="9">
                  <c:v>EF1G2    </c:v>
                </c:pt>
                <c:pt idx="10">
                  <c:v>EF1G3    </c:v>
                </c:pt>
                <c:pt idx="11">
                  <c:v>GHR1     </c:v>
                </c:pt>
                <c:pt idx="12">
                  <c:v>GHR2    </c:v>
                </c:pt>
                <c:pt idx="13">
                  <c:v>GSTT1    </c:v>
                </c:pt>
                <c:pt idx="14">
                  <c:v>GSTT2    </c:v>
                </c:pt>
              </c:strCache>
            </c:strRef>
          </c:cat>
          <c:val>
            <c:numRef>
              <c:f>Sheet12!$X$9:$AL$9</c:f>
              <c:numCache>
                <c:formatCode>0.00</c:formatCode>
                <c:ptCount val="15"/>
                <c:pt idx="0">
                  <c:v>2.7488746207282241E-2</c:v>
                </c:pt>
                <c:pt idx="1">
                  <c:v>1.3534687867039905E-2</c:v>
                </c:pt>
                <c:pt idx="2">
                  <c:v>0.11622180771167163</c:v>
                </c:pt>
                <c:pt idx="3">
                  <c:v>1.8585378678621114E-2</c:v>
                </c:pt>
                <c:pt idx="4">
                  <c:v>0.1340931185402599</c:v>
                </c:pt>
                <c:pt idx="5">
                  <c:v>9.6202415938524133E-2</c:v>
                </c:pt>
                <c:pt idx="6">
                  <c:v>3.5313351868278615E-2</c:v>
                </c:pt>
                <c:pt idx="7">
                  <c:v>1.0139838378819532</c:v>
                </c:pt>
                <c:pt idx="8">
                  <c:v>4.8321786556948569E-2</c:v>
                </c:pt>
                <c:pt idx="9">
                  <c:v>4.6340564769227502E-2</c:v>
                </c:pt>
                <c:pt idx="10">
                  <c:v>3.956344579025739E-2</c:v>
                </c:pt>
                <c:pt idx="11">
                  <c:v>3.8075549407611209E-2</c:v>
                </c:pt>
                <c:pt idx="12">
                  <c:v>0.17171947459428327</c:v>
                </c:pt>
                <c:pt idx="13">
                  <c:v>6.2524024189635929E-2</c:v>
                </c:pt>
                <c:pt idx="14">
                  <c:v>6.216373227615863E-2</c:v>
                </c:pt>
              </c:numCache>
            </c:numRef>
          </c:val>
        </c:ser>
        <c:axId val="74791552"/>
        <c:axId val="76292480"/>
      </c:barChart>
      <c:catAx>
        <c:axId val="74791552"/>
        <c:scaling>
          <c:orientation val="minMax"/>
        </c:scaling>
        <c:axPos val="b"/>
        <c:tickLblPos val="nextTo"/>
        <c:crossAx val="76292480"/>
        <c:crosses val="autoZero"/>
        <c:auto val="1"/>
        <c:lblAlgn val="ctr"/>
        <c:lblOffset val="100"/>
      </c:catAx>
      <c:valAx>
        <c:axId val="76292480"/>
        <c:scaling>
          <c:orientation val="minMax"/>
        </c:scaling>
        <c:axPos val="l"/>
        <c:numFmt formatCode="0.0" sourceLinked="0"/>
        <c:tickLblPos val="nextTo"/>
        <c:crossAx val="74791552"/>
        <c:crosses val="autoZero"/>
        <c:crossBetween val="between"/>
      </c:valAx>
    </c:plotArea>
    <c:plotVisOnly val="1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DA7591-1666-444E-8D43-486242742FFD}" type="datetimeFigureOut">
              <a:rPr lang="en-US" smtClean="0"/>
              <a:pPr/>
              <a:t>2/6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19CBDB-412D-4F80-AB73-3B8CE03F830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F31746-44C9-475A-B785-7FC154AAB9F1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3315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smtClean="0"/>
          </a:p>
        </p:txBody>
      </p:sp>
      <p:sp>
        <p:nvSpPr>
          <p:cNvPr id="14340" name="Slide Number Placeholder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82CAFE7F-079F-4793-8A6C-F568F4ADA3A2}" type="slidenum">
              <a:rPr 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6</a:t>
            </a:fld>
            <a:endParaRPr 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7E7E5-525B-4D60-919D-F285522ED80F}" type="datetimeFigureOut">
              <a:rPr lang="en-US" smtClean="0"/>
              <a:pPr/>
              <a:t>2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2C839-6850-4069-98BF-0C59DC919D7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7E7E5-525B-4D60-919D-F285522ED80F}" type="datetimeFigureOut">
              <a:rPr lang="en-US" smtClean="0"/>
              <a:pPr/>
              <a:t>2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2C839-6850-4069-98BF-0C59DC919D7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7E7E5-525B-4D60-919D-F285522ED80F}" type="datetimeFigureOut">
              <a:rPr lang="en-US" smtClean="0"/>
              <a:pPr/>
              <a:t>2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2C839-6850-4069-98BF-0C59DC919D7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7E7E5-525B-4D60-919D-F285522ED80F}" type="datetimeFigureOut">
              <a:rPr lang="en-US" smtClean="0"/>
              <a:pPr/>
              <a:t>2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2C839-6850-4069-98BF-0C59DC919D7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7E7E5-525B-4D60-919D-F285522ED80F}" type="datetimeFigureOut">
              <a:rPr lang="en-US" smtClean="0"/>
              <a:pPr/>
              <a:t>2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2C839-6850-4069-98BF-0C59DC919D7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7E7E5-525B-4D60-919D-F285522ED80F}" type="datetimeFigureOut">
              <a:rPr lang="en-US" smtClean="0"/>
              <a:pPr/>
              <a:t>2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2C839-6850-4069-98BF-0C59DC919D7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7E7E5-525B-4D60-919D-F285522ED80F}" type="datetimeFigureOut">
              <a:rPr lang="en-US" smtClean="0"/>
              <a:pPr/>
              <a:t>2/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2C839-6850-4069-98BF-0C59DC919D7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7E7E5-525B-4D60-919D-F285522ED80F}" type="datetimeFigureOut">
              <a:rPr lang="en-US" smtClean="0"/>
              <a:pPr/>
              <a:t>2/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2C839-6850-4069-98BF-0C59DC919D7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7E7E5-525B-4D60-919D-F285522ED80F}" type="datetimeFigureOut">
              <a:rPr lang="en-US" smtClean="0"/>
              <a:pPr/>
              <a:t>2/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2C839-6850-4069-98BF-0C59DC919D7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7E7E5-525B-4D60-919D-F285522ED80F}" type="datetimeFigureOut">
              <a:rPr lang="en-US" smtClean="0"/>
              <a:pPr/>
              <a:t>2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2C839-6850-4069-98BF-0C59DC919D7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7E7E5-525B-4D60-919D-F285522ED80F}" type="datetimeFigureOut">
              <a:rPr lang="en-US" smtClean="0"/>
              <a:pPr/>
              <a:t>2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2C839-6850-4069-98BF-0C59DC919D7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37E7E5-525B-4D60-919D-F285522ED80F}" type="datetimeFigureOut">
              <a:rPr lang="en-US" smtClean="0"/>
              <a:pPr/>
              <a:t>2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52C839-6850-4069-98BF-0C59DC919D7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6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8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Rectangle 34"/>
          <p:cNvSpPr/>
          <p:nvPr/>
        </p:nvSpPr>
        <p:spPr>
          <a:xfrm>
            <a:off x="381000" y="5433629"/>
            <a:ext cx="85344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ry Figure S1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equenc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tructural analysis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pumpkin GST  proteins with Arabidopsis, Rice and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opulu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richocarp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GSTs .  Protein sequenc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lignment of th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N-terminal domains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au, phi, Zeta, EF1G, GHR, lambda, Theta, DHAR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STs. </a:t>
            </a:r>
            <a:r>
              <a:rPr lang="el-GR" sz="1200" dirty="0" smtClean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Helices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l-GR" sz="1200" dirty="0" smtClean="0"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strands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r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epresented as red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reen arrow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espectively. Highly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conserved residues in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ll plant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GSTs are marked in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reen. Predicted G-sites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re marked in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black. Residues marked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in t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eal, light gray, turquoise, yellow, pink,  red indicat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conserved residues in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au, phi, zeta, EF1G, GHR, lambda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nd theta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GSTs, respectively. </a:t>
            </a:r>
          </a:p>
        </p:txBody>
      </p:sp>
      <p:grpSp>
        <p:nvGrpSpPr>
          <p:cNvPr id="2" name="Group 6"/>
          <p:cNvGrpSpPr/>
          <p:nvPr/>
        </p:nvGrpSpPr>
        <p:grpSpPr>
          <a:xfrm>
            <a:off x="847725" y="420455"/>
            <a:ext cx="7845552" cy="4913545"/>
            <a:chOff x="847725" y="76200"/>
            <a:chExt cx="7845552" cy="4913545"/>
          </a:xfrm>
        </p:grpSpPr>
        <p:pic>
          <p:nvPicPr>
            <p:cNvPr id="1028" name="Picture 4" descr="C:\Users\KAYUM\Desktop\Untitled-2.tif"/>
            <p:cNvPicPr preferRelativeResize="0">
              <a:picLocks noChangeArrowheads="1"/>
            </p:cNvPicPr>
            <p:nvPr/>
          </p:nvPicPr>
          <p:blipFill>
            <a:blip r:embed="rId2"/>
            <a:srcRect t="14583" b="22916"/>
            <a:stretch>
              <a:fillRect/>
            </a:stretch>
          </p:blipFill>
          <p:spPr bwMode="auto">
            <a:xfrm>
              <a:off x="1813560" y="76200"/>
              <a:ext cx="6492240" cy="228600"/>
            </a:xfrm>
            <a:prstGeom prst="rect">
              <a:avLst/>
            </a:prstGeom>
            <a:noFill/>
          </p:spPr>
        </p:pic>
        <p:pic>
          <p:nvPicPr>
            <p:cNvPr id="2049" name="Picture 1" descr="C:\Users\KAYUM\Desktop\Untitled-1.tif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847725" y="295275"/>
              <a:ext cx="7845552" cy="4694470"/>
            </a:xfrm>
            <a:prstGeom prst="rect">
              <a:avLst/>
            </a:prstGeom>
            <a:noFill/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4"/>
          <p:cNvGrpSpPr/>
          <p:nvPr/>
        </p:nvGrpSpPr>
        <p:grpSpPr>
          <a:xfrm>
            <a:off x="814842" y="716280"/>
            <a:ext cx="7643358" cy="5341620"/>
            <a:chOff x="814842" y="716280"/>
            <a:chExt cx="7643358" cy="5341620"/>
          </a:xfrm>
        </p:grpSpPr>
        <p:grpSp>
          <p:nvGrpSpPr>
            <p:cNvPr id="3" name="Group 3"/>
            <p:cNvGrpSpPr/>
            <p:nvPr/>
          </p:nvGrpSpPr>
          <p:grpSpPr>
            <a:xfrm>
              <a:off x="1546860" y="716280"/>
              <a:ext cx="6911340" cy="5341620"/>
              <a:chOff x="1143000" y="716280"/>
              <a:chExt cx="6911340" cy="5341620"/>
            </a:xfrm>
          </p:grpSpPr>
          <p:grpSp>
            <p:nvGrpSpPr>
              <p:cNvPr id="4" name="Group 7"/>
              <p:cNvGrpSpPr/>
              <p:nvPr/>
            </p:nvGrpSpPr>
            <p:grpSpPr>
              <a:xfrm>
                <a:off x="1143000" y="716280"/>
                <a:ext cx="6830541" cy="5170646"/>
                <a:chOff x="1143000" y="716280"/>
                <a:chExt cx="6830541" cy="5170646"/>
              </a:xfrm>
            </p:grpSpPr>
            <p:pic>
              <p:nvPicPr>
                <p:cNvPr id="7" name="Picture 2"/>
                <p:cNvPicPr>
                  <a:picLocks noChangeAspect="1" noChangeArrowheads="1"/>
                </p:cNvPicPr>
                <p:nvPr/>
              </p:nvPicPr>
              <p:blipFill>
                <a:blip r:embed="rId3"/>
                <a:srcRect/>
                <a:stretch>
                  <a:fillRect/>
                </a:stretch>
              </p:blipFill>
              <p:spPr bwMode="auto">
                <a:xfrm>
                  <a:off x="1955799" y="739140"/>
                  <a:ext cx="6017742" cy="5105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8" name="TextBox 7"/>
                <p:cNvSpPr txBox="1"/>
                <p:nvPr/>
              </p:nvSpPr>
              <p:spPr>
                <a:xfrm>
                  <a:off x="1143000" y="716280"/>
                  <a:ext cx="914400" cy="517064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lIns="0" tIns="0" rIns="0" bIns="0" rtlCol="0">
                  <a:spAutoFit/>
                </a:bodyPr>
                <a:lstStyle/>
                <a:p>
                  <a:pPr>
                    <a:lnSpc>
                      <a:spcPct val="95000"/>
                    </a:lnSpc>
                  </a:pPr>
                  <a:r>
                    <a:rPr lang="en-US" sz="1050" dirty="0" smtClean="0">
                      <a:latin typeface="Times New Roman" pitchFamily="18" charset="0"/>
                      <a:cs typeface="Times New Roman" pitchFamily="18" charset="0"/>
                    </a:rPr>
                    <a:t>CmaGSTU1</a:t>
                  </a:r>
                </a:p>
                <a:p>
                  <a:pPr>
                    <a:lnSpc>
                      <a:spcPct val="95000"/>
                    </a:lnSpc>
                  </a:pPr>
                  <a:r>
                    <a:rPr lang="en-US" sz="1050" dirty="0" smtClean="0">
                      <a:latin typeface="Times New Roman" pitchFamily="18" charset="0"/>
                      <a:cs typeface="Times New Roman" pitchFamily="18" charset="0"/>
                    </a:rPr>
                    <a:t>CmaGSTU2</a:t>
                  </a:r>
                </a:p>
                <a:p>
                  <a:pPr>
                    <a:lnSpc>
                      <a:spcPct val="95000"/>
                    </a:lnSpc>
                  </a:pPr>
                  <a:r>
                    <a:rPr lang="en-US" sz="1050" dirty="0" smtClean="0">
                      <a:latin typeface="Times New Roman" pitchFamily="18" charset="0"/>
                      <a:cs typeface="Times New Roman" pitchFamily="18" charset="0"/>
                    </a:rPr>
                    <a:t>CmaGSTU3</a:t>
                  </a:r>
                </a:p>
                <a:p>
                  <a:pPr>
                    <a:lnSpc>
                      <a:spcPct val="95000"/>
                    </a:lnSpc>
                  </a:pPr>
                  <a:r>
                    <a:rPr lang="en-US" sz="1050" dirty="0" smtClean="0">
                      <a:latin typeface="Times New Roman" pitchFamily="18" charset="0"/>
                      <a:cs typeface="Times New Roman" pitchFamily="18" charset="0"/>
                    </a:rPr>
                    <a:t>CmaGSTU4</a:t>
                  </a:r>
                </a:p>
                <a:p>
                  <a:pPr>
                    <a:lnSpc>
                      <a:spcPct val="95000"/>
                    </a:lnSpc>
                  </a:pPr>
                  <a:r>
                    <a:rPr lang="en-US" sz="1050" dirty="0" smtClean="0">
                      <a:latin typeface="Times New Roman" pitchFamily="18" charset="0"/>
                      <a:cs typeface="Times New Roman" pitchFamily="18" charset="0"/>
                    </a:rPr>
                    <a:t>CmaGSTU5</a:t>
                  </a:r>
                </a:p>
                <a:p>
                  <a:pPr>
                    <a:lnSpc>
                      <a:spcPct val="95000"/>
                    </a:lnSpc>
                  </a:pPr>
                  <a:r>
                    <a:rPr lang="en-US" sz="1050" dirty="0" smtClean="0">
                      <a:latin typeface="Times New Roman" pitchFamily="18" charset="0"/>
                      <a:cs typeface="Times New Roman" pitchFamily="18" charset="0"/>
                    </a:rPr>
                    <a:t>CmaGSTU6</a:t>
                  </a:r>
                </a:p>
                <a:p>
                  <a:pPr>
                    <a:lnSpc>
                      <a:spcPct val="95000"/>
                    </a:lnSpc>
                  </a:pPr>
                  <a:r>
                    <a:rPr lang="en-US" sz="1050" dirty="0" smtClean="0">
                      <a:latin typeface="Times New Roman" pitchFamily="18" charset="0"/>
                      <a:cs typeface="Times New Roman" pitchFamily="18" charset="0"/>
                    </a:rPr>
                    <a:t>CmaGSTU7</a:t>
                  </a:r>
                </a:p>
                <a:p>
                  <a:pPr>
                    <a:lnSpc>
                      <a:spcPct val="95000"/>
                    </a:lnSpc>
                  </a:pPr>
                  <a:r>
                    <a:rPr lang="en-US" sz="1050" dirty="0" smtClean="0">
                      <a:latin typeface="Times New Roman" pitchFamily="18" charset="0"/>
                      <a:cs typeface="Times New Roman" pitchFamily="18" charset="0"/>
                    </a:rPr>
                    <a:t>CmaGSTU8</a:t>
                  </a:r>
                </a:p>
                <a:p>
                  <a:pPr>
                    <a:lnSpc>
                      <a:spcPct val="95000"/>
                    </a:lnSpc>
                  </a:pPr>
                  <a:r>
                    <a:rPr lang="en-US" sz="1050" dirty="0" smtClean="0">
                      <a:latin typeface="Times New Roman" pitchFamily="18" charset="0"/>
                      <a:cs typeface="Times New Roman" pitchFamily="18" charset="0"/>
                    </a:rPr>
                    <a:t>CmaGSTU9</a:t>
                  </a:r>
                </a:p>
                <a:p>
                  <a:pPr>
                    <a:lnSpc>
                      <a:spcPct val="95000"/>
                    </a:lnSpc>
                  </a:pPr>
                  <a:r>
                    <a:rPr lang="en-US" sz="1050" dirty="0" smtClean="0">
                      <a:latin typeface="Times New Roman" pitchFamily="18" charset="0"/>
                      <a:cs typeface="Times New Roman" pitchFamily="18" charset="0"/>
                    </a:rPr>
                    <a:t>CmaGSTU10</a:t>
                  </a:r>
                </a:p>
                <a:p>
                  <a:pPr>
                    <a:lnSpc>
                      <a:spcPct val="95000"/>
                    </a:lnSpc>
                  </a:pPr>
                  <a:r>
                    <a:rPr lang="en-US" sz="1050" dirty="0" smtClean="0">
                      <a:latin typeface="Times New Roman" pitchFamily="18" charset="0"/>
                      <a:cs typeface="Times New Roman" pitchFamily="18" charset="0"/>
                    </a:rPr>
                    <a:t>CmaGSTU11</a:t>
                  </a:r>
                </a:p>
                <a:p>
                  <a:pPr>
                    <a:lnSpc>
                      <a:spcPct val="95000"/>
                    </a:lnSpc>
                  </a:pPr>
                  <a:r>
                    <a:rPr lang="en-US" sz="1050" dirty="0" smtClean="0">
                      <a:latin typeface="Times New Roman" pitchFamily="18" charset="0"/>
                      <a:cs typeface="Times New Roman" pitchFamily="18" charset="0"/>
                    </a:rPr>
                    <a:t>CmaGSTU12</a:t>
                  </a:r>
                </a:p>
                <a:p>
                  <a:pPr>
                    <a:lnSpc>
                      <a:spcPct val="95000"/>
                    </a:lnSpc>
                  </a:pPr>
                  <a:r>
                    <a:rPr lang="en-US" sz="1050" dirty="0" smtClean="0">
                      <a:latin typeface="Times New Roman" pitchFamily="18" charset="0"/>
                      <a:cs typeface="Times New Roman" pitchFamily="18" charset="0"/>
                    </a:rPr>
                    <a:t>CmaGSTU13</a:t>
                  </a:r>
                </a:p>
                <a:p>
                  <a:pPr>
                    <a:lnSpc>
                      <a:spcPct val="95000"/>
                    </a:lnSpc>
                  </a:pPr>
                  <a:r>
                    <a:rPr lang="en-US" sz="1050" dirty="0" smtClean="0">
                      <a:latin typeface="Times New Roman" pitchFamily="18" charset="0"/>
                      <a:cs typeface="Times New Roman" pitchFamily="18" charset="0"/>
                    </a:rPr>
                    <a:t>CmaGSTU14</a:t>
                  </a:r>
                </a:p>
                <a:p>
                  <a:pPr>
                    <a:lnSpc>
                      <a:spcPct val="95000"/>
                    </a:lnSpc>
                  </a:pPr>
                  <a:r>
                    <a:rPr lang="en-US" sz="1050" dirty="0" smtClean="0">
                      <a:latin typeface="Times New Roman" pitchFamily="18" charset="0"/>
                      <a:cs typeface="Times New Roman" pitchFamily="18" charset="0"/>
                    </a:rPr>
                    <a:t>CmaGSTU15</a:t>
                  </a:r>
                </a:p>
                <a:p>
                  <a:pPr>
                    <a:lnSpc>
                      <a:spcPct val="95000"/>
                    </a:lnSpc>
                  </a:pPr>
                  <a:r>
                    <a:rPr lang="en-US" sz="1050" dirty="0" smtClean="0">
                      <a:latin typeface="Times New Roman" pitchFamily="18" charset="0"/>
                      <a:cs typeface="Times New Roman" pitchFamily="18" charset="0"/>
                    </a:rPr>
                    <a:t>CmaGSTU16</a:t>
                  </a:r>
                </a:p>
                <a:p>
                  <a:r>
                    <a:rPr lang="en-US" sz="1050" dirty="0" smtClean="0">
                      <a:latin typeface="Times New Roman" pitchFamily="18" charset="0"/>
                      <a:cs typeface="Times New Roman" pitchFamily="18" charset="0"/>
                    </a:rPr>
                    <a:t>CmaGSTU17</a:t>
                  </a:r>
                </a:p>
                <a:p>
                  <a:r>
                    <a:rPr lang="en-US" sz="1050" dirty="0" smtClean="0">
                      <a:latin typeface="Times New Roman" pitchFamily="18" charset="0"/>
                      <a:cs typeface="Times New Roman" pitchFamily="18" charset="0"/>
                    </a:rPr>
                    <a:t>CmaGSTU18</a:t>
                  </a:r>
                </a:p>
                <a:p>
                  <a:r>
                    <a:rPr lang="en-US" sz="1050" dirty="0" smtClean="0">
                      <a:solidFill>
                        <a:srgbClr val="00B050"/>
                      </a:solidFill>
                      <a:latin typeface="Times New Roman" pitchFamily="18" charset="0"/>
                      <a:cs typeface="Times New Roman" pitchFamily="18" charset="0"/>
                    </a:rPr>
                    <a:t>CmaGSTF1</a:t>
                  </a:r>
                </a:p>
                <a:p>
                  <a:r>
                    <a:rPr lang="en-US" sz="1050" dirty="0" smtClean="0">
                      <a:solidFill>
                        <a:srgbClr val="00B050"/>
                      </a:solidFill>
                      <a:latin typeface="Times New Roman" pitchFamily="18" charset="0"/>
                      <a:cs typeface="Times New Roman" pitchFamily="18" charset="0"/>
                    </a:rPr>
                    <a:t>CmaGSTF2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sz="1050" dirty="0" smtClean="0">
                      <a:solidFill>
                        <a:srgbClr val="00B050"/>
                      </a:solidFill>
                      <a:latin typeface="Times New Roman" pitchFamily="18" charset="0"/>
                      <a:cs typeface="Times New Roman" pitchFamily="18" charset="0"/>
                    </a:rPr>
                    <a:t>CmaGSTF3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sz="1050" dirty="0" smtClean="0">
                      <a:solidFill>
                        <a:srgbClr val="00B0F0"/>
                      </a:solidFill>
                      <a:latin typeface="Times New Roman" pitchFamily="18" charset="0"/>
                      <a:cs typeface="Times New Roman" pitchFamily="18" charset="0"/>
                    </a:rPr>
                    <a:t>CmaEF1G1</a:t>
                  </a:r>
                </a:p>
                <a:p>
                  <a:pPr>
                    <a:lnSpc>
                      <a:spcPct val="96000"/>
                    </a:lnSpc>
                  </a:pPr>
                  <a:r>
                    <a:rPr lang="en-US" sz="1050" dirty="0" smtClean="0">
                      <a:solidFill>
                        <a:srgbClr val="00B0F0"/>
                      </a:solidFill>
                      <a:latin typeface="Times New Roman" pitchFamily="18" charset="0"/>
                      <a:cs typeface="Times New Roman" pitchFamily="18" charset="0"/>
                    </a:rPr>
                    <a:t>CmaEF1G2</a:t>
                  </a:r>
                </a:p>
                <a:p>
                  <a:pPr>
                    <a:lnSpc>
                      <a:spcPct val="96000"/>
                    </a:lnSpc>
                  </a:pPr>
                  <a:r>
                    <a:rPr lang="en-US" sz="1050" dirty="0" smtClean="0">
                      <a:solidFill>
                        <a:srgbClr val="00B0F0"/>
                      </a:solidFill>
                      <a:latin typeface="Times New Roman" pitchFamily="18" charset="0"/>
                      <a:cs typeface="Times New Roman" pitchFamily="18" charset="0"/>
                    </a:rPr>
                    <a:t>CmaEF1G3</a:t>
                  </a:r>
                </a:p>
                <a:p>
                  <a:r>
                    <a:rPr lang="en-US" sz="1050" dirty="0" smtClean="0">
                      <a:solidFill>
                        <a:srgbClr val="FF0000"/>
                      </a:solidFill>
                      <a:latin typeface="Times New Roman" pitchFamily="18" charset="0"/>
                      <a:cs typeface="Times New Roman" pitchFamily="18" charset="0"/>
                    </a:rPr>
                    <a:t>CmaGSTZ1</a:t>
                  </a:r>
                </a:p>
                <a:p>
                  <a:pPr>
                    <a:lnSpc>
                      <a:spcPct val="108000"/>
                    </a:lnSpc>
                  </a:pPr>
                  <a:r>
                    <a:rPr lang="en-US" sz="1050" dirty="0" smtClean="0">
                      <a:solidFill>
                        <a:srgbClr val="FF0000"/>
                      </a:solidFill>
                      <a:latin typeface="Times New Roman" pitchFamily="18" charset="0"/>
                      <a:cs typeface="Times New Roman" pitchFamily="18" charset="0"/>
                    </a:rPr>
                    <a:t>CmaGSTZ2</a:t>
                  </a:r>
                </a:p>
                <a:p>
                  <a:pPr>
                    <a:lnSpc>
                      <a:spcPct val="108000"/>
                    </a:lnSpc>
                  </a:pPr>
                  <a:r>
                    <a:rPr lang="en-US" sz="1050" dirty="0" smtClean="0">
                      <a:solidFill>
                        <a:srgbClr val="FF0000"/>
                      </a:solidFill>
                      <a:latin typeface="Times New Roman" pitchFamily="18" charset="0"/>
                      <a:cs typeface="Times New Roman" pitchFamily="18" charset="0"/>
                    </a:rPr>
                    <a:t>CmaGSTZ3</a:t>
                  </a:r>
                </a:p>
                <a:p>
                  <a:pPr>
                    <a:lnSpc>
                      <a:spcPct val="108000"/>
                    </a:lnSpc>
                  </a:pPr>
                  <a:r>
                    <a:rPr lang="en-US" sz="1050" dirty="0" smtClean="0">
                      <a:solidFill>
                        <a:srgbClr val="FF00FF"/>
                      </a:solidFill>
                      <a:latin typeface="Times New Roman" pitchFamily="18" charset="0"/>
                      <a:cs typeface="Times New Roman" pitchFamily="18" charset="0"/>
                    </a:rPr>
                    <a:t>CmaGHR1</a:t>
                  </a:r>
                </a:p>
                <a:p>
                  <a:pPr>
                    <a:lnSpc>
                      <a:spcPct val="108000"/>
                    </a:lnSpc>
                  </a:pPr>
                  <a:r>
                    <a:rPr lang="en-US" sz="1050" dirty="0" smtClean="0">
                      <a:solidFill>
                        <a:srgbClr val="FF00FF"/>
                      </a:solidFill>
                      <a:latin typeface="Times New Roman" pitchFamily="18" charset="0"/>
                      <a:cs typeface="Times New Roman" pitchFamily="18" charset="0"/>
                    </a:rPr>
                    <a:t>CmaGHR2</a:t>
                  </a:r>
                </a:p>
                <a:p>
                  <a:pPr>
                    <a:lnSpc>
                      <a:spcPct val="108000"/>
                    </a:lnSpc>
                  </a:pPr>
                  <a:r>
                    <a:rPr lang="en-US" sz="1050" dirty="0" smtClean="0">
                      <a:solidFill>
                        <a:schemeClr val="accent6">
                          <a:lumMod val="75000"/>
                        </a:schemeClr>
                      </a:solidFill>
                      <a:latin typeface="Times New Roman" pitchFamily="18" charset="0"/>
                      <a:cs typeface="Times New Roman" pitchFamily="18" charset="0"/>
                    </a:rPr>
                    <a:t>CmaGSTL1</a:t>
                  </a:r>
                </a:p>
                <a:p>
                  <a:pPr>
                    <a:lnSpc>
                      <a:spcPct val="108000"/>
                    </a:lnSpc>
                  </a:pPr>
                  <a:r>
                    <a:rPr lang="en-US" sz="1050" dirty="0" smtClean="0">
                      <a:solidFill>
                        <a:srgbClr val="0000FF"/>
                      </a:solidFill>
                      <a:latin typeface="Times New Roman" pitchFamily="18" charset="0"/>
                      <a:cs typeface="Times New Roman" pitchFamily="18" charset="0"/>
                    </a:rPr>
                    <a:t>CmaGSTT1</a:t>
                  </a:r>
                </a:p>
                <a:p>
                  <a:pPr>
                    <a:lnSpc>
                      <a:spcPct val="108000"/>
                    </a:lnSpc>
                  </a:pPr>
                  <a:r>
                    <a:rPr lang="en-US" sz="1050" dirty="0" smtClean="0">
                      <a:solidFill>
                        <a:srgbClr val="0000FF"/>
                      </a:solidFill>
                      <a:latin typeface="Times New Roman" pitchFamily="18" charset="0"/>
                      <a:cs typeface="Times New Roman" pitchFamily="18" charset="0"/>
                    </a:rPr>
                    <a:t>CmaGSTT2</a:t>
                  </a:r>
                  <a:endParaRPr lang="en-US" sz="1050" dirty="0">
                    <a:solidFill>
                      <a:srgbClr val="0000FF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pic>
            <p:nvPicPr>
              <p:cNvPr id="6" name="Picture 29"/>
              <p:cNvPicPr preferRelativeResize="0">
                <a:picLocks noChangeArrowheads="1"/>
              </p:cNvPicPr>
              <p:nvPr/>
            </p:nvPicPr>
            <p:blipFill>
              <a:blip r:embed="rId4"/>
              <a:srcRect t="8643"/>
              <a:stretch>
                <a:fillRect/>
              </a:stretch>
            </p:blipFill>
            <p:spPr bwMode="auto">
              <a:xfrm>
                <a:off x="1287780" y="5859405"/>
                <a:ext cx="6766560" cy="1984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cxnSp>
          <p:nvCxnSpPr>
            <p:cNvPr id="11" name="Straight Connector 10"/>
            <p:cNvCxnSpPr/>
            <p:nvPr/>
          </p:nvCxnSpPr>
          <p:spPr>
            <a:xfrm rot="5400000">
              <a:off x="183573" y="2095500"/>
              <a:ext cx="2667000" cy="158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1032141" y="1676400"/>
              <a:ext cx="457200" cy="215444"/>
            </a:xfrm>
            <a:prstGeom prst="rect">
              <a:avLst/>
            </a:prstGeom>
            <a:noFill/>
          </p:spPr>
          <p:txBody>
            <a:bodyPr wrap="square" lIns="0" tIns="0" rIns="91440" bIns="0" rtlCol="0">
              <a:spAutoFit/>
            </a:bodyPr>
            <a:lstStyle/>
            <a:p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Tau</a:t>
              </a:r>
              <a:endParaRPr 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3" name="Straight Connector 12"/>
            <p:cNvCxnSpPr/>
            <p:nvPr/>
          </p:nvCxnSpPr>
          <p:spPr>
            <a:xfrm rot="5400000">
              <a:off x="1289267" y="3712204"/>
              <a:ext cx="457200" cy="1588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1039074" y="3559918"/>
              <a:ext cx="457200" cy="215444"/>
            </a:xfrm>
            <a:prstGeom prst="rect">
              <a:avLst/>
            </a:prstGeom>
            <a:noFill/>
          </p:spPr>
          <p:txBody>
            <a:bodyPr wrap="square" lIns="0" tIns="0" rIns="91440" bIns="0" rtlCol="0">
              <a:spAutoFit/>
            </a:bodyPr>
            <a:lstStyle/>
            <a:p>
              <a:r>
                <a:rPr lang="en-US" sz="1400" dirty="0" smtClean="0">
                  <a:solidFill>
                    <a:srgbClr val="00B050"/>
                  </a:solidFill>
                  <a:latin typeface="Times New Roman" pitchFamily="18" charset="0"/>
                  <a:cs typeface="Times New Roman" pitchFamily="18" charset="0"/>
                </a:rPr>
                <a:t>Phi</a:t>
              </a:r>
              <a:endParaRPr lang="en-US" sz="1400" dirty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990600" y="4155646"/>
              <a:ext cx="588807" cy="215444"/>
            </a:xfrm>
            <a:prstGeom prst="rect">
              <a:avLst/>
            </a:prstGeom>
            <a:noFill/>
          </p:spPr>
          <p:txBody>
            <a:bodyPr wrap="square" lIns="0" tIns="0" rIns="91440" bIns="0" rtlCol="0">
              <a:spAutoFit/>
            </a:bodyPr>
            <a:lstStyle/>
            <a:p>
              <a:r>
                <a:rPr lang="en-US" sz="1400" dirty="0" smtClean="0">
                  <a:solidFill>
                    <a:srgbClr val="00B0F0"/>
                  </a:solidFill>
                  <a:latin typeface="Times New Roman" pitchFamily="18" charset="0"/>
                  <a:cs typeface="Times New Roman" pitchFamily="18" charset="0"/>
                </a:rPr>
                <a:t>EF1G</a:t>
              </a:r>
              <a:endParaRPr lang="en-US" sz="1400" dirty="0">
                <a:solidFill>
                  <a:srgbClr val="00B0F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6" name="Straight Connector 15"/>
            <p:cNvCxnSpPr/>
            <p:nvPr/>
          </p:nvCxnSpPr>
          <p:spPr>
            <a:xfrm rot="5400000">
              <a:off x="1312133" y="4243510"/>
              <a:ext cx="411480" cy="1588"/>
            </a:xfrm>
            <a:prstGeom prst="line">
              <a:avLst/>
            </a:prstGeom>
            <a:ln w="1905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 rot="5400000">
              <a:off x="1312139" y="4725685"/>
              <a:ext cx="411480" cy="1588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983679" y="4592053"/>
              <a:ext cx="588807" cy="215444"/>
            </a:xfrm>
            <a:prstGeom prst="rect">
              <a:avLst/>
            </a:prstGeom>
            <a:noFill/>
          </p:spPr>
          <p:txBody>
            <a:bodyPr wrap="square" lIns="0" tIns="0" rIns="91440" bIns="0" rtlCol="0">
              <a:spAutoFit/>
            </a:bodyPr>
            <a:lstStyle/>
            <a:p>
              <a:r>
                <a:rPr lang="en-US" sz="140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Zeta</a:t>
              </a:r>
              <a:endParaRPr lang="en-US" sz="1400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9" name="Straight Connector 18"/>
            <p:cNvCxnSpPr/>
            <p:nvPr/>
          </p:nvCxnSpPr>
          <p:spPr>
            <a:xfrm rot="5400000">
              <a:off x="1380725" y="5169724"/>
              <a:ext cx="274320" cy="1588"/>
            </a:xfrm>
            <a:prstGeom prst="line">
              <a:avLst/>
            </a:prstGeom>
            <a:ln w="19050">
              <a:solidFill>
                <a:srgbClr val="FF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>
              <a:off x="962905" y="5056168"/>
              <a:ext cx="484896" cy="215444"/>
            </a:xfrm>
            <a:prstGeom prst="rect">
              <a:avLst/>
            </a:prstGeom>
            <a:noFill/>
          </p:spPr>
          <p:txBody>
            <a:bodyPr wrap="square" lIns="0" tIns="0" rIns="91440" bIns="0" rtlCol="0">
              <a:spAutoFit/>
            </a:bodyPr>
            <a:lstStyle/>
            <a:p>
              <a:r>
                <a:rPr lang="en-US" sz="1400" dirty="0" smtClean="0">
                  <a:solidFill>
                    <a:srgbClr val="FF00FF"/>
                  </a:solidFill>
                  <a:latin typeface="Times New Roman" pitchFamily="18" charset="0"/>
                  <a:cs typeface="Times New Roman" pitchFamily="18" charset="0"/>
                </a:rPr>
                <a:t>GHR</a:t>
              </a:r>
              <a:endParaRPr lang="en-US" sz="1400" dirty="0">
                <a:solidFill>
                  <a:srgbClr val="FF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814842" y="5284765"/>
              <a:ext cx="741198" cy="215444"/>
            </a:xfrm>
            <a:prstGeom prst="rect">
              <a:avLst/>
            </a:prstGeom>
            <a:noFill/>
          </p:spPr>
          <p:txBody>
            <a:bodyPr wrap="square" lIns="0" tIns="0" rIns="91440" bIns="0" rtlCol="0">
              <a:spAutoFit/>
            </a:bodyPr>
            <a:lstStyle/>
            <a:p>
              <a:r>
                <a:rPr lang="en-US" sz="1400" dirty="0" smtClean="0">
                  <a:solidFill>
                    <a:schemeClr val="accent6">
                      <a:lumMod val="75000"/>
                    </a:schemeClr>
                  </a:solidFill>
                  <a:latin typeface="Times New Roman" pitchFamily="18" charset="0"/>
                  <a:cs typeface="Times New Roman" pitchFamily="18" charset="0"/>
                </a:rPr>
                <a:t>Lambda</a:t>
              </a:r>
              <a:endParaRPr lang="en-US" sz="1400" dirty="0">
                <a:solidFill>
                  <a:schemeClr val="accent6">
                    <a:lumMod val="75000"/>
                  </a:schemeClr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22" name="Straight Connector 21"/>
            <p:cNvCxnSpPr/>
            <p:nvPr/>
          </p:nvCxnSpPr>
          <p:spPr>
            <a:xfrm rot="5400000">
              <a:off x="1449305" y="5426698"/>
              <a:ext cx="137160" cy="1588"/>
            </a:xfrm>
            <a:prstGeom prst="line">
              <a:avLst/>
            </a:prstGeom>
            <a:ln w="1905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 rot="5400000">
              <a:off x="1380731" y="5675386"/>
              <a:ext cx="274320" cy="1588"/>
            </a:xfrm>
            <a:prstGeom prst="line">
              <a:avLst/>
            </a:prstGeom>
            <a:ln w="1905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928281" y="5541070"/>
              <a:ext cx="637281" cy="215444"/>
            </a:xfrm>
            <a:prstGeom prst="rect">
              <a:avLst/>
            </a:prstGeom>
            <a:noFill/>
          </p:spPr>
          <p:txBody>
            <a:bodyPr wrap="square" lIns="0" tIns="0" rIns="91440" bIns="0" rtlCol="0">
              <a:spAutoFit/>
            </a:bodyPr>
            <a:lstStyle/>
            <a:p>
              <a:r>
                <a:rPr lang="en-US" sz="1400" dirty="0" smtClean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rPr>
                <a:t>Theta</a:t>
              </a:r>
              <a:endParaRPr lang="en-US" sz="1400" dirty="0">
                <a:solidFill>
                  <a:srgbClr val="0000FF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26" name="Rectangle 25"/>
          <p:cNvSpPr/>
          <p:nvPr/>
        </p:nvSpPr>
        <p:spPr>
          <a:xfrm>
            <a:off x="381000" y="6211669"/>
            <a:ext cx="8305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ry Figure S2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enomic structures of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GST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enes of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maxim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Solid blue boxes and red lines indicat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exon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intron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respectively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30"/>
          <p:cNvGrpSpPr/>
          <p:nvPr/>
        </p:nvGrpSpPr>
        <p:grpSpPr>
          <a:xfrm>
            <a:off x="820078" y="-8763"/>
            <a:ext cx="7949907" cy="6104763"/>
            <a:chOff x="820078" y="-8763"/>
            <a:chExt cx="7949907" cy="6651498"/>
          </a:xfrm>
        </p:grpSpPr>
        <p:grpSp>
          <p:nvGrpSpPr>
            <p:cNvPr id="3" name="Group 128"/>
            <p:cNvGrpSpPr/>
            <p:nvPr/>
          </p:nvGrpSpPr>
          <p:grpSpPr>
            <a:xfrm>
              <a:off x="820078" y="975360"/>
              <a:ext cx="7949907" cy="5667375"/>
              <a:chOff x="820078" y="975360"/>
              <a:chExt cx="7949907" cy="5667378"/>
            </a:xfrm>
          </p:grpSpPr>
          <p:grpSp>
            <p:nvGrpSpPr>
              <p:cNvPr id="4" name="Group 123"/>
              <p:cNvGrpSpPr/>
              <p:nvPr/>
            </p:nvGrpSpPr>
            <p:grpSpPr>
              <a:xfrm>
                <a:off x="820078" y="975360"/>
                <a:ext cx="7949907" cy="5667378"/>
                <a:chOff x="820078" y="975354"/>
                <a:chExt cx="7949907" cy="5667345"/>
              </a:xfrm>
            </p:grpSpPr>
            <p:grpSp>
              <p:nvGrpSpPr>
                <p:cNvPr id="5" name="Group 119"/>
                <p:cNvGrpSpPr/>
                <p:nvPr/>
              </p:nvGrpSpPr>
              <p:grpSpPr>
                <a:xfrm>
                  <a:off x="820078" y="975354"/>
                  <a:ext cx="7949907" cy="5667345"/>
                  <a:chOff x="820078" y="975360"/>
                  <a:chExt cx="7949907" cy="5667375"/>
                </a:xfrm>
              </p:grpSpPr>
              <p:pic>
                <p:nvPicPr>
                  <p:cNvPr id="7" name="Picture 2"/>
                  <p:cNvPicPr preferRelativeResize="0">
                    <a:picLocks noChangeArrowheads="1"/>
                  </p:cNvPicPr>
                  <p:nvPr/>
                </p:nvPicPr>
                <p:blipFill>
                  <a:blip r:embed="rId3"/>
                  <a:srcRect l="9813" t="19390" r="1875" b="45613"/>
                  <a:stretch>
                    <a:fillRect/>
                  </a:stretch>
                </p:blipFill>
                <p:spPr bwMode="auto">
                  <a:xfrm>
                    <a:off x="2899829" y="1000758"/>
                    <a:ext cx="5852160" cy="31242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grpSp>
                <p:nvGrpSpPr>
                  <p:cNvPr id="6" name="Group 325"/>
                  <p:cNvGrpSpPr>
                    <a:grpSpLocks/>
                  </p:cNvGrpSpPr>
                  <p:nvPr/>
                </p:nvGrpSpPr>
                <p:grpSpPr bwMode="auto">
                  <a:xfrm>
                    <a:off x="820078" y="975360"/>
                    <a:ext cx="2076947" cy="5667375"/>
                    <a:chOff x="144" y="240"/>
                    <a:chExt cx="1833" cy="3570"/>
                  </a:xfrm>
                </p:grpSpPr>
                <p:sp>
                  <p:nvSpPr>
                    <p:cNvPr id="1348" name="AutoShape 324"/>
                    <p:cNvSpPr>
                      <a:spLocks noChangeAspect="1" noChangeArrowheads="1" noTextEdit="1"/>
                    </p:cNvSpPr>
                    <p:nvPr/>
                  </p:nvSpPr>
                  <p:spPr bwMode="auto">
                    <a:xfrm>
                      <a:off x="144" y="240"/>
                      <a:ext cx="1614" cy="3570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50" name="Rectangle 32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304"/>
                      <a:ext cx="525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U1</a:t>
                      </a:r>
                      <a:endParaRPr kumimoji="0" lang="en-US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51" name="Freeform 327"/>
                    <p:cNvSpPr>
                      <a:spLocks/>
                    </p:cNvSpPr>
                    <p:nvPr/>
                  </p:nvSpPr>
                  <p:spPr bwMode="auto">
                    <a:xfrm>
                      <a:off x="787" y="342"/>
                      <a:ext cx="612" cy="266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266"/>
                        </a:cxn>
                        <a:cxn ang="0">
                          <a:pos x="0" y="0"/>
                        </a:cxn>
                        <a:cxn ang="0">
                          <a:pos x="612" y="0"/>
                        </a:cxn>
                      </a:cxnLst>
                      <a:rect l="0" t="0" r="r" b="b"/>
                      <a:pathLst>
                        <a:path w="612" h="266">
                          <a:moveTo>
                            <a:pt x="0" y="266"/>
                          </a:moveTo>
                          <a:lnTo>
                            <a:pt x="0" y="0"/>
                          </a:lnTo>
                          <a:lnTo>
                            <a:pt x="61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52" name="Rectangle 32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413"/>
                      <a:ext cx="525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U2</a:t>
                      </a:r>
                      <a:endParaRPr kumimoji="0" lang="en-US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53" name="Freeform 329"/>
                    <p:cNvSpPr>
                      <a:spLocks/>
                    </p:cNvSpPr>
                    <p:nvPr/>
                  </p:nvSpPr>
                  <p:spPr bwMode="auto">
                    <a:xfrm>
                      <a:off x="1093" y="452"/>
                      <a:ext cx="306" cy="121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121"/>
                        </a:cxn>
                        <a:cxn ang="0">
                          <a:pos x="0" y="0"/>
                        </a:cxn>
                        <a:cxn ang="0">
                          <a:pos x="306" y="0"/>
                        </a:cxn>
                      </a:cxnLst>
                      <a:rect l="0" t="0" r="r" b="b"/>
                      <a:pathLst>
                        <a:path w="306" h="121">
                          <a:moveTo>
                            <a:pt x="0" y="121"/>
                          </a:moveTo>
                          <a:lnTo>
                            <a:pt x="0" y="0"/>
                          </a:lnTo>
                          <a:lnTo>
                            <a:pt x="306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54" name="Rectangle 33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523"/>
                      <a:ext cx="525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U7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55" name="Freeform 331"/>
                    <p:cNvSpPr>
                      <a:spLocks/>
                    </p:cNvSpPr>
                    <p:nvPr/>
                  </p:nvSpPr>
                  <p:spPr bwMode="auto">
                    <a:xfrm>
                      <a:off x="1297" y="562"/>
                      <a:ext cx="102" cy="52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52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52">
                          <a:moveTo>
                            <a:pt x="0" y="52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56" name="Rectangle 33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633"/>
                      <a:ext cx="525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U8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57" name="Freeform 333"/>
                    <p:cNvSpPr>
                      <a:spLocks/>
                    </p:cNvSpPr>
                    <p:nvPr/>
                  </p:nvSpPr>
                  <p:spPr bwMode="auto">
                    <a:xfrm>
                      <a:off x="1297" y="619"/>
                      <a:ext cx="102" cy="52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52"/>
                        </a:cxn>
                        <a:cxn ang="0">
                          <a:pos x="102" y="52"/>
                        </a:cxn>
                      </a:cxnLst>
                      <a:rect l="0" t="0" r="r" b="b"/>
                      <a:pathLst>
                        <a:path w="102" h="52">
                          <a:moveTo>
                            <a:pt x="0" y="0"/>
                          </a:moveTo>
                          <a:lnTo>
                            <a:pt x="0" y="52"/>
                          </a:lnTo>
                          <a:lnTo>
                            <a:pt x="102" y="52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58" name="Freeform 334"/>
                    <p:cNvSpPr>
                      <a:spLocks/>
                    </p:cNvSpPr>
                    <p:nvPr/>
                  </p:nvSpPr>
                  <p:spPr bwMode="auto">
                    <a:xfrm>
                      <a:off x="1195" y="616"/>
                      <a:ext cx="102" cy="81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81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81">
                          <a:moveTo>
                            <a:pt x="0" y="81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59" name="Rectangle 33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743"/>
                      <a:ext cx="525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U9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60" name="Freeform 336"/>
                    <p:cNvSpPr>
                      <a:spLocks/>
                    </p:cNvSpPr>
                    <p:nvPr/>
                  </p:nvSpPr>
                  <p:spPr bwMode="auto">
                    <a:xfrm>
                      <a:off x="1195" y="701"/>
                      <a:ext cx="204" cy="80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80"/>
                        </a:cxn>
                        <a:cxn ang="0">
                          <a:pos x="204" y="80"/>
                        </a:cxn>
                      </a:cxnLst>
                      <a:rect l="0" t="0" r="r" b="b"/>
                      <a:pathLst>
                        <a:path w="204" h="80">
                          <a:moveTo>
                            <a:pt x="0" y="0"/>
                          </a:moveTo>
                          <a:lnTo>
                            <a:pt x="0" y="80"/>
                          </a:lnTo>
                          <a:lnTo>
                            <a:pt x="204" y="8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61" name="Freeform 337"/>
                    <p:cNvSpPr>
                      <a:spLocks/>
                    </p:cNvSpPr>
                    <p:nvPr/>
                  </p:nvSpPr>
                  <p:spPr bwMode="auto">
                    <a:xfrm>
                      <a:off x="1093" y="578"/>
                      <a:ext cx="102" cy="121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121"/>
                        </a:cxn>
                        <a:cxn ang="0">
                          <a:pos x="102" y="121"/>
                        </a:cxn>
                      </a:cxnLst>
                      <a:rect l="0" t="0" r="r" b="b"/>
                      <a:pathLst>
                        <a:path w="102" h="121">
                          <a:moveTo>
                            <a:pt x="0" y="0"/>
                          </a:moveTo>
                          <a:lnTo>
                            <a:pt x="0" y="121"/>
                          </a:lnTo>
                          <a:lnTo>
                            <a:pt x="102" y="121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62" name="Freeform 338"/>
                    <p:cNvSpPr>
                      <a:spLocks/>
                    </p:cNvSpPr>
                    <p:nvPr/>
                  </p:nvSpPr>
                  <p:spPr bwMode="auto">
                    <a:xfrm>
                      <a:off x="889" y="575"/>
                      <a:ext cx="204" cy="303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303"/>
                        </a:cxn>
                        <a:cxn ang="0">
                          <a:pos x="0" y="0"/>
                        </a:cxn>
                        <a:cxn ang="0">
                          <a:pos x="204" y="0"/>
                        </a:cxn>
                      </a:cxnLst>
                      <a:rect l="0" t="0" r="r" b="b"/>
                      <a:pathLst>
                        <a:path w="204" h="303">
                          <a:moveTo>
                            <a:pt x="0" y="303"/>
                          </a:moveTo>
                          <a:lnTo>
                            <a:pt x="0" y="0"/>
                          </a:lnTo>
                          <a:lnTo>
                            <a:pt x="204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63" name="Rectangle 3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853"/>
                      <a:ext cx="525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U3</a:t>
                      </a:r>
                      <a:endParaRPr kumimoji="0" lang="en-US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64" name="Freeform 340"/>
                    <p:cNvSpPr>
                      <a:spLocks/>
                    </p:cNvSpPr>
                    <p:nvPr/>
                  </p:nvSpPr>
                  <p:spPr bwMode="auto">
                    <a:xfrm>
                      <a:off x="1093" y="891"/>
                      <a:ext cx="306" cy="94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94"/>
                        </a:cxn>
                        <a:cxn ang="0">
                          <a:pos x="0" y="0"/>
                        </a:cxn>
                        <a:cxn ang="0">
                          <a:pos x="306" y="0"/>
                        </a:cxn>
                      </a:cxnLst>
                      <a:rect l="0" t="0" r="r" b="b"/>
                      <a:pathLst>
                        <a:path w="306" h="94">
                          <a:moveTo>
                            <a:pt x="0" y="94"/>
                          </a:moveTo>
                          <a:lnTo>
                            <a:pt x="0" y="0"/>
                          </a:lnTo>
                          <a:lnTo>
                            <a:pt x="306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65" name="Rectangle 3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963"/>
                      <a:ext cx="525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U4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66" name="Freeform 342"/>
                    <p:cNvSpPr>
                      <a:spLocks/>
                    </p:cNvSpPr>
                    <p:nvPr/>
                  </p:nvSpPr>
                  <p:spPr bwMode="auto">
                    <a:xfrm>
                      <a:off x="1195" y="1001"/>
                      <a:ext cx="204" cy="80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80"/>
                        </a:cxn>
                        <a:cxn ang="0">
                          <a:pos x="0" y="0"/>
                        </a:cxn>
                        <a:cxn ang="0">
                          <a:pos x="204" y="0"/>
                        </a:cxn>
                      </a:cxnLst>
                      <a:rect l="0" t="0" r="r" b="b"/>
                      <a:pathLst>
                        <a:path w="204" h="80">
                          <a:moveTo>
                            <a:pt x="0" y="80"/>
                          </a:moveTo>
                          <a:lnTo>
                            <a:pt x="0" y="0"/>
                          </a:lnTo>
                          <a:lnTo>
                            <a:pt x="204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67" name="Rectangle 3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1072"/>
                      <a:ext cx="525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U5</a:t>
                      </a:r>
                      <a:endParaRPr kumimoji="0" lang="en-US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68" name="Freeform 344"/>
                    <p:cNvSpPr>
                      <a:spLocks/>
                    </p:cNvSpPr>
                    <p:nvPr/>
                  </p:nvSpPr>
                  <p:spPr bwMode="auto">
                    <a:xfrm>
                      <a:off x="1297" y="1111"/>
                      <a:ext cx="102" cy="52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52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52">
                          <a:moveTo>
                            <a:pt x="0" y="52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69" name="Rectangle 34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1182"/>
                      <a:ext cx="525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U6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70" name="Freeform 346"/>
                    <p:cNvSpPr>
                      <a:spLocks/>
                    </p:cNvSpPr>
                    <p:nvPr/>
                  </p:nvSpPr>
                  <p:spPr bwMode="auto">
                    <a:xfrm>
                      <a:off x="1297" y="1168"/>
                      <a:ext cx="102" cy="53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53"/>
                        </a:cxn>
                        <a:cxn ang="0">
                          <a:pos x="102" y="53"/>
                        </a:cxn>
                      </a:cxnLst>
                      <a:rect l="0" t="0" r="r" b="b"/>
                      <a:pathLst>
                        <a:path w="102" h="53">
                          <a:moveTo>
                            <a:pt x="0" y="0"/>
                          </a:moveTo>
                          <a:lnTo>
                            <a:pt x="0" y="53"/>
                          </a:lnTo>
                          <a:lnTo>
                            <a:pt x="102" y="53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71" name="Freeform 347"/>
                    <p:cNvSpPr>
                      <a:spLocks/>
                    </p:cNvSpPr>
                    <p:nvPr/>
                  </p:nvSpPr>
                  <p:spPr bwMode="auto">
                    <a:xfrm>
                      <a:off x="1195" y="1086"/>
                      <a:ext cx="102" cy="80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80"/>
                        </a:cxn>
                        <a:cxn ang="0">
                          <a:pos x="102" y="80"/>
                        </a:cxn>
                      </a:cxnLst>
                      <a:rect l="0" t="0" r="r" b="b"/>
                      <a:pathLst>
                        <a:path w="102" h="80">
                          <a:moveTo>
                            <a:pt x="0" y="0"/>
                          </a:moveTo>
                          <a:lnTo>
                            <a:pt x="0" y="80"/>
                          </a:lnTo>
                          <a:lnTo>
                            <a:pt x="102" y="8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72" name="Freeform 348"/>
                    <p:cNvSpPr>
                      <a:spLocks/>
                    </p:cNvSpPr>
                    <p:nvPr/>
                  </p:nvSpPr>
                  <p:spPr bwMode="auto">
                    <a:xfrm>
                      <a:off x="1093" y="989"/>
                      <a:ext cx="102" cy="94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94"/>
                        </a:cxn>
                        <a:cxn ang="0">
                          <a:pos x="102" y="94"/>
                        </a:cxn>
                      </a:cxnLst>
                      <a:rect l="0" t="0" r="r" b="b"/>
                      <a:pathLst>
                        <a:path w="102" h="94">
                          <a:moveTo>
                            <a:pt x="0" y="0"/>
                          </a:moveTo>
                          <a:lnTo>
                            <a:pt x="0" y="94"/>
                          </a:lnTo>
                          <a:lnTo>
                            <a:pt x="102" y="94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73" name="Freeform 349"/>
                    <p:cNvSpPr>
                      <a:spLocks/>
                    </p:cNvSpPr>
                    <p:nvPr/>
                  </p:nvSpPr>
                  <p:spPr bwMode="auto">
                    <a:xfrm>
                      <a:off x="991" y="987"/>
                      <a:ext cx="102" cy="197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197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197">
                          <a:moveTo>
                            <a:pt x="0" y="197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74" name="Rectangle 3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1292"/>
                      <a:ext cx="576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U10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75" name="Freeform 351"/>
                    <p:cNvSpPr>
                      <a:spLocks/>
                    </p:cNvSpPr>
                    <p:nvPr/>
                  </p:nvSpPr>
                  <p:spPr bwMode="auto">
                    <a:xfrm>
                      <a:off x="1297" y="1330"/>
                      <a:ext cx="102" cy="53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53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53">
                          <a:moveTo>
                            <a:pt x="0" y="53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76" name="Rectangle 3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1402"/>
                      <a:ext cx="576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U11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77" name="Freeform 353"/>
                    <p:cNvSpPr>
                      <a:spLocks/>
                    </p:cNvSpPr>
                    <p:nvPr/>
                  </p:nvSpPr>
                  <p:spPr bwMode="auto">
                    <a:xfrm>
                      <a:off x="1297" y="1388"/>
                      <a:ext cx="102" cy="52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52"/>
                        </a:cxn>
                        <a:cxn ang="0">
                          <a:pos x="102" y="52"/>
                        </a:cxn>
                      </a:cxnLst>
                      <a:rect l="0" t="0" r="r" b="b"/>
                      <a:pathLst>
                        <a:path w="102" h="52">
                          <a:moveTo>
                            <a:pt x="0" y="0"/>
                          </a:moveTo>
                          <a:lnTo>
                            <a:pt x="0" y="52"/>
                          </a:lnTo>
                          <a:lnTo>
                            <a:pt x="102" y="52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78" name="Freeform 354"/>
                    <p:cNvSpPr>
                      <a:spLocks/>
                    </p:cNvSpPr>
                    <p:nvPr/>
                  </p:nvSpPr>
                  <p:spPr bwMode="auto">
                    <a:xfrm>
                      <a:off x="991" y="1189"/>
                      <a:ext cx="306" cy="196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196"/>
                        </a:cxn>
                        <a:cxn ang="0">
                          <a:pos x="306" y="196"/>
                        </a:cxn>
                      </a:cxnLst>
                      <a:rect l="0" t="0" r="r" b="b"/>
                      <a:pathLst>
                        <a:path w="306" h="196">
                          <a:moveTo>
                            <a:pt x="0" y="0"/>
                          </a:moveTo>
                          <a:lnTo>
                            <a:pt x="0" y="196"/>
                          </a:lnTo>
                          <a:lnTo>
                            <a:pt x="306" y="196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79" name="Freeform 355"/>
                    <p:cNvSpPr>
                      <a:spLocks/>
                    </p:cNvSpPr>
                    <p:nvPr/>
                  </p:nvSpPr>
                  <p:spPr bwMode="auto">
                    <a:xfrm>
                      <a:off x="889" y="883"/>
                      <a:ext cx="102" cy="303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303"/>
                        </a:cxn>
                        <a:cxn ang="0">
                          <a:pos x="102" y="303"/>
                        </a:cxn>
                      </a:cxnLst>
                      <a:rect l="0" t="0" r="r" b="b"/>
                      <a:pathLst>
                        <a:path w="102" h="303">
                          <a:moveTo>
                            <a:pt x="0" y="0"/>
                          </a:moveTo>
                          <a:lnTo>
                            <a:pt x="0" y="303"/>
                          </a:lnTo>
                          <a:lnTo>
                            <a:pt x="102" y="303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80" name="Freeform 356"/>
                    <p:cNvSpPr>
                      <a:spLocks/>
                    </p:cNvSpPr>
                    <p:nvPr/>
                  </p:nvSpPr>
                  <p:spPr bwMode="auto">
                    <a:xfrm>
                      <a:off x="787" y="613"/>
                      <a:ext cx="102" cy="268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268"/>
                        </a:cxn>
                        <a:cxn ang="0">
                          <a:pos x="102" y="268"/>
                        </a:cxn>
                      </a:cxnLst>
                      <a:rect l="0" t="0" r="r" b="b"/>
                      <a:pathLst>
                        <a:path w="102" h="268">
                          <a:moveTo>
                            <a:pt x="0" y="0"/>
                          </a:moveTo>
                          <a:lnTo>
                            <a:pt x="0" y="268"/>
                          </a:lnTo>
                          <a:lnTo>
                            <a:pt x="102" y="268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81" name="Freeform 357"/>
                    <p:cNvSpPr>
                      <a:spLocks/>
                    </p:cNvSpPr>
                    <p:nvPr/>
                  </p:nvSpPr>
                  <p:spPr bwMode="auto">
                    <a:xfrm>
                      <a:off x="685" y="611"/>
                      <a:ext cx="102" cy="738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738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738">
                          <a:moveTo>
                            <a:pt x="0" y="738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82" name="Rectangle 35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1512"/>
                      <a:ext cx="576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U12</a:t>
                      </a:r>
                      <a:endParaRPr kumimoji="0" lang="en-US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83" name="Freeform 359"/>
                    <p:cNvSpPr>
                      <a:spLocks/>
                    </p:cNvSpPr>
                    <p:nvPr/>
                  </p:nvSpPr>
                  <p:spPr bwMode="auto">
                    <a:xfrm>
                      <a:off x="1297" y="1550"/>
                      <a:ext cx="102" cy="53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53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53">
                          <a:moveTo>
                            <a:pt x="0" y="53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84" name="Rectangle 36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1622"/>
                      <a:ext cx="576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U14</a:t>
                      </a:r>
                      <a:endParaRPr kumimoji="0" lang="en-US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85" name="Freeform 361"/>
                    <p:cNvSpPr>
                      <a:spLocks/>
                    </p:cNvSpPr>
                    <p:nvPr/>
                  </p:nvSpPr>
                  <p:spPr bwMode="auto">
                    <a:xfrm>
                      <a:off x="1297" y="1607"/>
                      <a:ext cx="102" cy="53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53"/>
                        </a:cxn>
                        <a:cxn ang="0">
                          <a:pos x="102" y="53"/>
                        </a:cxn>
                      </a:cxnLst>
                      <a:rect l="0" t="0" r="r" b="b"/>
                      <a:pathLst>
                        <a:path w="102" h="53">
                          <a:moveTo>
                            <a:pt x="0" y="0"/>
                          </a:moveTo>
                          <a:lnTo>
                            <a:pt x="0" y="53"/>
                          </a:lnTo>
                          <a:lnTo>
                            <a:pt x="102" y="53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86" name="Freeform 362"/>
                    <p:cNvSpPr>
                      <a:spLocks/>
                    </p:cNvSpPr>
                    <p:nvPr/>
                  </p:nvSpPr>
                  <p:spPr bwMode="auto">
                    <a:xfrm>
                      <a:off x="1195" y="1605"/>
                      <a:ext cx="102" cy="108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108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108">
                          <a:moveTo>
                            <a:pt x="0" y="108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87" name="Rectangle 36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1732"/>
                      <a:ext cx="576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U13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88" name="Freeform 364"/>
                    <p:cNvSpPr>
                      <a:spLocks/>
                    </p:cNvSpPr>
                    <p:nvPr/>
                  </p:nvSpPr>
                  <p:spPr bwMode="auto">
                    <a:xfrm>
                      <a:off x="1297" y="1770"/>
                      <a:ext cx="102" cy="52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52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52">
                          <a:moveTo>
                            <a:pt x="0" y="52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89" name="Rectangle 36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1841"/>
                      <a:ext cx="576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U15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90" name="Freeform 366"/>
                    <p:cNvSpPr>
                      <a:spLocks/>
                    </p:cNvSpPr>
                    <p:nvPr/>
                  </p:nvSpPr>
                  <p:spPr bwMode="auto">
                    <a:xfrm>
                      <a:off x="1297" y="1827"/>
                      <a:ext cx="102" cy="53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53"/>
                        </a:cxn>
                        <a:cxn ang="0">
                          <a:pos x="102" y="53"/>
                        </a:cxn>
                      </a:cxnLst>
                      <a:rect l="0" t="0" r="r" b="b"/>
                      <a:pathLst>
                        <a:path w="102" h="53">
                          <a:moveTo>
                            <a:pt x="0" y="0"/>
                          </a:moveTo>
                          <a:lnTo>
                            <a:pt x="0" y="53"/>
                          </a:lnTo>
                          <a:lnTo>
                            <a:pt x="102" y="53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91" name="Freeform 367"/>
                    <p:cNvSpPr>
                      <a:spLocks/>
                    </p:cNvSpPr>
                    <p:nvPr/>
                  </p:nvSpPr>
                  <p:spPr bwMode="auto">
                    <a:xfrm>
                      <a:off x="1195" y="1717"/>
                      <a:ext cx="102" cy="108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108"/>
                        </a:cxn>
                        <a:cxn ang="0">
                          <a:pos x="102" y="108"/>
                        </a:cxn>
                      </a:cxnLst>
                      <a:rect l="0" t="0" r="r" b="b"/>
                      <a:pathLst>
                        <a:path w="102" h="108">
                          <a:moveTo>
                            <a:pt x="0" y="0"/>
                          </a:moveTo>
                          <a:lnTo>
                            <a:pt x="0" y="108"/>
                          </a:lnTo>
                          <a:lnTo>
                            <a:pt x="102" y="108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92" name="Freeform 368"/>
                    <p:cNvSpPr>
                      <a:spLocks/>
                    </p:cNvSpPr>
                    <p:nvPr/>
                  </p:nvSpPr>
                  <p:spPr bwMode="auto">
                    <a:xfrm>
                      <a:off x="1093" y="1715"/>
                      <a:ext cx="102" cy="135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135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135">
                          <a:moveTo>
                            <a:pt x="0" y="135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93" name="Rectangle 36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1951"/>
                      <a:ext cx="576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U16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94" name="Freeform 370"/>
                    <p:cNvSpPr>
                      <a:spLocks/>
                    </p:cNvSpPr>
                    <p:nvPr/>
                  </p:nvSpPr>
                  <p:spPr bwMode="auto">
                    <a:xfrm>
                      <a:off x="1093" y="1854"/>
                      <a:ext cx="306" cy="136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136"/>
                        </a:cxn>
                        <a:cxn ang="0">
                          <a:pos x="306" y="136"/>
                        </a:cxn>
                      </a:cxnLst>
                      <a:rect l="0" t="0" r="r" b="b"/>
                      <a:pathLst>
                        <a:path w="306" h="136">
                          <a:moveTo>
                            <a:pt x="0" y="0"/>
                          </a:moveTo>
                          <a:lnTo>
                            <a:pt x="0" y="136"/>
                          </a:lnTo>
                          <a:lnTo>
                            <a:pt x="306" y="136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95" name="Freeform 371"/>
                    <p:cNvSpPr>
                      <a:spLocks/>
                    </p:cNvSpPr>
                    <p:nvPr/>
                  </p:nvSpPr>
                  <p:spPr bwMode="auto">
                    <a:xfrm>
                      <a:off x="991" y="1852"/>
                      <a:ext cx="102" cy="121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121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121">
                          <a:moveTo>
                            <a:pt x="0" y="121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96" name="Rectangle 37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2061"/>
                      <a:ext cx="576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U17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97" name="Freeform 373"/>
                    <p:cNvSpPr>
                      <a:spLocks/>
                    </p:cNvSpPr>
                    <p:nvPr/>
                  </p:nvSpPr>
                  <p:spPr bwMode="auto">
                    <a:xfrm>
                      <a:off x="991" y="1978"/>
                      <a:ext cx="408" cy="121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121"/>
                        </a:cxn>
                        <a:cxn ang="0">
                          <a:pos x="408" y="121"/>
                        </a:cxn>
                      </a:cxnLst>
                      <a:rect l="0" t="0" r="r" b="b"/>
                      <a:pathLst>
                        <a:path w="408" h="121">
                          <a:moveTo>
                            <a:pt x="0" y="0"/>
                          </a:moveTo>
                          <a:lnTo>
                            <a:pt x="0" y="121"/>
                          </a:lnTo>
                          <a:lnTo>
                            <a:pt x="408" y="121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98" name="Freeform 374"/>
                    <p:cNvSpPr>
                      <a:spLocks/>
                    </p:cNvSpPr>
                    <p:nvPr/>
                  </p:nvSpPr>
                  <p:spPr bwMode="auto">
                    <a:xfrm>
                      <a:off x="889" y="1976"/>
                      <a:ext cx="102" cy="114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114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114">
                          <a:moveTo>
                            <a:pt x="0" y="114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399" name="Rectangle 37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2171"/>
                      <a:ext cx="576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U18</a:t>
                      </a:r>
                      <a:endParaRPr kumimoji="0" lang="en-US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00" name="Freeform 376"/>
                    <p:cNvSpPr>
                      <a:spLocks/>
                    </p:cNvSpPr>
                    <p:nvPr/>
                  </p:nvSpPr>
                  <p:spPr bwMode="auto">
                    <a:xfrm>
                      <a:off x="889" y="2095"/>
                      <a:ext cx="510" cy="114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114"/>
                        </a:cxn>
                        <a:cxn ang="0">
                          <a:pos x="510" y="114"/>
                        </a:cxn>
                      </a:cxnLst>
                      <a:rect l="0" t="0" r="r" b="b"/>
                      <a:pathLst>
                        <a:path w="510" h="114">
                          <a:moveTo>
                            <a:pt x="0" y="0"/>
                          </a:moveTo>
                          <a:lnTo>
                            <a:pt x="0" y="114"/>
                          </a:lnTo>
                          <a:lnTo>
                            <a:pt x="510" y="114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01" name="Freeform 377"/>
                    <p:cNvSpPr>
                      <a:spLocks/>
                    </p:cNvSpPr>
                    <p:nvPr/>
                  </p:nvSpPr>
                  <p:spPr bwMode="auto">
                    <a:xfrm>
                      <a:off x="685" y="1353"/>
                      <a:ext cx="204" cy="739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739"/>
                        </a:cxn>
                        <a:cxn ang="0">
                          <a:pos x="204" y="739"/>
                        </a:cxn>
                      </a:cxnLst>
                      <a:rect l="0" t="0" r="r" b="b"/>
                      <a:pathLst>
                        <a:path w="204" h="739">
                          <a:moveTo>
                            <a:pt x="0" y="0"/>
                          </a:moveTo>
                          <a:lnTo>
                            <a:pt x="0" y="739"/>
                          </a:lnTo>
                          <a:lnTo>
                            <a:pt x="204" y="739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03" name="Freeform 379"/>
                    <p:cNvSpPr>
                      <a:spLocks/>
                    </p:cNvSpPr>
                    <p:nvPr/>
                  </p:nvSpPr>
                  <p:spPr bwMode="auto">
                    <a:xfrm>
                      <a:off x="583" y="1351"/>
                      <a:ext cx="102" cy="482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482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482">
                          <a:moveTo>
                            <a:pt x="0" y="482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90933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06" name="Freeform 382"/>
                    <p:cNvSpPr>
                      <a:spLocks/>
                    </p:cNvSpPr>
                    <p:nvPr/>
                  </p:nvSpPr>
                  <p:spPr bwMode="auto">
                    <a:xfrm>
                      <a:off x="583" y="1837"/>
                      <a:ext cx="816" cy="482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482"/>
                        </a:cxn>
                        <a:cxn ang="0">
                          <a:pos x="816" y="482"/>
                        </a:cxn>
                      </a:cxnLst>
                      <a:rect l="0" t="0" r="r" b="b"/>
                      <a:pathLst>
                        <a:path w="816" h="482">
                          <a:moveTo>
                            <a:pt x="0" y="0"/>
                          </a:moveTo>
                          <a:lnTo>
                            <a:pt x="0" y="482"/>
                          </a:lnTo>
                          <a:lnTo>
                            <a:pt x="816" y="482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00FFFF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07" name="Freeform 383"/>
                    <p:cNvSpPr>
                      <a:spLocks/>
                    </p:cNvSpPr>
                    <p:nvPr/>
                  </p:nvSpPr>
                  <p:spPr bwMode="auto">
                    <a:xfrm>
                      <a:off x="481" y="1835"/>
                      <a:ext cx="102" cy="322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322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322">
                          <a:moveTo>
                            <a:pt x="0" y="322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08" name="Rectangle 38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2391"/>
                      <a:ext cx="474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HR1</a:t>
                      </a:r>
                      <a:endParaRPr kumimoji="0" lang="en-US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09" name="Freeform 385"/>
                    <p:cNvSpPr>
                      <a:spLocks/>
                    </p:cNvSpPr>
                    <p:nvPr/>
                  </p:nvSpPr>
                  <p:spPr bwMode="auto">
                    <a:xfrm>
                      <a:off x="1297" y="2429"/>
                      <a:ext cx="102" cy="53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53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53">
                          <a:moveTo>
                            <a:pt x="0" y="53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00FF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10" name="Rectangle 38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2500"/>
                      <a:ext cx="474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HR2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11" name="Freeform 387"/>
                    <p:cNvSpPr>
                      <a:spLocks/>
                    </p:cNvSpPr>
                    <p:nvPr/>
                  </p:nvSpPr>
                  <p:spPr bwMode="auto">
                    <a:xfrm>
                      <a:off x="1297" y="2486"/>
                      <a:ext cx="102" cy="53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53"/>
                        </a:cxn>
                        <a:cxn ang="0">
                          <a:pos x="102" y="53"/>
                        </a:cxn>
                      </a:cxnLst>
                      <a:rect l="0" t="0" r="r" b="b"/>
                      <a:pathLst>
                        <a:path w="102" h="53">
                          <a:moveTo>
                            <a:pt x="0" y="0"/>
                          </a:moveTo>
                          <a:lnTo>
                            <a:pt x="0" y="53"/>
                          </a:lnTo>
                          <a:lnTo>
                            <a:pt x="102" y="53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00FF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13" name="Freeform 389"/>
                    <p:cNvSpPr>
                      <a:spLocks/>
                    </p:cNvSpPr>
                    <p:nvPr/>
                  </p:nvSpPr>
                  <p:spPr bwMode="auto">
                    <a:xfrm>
                      <a:off x="481" y="2161"/>
                      <a:ext cx="816" cy="323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323"/>
                        </a:cxn>
                        <a:cxn ang="0">
                          <a:pos x="816" y="323"/>
                        </a:cxn>
                      </a:cxnLst>
                      <a:rect l="0" t="0" r="r" b="b"/>
                      <a:pathLst>
                        <a:path w="816" h="323">
                          <a:moveTo>
                            <a:pt x="0" y="0"/>
                          </a:moveTo>
                          <a:lnTo>
                            <a:pt x="0" y="323"/>
                          </a:lnTo>
                          <a:lnTo>
                            <a:pt x="816" y="323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00FF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14" name="Freeform 390"/>
                    <p:cNvSpPr>
                      <a:spLocks/>
                    </p:cNvSpPr>
                    <p:nvPr/>
                  </p:nvSpPr>
                  <p:spPr bwMode="auto">
                    <a:xfrm>
                      <a:off x="379" y="2159"/>
                      <a:ext cx="102" cy="311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311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311">
                          <a:moveTo>
                            <a:pt x="0" y="311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15" name="Rectangle 39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2610"/>
                      <a:ext cx="515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Z1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16" name="Freeform 392"/>
                    <p:cNvSpPr>
                      <a:spLocks/>
                    </p:cNvSpPr>
                    <p:nvPr/>
                  </p:nvSpPr>
                  <p:spPr bwMode="auto">
                    <a:xfrm>
                      <a:off x="1297" y="2649"/>
                      <a:ext cx="102" cy="52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52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52">
                          <a:moveTo>
                            <a:pt x="0" y="52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0000FF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17" name="Rectangle 39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2720"/>
                      <a:ext cx="515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Z2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18" name="Freeform 394"/>
                    <p:cNvSpPr>
                      <a:spLocks/>
                    </p:cNvSpPr>
                    <p:nvPr/>
                  </p:nvSpPr>
                  <p:spPr bwMode="auto">
                    <a:xfrm>
                      <a:off x="1297" y="2706"/>
                      <a:ext cx="102" cy="52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52"/>
                        </a:cxn>
                        <a:cxn ang="0">
                          <a:pos x="102" y="52"/>
                        </a:cxn>
                      </a:cxnLst>
                      <a:rect l="0" t="0" r="r" b="b"/>
                      <a:pathLst>
                        <a:path w="102" h="52">
                          <a:moveTo>
                            <a:pt x="0" y="0"/>
                          </a:moveTo>
                          <a:lnTo>
                            <a:pt x="0" y="52"/>
                          </a:lnTo>
                          <a:lnTo>
                            <a:pt x="102" y="52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0000FF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19" name="Freeform 395"/>
                    <p:cNvSpPr>
                      <a:spLocks/>
                    </p:cNvSpPr>
                    <p:nvPr/>
                  </p:nvSpPr>
                  <p:spPr bwMode="auto">
                    <a:xfrm>
                      <a:off x="1195" y="2703"/>
                      <a:ext cx="102" cy="81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81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81">
                          <a:moveTo>
                            <a:pt x="0" y="81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0000FF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20" name="Rectangle 39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2830"/>
                      <a:ext cx="515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Z3</a:t>
                      </a:r>
                      <a:endParaRPr kumimoji="0" lang="en-US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21" name="Freeform 397"/>
                    <p:cNvSpPr>
                      <a:spLocks/>
                    </p:cNvSpPr>
                    <p:nvPr/>
                  </p:nvSpPr>
                  <p:spPr bwMode="auto">
                    <a:xfrm>
                      <a:off x="1195" y="2788"/>
                      <a:ext cx="204" cy="80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80"/>
                        </a:cxn>
                        <a:cxn ang="0">
                          <a:pos x="204" y="80"/>
                        </a:cxn>
                      </a:cxnLst>
                      <a:rect l="0" t="0" r="r" b="b"/>
                      <a:pathLst>
                        <a:path w="204" h="80">
                          <a:moveTo>
                            <a:pt x="0" y="0"/>
                          </a:moveTo>
                          <a:lnTo>
                            <a:pt x="0" y="80"/>
                          </a:lnTo>
                          <a:lnTo>
                            <a:pt x="204" y="8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0000FF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23" name="Freeform 399"/>
                    <p:cNvSpPr>
                      <a:spLocks/>
                    </p:cNvSpPr>
                    <p:nvPr/>
                  </p:nvSpPr>
                  <p:spPr bwMode="auto">
                    <a:xfrm>
                      <a:off x="379" y="2475"/>
                      <a:ext cx="816" cy="311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311"/>
                        </a:cxn>
                        <a:cxn ang="0">
                          <a:pos x="816" y="311"/>
                        </a:cxn>
                      </a:cxnLst>
                      <a:rect l="0" t="0" r="r" b="b"/>
                      <a:pathLst>
                        <a:path w="816" h="311">
                          <a:moveTo>
                            <a:pt x="0" y="0"/>
                          </a:moveTo>
                          <a:lnTo>
                            <a:pt x="0" y="311"/>
                          </a:lnTo>
                          <a:lnTo>
                            <a:pt x="816" y="311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0000FF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24" name="Freeform 400"/>
                    <p:cNvSpPr>
                      <a:spLocks/>
                    </p:cNvSpPr>
                    <p:nvPr/>
                  </p:nvSpPr>
                  <p:spPr bwMode="auto">
                    <a:xfrm>
                      <a:off x="277" y="2472"/>
                      <a:ext cx="102" cy="278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278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278">
                          <a:moveTo>
                            <a:pt x="0" y="278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25" name="Rectangle 40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2940"/>
                      <a:ext cx="515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T1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26" name="Freeform 402"/>
                    <p:cNvSpPr>
                      <a:spLocks/>
                    </p:cNvSpPr>
                    <p:nvPr/>
                  </p:nvSpPr>
                  <p:spPr bwMode="auto">
                    <a:xfrm>
                      <a:off x="1297" y="2978"/>
                      <a:ext cx="102" cy="53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53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53">
                          <a:moveTo>
                            <a:pt x="0" y="53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F00FF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27" name="Rectangle 40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3050"/>
                      <a:ext cx="515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T2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28" name="Freeform 404"/>
                    <p:cNvSpPr>
                      <a:spLocks/>
                    </p:cNvSpPr>
                    <p:nvPr/>
                  </p:nvSpPr>
                  <p:spPr bwMode="auto">
                    <a:xfrm>
                      <a:off x="1297" y="3035"/>
                      <a:ext cx="102" cy="53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53"/>
                        </a:cxn>
                        <a:cxn ang="0">
                          <a:pos x="102" y="53"/>
                        </a:cxn>
                      </a:cxnLst>
                      <a:rect l="0" t="0" r="r" b="b"/>
                      <a:pathLst>
                        <a:path w="102" h="53">
                          <a:moveTo>
                            <a:pt x="0" y="0"/>
                          </a:moveTo>
                          <a:lnTo>
                            <a:pt x="0" y="53"/>
                          </a:lnTo>
                          <a:lnTo>
                            <a:pt x="102" y="53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F00FF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30" name="Freeform 406"/>
                    <p:cNvSpPr>
                      <a:spLocks/>
                    </p:cNvSpPr>
                    <p:nvPr/>
                  </p:nvSpPr>
                  <p:spPr bwMode="auto">
                    <a:xfrm>
                      <a:off x="277" y="2755"/>
                      <a:ext cx="1020" cy="278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278"/>
                        </a:cxn>
                        <a:cxn ang="0">
                          <a:pos x="1020" y="278"/>
                        </a:cxn>
                      </a:cxnLst>
                      <a:rect l="0" t="0" r="r" b="b"/>
                      <a:pathLst>
                        <a:path w="1020" h="278">
                          <a:moveTo>
                            <a:pt x="0" y="0"/>
                          </a:moveTo>
                          <a:lnTo>
                            <a:pt x="0" y="278"/>
                          </a:lnTo>
                          <a:lnTo>
                            <a:pt x="1020" y="278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F00FF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31" name="Freeform 407"/>
                    <p:cNvSpPr>
                      <a:spLocks/>
                    </p:cNvSpPr>
                    <p:nvPr/>
                  </p:nvSpPr>
                  <p:spPr bwMode="auto">
                    <a:xfrm>
                      <a:off x="175" y="2753"/>
                      <a:ext cx="102" cy="288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288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288">
                          <a:moveTo>
                            <a:pt x="0" y="288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32" name="Rectangle 40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3160"/>
                      <a:ext cx="515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F1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33" name="Freeform 409"/>
                    <p:cNvSpPr>
                      <a:spLocks/>
                    </p:cNvSpPr>
                    <p:nvPr/>
                  </p:nvSpPr>
                  <p:spPr bwMode="auto">
                    <a:xfrm>
                      <a:off x="1297" y="3198"/>
                      <a:ext cx="102" cy="52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52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52">
                          <a:moveTo>
                            <a:pt x="0" y="52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F8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34" name="Rectangle 41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3269"/>
                      <a:ext cx="515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F2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35" name="Freeform 411"/>
                    <p:cNvSpPr>
                      <a:spLocks/>
                    </p:cNvSpPr>
                    <p:nvPr/>
                  </p:nvSpPr>
                  <p:spPr bwMode="auto">
                    <a:xfrm>
                      <a:off x="1297" y="3255"/>
                      <a:ext cx="102" cy="53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53"/>
                        </a:cxn>
                        <a:cxn ang="0">
                          <a:pos x="102" y="53"/>
                        </a:cxn>
                      </a:cxnLst>
                      <a:rect l="0" t="0" r="r" b="b"/>
                      <a:pathLst>
                        <a:path w="102" h="53">
                          <a:moveTo>
                            <a:pt x="0" y="0"/>
                          </a:moveTo>
                          <a:lnTo>
                            <a:pt x="0" y="53"/>
                          </a:lnTo>
                          <a:lnTo>
                            <a:pt x="102" y="53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F8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36" name="Freeform 412"/>
                    <p:cNvSpPr>
                      <a:spLocks/>
                    </p:cNvSpPr>
                    <p:nvPr/>
                  </p:nvSpPr>
                  <p:spPr bwMode="auto">
                    <a:xfrm>
                      <a:off x="1195" y="3253"/>
                      <a:ext cx="102" cy="80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80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80">
                          <a:moveTo>
                            <a:pt x="0" y="80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F8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37" name="Rectangle 41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3379"/>
                      <a:ext cx="515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GSTF3</a:t>
                      </a:r>
                      <a:endParaRPr kumimoji="0" lang="en-US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38" name="Freeform 414"/>
                    <p:cNvSpPr>
                      <a:spLocks/>
                    </p:cNvSpPr>
                    <p:nvPr/>
                  </p:nvSpPr>
                  <p:spPr bwMode="auto">
                    <a:xfrm>
                      <a:off x="1195" y="3337"/>
                      <a:ext cx="204" cy="80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80"/>
                        </a:cxn>
                        <a:cxn ang="0">
                          <a:pos x="204" y="80"/>
                        </a:cxn>
                      </a:cxnLst>
                      <a:rect l="0" t="0" r="r" b="b"/>
                      <a:pathLst>
                        <a:path w="204" h="80">
                          <a:moveTo>
                            <a:pt x="0" y="0"/>
                          </a:moveTo>
                          <a:lnTo>
                            <a:pt x="0" y="80"/>
                          </a:lnTo>
                          <a:lnTo>
                            <a:pt x="204" y="8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FF8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40" name="Line 41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76" y="3335"/>
                      <a:ext cx="1019" cy="1"/>
                    </a:xfrm>
                    <a:prstGeom prst="line">
                      <a:avLst/>
                    </a:prstGeom>
                    <a:noFill/>
                    <a:ln w="3" cap="sq">
                      <a:solidFill>
                        <a:srgbClr val="FF8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41" name="Rectangle 41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3489"/>
                      <a:ext cx="511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EF1G1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42" name="Freeform 418"/>
                    <p:cNvSpPr>
                      <a:spLocks/>
                    </p:cNvSpPr>
                    <p:nvPr/>
                  </p:nvSpPr>
                  <p:spPr bwMode="auto">
                    <a:xfrm>
                      <a:off x="1297" y="3527"/>
                      <a:ext cx="102" cy="53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53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53">
                          <a:moveTo>
                            <a:pt x="0" y="53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808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43" name="Rectangle 41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3599"/>
                      <a:ext cx="511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EF1G2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44" name="Freeform 420"/>
                    <p:cNvSpPr>
                      <a:spLocks/>
                    </p:cNvSpPr>
                    <p:nvPr/>
                  </p:nvSpPr>
                  <p:spPr bwMode="auto">
                    <a:xfrm>
                      <a:off x="1297" y="3585"/>
                      <a:ext cx="102" cy="52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52"/>
                        </a:cxn>
                        <a:cxn ang="0">
                          <a:pos x="102" y="52"/>
                        </a:cxn>
                      </a:cxnLst>
                      <a:rect l="0" t="0" r="r" b="b"/>
                      <a:pathLst>
                        <a:path w="102" h="52">
                          <a:moveTo>
                            <a:pt x="0" y="0"/>
                          </a:moveTo>
                          <a:lnTo>
                            <a:pt x="0" y="52"/>
                          </a:lnTo>
                          <a:lnTo>
                            <a:pt x="102" y="52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808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45" name="Freeform 421"/>
                    <p:cNvSpPr>
                      <a:spLocks/>
                    </p:cNvSpPr>
                    <p:nvPr/>
                  </p:nvSpPr>
                  <p:spPr bwMode="auto">
                    <a:xfrm>
                      <a:off x="1195" y="3582"/>
                      <a:ext cx="102" cy="80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80"/>
                        </a:cxn>
                        <a:cxn ang="0">
                          <a:pos x="0" y="0"/>
                        </a:cxn>
                        <a:cxn ang="0">
                          <a:pos x="102" y="0"/>
                        </a:cxn>
                      </a:cxnLst>
                      <a:rect l="0" t="0" r="r" b="b"/>
                      <a:pathLst>
                        <a:path w="102" h="80">
                          <a:moveTo>
                            <a:pt x="0" y="80"/>
                          </a:moveTo>
                          <a:lnTo>
                            <a:pt x="0" y="0"/>
                          </a:lnTo>
                          <a:lnTo>
                            <a:pt x="102" y="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808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46" name="Rectangle 42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401" y="3709"/>
                      <a:ext cx="511" cy="7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CmaEF1G3</a:t>
                      </a:r>
                      <a:endParaRPr kumimoji="0" 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47" name="Freeform 423"/>
                    <p:cNvSpPr>
                      <a:spLocks/>
                    </p:cNvSpPr>
                    <p:nvPr/>
                  </p:nvSpPr>
                  <p:spPr bwMode="auto">
                    <a:xfrm>
                      <a:off x="1195" y="3667"/>
                      <a:ext cx="204" cy="80"/>
                    </a:xfrm>
                    <a:custGeom>
                      <a:avLst/>
                      <a:gdLst/>
                      <a:ahLst/>
                      <a:cxnLst>
                        <a:cxn ang="0">
                          <a:pos x="0" y="0"/>
                        </a:cxn>
                        <a:cxn ang="0">
                          <a:pos x="0" y="80"/>
                        </a:cxn>
                        <a:cxn ang="0">
                          <a:pos x="204" y="80"/>
                        </a:cxn>
                      </a:cxnLst>
                      <a:rect l="0" t="0" r="r" b="b"/>
                      <a:pathLst>
                        <a:path w="204" h="80">
                          <a:moveTo>
                            <a:pt x="0" y="0"/>
                          </a:moveTo>
                          <a:lnTo>
                            <a:pt x="0" y="80"/>
                          </a:lnTo>
                          <a:lnTo>
                            <a:pt x="204" y="80"/>
                          </a:lnTo>
                        </a:path>
                      </a:pathLst>
                    </a:custGeom>
                    <a:noFill/>
                    <a:ln w="3" cap="sq">
                      <a:solidFill>
                        <a:srgbClr val="808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49" name="Line 42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76" y="3665"/>
                      <a:ext cx="1019" cy="1"/>
                    </a:xfrm>
                    <a:prstGeom prst="line">
                      <a:avLst/>
                    </a:prstGeom>
                    <a:noFill/>
                    <a:ln w="3" cap="sq">
                      <a:solidFill>
                        <a:srgbClr val="808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50" name="Line 42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75" y="2753"/>
                      <a:ext cx="1" cy="453"/>
                    </a:xfrm>
                    <a:prstGeom prst="line">
                      <a:avLst/>
                    </a:prstGeom>
                    <a:noFill/>
                    <a:ln w="3" cap="sq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  <p:sp>
                  <p:nvSpPr>
                    <p:cNvPr id="1451" name="Line 42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75" y="3210"/>
                      <a:ext cx="1" cy="455"/>
                    </a:xfrm>
                    <a:prstGeom prst="line">
                      <a:avLst/>
                    </a:prstGeom>
                    <a:noFill/>
                    <a:ln w="3" cap="sq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/>
                    </a:p>
                  </p:txBody>
                </p:sp>
              </p:grpSp>
              <p:sp>
                <p:nvSpPr>
                  <p:cNvPr id="108" name="Rectangle 381"/>
                  <p:cNvSpPr>
                    <a:spLocks noChangeArrowheads="1"/>
                  </p:cNvSpPr>
                  <p:nvPr/>
                </p:nvSpPr>
                <p:spPr bwMode="auto">
                  <a:xfrm>
                    <a:off x="2250934" y="4218092"/>
                    <a:ext cx="583493" cy="12311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rPr>
                      <a:t> CmaGSTL1</a:t>
                    </a:r>
                    <a:endParaRPr kumimoji="0" lang="en-US" sz="8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pic>
                <p:nvPicPr>
                  <p:cNvPr id="109" name="Picture 2"/>
                  <p:cNvPicPr preferRelativeResize="0">
                    <a:picLocks noChangeArrowheads="1"/>
                  </p:cNvPicPr>
                  <p:nvPr/>
                </p:nvPicPr>
                <p:blipFill>
                  <a:blip r:embed="rId3"/>
                  <a:srcRect l="9813" t="66337" r="2767" b="27688"/>
                  <a:stretch>
                    <a:fillRect/>
                  </a:stretch>
                </p:blipFill>
                <p:spPr bwMode="auto">
                  <a:xfrm>
                    <a:off x="2898775" y="6080760"/>
                    <a:ext cx="5852160" cy="5334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pic>
                <p:nvPicPr>
                  <p:cNvPr id="110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3"/>
                  <a:srcRect l="9813" t="75726" r="2767" b="22030"/>
                  <a:stretch>
                    <a:fillRect/>
                  </a:stretch>
                </p:blipFill>
                <p:spPr bwMode="auto">
                  <a:xfrm>
                    <a:off x="2917190" y="4150360"/>
                    <a:ext cx="5852160" cy="19034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pic>
                <p:nvPicPr>
                  <p:cNvPr id="111" name="Picture 2"/>
                  <p:cNvPicPr preferRelativeResize="0">
                    <a:picLocks noChangeArrowheads="1"/>
                  </p:cNvPicPr>
                  <p:nvPr/>
                </p:nvPicPr>
                <p:blipFill>
                  <a:blip r:embed="rId3"/>
                  <a:srcRect l="9813" t="72312" r="2767" b="24274"/>
                  <a:stretch>
                    <a:fillRect/>
                  </a:stretch>
                </p:blipFill>
                <p:spPr bwMode="auto">
                  <a:xfrm>
                    <a:off x="2901950" y="4366260"/>
                    <a:ext cx="5852160" cy="3048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pic>
                <p:nvPicPr>
                  <p:cNvPr id="112" name="Picture 2"/>
                  <p:cNvPicPr preferRelativeResize="0">
                    <a:picLocks noChangeArrowheads="1"/>
                  </p:cNvPicPr>
                  <p:nvPr/>
                </p:nvPicPr>
                <p:blipFill>
                  <a:blip r:embed="rId3"/>
                  <a:srcRect l="9813" t="60362" r="2767" b="33663"/>
                  <a:stretch>
                    <a:fillRect/>
                  </a:stretch>
                </p:blipFill>
                <p:spPr bwMode="auto">
                  <a:xfrm>
                    <a:off x="2917825" y="4683760"/>
                    <a:ext cx="5852160" cy="5334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pic>
                <p:nvPicPr>
                  <p:cNvPr id="113" name="Picture 2"/>
                  <p:cNvPicPr preferRelativeResize="0">
                    <a:picLocks noChangeArrowheads="1"/>
                  </p:cNvPicPr>
                  <p:nvPr/>
                </p:nvPicPr>
                <p:blipFill>
                  <a:blip r:embed="rId3"/>
                  <a:srcRect l="9813" t="77434" r="2767" b="18298"/>
                  <a:stretch>
                    <a:fillRect/>
                  </a:stretch>
                </p:blipFill>
                <p:spPr bwMode="auto">
                  <a:xfrm>
                    <a:off x="2917825" y="5172710"/>
                    <a:ext cx="5852160" cy="381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pic>
                <p:nvPicPr>
                  <p:cNvPr id="114" name="Picture 2"/>
                  <p:cNvPicPr preferRelativeResize="0">
                    <a:picLocks noChangeArrowheads="1"/>
                  </p:cNvPicPr>
                  <p:nvPr/>
                </p:nvPicPr>
                <p:blipFill>
                  <a:blip r:embed="rId3"/>
                  <a:srcRect l="9813" t="54387" r="2767" b="39638"/>
                  <a:stretch>
                    <a:fillRect/>
                  </a:stretch>
                </p:blipFill>
                <p:spPr bwMode="auto">
                  <a:xfrm>
                    <a:off x="2917825" y="5541010"/>
                    <a:ext cx="5852160" cy="5334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</p:grpSp>
            <p:pic>
              <p:nvPicPr>
                <p:cNvPr id="121" name="Picture 2"/>
                <p:cNvPicPr preferRelativeResize="0">
                  <a:picLocks noChangeArrowheads="1"/>
                </p:cNvPicPr>
                <p:nvPr/>
              </p:nvPicPr>
              <p:blipFill>
                <a:blip r:embed="rId3"/>
                <a:srcRect l="19447" t="60711" r="77434" b="38329"/>
                <a:stretch>
                  <a:fillRect/>
                </a:stretch>
              </p:blipFill>
              <p:spPr bwMode="auto">
                <a:xfrm>
                  <a:off x="3575957" y="5057470"/>
                  <a:ext cx="182880" cy="914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22" name="Picture 2"/>
                <p:cNvPicPr preferRelativeResize="0">
                  <a:picLocks noChangeArrowheads="1"/>
                </p:cNvPicPr>
                <p:nvPr/>
              </p:nvPicPr>
              <p:blipFill>
                <a:blip r:embed="rId3"/>
                <a:srcRect l="81540" t="49077" r="14025" b="49921"/>
                <a:stretch>
                  <a:fillRect/>
                </a:stretch>
              </p:blipFill>
              <p:spPr bwMode="auto">
                <a:xfrm>
                  <a:off x="3298370" y="1741716"/>
                  <a:ext cx="274320" cy="8229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23" name="Picture 2"/>
                <p:cNvPicPr preferRelativeResize="0">
                  <a:picLocks noChangeArrowheads="1"/>
                </p:cNvPicPr>
                <p:nvPr/>
              </p:nvPicPr>
              <p:blipFill>
                <a:blip r:embed="rId3"/>
                <a:srcRect l="81540" t="49077" r="14025" b="49921"/>
                <a:stretch>
                  <a:fillRect/>
                </a:stretch>
              </p:blipFill>
              <p:spPr bwMode="auto">
                <a:xfrm>
                  <a:off x="3298366" y="1915896"/>
                  <a:ext cx="274320" cy="8229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</p:grpSp>
          <p:sp>
            <p:nvSpPr>
              <p:cNvPr id="116" name="TextBox 115"/>
              <p:cNvSpPr txBox="1"/>
              <p:nvPr/>
            </p:nvSpPr>
            <p:spPr>
              <a:xfrm>
                <a:off x="1114425" y="6210302"/>
                <a:ext cx="685800" cy="2154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400" dirty="0" smtClean="0">
                    <a:solidFill>
                      <a:schemeClr val="accent3">
                        <a:lumMod val="75000"/>
                      </a:schemeClr>
                    </a:solidFill>
                    <a:latin typeface="Times New Roman" pitchFamily="18" charset="0"/>
                    <a:cs typeface="Times New Roman" pitchFamily="18" charset="0"/>
                  </a:rPr>
                  <a:t>EF1G</a:t>
                </a:r>
                <a:endParaRPr lang="en-US" sz="1400" dirty="0">
                  <a:solidFill>
                    <a:schemeClr val="accent3">
                      <a:lumMod val="75000"/>
                    </a:schemeClr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1143000" y="5648327"/>
                <a:ext cx="685800" cy="2154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400" dirty="0" smtClean="0">
                    <a:solidFill>
                      <a:schemeClr val="accent6">
                        <a:lumMod val="75000"/>
                      </a:schemeClr>
                    </a:solidFill>
                    <a:latin typeface="Times New Roman" pitchFamily="18" charset="0"/>
                    <a:cs typeface="Times New Roman" pitchFamily="18" charset="0"/>
                  </a:rPr>
                  <a:t>Phi</a:t>
                </a:r>
                <a:endParaRPr lang="en-US" sz="1400" dirty="0">
                  <a:solidFill>
                    <a:schemeClr val="accent6">
                      <a:lumMod val="75000"/>
                    </a:schemeClr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4" name="TextBox 123"/>
              <p:cNvSpPr txBox="1"/>
              <p:nvPr/>
            </p:nvSpPr>
            <p:spPr>
              <a:xfrm>
                <a:off x="1095375" y="5200652"/>
                <a:ext cx="685800" cy="2154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400" dirty="0" smtClean="0">
                    <a:solidFill>
                      <a:srgbClr val="FF00FF"/>
                    </a:solidFill>
                    <a:latin typeface="Times New Roman" pitchFamily="18" charset="0"/>
                    <a:cs typeface="Times New Roman" pitchFamily="18" charset="0"/>
                  </a:rPr>
                  <a:t>Theta</a:t>
                </a:r>
                <a:endParaRPr lang="en-US" sz="1400" dirty="0">
                  <a:solidFill>
                    <a:srgbClr val="FF00FF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5" name="TextBox 124"/>
              <p:cNvSpPr txBox="1"/>
              <p:nvPr/>
            </p:nvSpPr>
            <p:spPr>
              <a:xfrm>
                <a:off x="1228725" y="4333876"/>
                <a:ext cx="685800" cy="2154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400" dirty="0" smtClean="0">
                    <a:solidFill>
                      <a:srgbClr val="00B050"/>
                    </a:solidFill>
                    <a:latin typeface="Times New Roman" pitchFamily="18" charset="0"/>
                    <a:cs typeface="Times New Roman" pitchFamily="18" charset="0"/>
                  </a:rPr>
                  <a:t>GHR</a:t>
                </a:r>
                <a:endParaRPr lang="en-US" sz="1400" dirty="0">
                  <a:solidFill>
                    <a:srgbClr val="00B050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6" name="TextBox 125"/>
              <p:cNvSpPr txBox="1"/>
              <p:nvPr/>
            </p:nvSpPr>
            <p:spPr>
              <a:xfrm>
                <a:off x="1143000" y="4781551"/>
                <a:ext cx="685800" cy="2154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400" dirty="0" smtClean="0">
                    <a:solidFill>
                      <a:srgbClr val="0000FF"/>
                    </a:solidFill>
                    <a:latin typeface="Times New Roman" pitchFamily="18" charset="0"/>
                    <a:cs typeface="Times New Roman" pitchFamily="18" charset="0"/>
                  </a:rPr>
                  <a:t>Zeta</a:t>
                </a:r>
                <a:endParaRPr lang="en-US" sz="1400" dirty="0">
                  <a:solidFill>
                    <a:srgbClr val="0000FF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7" name="TextBox 126"/>
              <p:cNvSpPr txBox="1"/>
              <p:nvPr/>
            </p:nvSpPr>
            <p:spPr>
              <a:xfrm>
                <a:off x="1381125" y="4086226"/>
                <a:ext cx="685800" cy="2154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400" dirty="0" smtClean="0">
                    <a:solidFill>
                      <a:srgbClr val="00B0F0"/>
                    </a:solidFill>
                    <a:latin typeface="Times New Roman" pitchFamily="18" charset="0"/>
                    <a:cs typeface="Times New Roman" pitchFamily="18" charset="0"/>
                  </a:rPr>
                  <a:t>Lambda</a:t>
                </a:r>
                <a:endParaRPr lang="en-US" sz="1400" dirty="0">
                  <a:solidFill>
                    <a:srgbClr val="00B0F0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>
                <a:off x="1466850" y="2886075"/>
                <a:ext cx="685800" cy="2154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400" dirty="0" smtClean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Tau</a:t>
                </a:r>
                <a:endParaRPr lang="en-US" sz="1400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pic>
          <p:nvPicPr>
            <p:cNvPr id="24581" name="Picture 5" descr="C:\Users\KAYUM\Desktop\Untitled-2.tif"/>
            <p:cNvPicPr>
              <a:picLocks noChangeAspect="1"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914400" y="-8763"/>
              <a:ext cx="7239000" cy="984016"/>
            </a:xfrm>
            <a:prstGeom prst="rect">
              <a:avLst/>
            </a:prstGeom>
            <a:noFill/>
          </p:spPr>
        </p:pic>
      </p:grpSp>
      <p:sp>
        <p:nvSpPr>
          <p:cNvPr id="130" name="Rectangle 134"/>
          <p:cNvSpPr>
            <a:spLocks noChangeArrowheads="1"/>
          </p:cNvSpPr>
          <p:nvPr/>
        </p:nvSpPr>
        <p:spPr bwMode="auto">
          <a:xfrm>
            <a:off x="228600" y="6139720"/>
            <a:ext cx="8915400" cy="4924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3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Schematic representation of motif compositions in th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ST sequence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 Different motifs, numbere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1–10,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re displayed in different colored boxes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he names of all members are displayed on the left side while bottom scale indicates length of motifs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75"/>
          <p:cNvGrpSpPr>
            <a:grpSpLocks/>
          </p:cNvGrpSpPr>
          <p:nvPr/>
        </p:nvGrpSpPr>
        <p:grpSpPr bwMode="auto">
          <a:xfrm>
            <a:off x="66675" y="228600"/>
            <a:ext cx="8848725" cy="5273675"/>
            <a:chOff x="66676" y="228600"/>
            <a:chExt cx="8848724" cy="5273028"/>
          </a:xfrm>
        </p:grpSpPr>
        <p:grpSp>
          <p:nvGrpSpPr>
            <p:cNvPr id="3" name="Group 161"/>
            <p:cNvGrpSpPr>
              <a:grpSpLocks/>
            </p:cNvGrpSpPr>
            <p:nvPr/>
          </p:nvGrpSpPr>
          <p:grpSpPr bwMode="auto">
            <a:xfrm>
              <a:off x="66676" y="228600"/>
              <a:ext cx="8848724" cy="2682240"/>
              <a:chOff x="66676" y="228600"/>
              <a:chExt cx="8848724" cy="2682240"/>
            </a:xfrm>
          </p:grpSpPr>
          <p:grpSp>
            <p:nvGrpSpPr>
              <p:cNvPr id="4" name="Group 158"/>
              <p:cNvGrpSpPr>
                <a:grpSpLocks/>
              </p:cNvGrpSpPr>
              <p:nvPr/>
            </p:nvGrpSpPr>
            <p:grpSpPr bwMode="auto">
              <a:xfrm>
                <a:off x="66676" y="366588"/>
                <a:ext cx="8848724" cy="2544252"/>
                <a:chOff x="66676" y="366588"/>
                <a:chExt cx="8848724" cy="2544252"/>
              </a:xfrm>
            </p:grpSpPr>
            <p:graphicFrame>
              <p:nvGraphicFramePr>
                <p:cNvPr id="7" name="Chart 6"/>
                <p:cNvGraphicFramePr/>
                <p:nvPr/>
              </p:nvGraphicFramePr>
              <p:xfrm>
                <a:off x="228600" y="533400"/>
                <a:ext cx="8686800" cy="23774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8285" name="TextBox 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-701530" y="1406382"/>
                  <a:ext cx="1828800" cy="2923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Relative expression</a:t>
                  </a:r>
                </a:p>
              </p:txBody>
            </p:sp>
            <p:sp>
              <p:nvSpPr>
                <p:cNvPr id="8286" name="TextBox 5"/>
                <p:cNvSpPr txBox="1">
                  <a:spLocks noChangeArrowheads="1"/>
                </p:cNvSpPr>
                <p:nvPr/>
              </p:nvSpPr>
              <p:spPr bwMode="auto">
                <a:xfrm>
                  <a:off x="2895600" y="366588"/>
                  <a:ext cx="2590800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400">
                      <a:latin typeface="Times New Roman" pitchFamily="18" charset="0"/>
                      <a:cs typeface="Times New Roman" pitchFamily="18" charset="0"/>
                    </a:rPr>
                    <a:t>5°C  treatment vs. </a:t>
                  </a:r>
                  <a:r>
                    <a:rPr lang="en-US" sz="1400" i="1">
                      <a:latin typeface="Times New Roman" pitchFamily="18" charset="0"/>
                      <a:cs typeface="Times New Roman" pitchFamily="18" charset="0"/>
                    </a:rPr>
                    <a:t>C. maxima</a:t>
                  </a:r>
                </a:p>
              </p:txBody>
            </p:sp>
            <p:grpSp>
              <p:nvGrpSpPr>
                <p:cNvPr id="5" name="Group 21"/>
                <p:cNvGrpSpPr>
                  <a:grpSpLocks/>
                </p:cNvGrpSpPr>
                <p:nvPr/>
              </p:nvGrpSpPr>
              <p:grpSpPr bwMode="auto">
                <a:xfrm>
                  <a:off x="5848350" y="457200"/>
                  <a:ext cx="2743200" cy="207675"/>
                  <a:chOff x="5848350" y="457200"/>
                  <a:chExt cx="2743200" cy="207675"/>
                </a:xfrm>
              </p:grpSpPr>
              <p:sp>
                <p:nvSpPr>
                  <p:cNvPr id="12" name="Rectangle 11"/>
                  <p:cNvSpPr/>
                  <p:nvPr/>
                </p:nvSpPr>
                <p:spPr>
                  <a:xfrm>
                    <a:off x="5848350" y="511141"/>
                    <a:ext cx="109538" cy="109525"/>
                  </a:xfrm>
                  <a:prstGeom prst="rect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solidFill>
                      <a:schemeClr val="accent1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US"/>
                  </a:p>
                </p:txBody>
              </p:sp>
              <p:sp>
                <p:nvSpPr>
                  <p:cNvPr id="13" name="Rectangle 12"/>
                  <p:cNvSpPr/>
                  <p:nvPr/>
                </p:nvSpPr>
                <p:spPr>
                  <a:xfrm>
                    <a:off x="6362700" y="517490"/>
                    <a:ext cx="111125" cy="111112"/>
                  </a:xfrm>
                  <a:prstGeom prst="rect">
                    <a:avLst/>
                  </a:prstGeom>
                  <a:solidFill>
                    <a:srgbClr val="C00000"/>
                  </a:solidFill>
                  <a:ln>
                    <a:solidFill>
                      <a:srgbClr val="C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US"/>
                  </a:p>
                </p:txBody>
              </p:sp>
              <p:sp>
                <p:nvSpPr>
                  <p:cNvPr id="14" name="Rectangle 13"/>
                  <p:cNvSpPr/>
                  <p:nvPr/>
                </p:nvSpPr>
                <p:spPr>
                  <a:xfrm>
                    <a:off x="6988175" y="511141"/>
                    <a:ext cx="109538" cy="109525"/>
                  </a:xfrm>
                  <a:prstGeom prst="rect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US"/>
                  </a:p>
                </p:txBody>
              </p:sp>
              <p:sp>
                <p:nvSpPr>
                  <p:cNvPr id="15" name="Rectangle 14"/>
                  <p:cNvSpPr/>
                  <p:nvPr/>
                </p:nvSpPr>
                <p:spPr>
                  <a:xfrm>
                    <a:off x="7567613" y="517490"/>
                    <a:ext cx="109537" cy="111112"/>
                  </a:xfrm>
                  <a:prstGeom prst="rect">
                    <a:avLst/>
                  </a:prstGeom>
                  <a:solidFill>
                    <a:srgbClr val="7030A0"/>
                  </a:solidFill>
                  <a:ln>
                    <a:solidFill>
                      <a:srgbClr val="7030A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US"/>
                  </a:p>
                </p:txBody>
              </p:sp>
              <p:sp>
                <p:nvSpPr>
                  <p:cNvPr id="16" name="Rectangle 15"/>
                  <p:cNvSpPr/>
                  <p:nvPr/>
                </p:nvSpPr>
                <p:spPr>
                  <a:xfrm>
                    <a:off x="8134350" y="511141"/>
                    <a:ext cx="109538" cy="109525"/>
                  </a:xfrm>
                  <a:prstGeom prst="rect">
                    <a:avLst/>
                  </a:prstGeom>
                  <a:solidFill>
                    <a:schemeClr val="accent5"/>
                  </a:solidFill>
                  <a:ln>
                    <a:solidFill>
                      <a:schemeClr val="accent5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US"/>
                  </a:p>
                </p:txBody>
              </p:sp>
              <p:sp>
                <p:nvSpPr>
                  <p:cNvPr id="8361" name="TextBox 1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008370" y="457200"/>
                    <a:ext cx="304800" cy="20005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lIns="0" tIns="0" rIns="0" bIns="0">
                    <a:spAutoFit/>
                  </a:bodyPr>
                  <a:lstStyle/>
                  <a:p>
                    <a:r>
                      <a:rPr lang="en-US" sz="1300">
                        <a:latin typeface="Times New Roman" pitchFamily="18" charset="0"/>
                        <a:cs typeface="Times New Roman" pitchFamily="18" charset="0"/>
                      </a:rPr>
                      <a:t>0h</a:t>
                    </a:r>
                  </a:p>
                </p:txBody>
              </p:sp>
              <p:sp>
                <p:nvSpPr>
                  <p:cNvPr id="8362" name="TextBox 1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534150" y="464820"/>
                    <a:ext cx="304800" cy="20005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lIns="0" tIns="0" rIns="0" bIns="0">
                    <a:spAutoFit/>
                  </a:bodyPr>
                  <a:lstStyle/>
                  <a:p>
                    <a:r>
                      <a:rPr lang="en-US" sz="1300">
                        <a:latin typeface="Times New Roman" pitchFamily="18" charset="0"/>
                        <a:cs typeface="Times New Roman" pitchFamily="18" charset="0"/>
                      </a:rPr>
                      <a:t>6h</a:t>
                    </a:r>
                  </a:p>
                </p:txBody>
              </p:sp>
              <p:sp>
                <p:nvSpPr>
                  <p:cNvPr id="8363" name="TextBox 1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143750" y="457200"/>
                    <a:ext cx="304800" cy="20005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lIns="0" tIns="0" rIns="0" bIns="0">
                    <a:spAutoFit/>
                  </a:bodyPr>
                  <a:lstStyle/>
                  <a:p>
                    <a:r>
                      <a:rPr lang="en-US" sz="1300">
                        <a:latin typeface="Times New Roman" pitchFamily="18" charset="0"/>
                        <a:cs typeface="Times New Roman" pitchFamily="18" charset="0"/>
                      </a:rPr>
                      <a:t>24h</a:t>
                    </a:r>
                  </a:p>
                </p:txBody>
              </p:sp>
              <p:sp>
                <p:nvSpPr>
                  <p:cNvPr id="8364" name="TextBox 1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722870" y="457200"/>
                    <a:ext cx="304800" cy="20005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lIns="0" tIns="0" rIns="0" bIns="0">
                    <a:spAutoFit/>
                  </a:bodyPr>
                  <a:lstStyle/>
                  <a:p>
                    <a:r>
                      <a:rPr lang="en-US" sz="1300">
                        <a:latin typeface="Times New Roman" pitchFamily="18" charset="0"/>
                        <a:cs typeface="Times New Roman" pitchFamily="18" charset="0"/>
                      </a:rPr>
                      <a:t>48h</a:t>
                    </a:r>
                  </a:p>
                </p:txBody>
              </p:sp>
              <p:sp>
                <p:nvSpPr>
                  <p:cNvPr id="8365" name="TextBox 2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286750" y="457200"/>
                    <a:ext cx="304800" cy="20005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lIns="0" tIns="0" rIns="0" bIns="0">
                    <a:spAutoFit/>
                  </a:bodyPr>
                  <a:lstStyle/>
                  <a:p>
                    <a:r>
                      <a:rPr lang="en-US" sz="1300">
                        <a:latin typeface="Times New Roman" pitchFamily="18" charset="0"/>
                        <a:cs typeface="Times New Roman" pitchFamily="18" charset="0"/>
                      </a:rPr>
                      <a:t>72h</a:t>
                    </a:r>
                  </a:p>
                </p:txBody>
              </p:sp>
            </p:grpSp>
            <p:sp>
              <p:nvSpPr>
                <p:cNvPr id="8288" name="TextBox 2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26920" y="191538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8289" name="TextBox 2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23904" y="212320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8290" name="TextBox 2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07028" y="174914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-d</a:t>
                  </a:r>
                </a:p>
              </p:txBody>
            </p:sp>
            <p:sp>
              <p:nvSpPr>
                <p:cNvPr id="8291" name="TextBox 2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97085" y="215091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e</a:t>
                  </a:r>
                </a:p>
              </p:txBody>
            </p:sp>
            <p:sp>
              <p:nvSpPr>
                <p:cNvPr id="8292" name="TextBox 2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084108" y="1769927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8293" name="TextBox 2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181092" y="197774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8294" name="TextBox 2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264216" y="1506707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-c</a:t>
                  </a:r>
                </a:p>
              </p:txBody>
            </p:sp>
            <p:sp>
              <p:nvSpPr>
                <p:cNvPr id="8295" name="TextBox 2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354273" y="2005457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c</a:t>
                  </a:r>
                </a:p>
              </p:txBody>
            </p:sp>
            <p:sp>
              <p:nvSpPr>
                <p:cNvPr id="8296" name="TextBox 3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589804" y="1250402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8297" name="TextBox 3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693715" y="155519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-d</a:t>
                  </a:r>
                </a:p>
              </p:txBody>
            </p:sp>
            <p:sp>
              <p:nvSpPr>
                <p:cNvPr id="8298" name="TextBox 3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769912" y="182534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8299" name="TextBox 3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859969" y="20678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e</a:t>
                  </a:r>
                </a:p>
              </p:txBody>
            </p:sp>
            <p:sp>
              <p:nvSpPr>
                <p:cNvPr id="8300" name="TextBox 3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060862" y="192924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8301" name="TextBox 3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157846" y="213706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8302" name="TextBox 3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240970" y="1991597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8303" name="TextBox 3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331027" y="216477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8304" name="TextBox 3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531904" y="190154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8305" name="TextBox 3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628888" y="2109362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8306" name="TextBox 4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712012" y="19431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8307" name="TextBox 4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802069" y="213707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8308" name="TextBox 4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023727" y="17699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8309" name="TextBox 4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120711" y="113260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-c</a:t>
                  </a:r>
                </a:p>
              </p:txBody>
            </p:sp>
            <p:sp>
              <p:nvSpPr>
                <p:cNvPr id="8310" name="TextBox 4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203835" y="1603697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-d</a:t>
                  </a:r>
                </a:p>
              </p:txBody>
            </p:sp>
            <p:sp>
              <p:nvSpPr>
                <p:cNvPr id="8311" name="TextBox 4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293892" y="200546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c</a:t>
                  </a:r>
                </a:p>
              </p:txBody>
            </p:sp>
            <p:sp>
              <p:nvSpPr>
                <p:cNvPr id="8312" name="TextBox 4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508623" y="154135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c</a:t>
                  </a:r>
                </a:p>
              </p:txBody>
            </p:sp>
            <p:sp>
              <p:nvSpPr>
                <p:cNvPr id="8313" name="TextBox 4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605607" y="68928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8314" name="TextBox 4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688731" y="1375112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8315" name="TextBox 4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778788" y="177688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8316" name="TextBox 5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997276" y="133692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b</a:t>
                  </a:r>
                </a:p>
              </p:txBody>
            </p:sp>
            <p:sp>
              <p:nvSpPr>
                <p:cNvPr id="8317" name="TextBox 5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108114" y="1471712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-d</a:t>
                  </a:r>
                </a:p>
              </p:txBody>
            </p:sp>
            <p:sp>
              <p:nvSpPr>
                <p:cNvPr id="8318" name="TextBox 5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188017" y="202815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8319" name="TextBox 5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256808" y="21717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e</a:t>
                  </a:r>
                </a:p>
              </p:txBody>
            </p:sp>
            <p:sp>
              <p:nvSpPr>
                <p:cNvPr id="8320" name="TextBox 5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471554" y="179765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8321" name="TextBox 5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568538" y="71697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8322" name="TextBox 5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651662" y="149979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b</a:t>
                  </a:r>
                </a:p>
              </p:txBody>
            </p:sp>
            <p:sp>
              <p:nvSpPr>
                <p:cNvPr id="8323" name="TextBox 5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741719" y="192235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b</a:t>
                  </a:r>
                </a:p>
              </p:txBody>
            </p:sp>
            <p:sp>
              <p:nvSpPr>
                <p:cNvPr id="8324" name="TextBox 5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970313" y="2007392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8325" name="TextBox 5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039589" y="144625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-d</a:t>
                  </a:r>
                </a:p>
              </p:txBody>
            </p:sp>
            <p:sp>
              <p:nvSpPr>
                <p:cNvPr id="8326" name="TextBox 6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136567" y="15205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-c</a:t>
                  </a:r>
                </a:p>
              </p:txBody>
            </p:sp>
            <p:sp>
              <p:nvSpPr>
                <p:cNvPr id="8327" name="TextBox 6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212770" y="186000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8328" name="TextBox 6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427516" y="183228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8329" name="TextBox 6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524500" y="102870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b</a:t>
                  </a:r>
                </a:p>
              </p:txBody>
            </p:sp>
            <p:sp>
              <p:nvSpPr>
                <p:cNvPr id="8330" name="TextBox 6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614551" y="152750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-c</a:t>
                  </a:r>
                </a:p>
              </p:txBody>
            </p:sp>
            <p:sp>
              <p:nvSpPr>
                <p:cNvPr id="8331" name="TextBox 6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697681" y="206781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e</a:t>
                  </a:r>
                </a:p>
              </p:txBody>
            </p:sp>
            <p:sp>
              <p:nvSpPr>
                <p:cNvPr id="8332" name="TextBox 6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926278" y="93177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8333" name="TextBox 6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023262" y="134041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-d</a:t>
                  </a:r>
                </a:p>
              </p:txBody>
            </p:sp>
            <p:sp>
              <p:nvSpPr>
                <p:cNvPr id="8334" name="TextBox 6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092532" y="169375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8335" name="TextBox 6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182589" y="1943132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8336" name="TextBox 7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397320" y="120880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8337" name="TextBox 7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508158" y="147203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-d</a:t>
                  </a:r>
                </a:p>
              </p:txBody>
            </p:sp>
            <p:sp>
              <p:nvSpPr>
                <p:cNvPr id="8338" name="TextBox 7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577428" y="1804592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-d</a:t>
                  </a:r>
                </a:p>
              </p:txBody>
            </p:sp>
            <p:sp>
              <p:nvSpPr>
                <p:cNvPr id="8339" name="TextBox 7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667485" y="205397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e</a:t>
                  </a:r>
                </a:p>
              </p:txBody>
            </p:sp>
            <p:sp>
              <p:nvSpPr>
                <p:cNvPr id="8340" name="TextBox 7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861461" y="2060862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8341" name="TextBox 7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951518" y="19500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8342" name="TextBox 7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034642" y="177688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-d</a:t>
                  </a:r>
                </a:p>
              </p:txBody>
            </p:sp>
            <p:sp>
              <p:nvSpPr>
                <p:cNvPr id="8343" name="TextBox 7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124699" y="165220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8344" name="TextBox 7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346366" y="153443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c</a:t>
                  </a:r>
                </a:p>
              </p:txBody>
            </p:sp>
            <p:sp>
              <p:nvSpPr>
                <p:cNvPr id="8345" name="TextBox 7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443350" y="172141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8346" name="TextBox 8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526474" y="192927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8347" name="TextBox 8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616531" y="222118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8348" name="TextBox 8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831275" y="172836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8349" name="TextBox 8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921332" y="187380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8350" name="TextBox 8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011383" y="172146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-d</a:t>
                  </a:r>
                </a:p>
              </p:txBody>
            </p:sp>
            <p:sp>
              <p:nvSpPr>
                <p:cNvPr id="8351" name="TextBox 8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101440" y="2194112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8352" name="TextBox 8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330525" y="2126582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8353" name="TextBox 8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399316" y="2144007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8354" name="TextBox 8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521266" y="198436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8355" name="TextBox 8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600690" y="220184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</p:grpSp>
          <p:sp>
            <p:nvSpPr>
              <p:cNvPr id="8283" name="TextBox 160"/>
              <p:cNvSpPr txBox="1">
                <a:spLocks noChangeArrowheads="1"/>
              </p:cNvSpPr>
              <p:nvPr/>
            </p:nvSpPr>
            <p:spPr bwMode="auto">
              <a:xfrm>
                <a:off x="173187" y="228600"/>
                <a:ext cx="30480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r>
                  <a:rPr lang="en-US" sz="1600"/>
                  <a:t>a.</a:t>
                </a:r>
              </a:p>
            </p:txBody>
          </p:sp>
        </p:grpSp>
        <p:grpSp>
          <p:nvGrpSpPr>
            <p:cNvPr id="6" name="Group 174"/>
            <p:cNvGrpSpPr>
              <a:grpSpLocks/>
            </p:cNvGrpSpPr>
            <p:nvPr/>
          </p:nvGrpSpPr>
          <p:grpSpPr bwMode="auto">
            <a:xfrm>
              <a:off x="66676" y="2877967"/>
              <a:ext cx="8848724" cy="2623661"/>
              <a:chOff x="66676" y="3182779"/>
              <a:chExt cx="8848724" cy="2623661"/>
            </a:xfrm>
          </p:grpSpPr>
          <p:grpSp>
            <p:nvGrpSpPr>
              <p:cNvPr id="8" name="Group 159"/>
              <p:cNvGrpSpPr>
                <a:grpSpLocks/>
              </p:cNvGrpSpPr>
              <p:nvPr/>
            </p:nvGrpSpPr>
            <p:grpSpPr bwMode="auto">
              <a:xfrm>
                <a:off x="66676" y="3273623"/>
                <a:ext cx="8848724" cy="2532817"/>
                <a:chOff x="66676" y="3273623"/>
                <a:chExt cx="8848724" cy="2532817"/>
              </a:xfrm>
            </p:grpSpPr>
            <p:graphicFrame>
              <p:nvGraphicFramePr>
                <p:cNvPr id="9" name="Chart 8"/>
                <p:cNvGraphicFramePr/>
                <p:nvPr/>
              </p:nvGraphicFramePr>
              <p:xfrm>
                <a:off x="228600" y="3429000"/>
                <a:ext cx="8686800" cy="23774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8212" name="TextBox 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-701530" y="4349606"/>
                  <a:ext cx="1828800" cy="2923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Relative expression</a:t>
                  </a:r>
                </a:p>
              </p:txBody>
            </p:sp>
            <p:sp>
              <p:nvSpPr>
                <p:cNvPr id="8213" name="TextBox 10"/>
                <p:cNvSpPr txBox="1">
                  <a:spLocks noChangeArrowheads="1"/>
                </p:cNvSpPr>
                <p:nvPr/>
              </p:nvSpPr>
              <p:spPr bwMode="auto">
                <a:xfrm>
                  <a:off x="2895600" y="3273623"/>
                  <a:ext cx="2590800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400">
                      <a:latin typeface="Times New Roman" pitchFamily="18" charset="0"/>
                      <a:cs typeface="Times New Roman" pitchFamily="18" charset="0"/>
                    </a:rPr>
                    <a:t>5°C  treatment vs. </a:t>
                  </a:r>
                  <a:r>
                    <a:rPr lang="en-US" sz="1400" i="1">
                      <a:latin typeface="Times New Roman" pitchFamily="18" charset="0"/>
                      <a:cs typeface="Times New Roman" pitchFamily="18" charset="0"/>
                    </a:rPr>
                    <a:t>C. moschata</a:t>
                  </a:r>
                </a:p>
              </p:txBody>
            </p:sp>
            <p:sp>
              <p:nvSpPr>
                <p:cNvPr id="8214" name="TextBox 9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986646" y="4956462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e</a:t>
                  </a:r>
                </a:p>
              </p:txBody>
            </p:sp>
            <p:sp>
              <p:nvSpPr>
                <p:cNvPr id="8215" name="TextBox 9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097484" y="488020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8216" name="TextBox 9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180608" y="468627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g</a:t>
                  </a:r>
                </a:p>
              </p:txBody>
            </p:sp>
            <p:sp>
              <p:nvSpPr>
                <p:cNvPr id="8217" name="TextBox 9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270665" y="491487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8218" name="TextBox 9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471557" y="48941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e</a:t>
                  </a:r>
                </a:p>
              </p:txBody>
            </p:sp>
            <p:sp>
              <p:nvSpPr>
                <p:cNvPr id="8219" name="TextBox 9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554687" y="472785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8220" name="TextBox 9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651665" y="459624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-d</a:t>
                  </a:r>
                </a:p>
              </p:txBody>
            </p:sp>
            <p:sp>
              <p:nvSpPr>
                <p:cNvPr id="8221" name="TextBox 9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755576" y="482484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8222" name="TextBox 9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963389" y="48941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8223" name="TextBox 9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046519" y="393812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8224" name="TextBox 10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129643" y="418062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c</a:t>
                  </a:r>
                </a:p>
              </p:txBody>
            </p:sp>
            <p:sp>
              <p:nvSpPr>
                <p:cNvPr id="8225" name="TextBox 10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226627" y="4215267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b</a:t>
                  </a:r>
                </a:p>
              </p:txBody>
            </p:sp>
            <p:sp>
              <p:nvSpPr>
                <p:cNvPr id="8226" name="TextBox 10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427519" y="49910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e</a:t>
                  </a:r>
                </a:p>
              </p:txBody>
            </p:sp>
            <p:sp>
              <p:nvSpPr>
                <p:cNvPr id="8227" name="TextBox 10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538357" y="471402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e</a:t>
                  </a:r>
                </a:p>
              </p:txBody>
            </p:sp>
            <p:sp>
              <p:nvSpPr>
                <p:cNvPr id="8228" name="TextBox 10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628408" y="459624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-g</a:t>
                  </a:r>
                </a:p>
              </p:txBody>
            </p:sp>
            <p:sp>
              <p:nvSpPr>
                <p:cNvPr id="8229" name="TextBox 10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711538" y="481098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8230" name="TextBox 10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926281" y="49911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8231" name="TextBox 10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002484" y="45339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8232" name="TextBox 10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099462" y="467937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-g</a:t>
                  </a:r>
                </a:p>
              </p:txBody>
            </p:sp>
            <p:sp>
              <p:nvSpPr>
                <p:cNvPr id="8233" name="TextBox 10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189519" y="492874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8234" name="TextBox 11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390396" y="491490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8235" name="TextBox 11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459681" y="463088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8236" name="TextBox 11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577431" y="461703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-g</a:t>
                  </a:r>
                </a:p>
              </p:txBody>
            </p:sp>
            <p:sp>
              <p:nvSpPr>
                <p:cNvPr id="8237" name="TextBox 11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667488" y="486641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8238" name="TextBox 11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875318" y="480403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e</a:t>
                  </a:r>
                </a:p>
              </p:txBody>
            </p:sp>
            <p:sp>
              <p:nvSpPr>
                <p:cNvPr id="8239" name="TextBox 11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965375" y="382732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c</a:t>
                  </a:r>
                </a:p>
              </p:txBody>
            </p:sp>
            <p:sp>
              <p:nvSpPr>
                <p:cNvPr id="8240" name="TextBox 11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048499" y="4520055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e</a:t>
                  </a:r>
                </a:p>
              </p:txBody>
            </p:sp>
            <p:sp>
              <p:nvSpPr>
                <p:cNvPr id="8241" name="TextBox 11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138556" y="493568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8242" name="TextBox 11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360223" y="452697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</a:t>
                  </a:r>
                </a:p>
              </p:txBody>
            </p:sp>
            <p:sp>
              <p:nvSpPr>
                <p:cNvPr id="8243" name="TextBox 11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450280" y="4686245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8244" name="TextBox 12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540331" y="485255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g</a:t>
                  </a:r>
                </a:p>
              </p:txBody>
            </p:sp>
            <p:sp>
              <p:nvSpPr>
                <p:cNvPr id="8245" name="TextBox 12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623461" y="503958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8246" name="TextBox 12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845132" y="4471535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8247" name="TextBox 12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886700" y="4111342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-e</a:t>
                  </a:r>
                </a:p>
              </p:txBody>
            </p:sp>
            <p:sp>
              <p:nvSpPr>
                <p:cNvPr id="8248" name="TextBox 12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004459" y="4312245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b</a:t>
                  </a:r>
                </a:p>
              </p:txBody>
            </p:sp>
            <p:sp>
              <p:nvSpPr>
                <p:cNvPr id="8249" name="TextBox 12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115297" y="4714017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8250" name="TextBox 12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323116" y="4963392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e</a:t>
                  </a:r>
                </a:p>
              </p:txBody>
            </p:sp>
            <p:sp>
              <p:nvSpPr>
                <p:cNvPr id="8251" name="TextBox 12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399319" y="46863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e</a:t>
                  </a:r>
                </a:p>
              </p:txBody>
            </p:sp>
            <p:sp>
              <p:nvSpPr>
                <p:cNvPr id="8252" name="TextBox 12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482443" y="4492347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e</a:t>
                  </a:r>
                </a:p>
              </p:txBody>
            </p:sp>
            <p:sp>
              <p:nvSpPr>
                <p:cNvPr id="8253" name="TextBox 12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593281" y="483870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8254" name="TextBox 13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26920" y="49149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e</a:t>
                  </a:r>
                </a:p>
              </p:txBody>
            </p:sp>
            <p:sp>
              <p:nvSpPr>
                <p:cNvPr id="8255" name="TextBox 13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37758" y="344631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</a:t>
                  </a:r>
                </a:p>
              </p:txBody>
            </p:sp>
            <p:sp>
              <p:nvSpPr>
                <p:cNvPr id="8256" name="TextBox 13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07028" y="381347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8257" name="TextBox 13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97085" y="403512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8258" name="TextBox 13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111831" y="4305312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c</a:t>
                  </a:r>
                </a:p>
              </p:txBody>
            </p:sp>
            <p:sp>
              <p:nvSpPr>
                <p:cNvPr id="8259" name="TextBox 13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208815" y="349478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</a:t>
                  </a:r>
                </a:p>
              </p:txBody>
            </p:sp>
            <p:sp>
              <p:nvSpPr>
                <p:cNvPr id="8260" name="TextBox 13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298866" y="430531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f</a:t>
                  </a:r>
                </a:p>
              </p:txBody>
            </p:sp>
            <p:sp>
              <p:nvSpPr>
                <p:cNvPr id="8261" name="TextBox 13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388923" y="472787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8262" name="TextBox 13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610590" y="50049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8263" name="TextBox 13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679866" y="464468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8264" name="TextBox 14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776844" y="4804062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</a:t>
                  </a:r>
                </a:p>
              </p:txBody>
            </p:sp>
            <p:sp>
              <p:nvSpPr>
                <p:cNvPr id="8265" name="TextBox 14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853047" y="494260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8266" name="TextBox 14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067793" y="4339947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e</a:t>
                  </a:r>
                </a:p>
              </p:txBody>
            </p:sp>
            <p:sp>
              <p:nvSpPr>
                <p:cNvPr id="8267" name="TextBox 14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164777" y="353636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8268" name="TextBox 14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254828" y="4035165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8269" name="TextBox 14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337958" y="4575477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8270" name="TextBox 14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566555" y="46863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8271" name="TextBox 14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642758" y="364026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</a:t>
                  </a:r>
                </a:p>
              </p:txBody>
            </p:sp>
            <p:sp>
              <p:nvSpPr>
                <p:cNvPr id="8272" name="TextBox 14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732809" y="420141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f</a:t>
                  </a:r>
                </a:p>
              </p:txBody>
            </p:sp>
            <p:sp>
              <p:nvSpPr>
                <p:cNvPr id="8273" name="TextBox 14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822866" y="490104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8274" name="TextBox 15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037597" y="49149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8275" name="TextBox 15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099954" y="451311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e</a:t>
                  </a:r>
                </a:p>
              </p:txBody>
            </p:sp>
            <p:sp>
              <p:nvSpPr>
                <p:cNvPr id="8276" name="TextBox 15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210778" y="4194492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b</a:t>
                  </a:r>
                </a:p>
              </p:txBody>
            </p:sp>
            <p:sp>
              <p:nvSpPr>
                <p:cNvPr id="8277" name="TextBox 15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300835" y="444387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c</a:t>
                  </a:r>
                </a:p>
              </p:txBody>
            </p:sp>
            <p:sp>
              <p:nvSpPr>
                <p:cNvPr id="8278" name="TextBox 15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501738" y="483867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8279" name="TextBox 15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591795" y="472781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8280" name="TextBox 15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674919" y="455469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g</a:t>
                  </a:r>
                </a:p>
              </p:txBody>
            </p:sp>
            <p:sp>
              <p:nvSpPr>
                <p:cNvPr id="8281" name="TextBox 15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764976" y="49911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</p:grpSp>
          <p:grpSp>
            <p:nvGrpSpPr>
              <p:cNvPr id="10" name="Group 172"/>
              <p:cNvGrpSpPr>
                <a:grpSpLocks/>
              </p:cNvGrpSpPr>
              <p:nvPr/>
            </p:nvGrpSpPr>
            <p:grpSpPr bwMode="auto">
              <a:xfrm>
                <a:off x="5806009" y="3382195"/>
                <a:ext cx="2743200" cy="207675"/>
                <a:chOff x="6000750" y="3297525"/>
                <a:chExt cx="2743200" cy="207675"/>
              </a:xfrm>
            </p:grpSpPr>
            <p:sp>
              <p:nvSpPr>
                <p:cNvPr id="163" name="Rectangle 162"/>
                <p:cNvSpPr/>
                <p:nvPr/>
              </p:nvSpPr>
              <p:spPr>
                <a:xfrm>
                  <a:off x="6000229" y="3350337"/>
                  <a:ext cx="109537" cy="109525"/>
                </a:xfrm>
                <a:prstGeom prst="rect">
                  <a:avLst/>
                </a:prstGeom>
                <a:solidFill>
                  <a:schemeClr val="accent1">
                    <a:lumMod val="75000"/>
                  </a:schemeClr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164" name="Rectangle 163"/>
                <p:cNvSpPr/>
                <p:nvPr/>
              </p:nvSpPr>
              <p:spPr>
                <a:xfrm>
                  <a:off x="6514579" y="3358274"/>
                  <a:ext cx="111125" cy="109524"/>
                </a:xfrm>
                <a:prstGeom prst="rect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165" name="Rectangle 164"/>
                <p:cNvSpPr/>
                <p:nvPr/>
              </p:nvSpPr>
              <p:spPr>
                <a:xfrm>
                  <a:off x="7140054" y="3350337"/>
                  <a:ext cx="109537" cy="109525"/>
                </a:xfrm>
                <a:prstGeom prst="rect">
                  <a:avLst/>
                </a:prstGeom>
                <a:solidFill>
                  <a:srgbClr val="92D050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166" name="Rectangle 165"/>
                <p:cNvSpPr/>
                <p:nvPr/>
              </p:nvSpPr>
              <p:spPr>
                <a:xfrm>
                  <a:off x="7719491" y="3358274"/>
                  <a:ext cx="109538" cy="109524"/>
                </a:xfrm>
                <a:prstGeom prst="rect">
                  <a:avLst/>
                </a:prstGeom>
                <a:solidFill>
                  <a:srgbClr val="7030A0"/>
                </a:solidFill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167" name="Rectangle 166"/>
                <p:cNvSpPr/>
                <p:nvPr/>
              </p:nvSpPr>
              <p:spPr>
                <a:xfrm>
                  <a:off x="8286229" y="3350337"/>
                  <a:ext cx="109537" cy="109525"/>
                </a:xfrm>
                <a:prstGeom prst="rect">
                  <a:avLst/>
                </a:prstGeom>
                <a:solidFill>
                  <a:schemeClr val="accent5"/>
                </a:solidFill>
                <a:ln>
                  <a:solidFill>
                    <a:schemeClr val="accent5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8206" name="TextBox 167"/>
                <p:cNvSpPr txBox="1">
                  <a:spLocks noChangeArrowheads="1"/>
                </p:cNvSpPr>
                <p:nvPr/>
              </p:nvSpPr>
              <p:spPr bwMode="auto">
                <a:xfrm>
                  <a:off x="616077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0h</a:t>
                  </a:r>
                </a:p>
              </p:txBody>
            </p:sp>
            <p:sp>
              <p:nvSpPr>
                <p:cNvPr id="8207" name="TextBox 168"/>
                <p:cNvSpPr txBox="1">
                  <a:spLocks noChangeArrowheads="1"/>
                </p:cNvSpPr>
                <p:nvPr/>
              </p:nvSpPr>
              <p:spPr bwMode="auto">
                <a:xfrm>
                  <a:off x="6686550" y="330514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6h</a:t>
                  </a:r>
                </a:p>
              </p:txBody>
            </p:sp>
            <p:sp>
              <p:nvSpPr>
                <p:cNvPr id="8208" name="TextBox 169"/>
                <p:cNvSpPr txBox="1">
                  <a:spLocks noChangeArrowheads="1"/>
                </p:cNvSpPr>
                <p:nvPr/>
              </p:nvSpPr>
              <p:spPr bwMode="auto">
                <a:xfrm>
                  <a:off x="729615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24h</a:t>
                  </a:r>
                </a:p>
              </p:txBody>
            </p:sp>
            <p:sp>
              <p:nvSpPr>
                <p:cNvPr id="8209" name="TextBox 170"/>
                <p:cNvSpPr txBox="1">
                  <a:spLocks noChangeArrowheads="1"/>
                </p:cNvSpPr>
                <p:nvPr/>
              </p:nvSpPr>
              <p:spPr bwMode="auto">
                <a:xfrm>
                  <a:off x="787527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48h</a:t>
                  </a:r>
                </a:p>
              </p:txBody>
            </p:sp>
            <p:sp>
              <p:nvSpPr>
                <p:cNvPr id="8210" name="TextBox 171"/>
                <p:cNvSpPr txBox="1">
                  <a:spLocks noChangeArrowheads="1"/>
                </p:cNvSpPr>
                <p:nvPr/>
              </p:nvSpPr>
              <p:spPr bwMode="auto">
                <a:xfrm>
                  <a:off x="843915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72h</a:t>
                  </a:r>
                </a:p>
              </p:txBody>
            </p:sp>
          </p:grpSp>
          <p:sp>
            <p:nvSpPr>
              <p:cNvPr id="8200" name="TextBox 173"/>
              <p:cNvSpPr txBox="1">
                <a:spLocks noChangeArrowheads="1"/>
              </p:cNvSpPr>
              <p:nvPr/>
            </p:nvSpPr>
            <p:spPr bwMode="auto">
              <a:xfrm>
                <a:off x="203202" y="3182779"/>
                <a:ext cx="30480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r>
                  <a:rPr lang="en-US" sz="1600"/>
                  <a:t>b.</a:t>
                </a:r>
              </a:p>
            </p:txBody>
          </p:sp>
        </p:grpSp>
      </p:grpSp>
      <p:sp>
        <p:nvSpPr>
          <p:cNvPr id="8195" name="Rectangle 1"/>
          <p:cNvSpPr>
            <a:spLocks noChangeArrowheads="1"/>
          </p:cNvSpPr>
          <p:nvPr/>
        </p:nvSpPr>
        <p:spPr bwMode="auto">
          <a:xfrm>
            <a:off x="228600" y="6172200"/>
            <a:ext cx="2667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Supplementary Figure S4</a:t>
            </a:r>
            <a:endParaRPr lang="en-US" sz="1400" dirty="0">
              <a:ea typeface="Malgun Gothic" pitchFamily="34" charset="-127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66"/>
          <p:cNvGrpSpPr>
            <a:grpSpLocks/>
          </p:cNvGrpSpPr>
          <p:nvPr/>
        </p:nvGrpSpPr>
        <p:grpSpPr bwMode="auto">
          <a:xfrm>
            <a:off x="15875" y="200025"/>
            <a:ext cx="9144000" cy="5187950"/>
            <a:chOff x="16636" y="200234"/>
            <a:chExt cx="9144000" cy="5187088"/>
          </a:xfrm>
        </p:grpSpPr>
        <p:grpSp>
          <p:nvGrpSpPr>
            <p:cNvPr id="3" name="Group 363"/>
            <p:cNvGrpSpPr>
              <a:grpSpLocks/>
            </p:cNvGrpSpPr>
            <p:nvPr/>
          </p:nvGrpSpPr>
          <p:grpSpPr bwMode="auto">
            <a:xfrm>
              <a:off x="40224" y="200234"/>
              <a:ext cx="9105899" cy="2621717"/>
              <a:chOff x="-120649" y="-79177"/>
              <a:chExt cx="9105899" cy="2621717"/>
            </a:xfrm>
          </p:grpSpPr>
          <p:grpSp>
            <p:nvGrpSpPr>
              <p:cNvPr id="4" name="Group 253"/>
              <p:cNvGrpSpPr>
                <a:grpSpLocks/>
              </p:cNvGrpSpPr>
              <p:nvPr/>
            </p:nvGrpSpPr>
            <p:grpSpPr bwMode="auto">
              <a:xfrm>
                <a:off x="-120649" y="-79177"/>
                <a:ext cx="9105899" cy="2621717"/>
                <a:chOff x="-120649" y="-79177"/>
                <a:chExt cx="9105899" cy="2621717"/>
              </a:xfrm>
            </p:grpSpPr>
            <p:sp>
              <p:nvSpPr>
                <p:cNvPr id="9341" name="TextBox 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-888855" y="831706"/>
                  <a:ext cx="1828800" cy="2923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Relative expression</a:t>
                  </a:r>
                </a:p>
              </p:txBody>
            </p:sp>
            <p:sp>
              <p:nvSpPr>
                <p:cNvPr id="9342" name="TextBox 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852968" y="915844"/>
                  <a:ext cx="1704976" cy="2923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Relative expression</a:t>
                  </a:r>
                </a:p>
              </p:txBody>
            </p:sp>
            <p:sp>
              <p:nvSpPr>
                <p:cNvPr id="9343" name="TextBox 12"/>
                <p:cNvSpPr txBox="1">
                  <a:spLocks noChangeArrowheads="1"/>
                </p:cNvSpPr>
                <p:nvPr/>
              </p:nvSpPr>
              <p:spPr bwMode="auto">
                <a:xfrm>
                  <a:off x="2895600" y="-79177"/>
                  <a:ext cx="2590800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400">
                      <a:latin typeface="Times New Roman" pitchFamily="18" charset="0"/>
                      <a:cs typeface="Times New Roman" pitchFamily="18" charset="0"/>
                    </a:rPr>
                    <a:t>10°C  treatment vs. </a:t>
                  </a:r>
                  <a:r>
                    <a:rPr lang="en-US" sz="1400" i="1">
                      <a:latin typeface="Times New Roman" pitchFamily="18" charset="0"/>
                      <a:cs typeface="Times New Roman" pitchFamily="18" charset="0"/>
                    </a:rPr>
                    <a:t>C. maxima</a:t>
                  </a:r>
                </a:p>
              </p:txBody>
            </p:sp>
            <p:graphicFrame>
              <p:nvGraphicFramePr>
                <p:cNvPr id="159" name="Chart 158"/>
                <p:cNvGraphicFramePr/>
                <p:nvPr/>
              </p:nvGraphicFramePr>
              <p:xfrm>
                <a:off x="38100" y="165100"/>
                <a:ext cx="6583680" cy="23774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graphicFrame>
              <p:nvGraphicFramePr>
                <p:cNvPr id="160" name="Chart 159"/>
                <p:cNvGraphicFramePr/>
                <p:nvPr/>
              </p:nvGraphicFramePr>
              <p:xfrm>
                <a:off x="6699250" y="152400"/>
                <a:ext cx="2286000" cy="23774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9346" name="TextBox 16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127560" y="19343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9347" name="TextBox 16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210411" y="5461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</a:t>
                  </a:r>
                </a:p>
              </p:txBody>
            </p:sp>
            <p:sp>
              <p:nvSpPr>
                <p:cNvPr id="9348" name="TextBox 16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270325" y="11176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h</a:t>
                  </a:r>
                </a:p>
              </p:txBody>
            </p:sp>
            <p:sp>
              <p:nvSpPr>
                <p:cNvPr id="9349" name="TextBox 16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338872" y="13462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i</a:t>
                  </a:r>
                </a:p>
              </p:txBody>
            </p:sp>
            <p:sp>
              <p:nvSpPr>
                <p:cNvPr id="9350" name="TextBox 16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471438" y="147613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</a:t>
                  </a:r>
                </a:p>
              </p:txBody>
            </p:sp>
            <p:sp>
              <p:nvSpPr>
                <p:cNvPr id="9351" name="TextBox 16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541589" y="10552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k</a:t>
                  </a:r>
                </a:p>
              </p:txBody>
            </p:sp>
            <p:sp>
              <p:nvSpPr>
                <p:cNvPr id="9352" name="TextBox 16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626903" y="114351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</a:t>
                  </a:r>
                </a:p>
              </p:txBody>
            </p:sp>
            <p:sp>
              <p:nvSpPr>
                <p:cNvPr id="9353" name="TextBox 16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695450" y="137211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i</a:t>
                  </a:r>
                </a:p>
              </p:txBody>
            </p:sp>
            <p:sp>
              <p:nvSpPr>
                <p:cNvPr id="9354" name="TextBox 16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820688" y="14824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</a:t>
                  </a:r>
                </a:p>
              </p:txBody>
            </p:sp>
            <p:sp>
              <p:nvSpPr>
                <p:cNvPr id="9355" name="TextBox 16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890839" y="106159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jk</a:t>
                  </a:r>
                </a:p>
              </p:txBody>
            </p:sp>
            <p:sp>
              <p:nvSpPr>
                <p:cNvPr id="9356" name="TextBox 17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976153" y="114986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</a:t>
                  </a:r>
                </a:p>
              </p:txBody>
            </p:sp>
            <p:sp>
              <p:nvSpPr>
                <p:cNvPr id="9357" name="TextBox 17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044700" y="137846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i</a:t>
                  </a:r>
                </a:p>
              </p:txBody>
            </p:sp>
            <p:sp>
              <p:nvSpPr>
                <p:cNvPr id="9358" name="TextBox 17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184310" y="13477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g</a:t>
                  </a:r>
                </a:p>
              </p:txBody>
            </p:sp>
            <p:sp>
              <p:nvSpPr>
                <p:cNvPr id="9359" name="TextBox 17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242428" y="86269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-i</a:t>
                  </a:r>
                </a:p>
              </p:txBody>
            </p:sp>
            <p:sp>
              <p:nvSpPr>
                <p:cNvPr id="9360" name="TextBox 17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297028" y="5715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e</a:t>
                  </a:r>
                </a:p>
              </p:txBody>
            </p:sp>
            <p:sp>
              <p:nvSpPr>
                <p:cNvPr id="9361" name="TextBox 17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388267" y="65012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9362" name="TextBox 17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553304" y="230655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9363" name="TextBox 17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611422" y="6380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</a:t>
                  </a:r>
                </a:p>
              </p:txBody>
            </p:sp>
            <p:sp>
              <p:nvSpPr>
                <p:cNvPr id="9364" name="TextBox 17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685072" y="5354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e</a:t>
                  </a:r>
                </a:p>
              </p:txBody>
            </p:sp>
            <p:sp>
              <p:nvSpPr>
                <p:cNvPr id="9365" name="TextBox 17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737188" y="856245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366" name="TextBox 18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910265" y="270747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9367" name="TextBox 18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968383" y="678152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-h</a:t>
                  </a:r>
                </a:p>
              </p:txBody>
            </p:sp>
            <p:sp>
              <p:nvSpPr>
                <p:cNvPr id="9368" name="TextBox 18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042033" y="57549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e</a:t>
                  </a:r>
                </a:p>
              </p:txBody>
            </p:sp>
            <p:sp>
              <p:nvSpPr>
                <p:cNvPr id="9369" name="TextBox 18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094149" y="896337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-h</a:t>
                  </a:r>
                </a:p>
              </p:txBody>
            </p:sp>
            <p:sp>
              <p:nvSpPr>
                <p:cNvPr id="9370" name="TextBox 18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247125" y="1241265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g</a:t>
                  </a:r>
                </a:p>
              </p:txBody>
            </p:sp>
            <p:sp>
              <p:nvSpPr>
                <p:cNvPr id="9371" name="TextBox 18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313265" y="116749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-k</a:t>
                  </a:r>
                </a:p>
              </p:txBody>
            </p:sp>
            <p:sp>
              <p:nvSpPr>
                <p:cNvPr id="9372" name="TextBox 18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386915" y="9525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</a:t>
                  </a:r>
                </a:p>
              </p:txBody>
            </p:sp>
            <p:sp>
              <p:nvSpPr>
                <p:cNvPr id="9373" name="TextBox 18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439031" y="13856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i</a:t>
                  </a:r>
                </a:p>
              </p:txBody>
            </p:sp>
            <p:sp>
              <p:nvSpPr>
                <p:cNvPr id="9374" name="TextBox 18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596037" y="108096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375" name="TextBox 18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686243" y="79609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g</a:t>
                  </a:r>
                </a:p>
              </p:txBody>
            </p:sp>
            <p:sp>
              <p:nvSpPr>
                <p:cNvPr id="9376" name="TextBox 19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759893" y="114104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</a:t>
                  </a:r>
                </a:p>
              </p:txBody>
            </p:sp>
            <p:sp>
              <p:nvSpPr>
                <p:cNvPr id="9377" name="TextBox 19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812009" y="146188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i</a:t>
                  </a:r>
                </a:p>
              </p:txBody>
            </p:sp>
            <p:sp>
              <p:nvSpPr>
                <p:cNvPr id="9378" name="TextBox 19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957009" y="14859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</a:t>
                  </a:r>
                </a:p>
              </p:txBody>
            </p:sp>
            <p:sp>
              <p:nvSpPr>
                <p:cNvPr id="9379" name="TextBox 19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027160" y="13335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i-k</a:t>
                  </a:r>
                </a:p>
              </p:txBody>
            </p:sp>
            <p:sp>
              <p:nvSpPr>
                <p:cNvPr id="9380" name="TextBox 19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100810" y="12573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</a:t>
                  </a:r>
                </a:p>
              </p:txBody>
            </p:sp>
            <p:sp>
              <p:nvSpPr>
                <p:cNvPr id="9381" name="TextBox 19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152926" y="145785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i</a:t>
                  </a:r>
                </a:p>
              </p:txBody>
            </p:sp>
            <p:sp>
              <p:nvSpPr>
                <p:cNvPr id="9382" name="TextBox 19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313917" y="924522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e</a:t>
                  </a:r>
                </a:p>
              </p:txBody>
            </p:sp>
            <p:sp>
              <p:nvSpPr>
                <p:cNvPr id="9383" name="TextBox 19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372035" y="73593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-h</a:t>
                  </a:r>
                </a:p>
              </p:txBody>
            </p:sp>
            <p:sp>
              <p:nvSpPr>
                <p:cNvPr id="9384" name="TextBox 19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469751" y="6477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385" name="TextBox 20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529889" y="130544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-i</a:t>
                  </a:r>
                </a:p>
              </p:txBody>
            </p:sp>
            <p:sp>
              <p:nvSpPr>
                <p:cNvPr id="9386" name="TextBox 20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686300" y="14859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</a:t>
                  </a:r>
                </a:p>
              </p:txBody>
            </p:sp>
            <p:sp>
              <p:nvSpPr>
                <p:cNvPr id="9387" name="TextBox 20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741002" y="12573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k</a:t>
                  </a:r>
                </a:p>
              </p:txBody>
            </p:sp>
            <p:sp>
              <p:nvSpPr>
                <p:cNvPr id="9388" name="TextBox 20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814652" y="118314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</a:t>
                  </a:r>
                </a:p>
              </p:txBody>
            </p:sp>
            <p:sp>
              <p:nvSpPr>
                <p:cNvPr id="9389" name="TextBox 20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866768" y="154209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i</a:t>
                  </a:r>
                </a:p>
              </p:txBody>
            </p:sp>
            <p:sp>
              <p:nvSpPr>
                <p:cNvPr id="9390" name="TextBox 20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035825" y="1405842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</a:t>
                  </a:r>
                </a:p>
              </p:txBody>
            </p:sp>
            <p:sp>
              <p:nvSpPr>
                <p:cNvPr id="9391" name="TextBox 20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089932" y="106480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-k</a:t>
                  </a:r>
                </a:p>
              </p:txBody>
            </p:sp>
            <p:sp>
              <p:nvSpPr>
                <p:cNvPr id="9392" name="TextBox 20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163582" y="8001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-g</a:t>
                  </a:r>
                </a:p>
              </p:txBody>
            </p:sp>
            <p:sp>
              <p:nvSpPr>
                <p:cNvPr id="9393" name="TextBox 20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235753" y="97255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-g</a:t>
                  </a:r>
                </a:p>
              </p:txBody>
            </p:sp>
            <p:sp>
              <p:nvSpPr>
                <p:cNvPr id="9394" name="TextBox 21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400186" y="148989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</a:t>
                  </a:r>
                </a:p>
              </p:txBody>
            </p:sp>
            <p:sp>
              <p:nvSpPr>
                <p:cNvPr id="9395" name="TextBox 21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454888" y="126129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k</a:t>
                  </a:r>
                </a:p>
              </p:txBody>
            </p:sp>
            <p:sp>
              <p:nvSpPr>
                <p:cNvPr id="9396" name="TextBox 21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528538" y="12252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</a:t>
                  </a:r>
                </a:p>
              </p:txBody>
            </p:sp>
            <p:sp>
              <p:nvSpPr>
                <p:cNvPr id="9397" name="TextBox 21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580654" y="154608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i</a:t>
                  </a:r>
                </a:p>
              </p:txBody>
            </p:sp>
            <p:sp>
              <p:nvSpPr>
                <p:cNvPr id="9398" name="TextBox 21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757147" y="142971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</a:t>
                  </a:r>
                </a:p>
              </p:txBody>
            </p:sp>
            <p:sp>
              <p:nvSpPr>
                <p:cNvPr id="9399" name="TextBox 21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811849" y="120111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k</a:t>
                  </a:r>
                </a:p>
              </p:txBody>
            </p:sp>
            <p:sp>
              <p:nvSpPr>
                <p:cNvPr id="9400" name="TextBox 21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885499" y="111425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</a:t>
                  </a:r>
                </a:p>
              </p:txBody>
            </p:sp>
            <p:sp>
              <p:nvSpPr>
                <p:cNvPr id="9401" name="TextBox 22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937615" y="14859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i</a:t>
                  </a:r>
                </a:p>
              </p:txBody>
            </p:sp>
            <p:sp>
              <p:nvSpPr>
                <p:cNvPr id="9402" name="TextBox 22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114054" y="148586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</a:t>
                  </a:r>
                </a:p>
              </p:txBody>
            </p:sp>
            <p:sp>
              <p:nvSpPr>
                <p:cNvPr id="9403" name="TextBox 22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156723" y="110892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-k</a:t>
                  </a:r>
                </a:p>
              </p:txBody>
            </p:sp>
            <p:sp>
              <p:nvSpPr>
                <p:cNvPr id="9404" name="TextBox 22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234384" y="8001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-g</a:t>
                  </a:r>
                </a:p>
              </p:txBody>
            </p:sp>
            <p:sp>
              <p:nvSpPr>
                <p:cNvPr id="9405" name="TextBox 22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294522" y="580857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406" name="TextBox 22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136732" y="1449765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9407" name="TextBox 22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191434" y="58753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9408" name="TextBox 22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245029" y="13335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9409" name="TextBox 22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317200" y="102877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9410" name="TextBox 22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469600" y="110496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</a:t>
                  </a:r>
                </a:p>
              </p:txBody>
            </p:sp>
            <p:sp>
              <p:nvSpPr>
                <p:cNvPr id="9411" name="TextBox 23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521725" y="66373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9412" name="TextBox 23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597916" y="84822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</a:t>
                  </a:r>
                </a:p>
              </p:txBody>
            </p:sp>
            <p:sp>
              <p:nvSpPr>
                <p:cNvPr id="9413" name="TextBox 23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662074" y="1052767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9414" name="TextBox 23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802495" y="1092913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</a:t>
                  </a:r>
                </a:p>
              </p:txBody>
            </p:sp>
            <p:sp>
              <p:nvSpPr>
                <p:cNvPr id="9415" name="TextBox 23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854620" y="57547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9416" name="TextBox 23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938833" y="880294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</a:t>
                  </a:r>
                </a:p>
              </p:txBody>
            </p:sp>
            <p:sp>
              <p:nvSpPr>
                <p:cNvPr id="9417" name="TextBox 23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994969" y="1076815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9418" name="TextBox 23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151426" y="83219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9419" name="TextBox 23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195529" y="34684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</a:t>
                  </a:r>
                </a:p>
              </p:txBody>
            </p:sp>
            <p:sp>
              <p:nvSpPr>
                <p:cNvPr id="9420" name="TextBox 23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271720" y="531337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9421" name="TextBox 24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335878" y="7358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</a:t>
                  </a:r>
                </a:p>
              </p:txBody>
            </p:sp>
            <p:sp>
              <p:nvSpPr>
                <p:cNvPr id="9422" name="TextBox 24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480310" y="98459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</a:t>
                  </a:r>
                </a:p>
              </p:txBody>
            </p:sp>
            <p:sp>
              <p:nvSpPr>
                <p:cNvPr id="9423" name="TextBox 24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536446" y="2667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9424" name="TextBox 24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600604" y="683737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9425" name="TextBox 24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664762" y="407068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9426" name="TextBox 24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94277" y="133698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</a:t>
                  </a:r>
                </a:p>
              </p:txBody>
            </p:sp>
            <p:sp>
              <p:nvSpPr>
                <p:cNvPr id="9427" name="TextBox 24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82144" y="11273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-k</a:t>
                  </a:r>
                </a:p>
              </p:txBody>
            </p:sp>
            <p:sp>
              <p:nvSpPr>
                <p:cNvPr id="9428" name="TextBox 24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43392" y="89874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-h</a:t>
                  </a:r>
                </a:p>
              </p:txBody>
            </p:sp>
            <p:sp>
              <p:nvSpPr>
                <p:cNvPr id="9429" name="TextBox 24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15950" y="1115316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-i</a:t>
                  </a:r>
                </a:p>
              </p:txBody>
            </p:sp>
            <p:sp>
              <p:nvSpPr>
                <p:cNvPr id="9430" name="TextBox 24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59260" y="132894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g</a:t>
                  </a:r>
                </a:p>
              </p:txBody>
            </p:sp>
            <p:sp>
              <p:nvSpPr>
                <p:cNvPr id="9431" name="TextBox 25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23061" y="869207"/>
                  <a:ext cx="228600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-j</a:t>
                  </a:r>
                </a:p>
              </p:txBody>
            </p:sp>
            <p:sp>
              <p:nvSpPr>
                <p:cNvPr id="9432" name="TextBox 25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927425" y="95822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-h</a:t>
                  </a:r>
                </a:p>
              </p:txBody>
            </p:sp>
            <p:sp>
              <p:nvSpPr>
                <p:cNvPr id="9433" name="TextBox 25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983272" y="118682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-i</a:t>
                  </a:r>
                </a:p>
              </p:txBody>
            </p:sp>
          </p:grpSp>
          <p:grpSp>
            <p:nvGrpSpPr>
              <p:cNvPr id="5" name="Group 351"/>
              <p:cNvGrpSpPr>
                <a:grpSpLocks/>
              </p:cNvGrpSpPr>
              <p:nvPr/>
            </p:nvGrpSpPr>
            <p:grpSpPr bwMode="auto">
              <a:xfrm>
                <a:off x="6153150" y="-76200"/>
                <a:ext cx="2743200" cy="207675"/>
                <a:chOff x="6000750" y="3297525"/>
                <a:chExt cx="2743200" cy="207675"/>
              </a:xfrm>
            </p:grpSpPr>
            <p:sp>
              <p:nvSpPr>
                <p:cNvPr id="353" name="Rectangle 352"/>
                <p:cNvSpPr/>
                <p:nvPr/>
              </p:nvSpPr>
              <p:spPr>
                <a:xfrm>
                  <a:off x="6000976" y="3351689"/>
                  <a:ext cx="109537" cy="109520"/>
                </a:xfrm>
                <a:prstGeom prst="rect">
                  <a:avLst/>
                </a:prstGeom>
                <a:solidFill>
                  <a:schemeClr val="accent1">
                    <a:lumMod val="75000"/>
                  </a:schemeClr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354" name="Rectangle 353"/>
                <p:cNvSpPr/>
                <p:nvPr/>
              </p:nvSpPr>
              <p:spPr>
                <a:xfrm>
                  <a:off x="6515326" y="3358038"/>
                  <a:ext cx="111125" cy="111106"/>
                </a:xfrm>
                <a:prstGeom prst="rect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355" name="Rectangle 354"/>
                <p:cNvSpPr/>
                <p:nvPr/>
              </p:nvSpPr>
              <p:spPr>
                <a:xfrm>
                  <a:off x="7140801" y="3351689"/>
                  <a:ext cx="109537" cy="109520"/>
                </a:xfrm>
                <a:prstGeom prst="rect">
                  <a:avLst/>
                </a:prstGeom>
                <a:solidFill>
                  <a:srgbClr val="92D050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356" name="Rectangle 355"/>
                <p:cNvSpPr/>
                <p:nvPr/>
              </p:nvSpPr>
              <p:spPr>
                <a:xfrm>
                  <a:off x="7720238" y="3358038"/>
                  <a:ext cx="109538" cy="111106"/>
                </a:xfrm>
                <a:prstGeom prst="rect">
                  <a:avLst/>
                </a:prstGeom>
                <a:solidFill>
                  <a:srgbClr val="7030A0"/>
                </a:solidFill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357" name="Rectangle 356"/>
                <p:cNvSpPr/>
                <p:nvPr/>
              </p:nvSpPr>
              <p:spPr>
                <a:xfrm>
                  <a:off x="8286976" y="3351689"/>
                  <a:ext cx="109537" cy="109520"/>
                </a:xfrm>
                <a:prstGeom prst="rect">
                  <a:avLst/>
                </a:prstGeom>
                <a:solidFill>
                  <a:schemeClr val="accent5"/>
                </a:solidFill>
                <a:ln>
                  <a:solidFill>
                    <a:schemeClr val="accent5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9336" name="TextBox 357"/>
                <p:cNvSpPr txBox="1">
                  <a:spLocks noChangeArrowheads="1"/>
                </p:cNvSpPr>
                <p:nvPr/>
              </p:nvSpPr>
              <p:spPr bwMode="auto">
                <a:xfrm>
                  <a:off x="616077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0h</a:t>
                  </a:r>
                </a:p>
              </p:txBody>
            </p:sp>
            <p:sp>
              <p:nvSpPr>
                <p:cNvPr id="9337" name="TextBox 358"/>
                <p:cNvSpPr txBox="1">
                  <a:spLocks noChangeArrowheads="1"/>
                </p:cNvSpPr>
                <p:nvPr/>
              </p:nvSpPr>
              <p:spPr bwMode="auto">
                <a:xfrm>
                  <a:off x="6686550" y="330514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6h</a:t>
                  </a:r>
                </a:p>
              </p:txBody>
            </p:sp>
            <p:sp>
              <p:nvSpPr>
                <p:cNvPr id="9338" name="TextBox 359"/>
                <p:cNvSpPr txBox="1">
                  <a:spLocks noChangeArrowheads="1"/>
                </p:cNvSpPr>
                <p:nvPr/>
              </p:nvSpPr>
              <p:spPr bwMode="auto">
                <a:xfrm>
                  <a:off x="729615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24h</a:t>
                  </a:r>
                </a:p>
              </p:txBody>
            </p:sp>
            <p:sp>
              <p:nvSpPr>
                <p:cNvPr id="9339" name="TextBox 360"/>
                <p:cNvSpPr txBox="1">
                  <a:spLocks noChangeArrowheads="1"/>
                </p:cNvSpPr>
                <p:nvPr/>
              </p:nvSpPr>
              <p:spPr bwMode="auto">
                <a:xfrm>
                  <a:off x="787527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48h</a:t>
                  </a:r>
                </a:p>
              </p:txBody>
            </p:sp>
            <p:sp>
              <p:nvSpPr>
                <p:cNvPr id="9340" name="TextBox 361"/>
                <p:cNvSpPr txBox="1">
                  <a:spLocks noChangeArrowheads="1"/>
                </p:cNvSpPr>
                <p:nvPr/>
              </p:nvSpPr>
              <p:spPr bwMode="auto">
                <a:xfrm>
                  <a:off x="843915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72h</a:t>
                  </a:r>
                </a:p>
              </p:txBody>
            </p:sp>
          </p:grpSp>
          <p:sp>
            <p:nvSpPr>
              <p:cNvPr id="9330" name="TextBox 362"/>
              <p:cNvSpPr txBox="1">
                <a:spLocks noChangeArrowheads="1"/>
              </p:cNvSpPr>
              <p:nvPr/>
            </p:nvSpPr>
            <p:spPr bwMode="auto">
              <a:xfrm>
                <a:off x="-13087" y="-76212"/>
                <a:ext cx="30480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r>
                  <a:rPr lang="en-US" sz="1600"/>
                  <a:t>c.</a:t>
                </a:r>
              </a:p>
            </p:txBody>
          </p:sp>
        </p:grpSp>
        <p:grpSp>
          <p:nvGrpSpPr>
            <p:cNvPr id="6" name="Group 365"/>
            <p:cNvGrpSpPr>
              <a:grpSpLocks/>
            </p:cNvGrpSpPr>
            <p:nvPr/>
          </p:nvGrpSpPr>
          <p:grpSpPr bwMode="auto">
            <a:xfrm>
              <a:off x="16636" y="2730236"/>
              <a:ext cx="9144000" cy="2657086"/>
              <a:chOff x="202911" y="3187454"/>
              <a:chExt cx="8944899" cy="2657086"/>
            </a:xfrm>
          </p:grpSpPr>
          <p:grpSp>
            <p:nvGrpSpPr>
              <p:cNvPr id="7" name="Group 344"/>
              <p:cNvGrpSpPr>
                <a:grpSpLocks/>
              </p:cNvGrpSpPr>
              <p:nvPr/>
            </p:nvGrpSpPr>
            <p:grpSpPr bwMode="auto">
              <a:xfrm>
                <a:off x="202911" y="3197423"/>
                <a:ext cx="8944899" cy="2647117"/>
                <a:chOff x="202911" y="3197423"/>
                <a:chExt cx="8944899" cy="2647117"/>
              </a:xfrm>
            </p:grpSpPr>
            <p:sp>
              <p:nvSpPr>
                <p:cNvPr id="9235" name="TextBox 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-565295" y="4216256"/>
                  <a:ext cx="1828800" cy="2923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Relative expression</a:t>
                  </a:r>
                </a:p>
              </p:txBody>
            </p:sp>
            <p:sp>
              <p:nvSpPr>
                <p:cNvPr id="9236" name="TextBox 1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659293" y="4211494"/>
                  <a:ext cx="1628776" cy="2923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Relative expression</a:t>
                  </a:r>
                </a:p>
              </p:txBody>
            </p:sp>
            <p:sp>
              <p:nvSpPr>
                <p:cNvPr id="9237" name="TextBox 13"/>
                <p:cNvSpPr txBox="1">
                  <a:spLocks noChangeArrowheads="1"/>
                </p:cNvSpPr>
                <p:nvPr/>
              </p:nvSpPr>
              <p:spPr bwMode="auto">
                <a:xfrm>
                  <a:off x="2895600" y="3197423"/>
                  <a:ext cx="2590800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400">
                      <a:latin typeface="Times New Roman" pitchFamily="18" charset="0"/>
                      <a:cs typeface="Times New Roman" pitchFamily="18" charset="0"/>
                    </a:rPr>
                    <a:t>10°C  treatment vs. </a:t>
                  </a:r>
                  <a:r>
                    <a:rPr lang="en-US" sz="1400" i="1">
                      <a:latin typeface="Times New Roman" pitchFamily="18" charset="0"/>
                      <a:cs typeface="Times New Roman" pitchFamily="18" charset="0"/>
                    </a:rPr>
                    <a:t>C. moschta</a:t>
                  </a:r>
                </a:p>
              </p:txBody>
            </p:sp>
            <p:graphicFrame>
              <p:nvGraphicFramePr>
                <p:cNvPr id="255" name="Chart 254"/>
                <p:cNvGraphicFramePr/>
                <p:nvPr/>
              </p:nvGraphicFramePr>
              <p:xfrm>
                <a:off x="381000" y="3467100"/>
                <a:ext cx="6126480" cy="23774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graphicFrame>
              <p:nvGraphicFramePr>
                <p:cNvPr id="256" name="Chart 255"/>
                <p:cNvGraphicFramePr/>
                <p:nvPr/>
              </p:nvGraphicFramePr>
              <p:xfrm>
                <a:off x="6496050" y="3457575"/>
                <a:ext cx="2651760" cy="23774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sp>
              <p:nvSpPr>
                <p:cNvPr id="9240" name="TextBox 25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03276" y="40767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g</a:t>
                  </a:r>
                </a:p>
              </p:txBody>
            </p:sp>
            <p:sp>
              <p:nvSpPr>
                <p:cNvPr id="9241" name="TextBox 25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79476" y="45085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-g</a:t>
                  </a:r>
                </a:p>
              </p:txBody>
            </p:sp>
            <p:sp>
              <p:nvSpPr>
                <p:cNvPr id="9242" name="TextBox 25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935356" y="47117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243" name="TextBox 25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092836" y="476631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</a:t>
                  </a:r>
                </a:p>
              </p:txBody>
            </p:sp>
            <p:sp>
              <p:nvSpPr>
                <p:cNvPr id="9244" name="TextBox 26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143636" y="43815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</a:t>
                  </a:r>
                </a:p>
              </p:txBody>
            </p:sp>
            <p:sp>
              <p:nvSpPr>
                <p:cNvPr id="9245" name="TextBox 26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219836" y="45694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g</a:t>
                  </a:r>
                </a:p>
              </p:txBody>
            </p:sp>
            <p:sp>
              <p:nvSpPr>
                <p:cNvPr id="9246" name="TextBox 26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275716" y="47726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247" name="TextBox 26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440180" y="466979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e</a:t>
                  </a:r>
                </a:p>
              </p:txBody>
            </p:sp>
            <p:sp>
              <p:nvSpPr>
                <p:cNvPr id="9248" name="TextBox 26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490981" y="42341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-h</a:t>
                  </a:r>
                </a:p>
              </p:txBody>
            </p:sp>
            <p:sp>
              <p:nvSpPr>
                <p:cNvPr id="9249" name="TextBox 26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567180" y="44729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-g</a:t>
                  </a:r>
                </a:p>
              </p:txBody>
            </p:sp>
            <p:sp>
              <p:nvSpPr>
                <p:cNvPr id="9250" name="TextBox 26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633220" y="42951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-f</a:t>
                  </a:r>
                </a:p>
              </p:txBody>
            </p:sp>
            <p:sp>
              <p:nvSpPr>
                <p:cNvPr id="9251" name="TextBox 26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795780" y="478663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252" name="TextBox 26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846580" y="43053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-h</a:t>
                  </a:r>
                </a:p>
              </p:txBody>
            </p:sp>
            <p:sp>
              <p:nvSpPr>
                <p:cNvPr id="9253" name="TextBox 26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922780" y="45897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</a:t>
                  </a:r>
                </a:p>
              </p:txBody>
            </p:sp>
            <p:sp>
              <p:nvSpPr>
                <p:cNvPr id="9254" name="TextBox 27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978660" y="47929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255" name="TextBox 27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156460" y="458851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9256" name="TextBox 27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207260" y="41681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h</a:t>
                  </a:r>
                </a:p>
              </p:txBody>
            </p:sp>
            <p:sp>
              <p:nvSpPr>
                <p:cNvPr id="9257" name="TextBox 27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283460" y="43916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-g</a:t>
                  </a:r>
                </a:p>
              </p:txBody>
            </p:sp>
            <p:sp>
              <p:nvSpPr>
                <p:cNvPr id="9258" name="TextBox 27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339340" y="45948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259" name="TextBox 27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506979" y="456819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</a:t>
                  </a:r>
                </a:p>
              </p:txBody>
            </p:sp>
            <p:sp>
              <p:nvSpPr>
                <p:cNvPr id="9260" name="TextBox 27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557779" y="39395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g</a:t>
                  </a:r>
                </a:p>
              </p:txBody>
            </p:sp>
            <p:sp>
              <p:nvSpPr>
                <p:cNvPr id="9261" name="TextBox 27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628899" y="42900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-g</a:t>
                  </a:r>
                </a:p>
              </p:txBody>
            </p:sp>
            <p:sp>
              <p:nvSpPr>
                <p:cNvPr id="9262" name="TextBox 27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689859" y="409702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e</a:t>
                  </a:r>
                </a:p>
              </p:txBody>
            </p:sp>
            <p:sp>
              <p:nvSpPr>
                <p:cNvPr id="9263" name="TextBox 27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852419" y="477647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-f</a:t>
                  </a:r>
                </a:p>
              </p:txBody>
            </p:sp>
            <p:sp>
              <p:nvSpPr>
                <p:cNvPr id="9264" name="TextBox 28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903219" y="44983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</a:t>
                  </a:r>
                </a:p>
              </p:txBody>
            </p:sp>
            <p:sp>
              <p:nvSpPr>
                <p:cNvPr id="9265" name="TextBox 28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979419" y="457962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g</a:t>
                  </a:r>
                </a:p>
              </p:txBody>
            </p:sp>
            <p:sp>
              <p:nvSpPr>
                <p:cNvPr id="9266" name="TextBox 28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035299" y="478282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267" name="TextBox 28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202939" y="469519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-f</a:t>
                  </a:r>
                </a:p>
              </p:txBody>
            </p:sp>
            <p:sp>
              <p:nvSpPr>
                <p:cNvPr id="9268" name="TextBox 28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253739" y="44932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</a:t>
                  </a:r>
                </a:p>
              </p:txBody>
            </p:sp>
            <p:sp>
              <p:nvSpPr>
                <p:cNvPr id="9269" name="TextBox 28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329939" y="44221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-g</a:t>
                  </a:r>
                </a:p>
              </p:txBody>
            </p:sp>
            <p:sp>
              <p:nvSpPr>
                <p:cNvPr id="9270" name="TextBox 28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385819" y="47015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271" name="TextBox 28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558539" y="467487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-f</a:t>
                  </a:r>
                </a:p>
              </p:txBody>
            </p:sp>
            <p:sp>
              <p:nvSpPr>
                <p:cNvPr id="9272" name="TextBox 28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609339" y="44729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</a:t>
                  </a:r>
                </a:p>
              </p:txBody>
            </p:sp>
            <p:sp>
              <p:nvSpPr>
                <p:cNvPr id="9273" name="TextBox 28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675379" y="427482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-g</a:t>
                  </a:r>
                </a:p>
              </p:txBody>
            </p:sp>
            <p:sp>
              <p:nvSpPr>
                <p:cNvPr id="9274" name="TextBox 29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741419" y="468122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275" name="TextBox 29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903980" y="402971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9276" name="TextBox 29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954780" y="38277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 dirty="0" err="1"/>
                    <a:t>ef</a:t>
                  </a:r>
                  <a:endParaRPr lang="en-US" sz="1000" dirty="0"/>
                </a:p>
              </p:txBody>
            </p:sp>
            <p:sp>
              <p:nvSpPr>
                <p:cNvPr id="9277" name="TextBox 29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030980" y="44119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g</a:t>
                  </a:r>
                </a:p>
              </p:txBody>
            </p:sp>
            <p:sp>
              <p:nvSpPr>
                <p:cNvPr id="9278" name="TextBox 29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086860" y="46913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279" name="TextBox 29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254500" y="473583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280" name="TextBox 29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300220" y="43053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-h</a:t>
                  </a:r>
                </a:p>
              </p:txBody>
            </p:sp>
            <p:sp>
              <p:nvSpPr>
                <p:cNvPr id="9281" name="TextBox 29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356100" y="40005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282" name="TextBox 29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437380" y="375158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9283" name="TextBox 29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605020" y="460883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284" name="TextBox 30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655820" y="347726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9285" name="TextBox 30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732020" y="42595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-g</a:t>
                  </a:r>
                </a:p>
              </p:txBody>
            </p:sp>
            <p:sp>
              <p:nvSpPr>
                <p:cNvPr id="9286" name="TextBox 30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787900" y="46151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287" name="TextBox 30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955540" y="472059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-f</a:t>
                  </a:r>
                </a:p>
              </p:txBody>
            </p:sp>
            <p:sp>
              <p:nvSpPr>
                <p:cNvPr id="9288" name="TextBox 30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001260" y="45186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</a:t>
                  </a:r>
                </a:p>
              </p:txBody>
            </p:sp>
            <p:sp>
              <p:nvSpPr>
                <p:cNvPr id="9289" name="TextBox 30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077460" y="44475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-g</a:t>
                  </a:r>
                </a:p>
              </p:txBody>
            </p:sp>
            <p:sp>
              <p:nvSpPr>
                <p:cNvPr id="9290" name="TextBox 30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138420" y="47269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</a:t>
                  </a:r>
                </a:p>
              </p:txBody>
            </p:sp>
            <p:sp>
              <p:nvSpPr>
                <p:cNvPr id="9291" name="TextBox 30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300980" y="461391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292" name="TextBox 30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351780" y="40513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g</a:t>
                  </a:r>
                </a:p>
              </p:txBody>
            </p:sp>
            <p:sp>
              <p:nvSpPr>
                <p:cNvPr id="9293" name="TextBox 30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427980" y="391414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9294" name="TextBox 31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494020" y="46202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295" name="TextBox 31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666740" y="421386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9296" name="TextBox 31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717540" y="44119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</a:t>
                  </a:r>
                </a:p>
              </p:txBody>
            </p:sp>
            <p:sp>
              <p:nvSpPr>
                <p:cNvPr id="9297" name="TextBox 31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793740" y="45440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g</a:t>
                  </a:r>
                </a:p>
              </p:txBody>
            </p:sp>
            <p:sp>
              <p:nvSpPr>
                <p:cNvPr id="9298" name="TextBox 31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849620" y="47726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299" name="TextBox 31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002020" y="472567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300" name="TextBox 31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052820" y="45237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</a:t>
                  </a:r>
                </a:p>
              </p:txBody>
            </p:sp>
            <p:sp>
              <p:nvSpPr>
                <p:cNvPr id="9301" name="TextBox 31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108700" y="43053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-g</a:t>
                  </a:r>
                </a:p>
              </p:txBody>
            </p:sp>
            <p:sp>
              <p:nvSpPr>
                <p:cNvPr id="9302" name="TextBox 31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184900" y="413258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f</a:t>
                  </a:r>
                </a:p>
              </p:txBody>
            </p:sp>
            <p:sp>
              <p:nvSpPr>
                <p:cNvPr id="9303" name="TextBox 31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870700" y="464439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9304" name="TextBox 32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921500" y="33705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9305" name="TextBox 32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997700" y="35737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9306" name="TextBox 32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053580" y="390398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9307" name="TextBox 32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221220" y="490347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308" name="TextBox 32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272020" y="43053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9309" name="TextBox 32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348220" y="42291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9310" name="TextBox 32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414260" y="46863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9311" name="TextBox 32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576820" y="479679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-f</a:t>
                  </a:r>
                </a:p>
              </p:txBody>
            </p:sp>
            <p:sp>
              <p:nvSpPr>
                <p:cNvPr id="9312" name="TextBox 32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612380" y="38481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</a:t>
                  </a:r>
                </a:p>
              </p:txBody>
            </p:sp>
            <p:sp>
              <p:nvSpPr>
                <p:cNvPr id="9313" name="TextBox 32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703820" y="39039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</a:t>
                  </a:r>
                </a:p>
              </p:txBody>
            </p:sp>
            <p:sp>
              <p:nvSpPr>
                <p:cNvPr id="9314" name="TextBox 33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774940" y="414782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</a:t>
                  </a:r>
                </a:p>
              </p:txBody>
            </p:sp>
            <p:sp>
              <p:nvSpPr>
                <p:cNvPr id="9315" name="TextBox 33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932420" y="479679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</a:t>
                  </a:r>
                </a:p>
              </p:txBody>
            </p:sp>
            <p:sp>
              <p:nvSpPr>
                <p:cNvPr id="9316" name="TextBox 33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983220" y="40767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9317" name="TextBox 33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074660" y="42799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9318" name="TextBox 33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130540" y="46101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9319" name="TextBox 33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288020" y="479679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9320" name="TextBox 33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338820" y="45339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9321" name="TextBox 33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404860" y="36093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9322" name="TextBox 33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470900" y="405638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</a:t>
                  </a:r>
                </a:p>
              </p:txBody>
            </p:sp>
            <p:sp>
              <p:nvSpPr>
                <p:cNvPr id="9323" name="TextBox 33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643620" y="479679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-f</a:t>
                  </a:r>
                </a:p>
              </p:txBody>
            </p:sp>
            <p:sp>
              <p:nvSpPr>
                <p:cNvPr id="9324" name="TextBox 34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694420" y="42291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9325" name="TextBox 34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755380" y="34671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9326" name="TextBox 34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826500" y="405638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</a:t>
                  </a:r>
                </a:p>
              </p:txBody>
            </p:sp>
            <p:sp>
              <p:nvSpPr>
                <p:cNvPr id="9327" name="TextBox 34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49301" y="476123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</p:grpSp>
          <p:grpSp>
            <p:nvGrpSpPr>
              <p:cNvPr id="8" name="Group 192"/>
              <p:cNvGrpSpPr>
                <a:grpSpLocks/>
              </p:cNvGrpSpPr>
              <p:nvPr/>
            </p:nvGrpSpPr>
            <p:grpSpPr bwMode="auto">
              <a:xfrm>
                <a:off x="6000750" y="3187454"/>
                <a:ext cx="2743200" cy="207675"/>
                <a:chOff x="6000750" y="3297525"/>
                <a:chExt cx="2743200" cy="207675"/>
              </a:xfrm>
            </p:grpSpPr>
            <p:sp>
              <p:nvSpPr>
                <p:cNvPr id="210" name="Rectangle 209"/>
                <p:cNvSpPr/>
                <p:nvPr/>
              </p:nvSpPr>
              <p:spPr>
                <a:xfrm>
                  <a:off x="6000013" y="3351544"/>
                  <a:ext cx="110258" cy="109520"/>
                </a:xfrm>
                <a:prstGeom prst="rect">
                  <a:avLst/>
                </a:prstGeom>
                <a:solidFill>
                  <a:schemeClr val="accent1">
                    <a:lumMod val="75000"/>
                  </a:schemeClr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211" name="Rectangle 210"/>
                <p:cNvSpPr/>
                <p:nvPr/>
              </p:nvSpPr>
              <p:spPr>
                <a:xfrm>
                  <a:off x="6515587" y="3357893"/>
                  <a:ext cx="108705" cy="111106"/>
                </a:xfrm>
                <a:prstGeom prst="rect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212" name="Rectangle 211"/>
                <p:cNvSpPr/>
                <p:nvPr/>
              </p:nvSpPr>
              <p:spPr>
                <a:xfrm>
                  <a:off x="7139867" y="3351544"/>
                  <a:ext cx="110258" cy="109520"/>
                </a:xfrm>
                <a:prstGeom prst="rect">
                  <a:avLst/>
                </a:prstGeom>
                <a:solidFill>
                  <a:srgbClr val="92D050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213" name="Rectangle 212"/>
                <p:cNvSpPr/>
                <p:nvPr/>
              </p:nvSpPr>
              <p:spPr>
                <a:xfrm>
                  <a:off x="7719111" y="3357893"/>
                  <a:ext cx="110259" cy="111106"/>
                </a:xfrm>
                <a:prstGeom prst="rect">
                  <a:avLst/>
                </a:prstGeom>
                <a:solidFill>
                  <a:srgbClr val="7030A0"/>
                </a:solidFill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346" name="Rectangle 345"/>
                <p:cNvSpPr/>
                <p:nvPr/>
              </p:nvSpPr>
              <p:spPr>
                <a:xfrm>
                  <a:off x="8287484" y="3351544"/>
                  <a:ext cx="108705" cy="109520"/>
                </a:xfrm>
                <a:prstGeom prst="rect">
                  <a:avLst/>
                </a:prstGeom>
                <a:solidFill>
                  <a:schemeClr val="accent5"/>
                </a:solidFill>
                <a:ln>
                  <a:solidFill>
                    <a:schemeClr val="accent5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9230" name="TextBox 346"/>
                <p:cNvSpPr txBox="1">
                  <a:spLocks noChangeArrowheads="1"/>
                </p:cNvSpPr>
                <p:nvPr/>
              </p:nvSpPr>
              <p:spPr bwMode="auto">
                <a:xfrm>
                  <a:off x="616077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0h</a:t>
                  </a:r>
                </a:p>
              </p:txBody>
            </p:sp>
            <p:sp>
              <p:nvSpPr>
                <p:cNvPr id="9231" name="TextBox 347"/>
                <p:cNvSpPr txBox="1">
                  <a:spLocks noChangeArrowheads="1"/>
                </p:cNvSpPr>
                <p:nvPr/>
              </p:nvSpPr>
              <p:spPr bwMode="auto">
                <a:xfrm>
                  <a:off x="6686550" y="330514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6h</a:t>
                  </a:r>
                </a:p>
              </p:txBody>
            </p:sp>
            <p:sp>
              <p:nvSpPr>
                <p:cNvPr id="9232" name="TextBox 348"/>
                <p:cNvSpPr txBox="1">
                  <a:spLocks noChangeArrowheads="1"/>
                </p:cNvSpPr>
                <p:nvPr/>
              </p:nvSpPr>
              <p:spPr bwMode="auto">
                <a:xfrm>
                  <a:off x="729615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24h</a:t>
                  </a:r>
                </a:p>
              </p:txBody>
            </p:sp>
            <p:sp>
              <p:nvSpPr>
                <p:cNvPr id="9233" name="TextBox 349"/>
                <p:cNvSpPr txBox="1">
                  <a:spLocks noChangeArrowheads="1"/>
                </p:cNvSpPr>
                <p:nvPr/>
              </p:nvSpPr>
              <p:spPr bwMode="auto">
                <a:xfrm>
                  <a:off x="787527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48h</a:t>
                  </a:r>
                </a:p>
              </p:txBody>
            </p:sp>
            <p:sp>
              <p:nvSpPr>
                <p:cNvPr id="9234" name="TextBox 350"/>
                <p:cNvSpPr txBox="1">
                  <a:spLocks noChangeArrowheads="1"/>
                </p:cNvSpPr>
                <p:nvPr/>
              </p:nvSpPr>
              <p:spPr bwMode="auto">
                <a:xfrm>
                  <a:off x="843915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72h</a:t>
                  </a:r>
                </a:p>
              </p:txBody>
            </p:sp>
          </p:grpSp>
          <p:sp>
            <p:nvSpPr>
              <p:cNvPr id="9224" name="TextBox 364"/>
              <p:cNvSpPr txBox="1">
                <a:spLocks noChangeArrowheads="1"/>
              </p:cNvSpPr>
              <p:nvPr/>
            </p:nvSpPr>
            <p:spPr bwMode="auto">
              <a:xfrm>
                <a:off x="283252" y="3199713"/>
                <a:ext cx="30480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r>
                  <a:rPr lang="en-US" sz="1600"/>
                  <a:t>d.</a:t>
                </a:r>
              </a:p>
            </p:txBody>
          </p:sp>
        </p:grpSp>
      </p:grpSp>
      <p:sp>
        <p:nvSpPr>
          <p:cNvPr id="218" name="Rectangle 1"/>
          <p:cNvSpPr>
            <a:spLocks noChangeArrowheads="1"/>
          </p:cNvSpPr>
          <p:nvPr/>
        </p:nvSpPr>
        <p:spPr bwMode="auto">
          <a:xfrm>
            <a:off x="228600" y="6172200"/>
            <a:ext cx="2667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Supplementary Figure S4</a:t>
            </a:r>
            <a:endParaRPr lang="en-US" sz="1400" dirty="0">
              <a:ea typeface="Malgun Gothic" pitchFamily="34" charset="-127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13"/>
          <p:cNvGrpSpPr>
            <a:grpSpLocks/>
          </p:cNvGrpSpPr>
          <p:nvPr/>
        </p:nvGrpSpPr>
        <p:grpSpPr bwMode="auto">
          <a:xfrm>
            <a:off x="65088" y="473075"/>
            <a:ext cx="8859837" cy="5097463"/>
            <a:chOff x="65618" y="473450"/>
            <a:chExt cx="8859307" cy="5096607"/>
          </a:xfrm>
        </p:grpSpPr>
        <p:grpSp>
          <p:nvGrpSpPr>
            <p:cNvPr id="3" name="Group 211"/>
            <p:cNvGrpSpPr>
              <a:grpSpLocks/>
            </p:cNvGrpSpPr>
            <p:nvPr/>
          </p:nvGrpSpPr>
          <p:grpSpPr bwMode="auto">
            <a:xfrm>
              <a:off x="69561" y="473450"/>
              <a:ext cx="8855364" cy="2589790"/>
              <a:chOff x="69561" y="473450"/>
              <a:chExt cx="8855364" cy="2589790"/>
            </a:xfrm>
          </p:grpSpPr>
          <p:graphicFrame>
            <p:nvGraphicFramePr>
              <p:cNvPr id="4" name="Chart 3"/>
              <p:cNvGraphicFramePr/>
              <p:nvPr/>
            </p:nvGraphicFramePr>
            <p:xfrm>
              <a:off x="238125" y="685800"/>
              <a:ext cx="8686800" cy="237744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pSp>
            <p:nvGrpSpPr>
              <p:cNvPr id="5" name="Group 185"/>
              <p:cNvGrpSpPr>
                <a:grpSpLocks/>
              </p:cNvGrpSpPr>
              <p:nvPr/>
            </p:nvGrpSpPr>
            <p:grpSpPr bwMode="auto">
              <a:xfrm>
                <a:off x="69561" y="509639"/>
                <a:ext cx="8708679" cy="1919237"/>
                <a:chOff x="69561" y="509639"/>
                <a:chExt cx="8708679" cy="1919237"/>
              </a:xfrm>
            </p:grpSpPr>
            <p:sp>
              <p:nvSpPr>
                <p:cNvPr id="10364" name="TextBox 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-617683" y="1449244"/>
                  <a:ext cx="1666876" cy="2923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Relative expression</a:t>
                  </a:r>
                </a:p>
              </p:txBody>
            </p:sp>
            <p:sp>
              <p:nvSpPr>
                <p:cNvPr id="10365" name="TextBox 7"/>
                <p:cNvSpPr txBox="1">
                  <a:spLocks noChangeArrowheads="1"/>
                </p:cNvSpPr>
                <p:nvPr/>
              </p:nvSpPr>
              <p:spPr bwMode="auto">
                <a:xfrm>
                  <a:off x="2895600" y="509639"/>
                  <a:ext cx="2590800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400">
                      <a:latin typeface="Times New Roman" pitchFamily="18" charset="0"/>
                      <a:cs typeface="Times New Roman" pitchFamily="18" charset="0"/>
                    </a:rPr>
                    <a:t>15°C  treatment vs. </a:t>
                  </a:r>
                  <a:r>
                    <a:rPr lang="en-US" sz="1400" i="1">
                      <a:latin typeface="Times New Roman" pitchFamily="18" charset="0"/>
                      <a:cs typeface="Times New Roman" pitchFamily="18" charset="0"/>
                    </a:rPr>
                    <a:t>C. maxima</a:t>
                  </a:r>
                </a:p>
              </p:txBody>
            </p:sp>
            <p:sp>
              <p:nvSpPr>
                <p:cNvPr id="10366" name="TextBox 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12140" y="20243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367" name="TextBox 1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73100" y="184149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-h</a:t>
                  </a:r>
                </a:p>
              </p:txBody>
            </p:sp>
            <p:sp>
              <p:nvSpPr>
                <p:cNvPr id="10368" name="TextBox 1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34060" y="16535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e</a:t>
                  </a:r>
                </a:p>
              </p:txBody>
            </p:sp>
            <p:sp>
              <p:nvSpPr>
                <p:cNvPr id="10369" name="TextBox 1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10260" y="189229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370" name="TextBox 1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982980" y="185165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371" name="TextBox 1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043940" y="16687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-g</a:t>
                  </a:r>
                </a:p>
              </p:txBody>
            </p:sp>
            <p:sp>
              <p:nvSpPr>
                <p:cNvPr id="10372" name="TextBox 1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104900" y="148081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c</a:t>
                  </a:r>
                </a:p>
              </p:txBody>
            </p:sp>
            <p:sp>
              <p:nvSpPr>
                <p:cNvPr id="10373" name="TextBox 1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181100" y="18719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374" name="TextBox 1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353819" y="19989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375" name="TextBox 1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414779" y="181609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h</a:t>
                  </a:r>
                </a:p>
              </p:txBody>
            </p:sp>
            <p:sp>
              <p:nvSpPr>
                <p:cNvPr id="10376" name="TextBox 1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475739" y="16281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e</a:t>
                  </a:r>
                </a:p>
              </p:txBody>
            </p:sp>
            <p:sp>
              <p:nvSpPr>
                <p:cNvPr id="10377" name="TextBox 2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551939" y="186689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378" name="TextBox 2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709419" y="205485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379" name="TextBox 2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770379" y="18719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h</a:t>
                  </a:r>
                </a:p>
              </p:txBody>
            </p:sp>
            <p:sp>
              <p:nvSpPr>
                <p:cNvPr id="10380" name="TextBox 2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831339" y="168401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381" name="TextBox 2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907539" y="19227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10382" name="TextBox 2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090419" y="20243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383" name="TextBox 2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151379" y="184149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h</a:t>
                  </a:r>
                </a:p>
              </p:txBody>
            </p:sp>
            <p:sp>
              <p:nvSpPr>
                <p:cNvPr id="10384" name="TextBox 2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212339" y="16535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385" name="TextBox 2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288539" y="189229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10386" name="TextBox 2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456179" y="158241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10387" name="TextBox 3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517139" y="9423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b</a:t>
                  </a:r>
                </a:p>
              </p:txBody>
            </p:sp>
            <p:sp>
              <p:nvSpPr>
                <p:cNvPr id="10388" name="TextBox 3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588259" y="15925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e</a:t>
                  </a:r>
                </a:p>
              </p:txBody>
            </p:sp>
            <p:sp>
              <p:nvSpPr>
                <p:cNvPr id="10389" name="TextBox 3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664459" y="18313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390" name="TextBox 3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827020" y="170941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e</a:t>
                  </a:r>
                </a:p>
              </p:txBody>
            </p:sp>
            <p:sp>
              <p:nvSpPr>
                <p:cNvPr id="10391" name="TextBox 3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887980" y="15265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-h</a:t>
                  </a:r>
                </a:p>
              </p:txBody>
            </p:sp>
            <p:sp>
              <p:nvSpPr>
                <p:cNvPr id="10392" name="TextBox 3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959100" y="96265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10393" name="TextBox 3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035300" y="153669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10394" name="TextBox 3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208020" y="12319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395" name="TextBox 3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289300" y="158749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-f</a:t>
                  </a:r>
                </a:p>
              </p:txBody>
            </p:sp>
            <p:sp>
              <p:nvSpPr>
                <p:cNvPr id="10396" name="TextBox 3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340100" y="18465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e</a:t>
                  </a:r>
                </a:p>
              </p:txBody>
            </p:sp>
            <p:sp>
              <p:nvSpPr>
                <p:cNvPr id="10397" name="TextBox 4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416300" y="20853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10398" name="TextBox 4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583939" y="193801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399" name="TextBox 4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644899" y="14097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e</a:t>
                  </a:r>
                </a:p>
              </p:txBody>
            </p:sp>
            <p:sp>
              <p:nvSpPr>
                <p:cNvPr id="10400" name="TextBox 4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705859" y="107442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10401" name="TextBox 4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782059" y="18059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-c</a:t>
                  </a:r>
                </a:p>
              </p:txBody>
            </p:sp>
            <p:sp>
              <p:nvSpPr>
                <p:cNvPr id="10402" name="TextBox 4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954780" y="19735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403" name="TextBox 4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015740" y="179069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h</a:t>
                  </a:r>
                </a:p>
              </p:txBody>
            </p:sp>
            <p:sp>
              <p:nvSpPr>
                <p:cNvPr id="10404" name="TextBox 4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076700" y="16027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e</a:t>
                  </a:r>
                </a:p>
              </p:txBody>
            </p:sp>
            <p:sp>
              <p:nvSpPr>
                <p:cNvPr id="10405" name="TextBox 4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152900" y="184149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406" name="TextBox 4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325620" y="77978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10407" name="TextBox 5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386580" y="14147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10408" name="TextBox 5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447540" y="18719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e</a:t>
                  </a:r>
                </a:p>
              </p:txBody>
            </p:sp>
            <p:sp>
              <p:nvSpPr>
                <p:cNvPr id="10409" name="TextBox 5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513580" y="162305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410" name="TextBox 5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691380" y="9271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10411" name="TextBox 5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762500" y="11557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c</a:t>
                  </a:r>
                </a:p>
              </p:txBody>
            </p:sp>
            <p:sp>
              <p:nvSpPr>
                <p:cNvPr id="10412" name="TextBox 5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813300" y="15773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413" name="TextBox 5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889500" y="181609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414" name="TextBox 5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052060" y="20345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415" name="TextBox 5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113020" y="185165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</a:t>
                  </a:r>
                </a:p>
              </p:txBody>
            </p:sp>
            <p:sp>
              <p:nvSpPr>
                <p:cNvPr id="10416" name="TextBox 5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173980" y="166369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417" name="TextBox 6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250180" y="190245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10418" name="TextBox 6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433060" y="143001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c</a:t>
                  </a:r>
                </a:p>
              </p:txBody>
            </p:sp>
            <p:sp>
              <p:nvSpPr>
                <p:cNvPr id="10419" name="TextBox 6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494020" y="75438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10420" name="TextBox 6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554980" y="155701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e</a:t>
                  </a:r>
                </a:p>
              </p:txBody>
            </p:sp>
            <p:sp>
              <p:nvSpPr>
                <p:cNvPr id="10421" name="TextBox 6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631180" y="17957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422" name="TextBox 6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808980" y="200405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423" name="TextBox 6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869940" y="18211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</a:t>
                  </a:r>
                </a:p>
              </p:txBody>
            </p:sp>
            <p:sp>
              <p:nvSpPr>
                <p:cNvPr id="10424" name="TextBox 6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930900" y="163321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425" name="TextBox 6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007100" y="18719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10426" name="TextBox 6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169660" y="19735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427" name="TextBox 7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230620" y="179069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-h</a:t>
                  </a:r>
                </a:p>
              </p:txBody>
            </p:sp>
            <p:sp>
              <p:nvSpPr>
                <p:cNvPr id="10428" name="TextBox 7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291580" y="16027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e</a:t>
                  </a:r>
                </a:p>
              </p:txBody>
            </p:sp>
            <p:sp>
              <p:nvSpPr>
                <p:cNvPr id="10429" name="TextBox 7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367780" y="184149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430" name="TextBox 7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540500" y="198881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431" name="TextBox 7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601460" y="18059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h</a:t>
                  </a:r>
                </a:p>
              </p:txBody>
            </p:sp>
            <p:sp>
              <p:nvSpPr>
                <p:cNvPr id="10432" name="TextBox 7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662420" y="16179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e</a:t>
                  </a:r>
                </a:p>
              </p:txBody>
            </p:sp>
            <p:sp>
              <p:nvSpPr>
                <p:cNvPr id="10433" name="TextBox 7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738620" y="18567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434" name="TextBox 7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911339" y="183641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435" name="TextBox 7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972299" y="16535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-h</a:t>
                  </a:r>
                </a:p>
              </p:txBody>
            </p:sp>
            <p:sp>
              <p:nvSpPr>
                <p:cNvPr id="10436" name="TextBox 7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033259" y="14655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</a:t>
                  </a:r>
                </a:p>
              </p:txBody>
            </p:sp>
            <p:sp>
              <p:nvSpPr>
                <p:cNvPr id="10437" name="TextBox 8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109459" y="17043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b</a:t>
                  </a:r>
                </a:p>
              </p:txBody>
            </p:sp>
            <p:sp>
              <p:nvSpPr>
                <p:cNvPr id="10438" name="TextBox 8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292339" y="151638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10439" name="TextBox 8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353299" y="170941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-h</a:t>
                  </a:r>
                </a:p>
              </p:txBody>
            </p:sp>
            <p:sp>
              <p:nvSpPr>
                <p:cNvPr id="10440" name="TextBox 8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414259" y="18770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e</a:t>
                  </a:r>
                </a:p>
              </p:txBody>
            </p:sp>
            <p:sp>
              <p:nvSpPr>
                <p:cNvPr id="10441" name="TextBox 8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490459" y="20497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442" name="TextBox 8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653020" y="20497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443" name="TextBox 8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713980" y="186689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h</a:t>
                  </a:r>
                </a:p>
              </p:txBody>
            </p:sp>
            <p:sp>
              <p:nvSpPr>
                <p:cNvPr id="10444" name="TextBox 8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774940" y="16789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445" name="TextBox 8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851140" y="191769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10446" name="TextBox 8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028940" y="196341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447" name="TextBox 9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089900" y="17805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-h</a:t>
                  </a:r>
                </a:p>
              </p:txBody>
            </p:sp>
            <p:sp>
              <p:nvSpPr>
                <p:cNvPr id="10448" name="TextBox 9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150860" y="159257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e</a:t>
                  </a:r>
                </a:p>
              </p:txBody>
            </p:sp>
            <p:sp>
              <p:nvSpPr>
                <p:cNvPr id="10449" name="TextBox 9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227060" y="18313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450" name="TextBox 9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389620" y="203453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451" name="TextBox 9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450580" y="185165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h</a:t>
                  </a:r>
                </a:p>
              </p:txBody>
            </p:sp>
            <p:sp>
              <p:nvSpPr>
                <p:cNvPr id="10452" name="TextBox 9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511540" y="166369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e</a:t>
                  </a:r>
                </a:p>
              </p:txBody>
            </p:sp>
            <p:sp>
              <p:nvSpPr>
                <p:cNvPr id="10453" name="TextBox 9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587740" y="1902459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</p:grpSp>
          <p:grpSp>
            <p:nvGrpSpPr>
              <p:cNvPr id="7" name="Group 198"/>
              <p:cNvGrpSpPr>
                <a:grpSpLocks/>
              </p:cNvGrpSpPr>
              <p:nvPr/>
            </p:nvGrpSpPr>
            <p:grpSpPr bwMode="auto">
              <a:xfrm>
                <a:off x="6153150" y="592657"/>
                <a:ext cx="2743200" cy="207675"/>
                <a:chOff x="6000750" y="3297525"/>
                <a:chExt cx="2743200" cy="207675"/>
              </a:xfrm>
            </p:grpSpPr>
            <p:sp>
              <p:nvSpPr>
                <p:cNvPr id="200" name="Rectangle 199"/>
                <p:cNvSpPr/>
                <p:nvPr/>
              </p:nvSpPr>
              <p:spPr>
                <a:xfrm>
                  <a:off x="6000916" y="3351327"/>
                  <a:ext cx="109531" cy="109519"/>
                </a:xfrm>
                <a:prstGeom prst="rect">
                  <a:avLst/>
                </a:prstGeom>
                <a:solidFill>
                  <a:schemeClr val="accent1">
                    <a:lumMod val="75000"/>
                  </a:schemeClr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201" name="Rectangle 200"/>
                <p:cNvSpPr/>
                <p:nvPr/>
              </p:nvSpPr>
              <p:spPr>
                <a:xfrm>
                  <a:off x="6515235" y="3357676"/>
                  <a:ext cx="111118" cy="111106"/>
                </a:xfrm>
                <a:prstGeom prst="rect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202" name="Rectangle 201"/>
                <p:cNvSpPr/>
                <p:nvPr/>
              </p:nvSpPr>
              <p:spPr>
                <a:xfrm>
                  <a:off x="7140673" y="3351327"/>
                  <a:ext cx="109531" cy="109519"/>
                </a:xfrm>
                <a:prstGeom prst="rect">
                  <a:avLst/>
                </a:prstGeom>
                <a:solidFill>
                  <a:srgbClr val="92D050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203" name="Rectangle 202"/>
                <p:cNvSpPr/>
                <p:nvPr/>
              </p:nvSpPr>
              <p:spPr>
                <a:xfrm>
                  <a:off x="7720076" y="3357676"/>
                  <a:ext cx="109530" cy="111106"/>
                </a:xfrm>
                <a:prstGeom prst="rect">
                  <a:avLst/>
                </a:prstGeom>
                <a:solidFill>
                  <a:srgbClr val="7030A0"/>
                </a:solidFill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204" name="Rectangle 203"/>
                <p:cNvSpPr/>
                <p:nvPr/>
              </p:nvSpPr>
              <p:spPr>
                <a:xfrm>
                  <a:off x="8286779" y="3351327"/>
                  <a:ext cx="109531" cy="109519"/>
                </a:xfrm>
                <a:prstGeom prst="rect">
                  <a:avLst/>
                </a:prstGeom>
                <a:solidFill>
                  <a:schemeClr val="accent5"/>
                </a:solidFill>
                <a:ln>
                  <a:solidFill>
                    <a:schemeClr val="accent5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10359" name="TextBox 204"/>
                <p:cNvSpPr txBox="1">
                  <a:spLocks noChangeArrowheads="1"/>
                </p:cNvSpPr>
                <p:nvPr/>
              </p:nvSpPr>
              <p:spPr bwMode="auto">
                <a:xfrm>
                  <a:off x="616077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0h</a:t>
                  </a:r>
                </a:p>
              </p:txBody>
            </p:sp>
            <p:sp>
              <p:nvSpPr>
                <p:cNvPr id="10360" name="TextBox 205"/>
                <p:cNvSpPr txBox="1">
                  <a:spLocks noChangeArrowheads="1"/>
                </p:cNvSpPr>
                <p:nvPr/>
              </p:nvSpPr>
              <p:spPr bwMode="auto">
                <a:xfrm>
                  <a:off x="6686550" y="330514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6h</a:t>
                  </a:r>
                </a:p>
              </p:txBody>
            </p:sp>
            <p:sp>
              <p:nvSpPr>
                <p:cNvPr id="10361" name="TextBox 206"/>
                <p:cNvSpPr txBox="1">
                  <a:spLocks noChangeArrowheads="1"/>
                </p:cNvSpPr>
                <p:nvPr/>
              </p:nvSpPr>
              <p:spPr bwMode="auto">
                <a:xfrm>
                  <a:off x="729615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24h</a:t>
                  </a:r>
                </a:p>
              </p:txBody>
            </p:sp>
            <p:sp>
              <p:nvSpPr>
                <p:cNvPr id="10362" name="TextBox 207"/>
                <p:cNvSpPr txBox="1">
                  <a:spLocks noChangeArrowheads="1"/>
                </p:cNvSpPr>
                <p:nvPr/>
              </p:nvSpPr>
              <p:spPr bwMode="auto">
                <a:xfrm>
                  <a:off x="787527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48h</a:t>
                  </a:r>
                </a:p>
              </p:txBody>
            </p:sp>
            <p:sp>
              <p:nvSpPr>
                <p:cNvPr id="10363" name="TextBox 208"/>
                <p:cNvSpPr txBox="1">
                  <a:spLocks noChangeArrowheads="1"/>
                </p:cNvSpPr>
                <p:nvPr/>
              </p:nvSpPr>
              <p:spPr bwMode="auto">
                <a:xfrm>
                  <a:off x="843915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72h</a:t>
                  </a:r>
                </a:p>
              </p:txBody>
            </p:sp>
          </p:grpSp>
          <p:sp>
            <p:nvSpPr>
              <p:cNvPr id="10353" name="TextBox 209"/>
              <p:cNvSpPr txBox="1">
                <a:spLocks noChangeArrowheads="1"/>
              </p:cNvSpPr>
              <p:nvPr/>
            </p:nvSpPr>
            <p:spPr bwMode="auto">
              <a:xfrm>
                <a:off x="135469" y="473450"/>
                <a:ext cx="30480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r>
                  <a:rPr lang="en-US" sz="1600"/>
                  <a:t>e.</a:t>
                </a:r>
              </a:p>
            </p:txBody>
          </p:sp>
        </p:grpSp>
        <p:grpSp>
          <p:nvGrpSpPr>
            <p:cNvPr id="8" name="Group 212"/>
            <p:cNvGrpSpPr>
              <a:grpSpLocks/>
            </p:cNvGrpSpPr>
            <p:nvPr/>
          </p:nvGrpSpPr>
          <p:grpSpPr bwMode="auto">
            <a:xfrm>
              <a:off x="65618" y="2946396"/>
              <a:ext cx="8858249" cy="2623661"/>
              <a:chOff x="57151" y="3258979"/>
              <a:chExt cx="8858249" cy="2623661"/>
            </a:xfrm>
          </p:grpSpPr>
          <p:grpSp>
            <p:nvGrpSpPr>
              <p:cNvPr id="9" name="Group 186"/>
              <p:cNvGrpSpPr>
                <a:grpSpLocks/>
              </p:cNvGrpSpPr>
              <p:nvPr/>
            </p:nvGrpSpPr>
            <p:grpSpPr bwMode="auto">
              <a:xfrm>
                <a:off x="57151" y="3297375"/>
                <a:ext cx="8858249" cy="2585265"/>
                <a:chOff x="57151" y="3297375"/>
                <a:chExt cx="8858249" cy="2585265"/>
              </a:xfrm>
            </p:grpSpPr>
            <p:graphicFrame>
              <p:nvGraphicFramePr>
                <p:cNvPr id="6" name="Chart 5"/>
                <p:cNvGraphicFramePr/>
                <p:nvPr/>
              </p:nvGraphicFramePr>
              <p:xfrm>
                <a:off x="228600" y="3505200"/>
                <a:ext cx="8686800" cy="23774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10260" name="TextBox 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-630093" y="4316268"/>
                  <a:ext cx="1666876" cy="2923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Relative expression</a:t>
                  </a:r>
                </a:p>
              </p:txBody>
            </p:sp>
            <p:sp>
              <p:nvSpPr>
                <p:cNvPr id="10261" name="TextBox 8"/>
                <p:cNvSpPr txBox="1">
                  <a:spLocks noChangeArrowheads="1"/>
                </p:cNvSpPr>
                <p:nvPr/>
              </p:nvSpPr>
              <p:spPr bwMode="auto">
                <a:xfrm>
                  <a:off x="2743200" y="3297375"/>
                  <a:ext cx="2590800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1400">
                      <a:latin typeface="Times New Roman" pitchFamily="18" charset="0"/>
                      <a:cs typeface="Times New Roman" pitchFamily="18" charset="0"/>
                    </a:rPr>
                    <a:t>15°C  treatment vs. </a:t>
                  </a:r>
                  <a:r>
                    <a:rPr lang="en-US" sz="1400" i="1">
                      <a:latin typeface="Times New Roman" pitchFamily="18" charset="0"/>
                      <a:cs typeface="Times New Roman" pitchFamily="18" charset="0"/>
                    </a:rPr>
                    <a:t>C. moschta</a:t>
                  </a:r>
                </a:p>
              </p:txBody>
            </p:sp>
            <p:sp>
              <p:nvSpPr>
                <p:cNvPr id="10262" name="TextBox 9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12141" y="44577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b</a:t>
                  </a:r>
                </a:p>
              </p:txBody>
            </p:sp>
            <p:sp>
              <p:nvSpPr>
                <p:cNvPr id="10263" name="TextBox 9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68021" y="40157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10264" name="TextBox 9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28981" y="38277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b</a:t>
                  </a:r>
                </a:p>
              </p:txBody>
            </p:sp>
            <p:sp>
              <p:nvSpPr>
                <p:cNvPr id="10265" name="TextBox 10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10261" y="46101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-h</a:t>
                  </a:r>
                </a:p>
              </p:txBody>
            </p:sp>
            <p:sp>
              <p:nvSpPr>
                <p:cNvPr id="10266" name="TextBox 10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972821" y="49149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10267" name="TextBox 10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033781" y="45897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10268" name="TextBox 10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094741" y="440182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-g</a:t>
                  </a:r>
                </a:p>
              </p:txBody>
            </p:sp>
            <p:sp>
              <p:nvSpPr>
                <p:cNvPr id="10269" name="TextBox 10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181101" y="49047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-j</a:t>
                  </a:r>
                </a:p>
              </p:txBody>
            </p:sp>
            <p:sp>
              <p:nvSpPr>
                <p:cNvPr id="10270" name="TextBox 10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338580" y="48895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271" name="TextBox 10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414780" y="46863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</a:t>
                  </a:r>
                </a:p>
              </p:txBody>
            </p:sp>
            <p:sp>
              <p:nvSpPr>
                <p:cNvPr id="10272" name="TextBox 10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475740" y="44577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</a:t>
                  </a:r>
                </a:p>
              </p:txBody>
            </p:sp>
            <p:sp>
              <p:nvSpPr>
                <p:cNvPr id="10273" name="TextBox 10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546860" y="47625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-j</a:t>
                  </a:r>
                </a:p>
              </p:txBody>
            </p:sp>
            <p:sp>
              <p:nvSpPr>
                <p:cNvPr id="10274" name="TextBox 10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719580" y="46101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275" name="TextBox 11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775460" y="40005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10276" name="TextBox 11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851660" y="42951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e</a:t>
                  </a:r>
                </a:p>
              </p:txBody>
            </p:sp>
            <p:sp>
              <p:nvSpPr>
                <p:cNvPr id="10277" name="TextBox 11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917700" y="47625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-i</a:t>
                  </a:r>
                </a:p>
              </p:txBody>
            </p:sp>
            <p:sp>
              <p:nvSpPr>
                <p:cNvPr id="10278" name="TextBox 11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095500" y="46101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279" name="TextBox 11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151380" y="41681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</a:t>
                  </a:r>
                </a:p>
              </p:txBody>
            </p:sp>
            <p:sp>
              <p:nvSpPr>
                <p:cNvPr id="10280" name="TextBox 11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212340" y="353314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10281" name="TextBox 11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293620" y="47625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</a:t>
                  </a:r>
                </a:p>
              </p:txBody>
            </p:sp>
            <p:sp>
              <p:nvSpPr>
                <p:cNvPr id="10282" name="TextBox 11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456179" y="47675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10283" name="TextBox 11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512059" y="44729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e</a:t>
                  </a:r>
                </a:p>
              </p:txBody>
            </p:sp>
            <p:sp>
              <p:nvSpPr>
                <p:cNvPr id="10284" name="TextBox 11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593339" y="46863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g</a:t>
                  </a:r>
                </a:p>
              </p:txBody>
            </p:sp>
            <p:sp>
              <p:nvSpPr>
                <p:cNvPr id="10285" name="TextBox 12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654299" y="49199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g</a:t>
                  </a:r>
                </a:p>
              </p:txBody>
            </p:sp>
            <p:sp>
              <p:nvSpPr>
                <p:cNvPr id="10286" name="TextBox 12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816859" y="47625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10287" name="TextBox 12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872739" y="44678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</a:t>
                  </a:r>
                </a:p>
              </p:txBody>
            </p:sp>
            <p:sp>
              <p:nvSpPr>
                <p:cNvPr id="10288" name="TextBox 12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2954019" y="468122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</a:t>
                  </a:r>
                </a:p>
              </p:txBody>
            </p:sp>
            <p:sp>
              <p:nvSpPr>
                <p:cNvPr id="10289" name="TextBox 12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014979" y="49149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k</a:t>
                  </a:r>
                </a:p>
              </p:txBody>
            </p:sp>
            <p:sp>
              <p:nvSpPr>
                <p:cNvPr id="10290" name="TextBox 12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182619" y="47371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10291" name="TextBox 12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238499" y="44424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</a:t>
                  </a:r>
                </a:p>
              </p:txBody>
            </p:sp>
            <p:sp>
              <p:nvSpPr>
                <p:cNvPr id="10292" name="TextBox 12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319779" y="465582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</a:t>
                  </a:r>
                </a:p>
              </p:txBody>
            </p:sp>
            <p:sp>
              <p:nvSpPr>
                <p:cNvPr id="10293" name="TextBox 12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380739" y="48895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i-k</a:t>
                  </a:r>
                </a:p>
              </p:txBody>
            </p:sp>
            <p:sp>
              <p:nvSpPr>
                <p:cNvPr id="10294" name="TextBox 12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558539" y="47625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295" name="TextBox 13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614419" y="44678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</a:t>
                  </a:r>
                </a:p>
              </p:txBody>
            </p:sp>
            <p:sp>
              <p:nvSpPr>
                <p:cNvPr id="10296" name="TextBox 13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695699" y="468122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g</a:t>
                  </a:r>
                </a:p>
              </p:txBody>
            </p:sp>
            <p:sp>
              <p:nvSpPr>
                <p:cNvPr id="10297" name="TextBox 13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756659" y="49149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h-k</a:t>
                  </a:r>
                </a:p>
              </p:txBody>
            </p:sp>
            <p:sp>
              <p:nvSpPr>
                <p:cNvPr id="10298" name="TextBox 13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3944619" y="46609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299" name="TextBox 13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000499" y="42291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b</a:t>
                  </a:r>
                </a:p>
              </p:txBody>
            </p:sp>
            <p:sp>
              <p:nvSpPr>
                <p:cNvPr id="10300" name="TextBox 13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081779" y="37515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b</a:t>
                  </a:r>
                </a:p>
              </p:txBody>
            </p:sp>
            <p:sp>
              <p:nvSpPr>
                <p:cNvPr id="10301" name="TextBox 13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142739" y="48133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</a:t>
                  </a:r>
                </a:p>
              </p:txBody>
            </p:sp>
            <p:sp>
              <p:nvSpPr>
                <p:cNvPr id="10302" name="TextBox 13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290060" y="47523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10303" name="TextBox 13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345940" y="44577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</a:t>
                  </a:r>
                </a:p>
              </p:txBody>
            </p:sp>
            <p:sp>
              <p:nvSpPr>
                <p:cNvPr id="10304" name="TextBox 13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427220" y="46710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</a:t>
                  </a:r>
                </a:p>
              </p:txBody>
            </p:sp>
            <p:sp>
              <p:nvSpPr>
                <p:cNvPr id="10305" name="TextBox 14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488180" y="49047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-i</a:t>
                  </a:r>
                </a:p>
              </p:txBody>
            </p:sp>
            <p:sp>
              <p:nvSpPr>
                <p:cNvPr id="10306" name="TextBox 14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676140" y="47167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c</a:t>
                  </a:r>
                </a:p>
              </p:txBody>
            </p:sp>
            <p:sp>
              <p:nvSpPr>
                <p:cNvPr id="10307" name="TextBox 14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732020" y="44221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</a:t>
                  </a:r>
                </a:p>
              </p:txBody>
            </p:sp>
            <p:sp>
              <p:nvSpPr>
                <p:cNvPr id="10308" name="TextBox 14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813300" y="46355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g</a:t>
                  </a:r>
                </a:p>
              </p:txBody>
            </p:sp>
            <p:sp>
              <p:nvSpPr>
                <p:cNvPr id="10309" name="TextBox 14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4874260" y="48691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</a:t>
                  </a:r>
                </a:p>
              </p:txBody>
            </p:sp>
            <p:sp>
              <p:nvSpPr>
                <p:cNvPr id="10310" name="TextBox 14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057140" y="48437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311" name="TextBox 14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123180" y="43916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10312" name="TextBox 14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204460" y="460502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-g</a:t>
                  </a:r>
                </a:p>
              </p:txBody>
            </p:sp>
            <p:sp>
              <p:nvSpPr>
                <p:cNvPr id="10313" name="TextBox 14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265420" y="48945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i-k</a:t>
                  </a:r>
                </a:p>
              </p:txBody>
            </p:sp>
            <p:sp>
              <p:nvSpPr>
                <p:cNvPr id="10314" name="TextBox 14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412740" y="46863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c</a:t>
                  </a:r>
                </a:p>
              </p:txBody>
            </p:sp>
            <p:sp>
              <p:nvSpPr>
                <p:cNvPr id="10315" name="TextBox 15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468620" y="43916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</a:t>
                  </a:r>
                </a:p>
              </p:txBody>
            </p:sp>
            <p:sp>
              <p:nvSpPr>
                <p:cNvPr id="10316" name="TextBox 15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549900" y="460502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g</a:t>
                  </a:r>
                </a:p>
              </p:txBody>
            </p:sp>
            <p:sp>
              <p:nvSpPr>
                <p:cNvPr id="10317" name="TextBox 15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626100" y="47980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f</a:t>
                  </a:r>
                </a:p>
              </p:txBody>
            </p:sp>
            <p:sp>
              <p:nvSpPr>
                <p:cNvPr id="10318" name="TextBox 15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788660" y="47269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319" name="TextBox 15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864860" y="490982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</a:t>
                  </a:r>
                </a:p>
              </p:txBody>
            </p:sp>
            <p:sp>
              <p:nvSpPr>
                <p:cNvPr id="10320" name="TextBox 15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5925820" y="45491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-g</a:t>
                  </a:r>
                </a:p>
              </p:txBody>
            </p:sp>
            <p:sp>
              <p:nvSpPr>
                <p:cNvPr id="10321" name="TextBox 15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002020" y="48793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-j</a:t>
                  </a:r>
                </a:p>
              </p:txBody>
            </p:sp>
            <p:sp>
              <p:nvSpPr>
                <p:cNvPr id="10322" name="TextBox 15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169660" y="46761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  <p:sp>
              <p:nvSpPr>
                <p:cNvPr id="10323" name="TextBox 15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235700" y="48539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</a:t>
                  </a:r>
                </a:p>
              </p:txBody>
            </p:sp>
            <p:sp>
              <p:nvSpPr>
                <p:cNvPr id="10324" name="TextBox 15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306820" y="43815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-g</a:t>
                  </a:r>
                </a:p>
              </p:txBody>
            </p:sp>
            <p:sp>
              <p:nvSpPr>
                <p:cNvPr id="10325" name="TextBox 16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367780" y="48285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-h</a:t>
                  </a:r>
                </a:p>
              </p:txBody>
            </p:sp>
            <p:sp>
              <p:nvSpPr>
                <p:cNvPr id="10326" name="TextBox 16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545580" y="48641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c</a:t>
                  </a:r>
                </a:p>
              </p:txBody>
            </p:sp>
            <p:sp>
              <p:nvSpPr>
                <p:cNvPr id="10327" name="TextBox 16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601460" y="45694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</a:t>
                  </a:r>
                </a:p>
              </p:txBody>
            </p:sp>
            <p:sp>
              <p:nvSpPr>
                <p:cNvPr id="10328" name="TextBox 16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682740" y="434594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-f</a:t>
                  </a:r>
                </a:p>
              </p:txBody>
            </p:sp>
            <p:sp>
              <p:nvSpPr>
                <p:cNvPr id="10329" name="TextBox 16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738620" y="48488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i-k</a:t>
                  </a:r>
                </a:p>
              </p:txBody>
            </p:sp>
            <p:sp>
              <p:nvSpPr>
                <p:cNvPr id="10330" name="TextBox 16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921500" y="475742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10331" name="TextBox 16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6977380" y="44627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10332" name="TextBox 16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024025" y="38481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c</a:t>
                  </a:r>
                </a:p>
              </p:txBody>
            </p:sp>
            <p:sp>
              <p:nvSpPr>
                <p:cNvPr id="10333" name="TextBox 16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119620" y="490982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jk</a:t>
                  </a:r>
                </a:p>
              </p:txBody>
            </p:sp>
            <p:sp>
              <p:nvSpPr>
                <p:cNvPr id="10334" name="TextBox 16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282179" y="46964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335" name="TextBox 17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343139" y="48793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</a:t>
                  </a:r>
                </a:p>
              </p:txBody>
            </p:sp>
            <p:sp>
              <p:nvSpPr>
                <p:cNvPr id="10336" name="TextBox 17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409179" y="44983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</a:t>
                  </a:r>
                </a:p>
              </p:txBody>
            </p:sp>
            <p:sp>
              <p:nvSpPr>
                <p:cNvPr id="10337" name="TextBox 17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480299" y="43053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g-j</a:t>
                  </a:r>
                </a:p>
              </p:txBody>
            </p:sp>
            <p:sp>
              <p:nvSpPr>
                <p:cNvPr id="10338" name="TextBox 17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642860" y="482854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339" name="TextBox 17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698740" y="45339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</a:t>
                  </a:r>
                </a:p>
              </p:txBody>
            </p:sp>
            <p:sp>
              <p:nvSpPr>
                <p:cNvPr id="10340" name="TextBox 175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759239" y="40513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341" name="TextBox 176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7840980" y="48437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cd</a:t>
                  </a:r>
                </a:p>
              </p:txBody>
            </p:sp>
            <p:sp>
              <p:nvSpPr>
                <p:cNvPr id="10342" name="TextBox 177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028940" y="46964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343" name="TextBox 178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084820" y="433578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c</a:t>
                  </a:r>
                </a:p>
              </p:txBody>
            </p:sp>
            <p:sp>
              <p:nvSpPr>
                <p:cNvPr id="10344" name="TextBox 179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145319" y="399542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c</a:t>
                  </a:r>
                </a:p>
              </p:txBody>
            </p:sp>
            <p:sp>
              <p:nvSpPr>
                <p:cNvPr id="10345" name="TextBox 180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227060" y="484886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e</a:t>
                  </a:r>
                </a:p>
              </p:txBody>
            </p:sp>
            <p:sp>
              <p:nvSpPr>
                <p:cNvPr id="10346" name="TextBox 18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389620" y="49149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b-d</a:t>
                  </a:r>
                </a:p>
              </p:txBody>
            </p:sp>
            <p:sp>
              <p:nvSpPr>
                <p:cNvPr id="10347" name="TextBox 182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455660" y="4711700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f</a:t>
                  </a:r>
                </a:p>
              </p:txBody>
            </p:sp>
            <p:sp>
              <p:nvSpPr>
                <p:cNvPr id="10348" name="TextBox 183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526780" y="447294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d-g</a:t>
                  </a:r>
                </a:p>
              </p:txBody>
            </p:sp>
            <p:sp>
              <p:nvSpPr>
                <p:cNvPr id="10349" name="TextBox 184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8597900" y="4686301"/>
                  <a:ext cx="228600" cy="152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000"/>
                    <a:t>a</a:t>
                  </a:r>
                </a:p>
              </p:txBody>
            </p:sp>
          </p:grpSp>
          <p:grpSp>
            <p:nvGrpSpPr>
              <p:cNvPr id="10" name="Group 187"/>
              <p:cNvGrpSpPr>
                <a:grpSpLocks/>
              </p:cNvGrpSpPr>
              <p:nvPr/>
            </p:nvGrpSpPr>
            <p:grpSpPr bwMode="auto">
              <a:xfrm>
                <a:off x="6000750" y="3297525"/>
                <a:ext cx="2743200" cy="207675"/>
                <a:chOff x="6000750" y="3297525"/>
                <a:chExt cx="2743200" cy="207675"/>
              </a:xfrm>
            </p:grpSpPr>
            <p:sp>
              <p:nvSpPr>
                <p:cNvPr id="189" name="Rectangle 188"/>
                <p:cNvSpPr/>
                <p:nvPr/>
              </p:nvSpPr>
              <p:spPr>
                <a:xfrm>
                  <a:off x="6000395" y="3351003"/>
                  <a:ext cx="109530" cy="109520"/>
                </a:xfrm>
                <a:prstGeom prst="rect">
                  <a:avLst/>
                </a:prstGeom>
                <a:solidFill>
                  <a:schemeClr val="accent1">
                    <a:lumMod val="75000"/>
                  </a:schemeClr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190" name="Rectangle 189"/>
                <p:cNvSpPr/>
                <p:nvPr/>
              </p:nvSpPr>
              <p:spPr>
                <a:xfrm>
                  <a:off x="6514714" y="3357352"/>
                  <a:ext cx="111118" cy="111106"/>
                </a:xfrm>
                <a:prstGeom prst="rect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191" name="Rectangle 190"/>
                <p:cNvSpPr/>
                <p:nvPr/>
              </p:nvSpPr>
              <p:spPr>
                <a:xfrm>
                  <a:off x="7140152" y="3351003"/>
                  <a:ext cx="109530" cy="109520"/>
                </a:xfrm>
                <a:prstGeom prst="rect">
                  <a:avLst/>
                </a:prstGeom>
                <a:solidFill>
                  <a:srgbClr val="92D050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192" name="Rectangle 191"/>
                <p:cNvSpPr/>
                <p:nvPr/>
              </p:nvSpPr>
              <p:spPr>
                <a:xfrm>
                  <a:off x="7719554" y="3357352"/>
                  <a:ext cx="109531" cy="111106"/>
                </a:xfrm>
                <a:prstGeom prst="rect">
                  <a:avLst/>
                </a:prstGeom>
                <a:solidFill>
                  <a:srgbClr val="7030A0"/>
                </a:solidFill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193" name="Rectangle 192"/>
                <p:cNvSpPr/>
                <p:nvPr/>
              </p:nvSpPr>
              <p:spPr>
                <a:xfrm>
                  <a:off x="8286258" y="3351003"/>
                  <a:ext cx="109530" cy="109520"/>
                </a:xfrm>
                <a:prstGeom prst="rect">
                  <a:avLst/>
                </a:prstGeom>
                <a:solidFill>
                  <a:schemeClr val="accent5"/>
                </a:solidFill>
                <a:ln>
                  <a:solidFill>
                    <a:schemeClr val="accent5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10254" name="TextBox 193"/>
                <p:cNvSpPr txBox="1">
                  <a:spLocks noChangeArrowheads="1"/>
                </p:cNvSpPr>
                <p:nvPr/>
              </p:nvSpPr>
              <p:spPr bwMode="auto">
                <a:xfrm>
                  <a:off x="616077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0h</a:t>
                  </a:r>
                </a:p>
              </p:txBody>
            </p:sp>
            <p:sp>
              <p:nvSpPr>
                <p:cNvPr id="10255" name="TextBox 194"/>
                <p:cNvSpPr txBox="1">
                  <a:spLocks noChangeArrowheads="1"/>
                </p:cNvSpPr>
                <p:nvPr/>
              </p:nvSpPr>
              <p:spPr bwMode="auto">
                <a:xfrm>
                  <a:off x="6686550" y="330514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6h</a:t>
                  </a:r>
                </a:p>
              </p:txBody>
            </p:sp>
            <p:sp>
              <p:nvSpPr>
                <p:cNvPr id="10256" name="TextBox 195"/>
                <p:cNvSpPr txBox="1">
                  <a:spLocks noChangeArrowheads="1"/>
                </p:cNvSpPr>
                <p:nvPr/>
              </p:nvSpPr>
              <p:spPr bwMode="auto">
                <a:xfrm>
                  <a:off x="729615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24h</a:t>
                  </a:r>
                </a:p>
              </p:txBody>
            </p:sp>
            <p:sp>
              <p:nvSpPr>
                <p:cNvPr id="10257" name="TextBox 196"/>
                <p:cNvSpPr txBox="1">
                  <a:spLocks noChangeArrowheads="1"/>
                </p:cNvSpPr>
                <p:nvPr/>
              </p:nvSpPr>
              <p:spPr bwMode="auto">
                <a:xfrm>
                  <a:off x="787527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48h</a:t>
                  </a:r>
                </a:p>
              </p:txBody>
            </p:sp>
            <p:sp>
              <p:nvSpPr>
                <p:cNvPr id="10258" name="TextBox 197"/>
                <p:cNvSpPr txBox="1">
                  <a:spLocks noChangeArrowheads="1"/>
                </p:cNvSpPr>
                <p:nvPr/>
              </p:nvSpPr>
              <p:spPr bwMode="auto">
                <a:xfrm>
                  <a:off x="8439150" y="3297525"/>
                  <a:ext cx="304800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r>
                    <a:rPr lang="en-US" sz="1300">
                      <a:latin typeface="Times New Roman" pitchFamily="18" charset="0"/>
                      <a:cs typeface="Times New Roman" pitchFamily="18" charset="0"/>
                    </a:rPr>
                    <a:t>72h</a:t>
                  </a:r>
                </a:p>
              </p:txBody>
            </p:sp>
          </p:grpSp>
          <p:sp>
            <p:nvSpPr>
              <p:cNvPr id="10248" name="TextBox 210"/>
              <p:cNvSpPr txBox="1">
                <a:spLocks noChangeArrowheads="1"/>
              </p:cNvSpPr>
              <p:nvPr/>
            </p:nvSpPr>
            <p:spPr bwMode="auto">
              <a:xfrm>
                <a:off x="152400" y="3258979"/>
                <a:ext cx="30480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r>
                  <a:rPr lang="en-US" sz="1600"/>
                  <a:t>f.</a:t>
                </a:r>
              </a:p>
            </p:txBody>
          </p:sp>
        </p:grpSp>
      </p:grpSp>
      <p:sp>
        <p:nvSpPr>
          <p:cNvPr id="214" name="Rectangle 213"/>
          <p:cNvSpPr/>
          <p:nvPr/>
        </p:nvSpPr>
        <p:spPr>
          <a:xfrm>
            <a:off x="0" y="5638800"/>
            <a:ext cx="9144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Supplementary Figure S4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Expression patterns of the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CmaGST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enes under various temperature treatments. The relative expression data of the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CmaGST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enes is presented for the following: 5°C treatment of the cold-tolerant line CP-1 from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maxim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(a) and the cold-susceptible line EP-1 from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moschat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(b); 10°C treatment of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maxima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P-1 (c) and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moschat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EP-1 (d); 15°C treatment in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maxim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CP-1 (e) and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moschat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EP-1 (f). Error bars represent the standard deviation of the means of three independent replicates for each sample, different letters indicate the significance differences at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 ˂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0.01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2"/>
          <p:cNvGrpSpPr/>
          <p:nvPr/>
        </p:nvGrpSpPr>
        <p:grpSpPr>
          <a:xfrm>
            <a:off x="95251" y="58567"/>
            <a:ext cx="8839199" cy="2623673"/>
            <a:chOff x="95251" y="58567"/>
            <a:chExt cx="8839199" cy="2623673"/>
          </a:xfrm>
        </p:grpSpPr>
        <p:graphicFrame>
          <p:nvGraphicFramePr>
            <p:cNvPr id="4" name="Chart 3"/>
            <p:cNvGraphicFramePr/>
            <p:nvPr/>
          </p:nvGraphicFramePr>
          <p:xfrm>
            <a:off x="247650" y="304800"/>
            <a:ext cx="8686800" cy="23774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 rot="16200000">
              <a:off x="-591993" y="1220645"/>
              <a:ext cx="1666876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dirty="0" smtClean="0">
                  <a:latin typeface="Times New Roman" pitchFamily="18" charset="0"/>
                  <a:cs typeface="Times New Roman" pitchFamily="18" charset="0"/>
                </a:rPr>
                <a:t>Relative expression</a:t>
              </a:r>
              <a:endParaRPr lang="en-US" sz="13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895600" y="190500"/>
              <a:ext cx="2590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5ᴼC  treatment vs. </a:t>
              </a:r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C. maxima</a:t>
              </a:r>
              <a:endParaRPr lang="en-US" sz="14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3" name="Group 9"/>
            <p:cNvGrpSpPr/>
            <p:nvPr/>
          </p:nvGrpSpPr>
          <p:grpSpPr>
            <a:xfrm>
              <a:off x="6096000" y="228600"/>
              <a:ext cx="2743200" cy="207675"/>
              <a:chOff x="5848350" y="457200"/>
              <a:chExt cx="2743200" cy="207675"/>
            </a:xfrm>
          </p:grpSpPr>
          <p:sp>
            <p:nvSpPr>
              <p:cNvPr id="11" name="Rectangle 10"/>
              <p:cNvSpPr/>
              <p:nvPr/>
            </p:nvSpPr>
            <p:spPr>
              <a:xfrm>
                <a:off x="5848350" y="510540"/>
                <a:ext cx="109728" cy="109728"/>
              </a:xfrm>
              <a:prstGeom prst="rect">
                <a:avLst/>
              </a:prstGeom>
              <a:solidFill>
                <a:schemeClr val="accent1">
                  <a:lumMod val="75000"/>
                </a:schemeClr>
              </a:solidFill>
              <a:ln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Rectangle 11"/>
              <p:cNvSpPr/>
              <p:nvPr/>
            </p:nvSpPr>
            <p:spPr>
              <a:xfrm>
                <a:off x="6363462" y="518160"/>
                <a:ext cx="109728" cy="109728"/>
              </a:xfrm>
              <a:prstGeom prst="rect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Rectangle 12"/>
              <p:cNvSpPr/>
              <p:nvPr/>
            </p:nvSpPr>
            <p:spPr>
              <a:xfrm>
                <a:off x="6988302" y="510540"/>
                <a:ext cx="109728" cy="109728"/>
              </a:xfrm>
              <a:prstGeom prst="rect">
                <a:avLst/>
              </a:prstGeom>
              <a:solidFill>
                <a:srgbClr val="92D050"/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7567422" y="518160"/>
                <a:ext cx="109728" cy="109728"/>
              </a:xfrm>
              <a:prstGeom prst="rect">
                <a:avLst/>
              </a:prstGeom>
              <a:solidFill>
                <a:srgbClr val="7030A0"/>
              </a:solidFill>
              <a:ln>
                <a:solidFill>
                  <a:srgbClr val="7030A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8134350" y="510540"/>
                <a:ext cx="109728" cy="109728"/>
              </a:xfrm>
              <a:prstGeom prst="rect">
                <a:avLst/>
              </a:prstGeom>
              <a:solidFill>
                <a:schemeClr val="accent5"/>
              </a:solidFill>
              <a:ln>
                <a:solidFill>
                  <a:schemeClr val="accent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6008370" y="457200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0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6534150" y="464820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6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7143750" y="457200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24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7722870" y="457200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48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8286750" y="457200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72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32" name="TextBox 31"/>
            <p:cNvSpPr txBox="1"/>
            <p:nvPr/>
          </p:nvSpPr>
          <p:spPr>
            <a:xfrm>
              <a:off x="152403" y="58567"/>
              <a:ext cx="304800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600" dirty="0" smtClean="0">
                  <a:latin typeface="Arial" pitchFamily="34" charset="0"/>
                  <a:cs typeface="Arial" pitchFamily="34" charset="0"/>
                </a:rPr>
                <a:t>a.</a:t>
              </a:r>
              <a:endParaRPr lang="en-US" sz="16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" name="Group 34"/>
          <p:cNvGrpSpPr/>
          <p:nvPr/>
        </p:nvGrpSpPr>
        <p:grpSpPr>
          <a:xfrm>
            <a:off x="95251" y="3250509"/>
            <a:ext cx="8839199" cy="2555931"/>
            <a:chOff x="95251" y="3250509"/>
            <a:chExt cx="8839199" cy="2555931"/>
          </a:xfrm>
        </p:grpSpPr>
        <p:graphicFrame>
          <p:nvGraphicFramePr>
            <p:cNvPr id="6" name="Chart 5"/>
            <p:cNvGraphicFramePr/>
            <p:nvPr/>
          </p:nvGraphicFramePr>
          <p:xfrm>
            <a:off x="247650" y="3429000"/>
            <a:ext cx="8686800" cy="23774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7" name="TextBox 6"/>
            <p:cNvSpPr txBox="1"/>
            <p:nvPr/>
          </p:nvSpPr>
          <p:spPr>
            <a:xfrm rot="16200000">
              <a:off x="-591993" y="4278168"/>
              <a:ext cx="1666876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dirty="0" smtClean="0">
                  <a:latin typeface="Times New Roman" pitchFamily="18" charset="0"/>
                  <a:cs typeface="Times New Roman" pitchFamily="18" charset="0"/>
                </a:rPr>
                <a:t>Relative expression</a:t>
              </a:r>
              <a:endParaRPr lang="en-US" sz="13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743200" y="3349823"/>
              <a:ext cx="2590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5ᴼC  treatment vs. </a:t>
              </a:r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C. </a:t>
              </a:r>
              <a:r>
                <a:rPr lang="en-US" sz="1400" i="1" dirty="0" err="1" smtClean="0">
                  <a:latin typeface="Times New Roman" pitchFamily="18" charset="0"/>
                  <a:cs typeface="Times New Roman" pitchFamily="18" charset="0"/>
                </a:rPr>
                <a:t>moschta</a:t>
              </a:r>
              <a:endParaRPr lang="en-US" sz="14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21" name="Group 20"/>
            <p:cNvGrpSpPr/>
            <p:nvPr/>
          </p:nvGrpSpPr>
          <p:grpSpPr>
            <a:xfrm>
              <a:off x="6000750" y="3297525"/>
              <a:ext cx="2743200" cy="207675"/>
              <a:chOff x="6000750" y="3297525"/>
              <a:chExt cx="2743200" cy="207675"/>
            </a:xfrm>
          </p:grpSpPr>
          <p:sp>
            <p:nvSpPr>
              <p:cNvPr id="22" name="Rectangle 21"/>
              <p:cNvSpPr/>
              <p:nvPr/>
            </p:nvSpPr>
            <p:spPr>
              <a:xfrm>
                <a:off x="6000750" y="3350865"/>
                <a:ext cx="109728" cy="109728"/>
              </a:xfrm>
              <a:prstGeom prst="rect">
                <a:avLst/>
              </a:prstGeom>
              <a:solidFill>
                <a:schemeClr val="accent1">
                  <a:lumMod val="75000"/>
                </a:schemeClr>
              </a:solidFill>
              <a:ln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6515862" y="3358485"/>
                <a:ext cx="109728" cy="109728"/>
              </a:xfrm>
              <a:prstGeom prst="rect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7140702" y="3350865"/>
                <a:ext cx="109728" cy="109728"/>
              </a:xfrm>
              <a:prstGeom prst="rect">
                <a:avLst/>
              </a:prstGeom>
              <a:solidFill>
                <a:srgbClr val="92D050"/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7719822" y="3358485"/>
                <a:ext cx="109728" cy="109728"/>
              </a:xfrm>
              <a:prstGeom prst="rect">
                <a:avLst/>
              </a:prstGeom>
              <a:solidFill>
                <a:srgbClr val="7030A0"/>
              </a:solidFill>
              <a:ln>
                <a:solidFill>
                  <a:srgbClr val="7030A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8286750" y="3350865"/>
                <a:ext cx="109728" cy="109728"/>
              </a:xfrm>
              <a:prstGeom prst="rect">
                <a:avLst/>
              </a:prstGeom>
              <a:solidFill>
                <a:schemeClr val="accent5"/>
              </a:solidFill>
              <a:ln>
                <a:solidFill>
                  <a:schemeClr val="accent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6160770" y="329752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0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6686550" y="330514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6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7296150" y="329752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24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7875270" y="329752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48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8439150" y="329752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72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34" name="TextBox 33"/>
            <p:cNvSpPr txBox="1"/>
            <p:nvPr/>
          </p:nvSpPr>
          <p:spPr>
            <a:xfrm>
              <a:off x="160870" y="3250509"/>
              <a:ext cx="304800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600" dirty="0" smtClean="0">
                  <a:latin typeface="Arial" pitchFamily="34" charset="0"/>
                  <a:cs typeface="Arial" pitchFamily="34" charset="0"/>
                </a:rPr>
                <a:t>b.</a:t>
              </a:r>
              <a:endParaRPr lang="en-US" sz="16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5" name="Rectangle 1"/>
          <p:cNvSpPr>
            <a:spLocks noChangeArrowheads="1"/>
          </p:cNvSpPr>
          <p:nvPr/>
        </p:nvSpPr>
        <p:spPr bwMode="auto">
          <a:xfrm>
            <a:off x="228600" y="6172200"/>
            <a:ext cx="2667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Supplementary Figure S5</a:t>
            </a:r>
            <a:endParaRPr lang="en-US" sz="1400" dirty="0">
              <a:ea typeface="Malgun Gothic" pitchFamily="34" charset="-127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2"/>
          <p:cNvGrpSpPr/>
          <p:nvPr/>
        </p:nvGrpSpPr>
        <p:grpSpPr>
          <a:xfrm>
            <a:off x="602962" y="152400"/>
            <a:ext cx="6966238" cy="2529840"/>
            <a:chOff x="602962" y="152400"/>
            <a:chExt cx="6966238" cy="2529840"/>
          </a:xfrm>
        </p:grpSpPr>
        <p:graphicFrame>
          <p:nvGraphicFramePr>
            <p:cNvPr id="4" name="Chart 3"/>
            <p:cNvGraphicFramePr/>
            <p:nvPr/>
          </p:nvGraphicFramePr>
          <p:xfrm>
            <a:off x="762000" y="304800"/>
            <a:ext cx="6807200" cy="23774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 rot="16200000">
              <a:off x="-84282" y="1144443"/>
              <a:ext cx="1666876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dirty="0" smtClean="0">
                  <a:latin typeface="Times New Roman" pitchFamily="18" charset="0"/>
                  <a:cs typeface="Times New Roman" pitchFamily="18" charset="0"/>
                </a:rPr>
                <a:t>Relative expression</a:t>
              </a:r>
              <a:endParaRPr lang="en-US" sz="13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752600" y="152400"/>
              <a:ext cx="2590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10ᴼC  treatment vs. </a:t>
              </a:r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C. maxima</a:t>
              </a:r>
              <a:endParaRPr lang="en-US" sz="14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3" name="Group 20"/>
            <p:cNvGrpSpPr/>
            <p:nvPr/>
          </p:nvGrpSpPr>
          <p:grpSpPr>
            <a:xfrm>
              <a:off x="4724400" y="304800"/>
              <a:ext cx="2743200" cy="207675"/>
              <a:chOff x="6000750" y="3297525"/>
              <a:chExt cx="2743200" cy="207675"/>
            </a:xfrm>
          </p:grpSpPr>
          <p:sp>
            <p:nvSpPr>
              <p:cNvPr id="22" name="Rectangle 21"/>
              <p:cNvSpPr/>
              <p:nvPr/>
            </p:nvSpPr>
            <p:spPr>
              <a:xfrm>
                <a:off x="6000750" y="3350865"/>
                <a:ext cx="109728" cy="109728"/>
              </a:xfrm>
              <a:prstGeom prst="rect">
                <a:avLst/>
              </a:prstGeom>
              <a:solidFill>
                <a:schemeClr val="accent1">
                  <a:lumMod val="75000"/>
                </a:schemeClr>
              </a:solidFill>
              <a:ln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6515862" y="3358485"/>
                <a:ext cx="109728" cy="109728"/>
              </a:xfrm>
              <a:prstGeom prst="rect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7140702" y="3350865"/>
                <a:ext cx="109728" cy="109728"/>
              </a:xfrm>
              <a:prstGeom prst="rect">
                <a:avLst/>
              </a:prstGeom>
              <a:solidFill>
                <a:srgbClr val="92D050"/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7719822" y="3358485"/>
                <a:ext cx="109728" cy="109728"/>
              </a:xfrm>
              <a:prstGeom prst="rect">
                <a:avLst/>
              </a:prstGeom>
              <a:solidFill>
                <a:srgbClr val="7030A0"/>
              </a:solidFill>
              <a:ln>
                <a:solidFill>
                  <a:srgbClr val="7030A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8286750" y="3350865"/>
                <a:ext cx="109728" cy="109728"/>
              </a:xfrm>
              <a:prstGeom prst="rect">
                <a:avLst/>
              </a:prstGeom>
              <a:solidFill>
                <a:schemeClr val="accent5"/>
              </a:solidFill>
              <a:ln>
                <a:solidFill>
                  <a:schemeClr val="accent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6160770" y="329752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0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6686550" y="330514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6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7296150" y="329752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24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7875270" y="329752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48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8439150" y="329752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72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32" name="TextBox 31"/>
            <p:cNvSpPr txBox="1"/>
            <p:nvPr/>
          </p:nvSpPr>
          <p:spPr>
            <a:xfrm>
              <a:off x="651935" y="160867"/>
              <a:ext cx="304800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600" dirty="0" smtClean="0">
                  <a:latin typeface="Arial" pitchFamily="34" charset="0"/>
                  <a:cs typeface="Arial" pitchFamily="34" charset="0"/>
                </a:rPr>
                <a:t>c.</a:t>
              </a:r>
              <a:endParaRPr lang="en-US" sz="16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" name="Group 35"/>
          <p:cNvGrpSpPr/>
          <p:nvPr/>
        </p:nvGrpSpPr>
        <p:grpSpPr>
          <a:xfrm>
            <a:off x="609601" y="2827180"/>
            <a:ext cx="6951133" cy="2583020"/>
            <a:chOff x="609601" y="2827180"/>
            <a:chExt cx="6951133" cy="2583020"/>
          </a:xfrm>
        </p:grpSpPr>
        <p:grpSp>
          <p:nvGrpSpPr>
            <p:cNvPr id="21" name="Group 33"/>
            <p:cNvGrpSpPr/>
            <p:nvPr/>
          </p:nvGrpSpPr>
          <p:grpSpPr>
            <a:xfrm>
              <a:off x="609601" y="3007362"/>
              <a:ext cx="6951133" cy="2402838"/>
              <a:chOff x="609601" y="2794002"/>
              <a:chExt cx="6951133" cy="2402838"/>
            </a:xfrm>
          </p:grpSpPr>
          <p:graphicFrame>
            <p:nvGraphicFramePr>
              <p:cNvPr id="6" name="Chart 5"/>
              <p:cNvGraphicFramePr/>
              <p:nvPr/>
            </p:nvGraphicFramePr>
            <p:xfrm>
              <a:off x="762000" y="2819400"/>
              <a:ext cx="6743700" cy="237744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7" name="TextBox 6"/>
              <p:cNvSpPr txBox="1"/>
              <p:nvPr/>
            </p:nvSpPr>
            <p:spPr>
              <a:xfrm rot="16200000">
                <a:off x="-77643" y="3659044"/>
                <a:ext cx="1666876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Relative expression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1752600" y="2794002"/>
                <a:ext cx="25908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10ᴼC  treatment vs. </a:t>
                </a:r>
                <a:r>
                  <a:rPr lang="en-US" sz="1400" i="1" dirty="0" smtClean="0">
                    <a:latin typeface="Times New Roman" pitchFamily="18" charset="0"/>
                    <a:cs typeface="Times New Roman" pitchFamily="18" charset="0"/>
                  </a:rPr>
                  <a:t>C. </a:t>
                </a:r>
                <a:r>
                  <a:rPr lang="en-US" sz="1400" i="1" dirty="0" err="1" smtClean="0">
                    <a:latin typeface="Times New Roman" pitchFamily="18" charset="0"/>
                    <a:cs typeface="Times New Roman" pitchFamily="18" charset="0"/>
                  </a:rPr>
                  <a:t>moschta</a:t>
                </a:r>
                <a:endParaRPr lang="en-US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grpSp>
            <p:nvGrpSpPr>
              <p:cNvPr id="33" name="Group 9"/>
              <p:cNvGrpSpPr/>
              <p:nvPr/>
            </p:nvGrpSpPr>
            <p:grpSpPr>
              <a:xfrm>
                <a:off x="4817534" y="2827849"/>
                <a:ext cx="2743200" cy="228600"/>
                <a:chOff x="6000750" y="3276600"/>
                <a:chExt cx="2743200" cy="228600"/>
              </a:xfrm>
            </p:grpSpPr>
            <p:sp>
              <p:nvSpPr>
                <p:cNvPr id="11" name="Rectangle 10"/>
                <p:cNvSpPr/>
                <p:nvPr/>
              </p:nvSpPr>
              <p:spPr>
                <a:xfrm>
                  <a:off x="6000750" y="3350865"/>
                  <a:ext cx="109728" cy="109728"/>
                </a:xfrm>
                <a:prstGeom prst="rect">
                  <a:avLst/>
                </a:prstGeom>
                <a:solidFill>
                  <a:schemeClr val="accent1">
                    <a:lumMod val="75000"/>
                  </a:schemeClr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" name="Rectangle 11"/>
                <p:cNvSpPr/>
                <p:nvPr/>
              </p:nvSpPr>
              <p:spPr>
                <a:xfrm>
                  <a:off x="6515862" y="3358485"/>
                  <a:ext cx="109728" cy="109728"/>
                </a:xfrm>
                <a:prstGeom prst="rect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" name="Rectangle 12"/>
                <p:cNvSpPr/>
                <p:nvPr/>
              </p:nvSpPr>
              <p:spPr>
                <a:xfrm>
                  <a:off x="7140702" y="3350865"/>
                  <a:ext cx="109728" cy="109728"/>
                </a:xfrm>
                <a:prstGeom prst="rect">
                  <a:avLst/>
                </a:prstGeom>
                <a:solidFill>
                  <a:srgbClr val="92D050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4" name="Rectangle 13"/>
                <p:cNvSpPr/>
                <p:nvPr/>
              </p:nvSpPr>
              <p:spPr>
                <a:xfrm>
                  <a:off x="7719822" y="3358485"/>
                  <a:ext cx="109728" cy="109728"/>
                </a:xfrm>
                <a:prstGeom prst="rect">
                  <a:avLst/>
                </a:prstGeom>
                <a:solidFill>
                  <a:srgbClr val="7030A0"/>
                </a:solidFill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" name="Rectangle 14"/>
                <p:cNvSpPr/>
                <p:nvPr/>
              </p:nvSpPr>
              <p:spPr>
                <a:xfrm>
                  <a:off x="8286750" y="3350865"/>
                  <a:ext cx="109728" cy="109728"/>
                </a:xfrm>
                <a:prstGeom prst="rect">
                  <a:avLst/>
                </a:prstGeom>
                <a:solidFill>
                  <a:schemeClr val="accent5"/>
                </a:solidFill>
                <a:ln>
                  <a:solidFill>
                    <a:schemeClr val="accent5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6160770" y="3297525"/>
                  <a:ext cx="304800" cy="200055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1300" dirty="0" smtClean="0">
                      <a:latin typeface="Times New Roman" pitchFamily="18" charset="0"/>
                      <a:cs typeface="Times New Roman" pitchFamily="18" charset="0"/>
                    </a:rPr>
                    <a:t>0h</a:t>
                  </a:r>
                  <a:endParaRPr lang="en-US" sz="13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6686550" y="3305145"/>
                  <a:ext cx="304800" cy="200055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1300" dirty="0" smtClean="0">
                      <a:latin typeface="Times New Roman" pitchFamily="18" charset="0"/>
                      <a:cs typeface="Times New Roman" pitchFamily="18" charset="0"/>
                    </a:rPr>
                    <a:t>6h</a:t>
                  </a:r>
                  <a:endParaRPr lang="en-US" sz="13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7296150" y="3297525"/>
                  <a:ext cx="304800" cy="200055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1300" dirty="0" smtClean="0">
                      <a:latin typeface="Times New Roman" pitchFamily="18" charset="0"/>
                      <a:cs typeface="Times New Roman" pitchFamily="18" charset="0"/>
                    </a:rPr>
                    <a:t>24h</a:t>
                  </a:r>
                  <a:endParaRPr lang="en-US" sz="13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7875270" y="3297525"/>
                  <a:ext cx="304800" cy="200055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1300" dirty="0" smtClean="0">
                      <a:latin typeface="Times New Roman" pitchFamily="18" charset="0"/>
                      <a:cs typeface="Times New Roman" pitchFamily="18" charset="0"/>
                    </a:rPr>
                    <a:t>48h</a:t>
                  </a:r>
                  <a:endParaRPr lang="en-US" sz="13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8439150" y="3276600"/>
                  <a:ext cx="304800" cy="200055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1300" dirty="0" smtClean="0">
                      <a:latin typeface="Times New Roman" pitchFamily="18" charset="0"/>
                      <a:cs typeface="Times New Roman" pitchFamily="18" charset="0"/>
                    </a:rPr>
                    <a:t>72h</a:t>
                  </a:r>
                  <a:endParaRPr lang="en-US" sz="13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  <p:sp>
          <p:nvSpPr>
            <p:cNvPr id="35" name="TextBox 34"/>
            <p:cNvSpPr txBox="1"/>
            <p:nvPr/>
          </p:nvSpPr>
          <p:spPr>
            <a:xfrm>
              <a:off x="660396" y="2827180"/>
              <a:ext cx="304800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600" dirty="0" smtClean="0">
                  <a:latin typeface="Arial" pitchFamily="34" charset="0"/>
                  <a:cs typeface="Arial" pitchFamily="34" charset="0"/>
                </a:rPr>
                <a:t>d.</a:t>
              </a:r>
              <a:endParaRPr lang="en-US" sz="16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6" name="Rectangle 1"/>
          <p:cNvSpPr>
            <a:spLocks noChangeArrowheads="1"/>
          </p:cNvSpPr>
          <p:nvPr/>
        </p:nvSpPr>
        <p:spPr bwMode="auto">
          <a:xfrm>
            <a:off x="228600" y="6172200"/>
            <a:ext cx="2667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Supplementary Figure S5</a:t>
            </a:r>
            <a:endParaRPr lang="en-US" sz="1400" dirty="0">
              <a:ea typeface="Malgun Gothic" pitchFamily="34" charset="-127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3"/>
          <p:cNvGrpSpPr/>
          <p:nvPr/>
        </p:nvGrpSpPr>
        <p:grpSpPr>
          <a:xfrm>
            <a:off x="593437" y="434979"/>
            <a:ext cx="8302913" cy="2475861"/>
            <a:chOff x="593437" y="434979"/>
            <a:chExt cx="8302913" cy="2475861"/>
          </a:xfrm>
        </p:grpSpPr>
        <p:graphicFrame>
          <p:nvGraphicFramePr>
            <p:cNvPr id="4" name="Chart 3"/>
            <p:cNvGraphicFramePr/>
            <p:nvPr/>
          </p:nvGraphicFramePr>
          <p:xfrm>
            <a:off x="762000" y="533400"/>
            <a:ext cx="7848600" cy="23774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 rot="16200000">
              <a:off x="-93807" y="1373043"/>
              <a:ext cx="1666876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dirty="0" smtClean="0">
                  <a:latin typeface="Times New Roman" pitchFamily="18" charset="0"/>
                  <a:cs typeface="Times New Roman" pitchFamily="18" charset="0"/>
                </a:rPr>
                <a:t>Relative expression</a:t>
              </a:r>
              <a:endParaRPr lang="en-US" sz="13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895600" y="434979"/>
              <a:ext cx="2590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15ᴼC  treatment vs. </a:t>
              </a:r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C. maxima</a:t>
              </a:r>
              <a:endParaRPr lang="en-US" sz="14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3" name="Group 20"/>
            <p:cNvGrpSpPr/>
            <p:nvPr/>
          </p:nvGrpSpPr>
          <p:grpSpPr>
            <a:xfrm>
              <a:off x="6153150" y="533400"/>
              <a:ext cx="2743200" cy="207675"/>
              <a:chOff x="6000750" y="3297525"/>
              <a:chExt cx="2743200" cy="207675"/>
            </a:xfrm>
          </p:grpSpPr>
          <p:sp>
            <p:nvSpPr>
              <p:cNvPr id="22" name="Rectangle 21"/>
              <p:cNvSpPr/>
              <p:nvPr/>
            </p:nvSpPr>
            <p:spPr>
              <a:xfrm>
                <a:off x="6000750" y="3350865"/>
                <a:ext cx="109728" cy="109728"/>
              </a:xfrm>
              <a:prstGeom prst="rect">
                <a:avLst/>
              </a:prstGeom>
              <a:solidFill>
                <a:schemeClr val="accent1">
                  <a:lumMod val="75000"/>
                </a:schemeClr>
              </a:solidFill>
              <a:ln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6515862" y="3358485"/>
                <a:ext cx="109728" cy="109728"/>
              </a:xfrm>
              <a:prstGeom prst="rect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7140702" y="3350865"/>
                <a:ext cx="109728" cy="109728"/>
              </a:xfrm>
              <a:prstGeom prst="rect">
                <a:avLst/>
              </a:prstGeom>
              <a:solidFill>
                <a:srgbClr val="92D050"/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7719822" y="3358485"/>
                <a:ext cx="109728" cy="109728"/>
              </a:xfrm>
              <a:prstGeom prst="rect">
                <a:avLst/>
              </a:prstGeom>
              <a:solidFill>
                <a:srgbClr val="7030A0"/>
              </a:solidFill>
              <a:ln>
                <a:solidFill>
                  <a:srgbClr val="7030A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8286750" y="3350865"/>
                <a:ext cx="109728" cy="109728"/>
              </a:xfrm>
              <a:prstGeom prst="rect">
                <a:avLst/>
              </a:prstGeom>
              <a:solidFill>
                <a:schemeClr val="accent5"/>
              </a:solidFill>
              <a:ln>
                <a:solidFill>
                  <a:schemeClr val="accent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6160770" y="329752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0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6686550" y="330514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6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7296150" y="329752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24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7875270" y="329752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48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8439150" y="329752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72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32" name="TextBox 31"/>
            <p:cNvSpPr txBox="1"/>
            <p:nvPr/>
          </p:nvSpPr>
          <p:spPr>
            <a:xfrm>
              <a:off x="609600" y="473450"/>
              <a:ext cx="304800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600" dirty="0" smtClean="0">
                  <a:latin typeface="Arial" pitchFamily="34" charset="0"/>
                  <a:cs typeface="Arial" pitchFamily="34" charset="0"/>
                </a:rPr>
                <a:t>e.</a:t>
              </a:r>
              <a:endParaRPr lang="en-US" sz="16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" name="Group 34"/>
          <p:cNvGrpSpPr/>
          <p:nvPr/>
        </p:nvGrpSpPr>
        <p:grpSpPr>
          <a:xfrm>
            <a:off x="602961" y="3106579"/>
            <a:ext cx="8140989" cy="2471261"/>
            <a:chOff x="602961" y="3106579"/>
            <a:chExt cx="8140989" cy="2471261"/>
          </a:xfrm>
        </p:grpSpPr>
        <p:graphicFrame>
          <p:nvGraphicFramePr>
            <p:cNvPr id="6" name="Chart 5"/>
            <p:cNvGraphicFramePr/>
            <p:nvPr/>
          </p:nvGraphicFramePr>
          <p:xfrm>
            <a:off x="771525" y="3200400"/>
            <a:ext cx="7845552" cy="23774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7" name="TextBox 6"/>
            <p:cNvSpPr txBox="1"/>
            <p:nvPr/>
          </p:nvSpPr>
          <p:spPr>
            <a:xfrm rot="16200000">
              <a:off x="-84283" y="4040043"/>
              <a:ext cx="1666876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dirty="0" smtClean="0">
                  <a:latin typeface="Times New Roman" pitchFamily="18" charset="0"/>
                  <a:cs typeface="Times New Roman" pitchFamily="18" charset="0"/>
                </a:rPr>
                <a:t>Relative expression</a:t>
              </a:r>
              <a:endParaRPr lang="en-US" sz="13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743200" y="3175202"/>
              <a:ext cx="2590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15ᴼC  treatment vs. </a:t>
              </a:r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C. </a:t>
              </a:r>
              <a:r>
                <a:rPr lang="en-US" sz="1400" i="1" dirty="0" err="1" smtClean="0">
                  <a:latin typeface="Times New Roman" pitchFamily="18" charset="0"/>
                  <a:cs typeface="Times New Roman" pitchFamily="18" charset="0"/>
                </a:rPr>
                <a:t>moschta</a:t>
              </a:r>
              <a:endParaRPr lang="en-US" sz="14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21" name="Group 9"/>
            <p:cNvGrpSpPr/>
            <p:nvPr/>
          </p:nvGrpSpPr>
          <p:grpSpPr>
            <a:xfrm>
              <a:off x="6000750" y="3297525"/>
              <a:ext cx="2743200" cy="207675"/>
              <a:chOff x="6000750" y="3297525"/>
              <a:chExt cx="2743200" cy="207675"/>
            </a:xfrm>
          </p:grpSpPr>
          <p:sp>
            <p:nvSpPr>
              <p:cNvPr id="11" name="Rectangle 10"/>
              <p:cNvSpPr/>
              <p:nvPr/>
            </p:nvSpPr>
            <p:spPr>
              <a:xfrm>
                <a:off x="6000750" y="3350865"/>
                <a:ext cx="109728" cy="109728"/>
              </a:xfrm>
              <a:prstGeom prst="rect">
                <a:avLst/>
              </a:prstGeom>
              <a:solidFill>
                <a:schemeClr val="accent1">
                  <a:lumMod val="75000"/>
                </a:schemeClr>
              </a:solidFill>
              <a:ln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Rectangle 11"/>
              <p:cNvSpPr/>
              <p:nvPr/>
            </p:nvSpPr>
            <p:spPr>
              <a:xfrm>
                <a:off x="6515862" y="3358485"/>
                <a:ext cx="109728" cy="109728"/>
              </a:xfrm>
              <a:prstGeom prst="rect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Rectangle 12"/>
              <p:cNvSpPr/>
              <p:nvPr/>
            </p:nvSpPr>
            <p:spPr>
              <a:xfrm>
                <a:off x="7140702" y="3350865"/>
                <a:ext cx="109728" cy="109728"/>
              </a:xfrm>
              <a:prstGeom prst="rect">
                <a:avLst/>
              </a:prstGeom>
              <a:solidFill>
                <a:srgbClr val="92D050"/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7719822" y="3358485"/>
                <a:ext cx="109728" cy="109728"/>
              </a:xfrm>
              <a:prstGeom prst="rect">
                <a:avLst/>
              </a:prstGeom>
              <a:solidFill>
                <a:srgbClr val="7030A0"/>
              </a:solidFill>
              <a:ln>
                <a:solidFill>
                  <a:srgbClr val="7030A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8286750" y="3350865"/>
                <a:ext cx="109728" cy="109728"/>
              </a:xfrm>
              <a:prstGeom prst="rect">
                <a:avLst/>
              </a:prstGeom>
              <a:solidFill>
                <a:schemeClr val="accent5"/>
              </a:solidFill>
              <a:ln>
                <a:solidFill>
                  <a:schemeClr val="accent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6160770" y="329752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0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6686550" y="330514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6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7296150" y="329752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24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7875270" y="329752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48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8439150" y="3297525"/>
                <a:ext cx="304800" cy="20005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300" dirty="0" smtClean="0">
                    <a:latin typeface="Times New Roman" pitchFamily="18" charset="0"/>
                    <a:cs typeface="Times New Roman" pitchFamily="18" charset="0"/>
                  </a:rPr>
                  <a:t>72h</a:t>
                </a:r>
                <a:endParaRPr lang="en-US" sz="13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33" name="TextBox 32"/>
            <p:cNvSpPr txBox="1"/>
            <p:nvPr/>
          </p:nvSpPr>
          <p:spPr>
            <a:xfrm>
              <a:off x="626534" y="3106579"/>
              <a:ext cx="304800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600" dirty="0" smtClean="0">
                  <a:latin typeface="Arial" pitchFamily="34" charset="0"/>
                  <a:cs typeface="Arial" pitchFamily="34" charset="0"/>
                </a:rPr>
                <a:t>f.</a:t>
              </a:r>
              <a:endParaRPr lang="en-US" sz="16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4" name="Rectangle 33"/>
          <p:cNvSpPr/>
          <p:nvPr/>
        </p:nvSpPr>
        <p:spPr>
          <a:xfrm>
            <a:off x="457200" y="5638800"/>
            <a:ext cx="84582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Supplementary Figure S5 </a:t>
            </a:r>
            <a:r>
              <a:rPr lang="en-US" sz="1200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Expression patterns of </a:t>
            </a:r>
            <a:r>
              <a:rPr lang="en-US" sz="1200" i="1" dirty="0" err="1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CmaGST</a:t>
            </a:r>
            <a:r>
              <a:rPr lang="en-US" sz="1200" i="1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genes under various temperature treatments. The relative expression data of </a:t>
            </a:r>
            <a:r>
              <a:rPr lang="en-US" sz="1200" dirty="0" err="1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qPCR</a:t>
            </a:r>
            <a:r>
              <a:rPr lang="en-US" sz="1200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 of </a:t>
            </a:r>
            <a:r>
              <a:rPr lang="en-US" sz="1200" i="1" dirty="0" err="1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CmaGST</a:t>
            </a:r>
            <a:r>
              <a:rPr lang="en-US" sz="1200" i="1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genes at 5ᴼ C temperature treatment to resistance line CP-1‘</a:t>
            </a:r>
            <a:r>
              <a:rPr lang="en-US" sz="1200" i="1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C. maxima</a:t>
            </a:r>
            <a:r>
              <a:rPr lang="en-US" sz="1200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’ (a), susceptible line EP-1 ‘</a:t>
            </a:r>
            <a:r>
              <a:rPr lang="en-US" sz="1200" i="1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C. </a:t>
            </a:r>
            <a:r>
              <a:rPr lang="en-US" sz="1200" i="1" dirty="0" err="1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moschata</a:t>
            </a:r>
            <a:r>
              <a:rPr lang="en-US" sz="1200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’ (b); 10ᴼ C temperature treatment to resistance line CP-1 ‘</a:t>
            </a:r>
            <a:r>
              <a:rPr lang="en-US" sz="1200" i="1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C. maxima</a:t>
            </a:r>
            <a:r>
              <a:rPr lang="en-US" sz="1200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’ (c), susceptible EP-1 ‘</a:t>
            </a:r>
            <a:r>
              <a:rPr lang="en-US" sz="1200" i="1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C. </a:t>
            </a:r>
            <a:r>
              <a:rPr lang="en-US" sz="1200" i="1" dirty="0" err="1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moschata</a:t>
            </a:r>
            <a:r>
              <a:rPr lang="en-US" sz="1200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’ (d); and 15ᴼ C temperature treatment to resistance line CP-1 ‘</a:t>
            </a:r>
            <a:r>
              <a:rPr lang="en-US" sz="1200" i="1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C. maxima</a:t>
            </a:r>
            <a:r>
              <a:rPr lang="en-US" sz="1200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’ (e), susceptible EP-1 ‘</a:t>
            </a:r>
            <a:r>
              <a:rPr lang="en-US" sz="1200" i="1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C. </a:t>
            </a:r>
            <a:r>
              <a:rPr lang="en-US" sz="1200" i="1" dirty="0" err="1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moschata</a:t>
            </a:r>
            <a:r>
              <a:rPr lang="en-US" sz="1200" dirty="0" smtClean="0"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’ (f). Error bars represent the standard deviation of the means of three independent replicates for each sample. </a:t>
            </a:r>
            <a:endParaRPr lang="en-US" sz="1200" dirty="0" smtClean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0</TotalTime>
  <Words>1232</Words>
  <Application>Microsoft Office PowerPoint</Application>
  <PresentationFormat>On-screen Show (4:3)</PresentationFormat>
  <Paragraphs>675</Paragraphs>
  <Slides>9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AYUM</dc:creator>
  <cp:lastModifiedBy>super</cp:lastModifiedBy>
  <cp:revision>6</cp:revision>
  <dcterms:created xsi:type="dcterms:W3CDTF">2017-12-21T05:55:41Z</dcterms:created>
  <dcterms:modified xsi:type="dcterms:W3CDTF">2018-02-06T02:46:43Z</dcterms:modified>
</cp:coreProperties>
</file>